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6"/>
  </p:notesMasterIdLst>
  <p:sldIdLst>
    <p:sldId id="256" r:id="rId2"/>
    <p:sldId id="276" r:id="rId3"/>
    <p:sldId id="277" r:id="rId4"/>
    <p:sldId id="329" r:id="rId5"/>
    <p:sldId id="278" r:id="rId6"/>
    <p:sldId id="279" r:id="rId7"/>
    <p:sldId id="273" r:id="rId8"/>
    <p:sldId id="269" r:id="rId9"/>
    <p:sldId id="262" r:id="rId10"/>
    <p:sldId id="261" r:id="rId11"/>
    <p:sldId id="263" r:id="rId12"/>
    <p:sldId id="264" r:id="rId13"/>
    <p:sldId id="265" r:id="rId14"/>
    <p:sldId id="274" r:id="rId15"/>
    <p:sldId id="267" r:id="rId16"/>
    <p:sldId id="288" r:id="rId17"/>
    <p:sldId id="270" r:id="rId18"/>
    <p:sldId id="280" r:id="rId19"/>
    <p:sldId id="259" r:id="rId20"/>
    <p:sldId id="281" r:id="rId21"/>
    <p:sldId id="257" r:id="rId22"/>
    <p:sldId id="282" r:id="rId23"/>
    <p:sldId id="283" r:id="rId24"/>
    <p:sldId id="285" r:id="rId25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5208"/>
    <a:srgbClr val="F4B183"/>
    <a:srgbClr val="0000FF"/>
    <a:srgbClr val="C35D1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81" autoAdjust="0"/>
    <p:restoredTop sz="94660"/>
  </p:normalViewPr>
  <p:slideViewPr>
    <p:cSldViewPr snapToGrid="0">
      <p:cViewPr>
        <p:scale>
          <a:sx n="80" d="100"/>
          <a:sy n="80" d="100"/>
        </p:scale>
        <p:origin x="854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5778F7-1B1F-45B1-9565-DCCD5681ACEF}" type="datetimeFigureOut">
              <a:rPr lang="en-US" smtClean="0"/>
              <a:t>9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1E71D8-799B-483E-BACA-8D6C124C3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41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4F6CC7-07BF-493D-8022-E731EFB37F3E}" type="slidenum">
              <a:rPr lang="fi-FI" smtClean="0"/>
              <a:t>4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9478476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909336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99472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87286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13455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2931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31640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2666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96908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47446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3009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1025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6A47A6-26A2-443A-92FC-7CD2A3DF08B5}" type="datetimeFigureOut">
              <a:rPr lang="fi-FI" smtClean="0"/>
              <a:t>17.9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EEDE56-A95B-41B5-87E6-708AD2D9139B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83890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5.png"/><Relationship Id="rId4" Type="http://schemas.openxmlformats.org/officeDocument/2006/relationships/image" Target="../media/image1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5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15.png"/><Relationship Id="rId7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34.png"/><Relationship Id="rId5" Type="http://schemas.microsoft.com/office/2007/relationships/hdphoto" Target="../media/hdphoto1.wdp"/><Relationship Id="rId10" Type="http://schemas.openxmlformats.org/officeDocument/2006/relationships/image" Target="../media/image33.png"/><Relationship Id="rId4" Type="http://schemas.openxmlformats.org/officeDocument/2006/relationships/image" Target="../media/image17.png"/><Relationship Id="rId9" Type="http://schemas.openxmlformats.org/officeDocument/2006/relationships/image" Target="../media/image3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7" Type="http://schemas.openxmlformats.org/officeDocument/2006/relationships/image" Target="../media/image34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19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/>
              <a:t>Solving the large-scale TSP problem in 1 hour: </a:t>
            </a:r>
            <a:br>
              <a:rPr lang="en-US" b="1" dirty="0"/>
            </a:br>
            <a:r>
              <a:rPr lang="en-US" b="1" dirty="0"/>
              <a:t>Santa Claus Challenge 2020</a:t>
            </a:r>
            <a:endParaRPr lang="fi-FI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sz="3000" dirty="0">
                <a:solidFill>
                  <a:srgbClr val="FF0000"/>
                </a:solidFill>
              </a:rPr>
              <a:t>Figures</a:t>
            </a:r>
          </a:p>
          <a:p>
            <a:r>
              <a:rPr lang="en-US" dirty="0"/>
              <a:t>17.9.2021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3041953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Freeform 96"/>
          <p:cNvSpPr/>
          <p:nvPr/>
        </p:nvSpPr>
        <p:spPr>
          <a:xfrm>
            <a:off x="7655241" y="4016693"/>
            <a:ext cx="728663" cy="799148"/>
          </a:xfrm>
          <a:custGeom>
            <a:avLst/>
            <a:gdLst>
              <a:gd name="connsiteX0" fmla="*/ 0 w 723900"/>
              <a:gd name="connsiteY0" fmla="*/ 0 h 784860"/>
              <a:gd name="connsiteX1" fmla="*/ 723900 w 723900"/>
              <a:gd name="connsiteY1" fmla="*/ 784860 h 784860"/>
              <a:gd name="connsiteX0" fmla="*/ 0 w 731044"/>
              <a:gd name="connsiteY0" fmla="*/ 0 h 799148"/>
              <a:gd name="connsiteX1" fmla="*/ 731044 w 731044"/>
              <a:gd name="connsiteY1" fmla="*/ 799148 h 799148"/>
              <a:gd name="connsiteX0" fmla="*/ 0 w 733425"/>
              <a:gd name="connsiteY0" fmla="*/ 0 h 799148"/>
              <a:gd name="connsiteX1" fmla="*/ 733425 w 733425"/>
              <a:gd name="connsiteY1" fmla="*/ 799148 h 799148"/>
              <a:gd name="connsiteX0" fmla="*/ 0 w 735807"/>
              <a:gd name="connsiteY0" fmla="*/ 0 h 799148"/>
              <a:gd name="connsiteX1" fmla="*/ 735807 w 735807"/>
              <a:gd name="connsiteY1" fmla="*/ 799148 h 799148"/>
              <a:gd name="connsiteX0" fmla="*/ 0 w 735807"/>
              <a:gd name="connsiteY0" fmla="*/ 0 h 803910"/>
              <a:gd name="connsiteX1" fmla="*/ 735807 w 735807"/>
              <a:gd name="connsiteY1" fmla="*/ 803910 h 803910"/>
              <a:gd name="connsiteX0" fmla="*/ 0 w 726282"/>
              <a:gd name="connsiteY0" fmla="*/ 0 h 801529"/>
              <a:gd name="connsiteX1" fmla="*/ 726282 w 726282"/>
              <a:gd name="connsiteY1" fmla="*/ 801529 h 801529"/>
              <a:gd name="connsiteX0" fmla="*/ 0 w 728663"/>
              <a:gd name="connsiteY0" fmla="*/ 0 h 799148"/>
              <a:gd name="connsiteX1" fmla="*/ 728663 w 728663"/>
              <a:gd name="connsiteY1" fmla="*/ 799148 h 7991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728663" h="799148">
                <a:moveTo>
                  <a:pt x="0" y="0"/>
                </a:moveTo>
                <a:lnTo>
                  <a:pt x="728663" y="799148"/>
                </a:lnTo>
              </a:path>
            </a:pathLst>
          </a:custGeom>
          <a:noFill/>
          <a:ln w="25400" cap="rnd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95" name="Freeform 94"/>
          <p:cNvSpPr/>
          <p:nvPr/>
        </p:nvSpPr>
        <p:spPr>
          <a:xfrm>
            <a:off x="4888230" y="2750820"/>
            <a:ext cx="746760" cy="967740"/>
          </a:xfrm>
          <a:custGeom>
            <a:avLst/>
            <a:gdLst>
              <a:gd name="connsiteX0" fmla="*/ 0 w 746760"/>
              <a:gd name="connsiteY0" fmla="*/ 0 h 967740"/>
              <a:gd name="connsiteX1" fmla="*/ 114300 w 746760"/>
              <a:gd name="connsiteY1" fmla="*/ 967740 h 967740"/>
              <a:gd name="connsiteX2" fmla="*/ 746760 w 746760"/>
              <a:gd name="connsiteY2" fmla="*/ 335280 h 9677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46760" h="967740">
                <a:moveTo>
                  <a:pt x="0" y="0"/>
                </a:moveTo>
                <a:lnTo>
                  <a:pt x="114300" y="967740"/>
                </a:lnTo>
                <a:lnTo>
                  <a:pt x="746760" y="335280"/>
                </a:lnTo>
              </a:path>
            </a:pathLst>
          </a:custGeom>
          <a:noFill/>
          <a:ln w="254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93" name="Freeform 92"/>
          <p:cNvSpPr/>
          <p:nvPr/>
        </p:nvSpPr>
        <p:spPr>
          <a:xfrm>
            <a:off x="3524250" y="3990975"/>
            <a:ext cx="742950" cy="809625"/>
          </a:xfrm>
          <a:custGeom>
            <a:avLst/>
            <a:gdLst>
              <a:gd name="connsiteX0" fmla="*/ 0 w 742950"/>
              <a:gd name="connsiteY0" fmla="*/ 0 h 809625"/>
              <a:gd name="connsiteX1" fmla="*/ 742950 w 742950"/>
              <a:gd name="connsiteY1" fmla="*/ 809625 h 8096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742950" h="809625">
                <a:moveTo>
                  <a:pt x="0" y="0"/>
                </a:moveTo>
                <a:lnTo>
                  <a:pt x="742950" y="809625"/>
                </a:lnTo>
              </a:path>
            </a:pathLst>
          </a:custGeom>
          <a:noFill/>
          <a:ln w="254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67" name="Freeform 66"/>
          <p:cNvSpPr/>
          <p:nvPr/>
        </p:nvSpPr>
        <p:spPr>
          <a:xfrm>
            <a:off x="3524250" y="2495550"/>
            <a:ext cx="600075" cy="619125"/>
          </a:xfrm>
          <a:custGeom>
            <a:avLst/>
            <a:gdLst>
              <a:gd name="connsiteX0" fmla="*/ 0 w 1209675"/>
              <a:gd name="connsiteY0" fmla="*/ 1619250 h 1619250"/>
              <a:gd name="connsiteX1" fmla="*/ 600075 w 1209675"/>
              <a:gd name="connsiteY1" fmla="*/ 1000125 h 1619250"/>
              <a:gd name="connsiteX2" fmla="*/ 1209675 w 1209675"/>
              <a:gd name="connsiteY2" fmla="*/ 0 h 1619250"/>
              <a:gd name="connsiteX0" fmla="*/ 0 w 600075"/>
              <a:gd name="connsiteY0" fmla="*/ 619125 h 619125"/>
              <a:gd name="connsiteX1" fmla="*/ 600075 w 600075"/>
              <a:gd name="connsiteY1" fmla="*/ 0 h 6191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00075" h="619125">
                <a:moveTo>
                  <a:pt x="0" y="619125"/>
                </a:moveTo>
                <a:lnTo>
                  <a:pt x="600075" y="0"/>
                </a:lnTo>
              </a:path>
            </a:pathLst>
          </a:custGeom>
          <a:noFill/>
          <a:ln w="254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grpSp>
        <p:nvGrpSpPr>
          <p:cNvPr id="70" name="Group 69"/>
          <p:cNvGrpSpPr/>
          <p:nvPr/>
        </p:nvGrpSpPr>
        <p:grpSpPr>
          <a:xfrm>
            <a:off x="2552700" y="1838325"/>
            <a:ext cx="3089197" cy="2156468"/>
            <a:chOff x="1314450" y="1838325"/>
            <a:chExt cx="3089197" cy="2156468"/>
          </a:xfrm>
        </p:grpSpPr>
        <p:sp>
          <p:nvSpPr>
            <p:cNvPr id="68" name="Freeform 67"/>
            <p:cNvSpPr/>
            <p:nvPr/>
          </p:nvSpPr>
          <p:spPr>
            <a:xfrm>
              <a:off x="1314450" y="1838325"/>
              <a:ext cx="790575" cy="1209675"/>
            </a:xfrm>
            <a:custGeom>
              <a:avLst/>
              <a:gdLst>
                <a:gd name="connsiteX0" fmla="*/ 790575 w 790575"/>
                <a:gd name="connsiteY0" fmla="*/ 0 h 1209675"/>
                <a:gd name="connsiteX1" fmla="*/ 552450 w 790575"/>
                <a:gd name="connsiteY1" fmla="*/ 657225 h 1209675"/>
                <a:gd name="connsiteX2" fmla="*/ 0 w 790575"/>
                <a:gd name="connsiteY2" fmla="*/ 1209675 h 12096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90575" h="1209675">
                  <a:moveTo>
                    <a:pt x="790575" y="0"/>
                  </a:moveTo>
                  <a:lnTo>
                    <a:pt x="552450" y="657225"/>
                  </a:lnTo>
                  <a:lnTo>
                    <a:pt x="0" y="1209675"/>
                  </a:lnTo>
                </a:path>
              </a:pathLst>
            </a:custGeom>
            <a:noFill/>
            <a:ln w="254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1867961" y="1981636"/>
              <a:ext cx="2535686" cy="2013157"/>
              <a:chOff x="3981450" y="1447800"/>
              <a:chExt cx="3975100" cy="3155950"/>
            </a:xfrm>
          </p:grpSpPr>
          <p:sp>
            <p:nvSpPr>
              <p:cNvPr id="39" name="Freeform 38"/>
              <p:cNvSpPr/>
              <p:nvPr/>
            </p:nvSpPr>
            <p:spPr>
              <a:xfrm>
                <a:off x="5581649" y="2254252"/>
                <a:ext cx="2374901" cy="927100"/>
              </a:xfrm>
              <a:custGeom>
                <a:avLst/>
                <a:gdLst>
                  <a:gd name="connsiteX0" fmla="*/ 0 w 4857750"/>
                  <a:gd name="connsiteY0" fmla="*/ 1873250 h 1943100"/>
                  <a:gd name="connsiteX1" fmla="*/ 869950 w 4857750"/>
                  <a:gd name="connsiteY1" fmla="*/ 1022350 h 1943100"/>
                  <a:gd name="connsiteX2" fmla="*/ 1250950 w 4857750"/>
                  <a:gd name="connsiteY2" fmla="*/ 0 h 1943100"/>
                  <a:gd name="connsiteX3" fmla="*/ 2482850 w 4857750"/>
                  <a:gd name="connsiteY3" fmla="*/ 1016000 h 1943100"/>
                  <a:gd name="connsiteX4" fmla="*/ 3683000 w 4857750"/>
                  <a:gd name="connsiteY4" fmla="*/ 1435100 h 1943100"/>
                  <a:gd name="connsiteX5" fmla="*/ 4857750 w 4857750"/>
                  <a:gd name="connsiteY5" fmla="*/ 1943100 h 1943100"/>
                  <a:gd name="connsiteX0" fmla="*/ 0 w 4857750"/>
                  <a:gd name="connsiteY0" fmla="*/ 1873250 h 1943100"/>
                  <a:gd name="connsiteX1" fmla="*/ 1250950 w 4857750"/>
                  <a:gd name="connsiteY1" fmla="*/ 0 h 1943100"/>
                  <a:gd name="connsiteX2" fmla="*/ 2482850 w 4857750"/>
                  <a:gd name="connsiteY2" fmla="*/ 1016000 h 1943100"/>
                  <a:gd name="connsiteX3" fmla="*/ 3683000 w 4857750"/>
                  <a:gd name="connsiteY3" fmla="*/ 1435100 h 1943100"/>
                  <a:gd name="connsiteX4" fmla="*/ 4857750 w 4857750"/>
                  <a:gd name="connsiteY4" fmla="*/ 1943100 h 1943100"/>
                  <a:gd name="connsiteX0" fmla="*/ -1 w 3606799"/>
                  <a:gd name="connsiteY0" fmla="*/ 0 h 1943100"/>
                  <a:gd name="connsiteX1" fmla="*/ 1231899 w 3606799"/>
                  <a:gd name="connsiteY1" fmla="*/ 1016000 h 1943100"/>
                  <a:gd name="connsiteX2" fmla="*/ 2432049 w 3606799"/>
                  <a:gd name="connsiteY2" fmla="*/ 1435100 h 1943100"/>
                  <a:gd name="connsiteX3" fmla="*/ 3606799 w 3606799"/>
                  <a:gd name="connsiteY3" fmla="*/ 1943100 h 1943100"/>
                  <a:gd name="connsiteX0" fmla="*/ 0 w 2374900"/>
                  <a:gd name="connsiteY0" fmla="*/ 0 h 927100"/>
                  <a:gd name="connsiteX1" fmla="*/ 1200150 w 2374900"/>
                  <a:gd name="connsiteY1" fmla="*/ 419100 h 927100"/>
                  <a:gd name="connsiteX2" fmla="*/ 2374900 w 2374900"/>
                  <a:gd name="connsiteY2" fmla="*/ 927100 h 927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374900" h="927100">
                    <a:moveTo>
                      <a:pt x="0" y="0"/>
                    </a:moveTo>
                    <a:lnTo>
                      <a:pt x="1200150" y="419100"/>
                    </a:lnTo>
                    <a:lnTo>
                      <a:pt x="2374900" y="92710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  <p:sp>
            <p:nvSpPr>
              <p:cNvPr id="40" name="Freeform 39"/>
              <p:cNvSpPr/>
              <p:nvPr/>
            </p:nvSpPr>
            <p:spPr>
              <a:xfrm>
                <a:off x="6794500" y="1447800"/>
                <a:ext cx="495300" cy="1225550"/>
              </a:xfrm>
              <a:custGeom>
                <a:avLst/>
                <a:gdLst>
                  <a:gd name="connsiteX0" fmla="*/ 495300 w 495300"/>
                  <a:gd name="connsiteY0" fmla="*/ 0 h 2724150"/>
                  <a:gd name="connsiteX1" fmla="*/ 0 w 495300"/>
                  <a:gd name="connsiteY1" fmla="*/ 1225550 h 2724150"/>
                  <a:gd name="connsiteX2" fmla="*/ 152400 w 495300"/>
                  <a:gd name="connsiteY2" fmla="*/ 2724150 h 2724150"/>
                  <a:gd name="connsiteX0" fmla="*/ 495300 w 495300"/>
                  <a:gd name="connsiteY0" fmla="*/ 0 h 1225550"/>
                  <a:gd name="connsiteX1" fmla="*/ 0 w 495300"/>
                  <a:gd name="connsiteY1" fmla="*/ 1225550 h 12255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5300" h="1225550">
                    <a:moveTo>
                      <a:pt x="495300" y="0"/>
                    </a:moveTo>
                    <a:lnTo>
                      <a:pt x="0" y="122555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  <p:sp>
            <p:nvSpPr>
              <p:cNvPr id="41" name="Freeform 40"/>
              <p:cNvSpPr/>
              <p:nvPr/>
            </p:nvSpPr>
            <p:spPr>
              <a:xfrm>
                <a:off x="3981450" y="2254250"/>
                <a:ext cx="660400" cy="2349500"/>
              </a:xfrm>
              <a:custGeom>
                <a:avLst/>
                <a:gdLst>
                  <a:gd name="connsiteX0" fmla="*/ 660400 w 660400"/>
                  <a:gd name="connsiteY0" fmla="*/ 2349500 h 2349500"/>
                  <a:gd name="connsiteX1" fmla="*/ 660400 w 660400"/>
                  <a:gd name="connsiteY1" fmla="*/ 971550 h 2349500"/>
                  <a:gd name="connsiteX2" fmla="*/ 0 w 660400"/>
                  <a:gd name="connsiteY2" fmla="*/ 0 h 2349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60400" h="2349500">
                    <a:moveTo>
                      <a:pt x="660400" y="2349500"/>
                    </a:moveTo>
                    <a:lnTo>
                      <a:pt x="660400" y="971550"/>
                    </a:lnTo>
                    <a:lnTo>
                      <a:pt x="0" y="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</p:grpSp>
      </p:grpSp>
      <p:sp>
        <p:nvSpPr>
          <p:cNvPr id="43" name="Oval 42"/>
          <p:cNvSpPr/>
          <p:nvPr/>
        </p:nvSpPr>
        <p:spPr>
          <a:xfrm>
            <a:off x="2502669" y="2998340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4" name="Oval 43"/>
          <p:cNvSpPr/>
          <p:nvPr/>
        </p:nvSpPr>
        <p:spPr>
          <a:xfrm>
            <a:off x="3053553" y="2447456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5" name="Oval 44"/>
          <p:cNvSpPr/>
          <p:nvPr/>
        </p:nvSpPr>
        <p:spPr>
          <a:xfrm>
            <a:off x="3300641" y="1803408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6" name="Oval 45"/>
          <p:cNvSpPr/>
          <p:nvPr/>
        </p:nvSpPr>
        <p:spPr>
          <a:xfrm>
            <a:off x="4078359" y="2443405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7" name="Oval 46"/>
          <p:cNvSpPr/>
          <p:nvPr/>
        </p:nvSpPr>
        <p:spPr>
          <a:xfrm>
            <a:off x="4852027" y="2714797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8" name="Oval 47"/>
          <p:cNvSpPr/>
          <p:nvPr/>
        </p:nvSpPr>
        <p:spPr>
          <a:xfrm>
            <a:off x="5172026" y="1937078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49" name="Oval 48"/>
          <p:cNvSpPr/>
          <p:nvPr/>
        </p:nvSpPr>
        <p:spPr>
          <a:xfrm>
            <a:off x="5593290" y="3038846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50" name="Oval 49"/>
          <p:cNvSpPr/>
          <p:nvPr/>
        </p:nvSpPr>
        <p:spPr>
          <a:xfrm>
            <a:off x="4953293" y="3670742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51" name="Oval 50"/>
          <p:cNvSpPr/>
          <p:nvPr/>
        </p:nvSpPr>
        <p:spPr>
          <a:xfrm>
            <a:off x="3478868" y="3067201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52" name="Oval 51"/>
          <p:cNvSpPr/>
          <p:nvPr/>
        </p:nvSpPr>
        <p:spPr>
          <a:xfrm>
            <a:off x="3482918" y="3942134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53" name="Oval 52"/>
          <p:cNvSpPr/>
          <p:nvPr/>
        </p:nvSpPr>
        <p:spPr>
          <a:xfrm>
            <a:off x="4216080" y="4748207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65" name="TextBox 64"/>
          <p:cNvSpPr txBox="1"/>
          <p:nvPr/>
        </p:nvSpPr>
        <p:spPr>
          <a:xfrm>
            <a:off x="3000375" y="1194435"/>
            <a:ext cx="22779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Minimum 1-tree</a:t>
            </a:r>
            <a:endParaRPr lang="fi-FI" sz="2400" b="1" dirty="0"/>
          </a:p>
        </p:txBody>
      </p:sp>
      <p:sp>
        <p:nvSpPr>
          <p:cNvPr id="71" name="TextBox 70"/>
          <p:cNvSpPr txBox="1"/>
          <p:nvPr/>
        </p:nvSpPr>
        <p:spPr>
          <a:xfrm>
            <a:off x="3876675" y="2914650"/>
            <a:ext cx="7491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0000FF"/>
                </a:solidFill>
              </a:rPr>
              <a:t>MST</a:t>
            </a:r>
            <a:endParaRPr lang="fi-FI" sz="2400" b="1" dirty="0">
              <a:solidFill>
                <a:srgbClr val="0000FF"/>
              </a:solidFill>
            </a:endParaRPr>
          </a:p>
        </p:txBody>
      </p:sp>
      <p:sp>
        <p:nvSpPr>
          <p:cNvPr id="72" name="Freeform 71"/>
          <p:cNvSpPr/>
          <p:nvPr/>
        </p:nvSpPr>
        <p:spPr>
          <a:xfrm>
            <a:off x="7667625" y="2495550"/>
            <a:ext cx="600075" cy="619125"/>
          </a:xfrm>
          <a:custGeom>
            <a:avLst/>
            <a:gdLst>
              <a:gd name="connsiteX0" fmla="*/ 0 w 1209675"/>
              <a:gd name="connsiteY0" fmla="*/ 1619250 h 1619250"/>
              <a:gd name="connsiteX1" fmla="*/ 600075 w 1209675"/>
              <a:gd name="connsiteY1" fmla="*/ 1000125 h 1619250"/>
              <a:gd name="connsiteX2" fmla="*/ 1209675 w 1209675"/>
              <a:gd name="connsiteY2" fmla="*/ 0 h 1619250"/>
              <a:gd name="connsiteX0" fmla="*/ 0 w 600075"/>
              <a:gd name="connsiteY0" fmla="*/ 619125 h 619125"/>
              <a:gd name="connsiteX1" fmla="*/ 600075 w 600075"/>
              <a:gd name="connsiteY1" fmla="*/ 0 h 6191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00075" h="619125">
                <a:moveTo>
                  <a:pt x="0" y="619125"/>
                </a:moveTo>
                <a:lnTo>
                  <a:pt x="600075" y="0"/>
                </a:lnTo>
              </a:path>
            </a:pathLst>
          </a:custGeom>
          <a:noFill/>
          <a:ln w="254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grpSp>
        <p:nvGrpSpPr>
          <p:cNvPr id="73" name="Group 72"/>
          <p:cNvGrpSpPr/>
          <p:nvPr/>
        </p:nvGrpSpPr>
        <p:grpSpPr>
          <a:xfrm>
            <a:off x="6696075" y="1838325"/>
            <a:ext cx="3089197" cy="2156468"/>
            <a:chOff x="1314450" y="1838325"/>
            <a:chExt cx="3089197" cy="2156468"/>
          </a:xfrm>
        </p:grpSpPr>
        <p:sp>
          <p:nvSpPr>
            <p:cNvPr id="74" name="Freeform 73"/>
            <p:cNvSpPr/>
            <p:nvPr/>
          </p:nvSpPr>
          <p:spPr>
            <a:xfrm>
              <a:off x="1314450" y="1838325"/>
              <a:ext cx="790575" cy="1209675"/>
            </a:xfrm>
            <a:custGeom>
              <a:avLst/>
              <a:gdLst>
                <a:gd name="connsiteX0" fmla="*/ 790575 w 790575"/>
                <a:gd name="connsiteY0" fmla="*/ 0 h 1209675"/>
                <a:gd name="connsiteX1" fmla="*/ 552450 w 790575"/>
                <a:gd name="connsiteY1" fmla="*/ 657225 h 1209675"/>
                <a:gd name="connsiteX2" fmla="*/ 0 w 790575"/>
                <a:gd name="connsiteY2" fmla="*/ 1209675 h 12096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90575" h="1209675">
                  <a:moveTo>
                    <a:pt x="790575" y="0"/>
                  </a:moveTo>
                  <a:lnTo>
                    <a:pt x="552450" y="657225"/>
                  </a:lnTo>
                  <a:lnTo>
                    <a:pt x="0" y="1209675"/>
                  </a:lnTo>
                </a:path>
              </a:pathLst>
            </a:custGeom>
            <a:noFill/>
            <a:ln w="254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grpSp>
          <p:nvGrpSpPr>
            <p:cNvPr id="75" name="Group 74"/>
            <p:cNvGrpSpPr/>
            <p:nvPr/>
          </p:nvGrpSpPr>
          <p:grpSpPr>
            <a:xfrm>
              <a:off x="1867961" y="1981636"/>
              <a:ext cx="2535686" cy="2013157"/>
              <a:chOff x="3981450" y="1447800"/>
              <a:chExt cx="3975100" cy="3155950"/>
            </a:xfrm>
          </p:grpSpPr>
          <p:sp>
            <p:nvSpPr>
              <p:cNvPr id="76" name="Freeform 75"/>
              <p:cNvSpPr/>
              <p:nvPr/>
            </p:nvSpPr>
            <p:spPr>
              <a:xfrm>
                <a:off x="5581649" y="2254252"/>
                <a:ext cx="2374901" cy="927100"/>
              </a:xfrm>
              <a:custGeom>
                <a:avLst/>
                <a:gdLst>
                  <a:gd name="connsiteX0" fmla="*/ 0 w 4857750"/>
                  <a:gd name="connsiteY0" fmla="*/ 1873250 h 1943100"/>
                  <a:gd name="connsiteX1" fmla="*/ 869950 w 4857750"/>
                  <a:gd name="connsiteY1" fmla="*/ 1022350 h 1943100"/>
                  <a:gd name="connsiteX2" fmla="*/ 1250950 w 4857750"/>
                  <a:gd name="connsiteY2" fmla="*/ 0 h 1943100"/>
                  <a:gd name="connsiteX3" fmla="*/ 2482850 w 4857750"/>
                  <a:gd name="connsiteY3" fmla="*/ 1016000 h 1943100"/>
                  <a:gd name="connsiteX4" fmla="*/ 3683000 w 4857750"/>
                  <a:gd name="connsiteY4" fmla="*/ 1435100 h 1943100"/>
                  <a:gd name="connsiteX5" fmla="*/ 4857750 w 4857750"/>
                  <a:gd name="connsiteY5" fmla="*/ 1943100 h 1943100"/>
                  <a:gd name="connsiteX0" fmla="*/ 0 w 4857750"/>
                  <a:gd name="connsiteY0" fmla="*/ 1873250 h 1943100"/>
                  <a:gd name="connsiteX1" fmla="*/ 1250950 w 4857750"/>
                  <a:gd name="connsiteY1" fmla="*/ 0 h 1943100"/>
                  <a:gd name="connsiteX2" fmla="*/ 2482850 w 4857750"/>
                  <a:gd name="connsiteY2" fmla="*/ 1016000 h 1943100"/>
                  <a:gd name="connsiteX3" fmla="*/ 3683000 w 4857750"/>
                  <a:gd name="connsiteY3" fmla="*/ 1435100 h 1943100"/>
                  <a:gd name="connsiteX4" fmla="*/ 4857750 w 4857750"/>
                  <a:gd name="connsiteY4" fmla="*/ 1943100 h 1943100"/>
                  <a:gd name="connsiteX0" fmla="*/ -1 w 3606799"/>
                  <a:gd name="connsiteY0" fmla="*/ 0 h 1943100"/>
                  <a:gd name="connsiteX1" fmla="*/ 1231899 w 3606799"/>
                  <a:gd name="connsiteY1" fmla="*/ 1016000 h 1943100"/>
                  <a:gd name="connsiteX2" fmla="*/ 2432049 w 3606799"/>
                  <a:gd name="connsiteY2" fmla="*/ 1435100 h 1943100"/>
                  <a:gd name="connsiteX3" fmla="*/ 3606799 w 3606799"/>
                  <a:gd name="connsiteY3" fmla="*/ 1943100 h 1943100"/>
                  <a:gd name="connsiteX0" fmla="*/ 0 w 2374900"/>
                  <a:gd name="connsiteY0" fmla="*/ 0 h 927100"/>
                  <a:gd name="connsiteX1" fmla="*/ 1200150 w 2374900"/>
                  <a:gd name="connsiteY1" fmla="*/ 419100 h 927100"/>
                  <a:gd name="connsiteX2" fmla="*/ 2374900 w 2374900"/>
                  <a:gd name="connsiteY2" fmla="*/ 927100 h 9271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374900" h="927100">
                    <a:moveTo>
                      <a:pt x="0" y="0"/>
                    </a:moveTo>
                    <a:lnTo>
                      <a:pt x="1200150" y="419100"/>
                    </a:lnTo>
                    <a:lnTo>
                      <a:pt x="2374900" y="92710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  <p:sp>
            <p:nvSpPr>
              <p:cNvPr id="77" name="Freeform 76"/>
              <p:cNvSpPr/>
              <p:nvPr/>
            </p:nvSpPr>
            <p:spPr>
              <a:xfrm>
                <a:off x="6794500" y="1447800"/>
                <a:ext cx="495300" cy="2724150"/>
              </a:xfrm>
              <a:custGeom>
                <a:avLst/>
                <a:gdLst>
                  <a:gd name="connsiteX0" fmla="*/ 495300 w 495300"/>
                  <a:gd name="connsiteY0" fmla="*/ 0 h 2724150"/>
                  <a:gd name="connsiteX1" fmla="*/ 0 w 495300"/>
                  <a:gd name="connsiteY1" fmla="*/ 1225550 h 2724150"/>
                  <a:gd name="connsiteX2" fmla="*/ 152400 w 495300"/>
                  <a:gd name="connsiteY2" fmla="*/ 2724150 h 27241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95300" h="2724150">
                    <a:moveTo>
                      <a:pt x="495300" y="0"/>
                    </a:moveTo>
                    <a:lnTo>
                      <a:pt x="0" y="1225550"/>
                    </a:lnTo>
                    <a:lnTo>
                      <a:pt x="152400" y="272415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  <p:sp>
            <p:nvSpPr>
              <p:cNvPr id="78" name="Freeform 77"/>
              <p:cNvSpPr/>
              <p:nvPr/>
            </p:nvSpPr>
            <p:spPr>
              <a:xfrm>
                <a:off x="3981450" y="2254250"/>
                <a:ext cx="660400" cy="2349500"/>
              </a:xfrm>
              <a:custGeom>
                <a:avLst/>
                <a:gdLst>
                  <a:gd name="connsiteX0" fmla="*/ 660400 w 660400"/>
                  <a:gd name="connsiteY0" fmla="*/ 2349500 h 2349500"/>
                  <a:gd name="connsiteX1" fmla="*/ 660400 w 660400"/>
                  <a:gd name="connsiteY1" fmla="*/ 971550 h 2349500"/>
                  <a:gd name="connsiteX2" fmla="*/ 0 w 660400"/>
                  <a:gd name="connsiteY2" fmla="*/ 0 h 2349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60400" h="2349500">
                    <a:moveTo>
                      <a:pt x="660400" y="2349500"/>
                    </a:moveTo>
                    <a:lnTo>
                      <a:pt x="660400" y="971550"/>
                    </a:lnTo>
                    <a:lnTo>
                      <a:pt x="0" y="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 sz="1200"/>
              </a:p>
            </p:txBody>
          </p:sp>
        </p:grpSp>
      </p:grpSp>
      <p:sp>
        <p:nvSpPr>
          <p:cNvPr id="79" name="Oval 78"/>
          <p:cNvSpPr/>
          <p:nvPr/>
        </p:nvSpPr>
        <p:spPr>
          <a:xfrm>
            <a:off x="6646044" y="2998340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0" name="Oval 79"/>
          <p:cNvSpPr/>
          <p:nvPr/>
        </p:nvSpPr>
        <p:spPr>
          <a:xfrm>
            <a:off x="7196928" y="2447456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1" name="Oval 80"/>
          <p:cNvSpPr/>
          <p:nvPr/>
        </p:nvSpPr>
        <p:spPr>
          <a:xfrm>
            <a:off x="7444016" y="1803408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2" name="Oval 81"/>
          <p:cNvSpPr/>
          <p:nvPr/>
        </p:nvSpPr>
        <p:spPr>
          <a:xfrm>
            <a:off x="8221734" y="2443405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3" name="Oval 82"/>
          <p:cNvSpPr/>
          <p:nvPr/>
        </p:nvSpPr>
        <p:spPr>
          <a:xfrm>
            <a:off x="8995402" y="2714797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4" name="Oval 83"/>
          <p:cNvSpPr/>
          <p:nvPr/>
        </p:nvSpPr>
        <p:spPr>
          <a:xfrm>
            <a:off x="9315401" y="1937078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5" name="Oval 84"/>
          <p:cNvSpPr/>
          <p:nvPr/>
        </p:nvSpPr>
        <p:spPr>
          <a:xfrm>
            <a:off x="9736665" y="3038846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6" name="Oval 85"/>
          <p:cNvSpPr/>
          <p:nvPr/>
        </p:nvSpPr>
        <p:spPr>
          <a:xfrm>
            <a:off x="9096668" y="3670742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7" name="Oval 86"/>
          <p:cNvSpPr/>
          <p:nvPr/>
        </p:nvSpPr>
        <p:spPr>
          <a:xfrm>
            <a:off x="7622243" y="3067201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8" name="Oval 87"/>
          <p:cNvSpPr/>
          <p:nvPr/>
        </p:nvSpPr>
        <p:spPr>
          <a:xfrm>
            <a:off x="7626293" y="3942134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89" name="Oval 88"/>
          <p:cNvSpPr/>
          <p:nvPr/>
        </p:nvSpPr>
        <p:spPr>
          <a:xfrm>
            <a:off x="8359455" y="4748207"/>
            <a:ext cx="93164" cy="9316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91" name="Freeform 90"/>
          <p:cNvSpPr/>
          <p:nvPr/>
        </p:nvSpPr>
        <p:spPr>
          <a:xfrm>
            <a:off x="7672201" y="3724825"/>
            <a:ext cx="1475137" cy="1077464"/>
          </a:xfrm>
          <a:custGeom>
            <a:avLst/>
            <a:gdLst>
              <a:gd name="connsiteX0" fmla="*/ 0 w 2305050"/>
              <a:gd name="connsiteY0" fmla="*/ 438150 h 1689100"/>
              <a:gd name="connsiteX1" fmla="*/ 1155700 w 2305050"/>
              <a:gd name="connsiteY1" fmla="*/ 1689100 h 1689100"/>
              <a:gd name="connsiteX2" fmla="*/ 2305050 w 2305050"/>
              <a:gd name="connsiteY2" fmla="*/ 0 h 1689100"/>
              <a:gd name="connsiteX3" fmla="*/ 2305050 w 2305050"/>
              <a:gd name="connsiteY3" fmla="*/ 0 h 1689100"/>
              <a:gd name="connsiteX0" fmla="*/ 0 w 2305050"/>
              <a:gd name="connsiteY0" fmla="*/ 415752 h 1689100"/>
              <a:gd name="connsiteX1" fmla="*/ 1155700 w 2305050"/>
              <a:gd name="connsiteY1" fmla="*/ 1689100 h 1689100"/>
              <a:gd name="connsiteX2" fmla="*/ 2305050 w 2305050"/>
              <a:gd name="connsiteY2" fmla="*/ 0 h 1689100"/>
              <a:gd name="connsiteX3" fmla="*/ 2305050 w 2305050"/>
              <a:gd name="connsiteY3" fmla="*/ 0 h 1689100"/>
              <a:gd name="connsiteX0" fmla="*/ 0 w 2312517"/>
              <a:gd name="connsiteY0" fmla="*/ 415752 h 1689100"/>
              <a:gd name="connsiteX1" fmla="*/ 1163167 w 2312517"/>
              <a:gd name="connsiteY1" fmla="*/ 1689100 h 1689100"/>
              <a:gd name="connsiteX2" fmla="*/ 2312517 w 2312517"/>
              <a:gd name="connsiteY2" fmla="*/ 0 h 1689100"/>
              <a:gd name="connsiteX3" fmla="*/ 2312517 w 2312517"/>
              <a:gd name="connsiteY3" fmla="*/ 0 h 168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312517" h="1689100">
                <a:moveTo>
                  <a:pt x="0" y="415752"/>
                </a:moveTo>
                <a:lnTo>
                  <a:pt x="1163167" y="1689100"/>
                </a:lnTo>
                <a:lnTo>
                  <a:pt x="2312517" y="0"/>
                </a:lnTo>
                <a:lnTo>
                  <a:pt x="2312517" y="0"/>
                </a:lnTo>
              </a:path>
            </a:pathLst>
          </a:custGeom>
          <a:noFill/>
          <a:ln w="254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sz="1200"/>
          </a:p>
        </p:txBody>
      </p:sp>
      <p:sp>
        <p:nvSpPr>
          <p:cNvPr id="92" name="TextBox 91"/>
          <p:cNvSpPr txBox="1"/>
          <p:nvPr/>
        </p:nvSpPr>
        <p:spPr>
          <a:xfrm>
            <a:off x="8020050" y="2914650"/>
            <a:ext cx="7491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0000FF"/>
                </a:solidFill>
              </a:rPr>
              <a:t>MST</a:t>
            </a:r>
            <a:endParaRPr lang="fi-FI" sz="2400" b="1" dirty="0">
              <a:solidFill>
                <a:srgbClr val="0000FF"/>
              </a:solidFill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7124904" y="965835"/>
            <a:ext cx="227793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Minimum 1-tree</a:t>
            </a:r>
          </a:p>
          <a:p>
            <a:pPr algn="ctr"/>
            <a:r>
              <a:rPr lang="en-US" dirty="0"/>
              <a:t>with a forced link</a:t>
            </a:r>
            <a:endParaRPr lang="fi-FI" dirty="0"/>
          </a:p>
        </p:txBody>
      </p:sp>
      <p:sp>
        <p:nvSpPr>
          <p:cNvPr id="98" name="TextBox 97"/>
          <p:cNvSpPr txBox="1"/>
          <p:nvPr/>
        </p:nvSpPr>
        <p:spPr>
          <a:xfrm>
            <a:off x="7034219" y="4221480"/>
            <a:ext cx="8209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Forced</a:t>
            </a:r>
          </a:p>
          <a:p>
            <a:pPr algn="ctr"/>
            <a:r>
              <a:rPr lang="en-US" b="1" dirty="0">
                <a:solidFill>
                  <a:srgbClr val="FF0000"/>
                </a:solidFill>
              </a:rPr>
              <a:t>Link</a:t>
            </a:r>
            <a:endParaRPr lang="fi-FI" b="1" dirty="0">
              <a:solidFill>
                <a:srgbClr val="FF0000"/>
              </a:solidFill>
            </a:endParaRPr>
          </a:p>
        </p:txBody>
      </p:sp>
      <p:sp>
        <p:nvSpPr>
          <p:cNvPr id="99" name="Right Arrow 98"/>
          <p:cNvSpPr/>
          <p:nvPr/>
        </p:nvSpPr>
        <p:spPr>
          <a:xfrm rot="19899955">
            <a:off x="7767320" y="4472941"/>
            <a:ext cx="205740" cy="160020"/>
          </a:xfrm>
          <a:prstGeom prst="rightArrow">
            <a:avLst>
              <a:gd name="adj1" fmla="val 50000"/>
              <a:gd name="adj2" fmla="val 63889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0" name="TextBox 99"/>
          <p:cNvSpPr txBox="1"/>
          <p:nvPr/>
        </p:nvSpPr>
        <p:spPr>
          <a:xfrm>
            <a:off x="2476500" y="429006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ost = 42</a:t>
            </a:r>
            <a:endParaRPr lang="fi-FI" sz="2400" dirty="0"/>
          </a:p>
        </p:txBody>
      </p:sp>
      <p:sp>
        <p:nvSpPr>
          <p:cNvPr id="101" name="TextBox 100"/>
          <p:cNvSpPr txBox="1"/>
          <p:nvPr/>
        </p:nvSpPr>
        <p:spPr>
          <a:xfrm>
            <a:off x="8905875" y="4032885"/>
            <a:ext cx="303640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ost = 45</a:t>
            </a:r>
          </a:p>
          <a:p>
            <a:r>
              <a:rPr lang="en-US" sz="2400" dirty="0">
                <a:cs typeface="Arial" panose="020B0604020202020204" pitchFamily="34" charset="0"/>
              </a:rPr>
              <a:t>α-nearness = 45-42 = 3</a:t>
            </a:r>
            <a:endParaRPr lang="fi-FI" sz="2400" dirty="0"/>
          </a:p>
        </p:txBody>
      </p:sp>
    </p:spTree>
    <p:extLst>
      <p:ext uri="{BB962C8B-B14F-4D97-AF65-F5344CB8AC3E}">
        <p14:creationId xmlns:p14="http://schemas.microsoft.com/office/powerpoint/2010/main" val="38419622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0616" y="1254322"/>
            <a:ext cx="2658204" cy="470852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84515" y="1516545"/>
            <a:ext cx="6464300" cy="41730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1. Choose a random node i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2. While nodes are remaining,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622300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	Choose an unvisited node j, as follow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270510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		If possible, choose j such that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630555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		  (a) (i,j) is a candidate link,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630555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	    (b) alpha-nearness(i,j) = 0, and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270510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		Otherwise, if possible, choose j such    		that (i,j) is a candidate link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270510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 		Otherwise, choose j among those nodes 		not already chosen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270510" algn="l"/>
              </a:tabLst>
            </a:pPr>
            <a:r>
              <a:rPr lang="en-US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	i &lt;- j</a:t>
            </a:r>
          </a:p>
        </p:txBody>
      </p:sp>
      <p:sp>
        <p:nvSpPr>
          <p:cNvPr id="6" name="Rectangle 5"/>
          <p:cNvSpPr/>
          <p:nvPr/>
        </p:nvSpPr>
        <p:spPr>
          <a:xfrm>
            <a:off x="1314352" y="927100"/>
            <a:ext cx="272356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Greedy Pseudocode</a:t>
            </a:r>
          </a:p>
        </p:txBody>
      </p:sp>
      <p:sp>
        <p:nvSpPr>
          <p:cNvPr id="7" name="Rectangle 6"/>
          <p:cNvSpPr/>
          <p:nvPr/>
        </p:nvSpPr>
        <p:spPr>
          <a:xfrm>
            <a:off x="8870852" y="736600"/>
            <a:ext cx="135896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Outcome</a:t>
            </a:r>
          </a:p>
        </p:txBody>
      </p:sp>
      <p:sp>
        <p:nvSpPr>
          <p:cNvPr id="8" name="Rectangle 7"/>
          <p:cNvSpPr/>
          <p:nvPr/>
        </p:nvSpPr>
        <p:spPr>
          <a:xfrm>
            <a:off x="8909250" y="1072634"/>
            <a:ext cx="12859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/>
              <a:t>129,775 km</a:t>
            </a:r>
          </a:p>
        </p:txBody>
      </p:sp>
    </p:spTree>
    <p:extLst>
      <p:ext uri="{BB962C8B-B14F-4D97-AF65-F5344CB8AC3E}">
        <p14:creationId xmlns:p14="http://schemas.microsoft.com/office/powerpoint/2010/main" val="7387479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8381" y="-256761"/>
            <a:ext cx="4423664" cy="7837200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-537702" y="-241300"/>
            <a:ext cx="7661685" cy="7836444"/>
            <a:chOff x="9031748" y="-431800"/>
            <a:chExt cx="7661685" cy="783644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31748" y="-431800"/>
              <a:ext cx="4423237" cy="7836444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9525000" y="-104778"/>
              <a:ext cx="3441700" cy="7218798"/>
              <a:chOff x="9525000" y="-104778"/>
              <a:chExt cx="3441700" cy="7218798"/>
            </a:xfrm>
            <a:effectLst>
              <a:glow rad="63500">
                <a:schemeClr val="bg1">
                  <a:alpha val="50000"/>
                </a:schemeClr>
              </a:glow>
            </a:effectLst>
          </p:grpSpPr>
          <p:grpSp>
            <p:nvGrpSpPr>
              <p:cNvPr id="36" name="Group 35"/>
              <p:cNvGrpSpPr/>
              <p:nvPr/>
            </p:nvGrpSpPr>
            <p:grpSpPr>
              <a:xfrm>
                <a:off x="9525000" y="820680"/>
                <a:ext cx="3441700" cy="5335822"/>
                <a:chOff x="9293233" y="820680"/>
                <a:chExt cx="4032185" cy="5335822"/>
              </a:xfrm>
            </p:grpSpPr>
            <p:sp>
              <p:nvSpPr>
                <p:cNvPr id="42" name="Freeform 41"/>
                <p:cNvSpPr/>
                <p:nvPr/>
              </p:nvSpPr>
              <p:spPr>
                <a:xfrm>
                  <a:off x="9293233" y="820680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3" name="Freeform 42"/>
                <p:cNvSpPr/>
                <p:nvPr/>
              </p:nvSpPr>
              <p:spPr>
                <a:xfrm>
                  <a:off x="10431470" y="1709983"/>
                  <a:ext cx="2893948" cy="101061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4" name="Freeform 43"/>
                <p:cNvSpPr/>
                <p:nvPr/>
              </p:nvSpPr>
              <p:spPr>
                <a:xfrm flipV="1">
                  <a:off x="10431470" y="2553568"/>
                  <a:ext cx="2893948" cy="45719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5" name="Freeform 44"/>
                <p:cNvSpPr/>
                <p:nvPr/>
              </p:nvSpPr>
              <p:spPr>
                <a:xfrm flipV="1">
                  <a:off x="10431470" y="3442872"/>
                  <a:ext cx="2893948" cy="45719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6" name="Freeform 45"/>
                <p:cNvSpPr/>
                <p:nvPr/>
              </p:nvSpPr>
              <p:spPr>
                <a:xfrm>
                  <a:off x="9293233" y="4377894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7" name="Freeform 46"/>
                <p:cNvSpPr/>
                <p:nvPr/>
              </p:nvSpPr>
              <p:spPr>
                <a:xfrm>
                  <a:off x="9293233" y="5267198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48" name="Freeform 47"/>
                <p:cNvSpPr/>
                <p:nvPr/>
              </p:nvSpPr>
              <p:spPr>
                <a:xfrm>
                  <a:off x="9293233" y="6156502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</p:grpSp>
          <p:sp>
            <p:nvSpPr>
              <p:cNvPr id="37" name="Freeform 36"/>
              <p:cNvSpPr/>
              <p:nvPr/>
            </p:nvSpPr>
            <p:spPr>
              <a:xfrm rot="5400000" flipV="1">
                <a:off x="8590381" y="5527446"/>
                <a:ext cx="3065800" cy="107347"/>
              </a:xfrm>
              <a:custGeom>
                <a:avLst/>
                <a:gdLst>
                  <a:gd name="connsiteX0" fmla="*/ 0 w 3078866"/>
                  <a:gd name="connsiteY0" fmla="*/ 0 h 0"/>
                  <a:gd name="connsiteX1" fmla="*/ 3078866 w 3078866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78866">
                    <a:moveTo>
                      <a:pt x="0" y="0"/>
                    </a:moveTo>
                    <a:lnTo>
                      <a:pt x="3078866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38" name="Freeform 37"/>
              <p:cNvSpPr/>
              <p:nvPr/>
            </p:nvSpPr>
            <p:spPr>
              <a:xfrm rot="5400000" flipV="1">
                <a:off x="7273731" y="3475075"/>
                <a:ext cx="7218014" cy="59875"/>
              </a:xfrm>
              <a:custGeom>
                <a:avLst/>
                <a:gdLst>
                  <a:gd name="connsiteX0" fmla="*/ 0 w 3078866"/>
                  <a:gd name="connsiteY0" fmla="*/ 0 h 0"/>
                  <a:gd name="connsiteX1" fmla="*/ 3078866 w 3078866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78866">
                    <a:moveTo>
                      <a:pt x="0" y="0"/>
                    </a:moveTo>
                    <a:lnTo>
                      <a:pt x="3078866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39" name="Freeform 38"/>
              <p:cNvSpPr/>
              <p:nvPr/>
            </p:nvSpPr>
            <p:spPr>
              <a:xfrm rot="5400000" flipV="1">
                <a:off x="8056924" y="3475075"/>
                <a:ext cx="7218014" cy="59875"/>
              </a:xfrm>
              <a:custGeom>
                <a:avLst/>
                <a:gdLst>
                  <a:gd name="connsiteX0" fmla="*/ 0 w 3078866"/>
                  <a:gd name="connsiteY0" fmla="*/ 0 h 0"/>
                  <a:gd name="connsiteX1" fmla="*/ 3078866 w 3078866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78866">
                    <a:moveTo>
                      <a:pt x="0" y="0"/>
                    </a:moveTo>
                    <a:lnTo>
                      <a:pt x="3078866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40" name="Freeform 39"/>
              <p:cNvSpPr/>
              <p:nvPr/>
            </p:nvSpPr>
            <p:spPr>
              <a:xfrm rot="5400000" flipV="1">
                <a:off x="8840118" y="3475075"/>
                <a:ext cx="7218014" cy="59875"/>
              </a:xfrm>
              <a:custGeom>
                <a:avLst/>
                <a:gdLst>
                  <a:gd name="connsiteX0" fmla="*/ 0 w 3078866"/>
                  <a:gd name="connsiteY0" fmla="*/ 0 h 0"/>
                  <a:gd name="connsiteX1" fmla="*/ 3078866 w 3078866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78866">
                    <a:moveTo>
                      <a:pt x="0" y="0"/>
                    </a:moveTo>
                    <a:lnTo>
                      <a:pt x="3078866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41" name="Freeform 40"/>
              <p:cNvSpPr/>
              <p:nvPr/>
            </p:nvSpPr>
            <p:spPr>
              <a:xfrm rot="5400000" flipV="1">
                <a:off x="9560424" y="404404"/>
                <a:ext cx="1285509" cy="267145"/>
              </a:xfrm>
              <a:custGeom>
                <a:avLst/>
                <a:gdLst>
                  <a:gd name="connsiteX0" fmla="*/ 0 w 3078866"/>
                  <a:gd name="connsiteY0" fmla="*/ 0 h 0"/>
                  <a:gd name="connsiteX1" fmla="*/ 3078866 w 3078866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78866">
                    <a:moveTo>
                      <a:pt x="0" y="0"/>
                    </a:moveTo>
                    <a:lnTo>
                      <a:pt x="3078866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2433290" y="4019550"/>
              <a:ext cx="4121161" cy="3000375"/>
              <a:chOff x="3746490" y="4019550"/>
              <a:chExt cx="4121161" cy="3000375"/>
            </a:xfrm>
          </p:grpSpPr>
          <p:sp>
            <p:nvSpPr>
              <p:cNvPr id="34" name="Freeform 33"/>
              <p:cNvSpPr/>
              <p:nvPr/>
            </p:nvSpPr>
            <p:spPr>
              <a:xfrm>
                <a:off x="3943351" y="4019550"/>
                <a:ext cx="3924300" cy="3000375"/>
              </a:xfrm>
              <a:custGeom>
                <a:avLst/>
                <a:gdLst>
                  <a:gd name="connsiteX0" fmla="*/ 0 w 4886325"/>
                  <a:gd name="connsiteY0" fmla="*/ 962025 h 3000375"/>
                  <a:gd name="connsiteX1" fmla="*/ 1571625 w 4886325"/>
                  <a:gd name="connsiteY1" fmla="*/ 0 h 3000375"/>
                  <a:gd name="connsiteX2" fmla="*/ 4886325 w 4886325"/>
                  <a:gd name="connsiteY2" fmla="*/ 0 h 3000375"/>
                  <a:gd name="connsiteX3" fmla="*/ 4886325 w 4886325"/>
                  <a:gd name="connsiteY3" fmla="*/ 3000375 h 3000375"/>
                  <a:gd name="connsiteX4" fmla="*/ 4886325 w 4886325"/>
                  <a:gd name="connsiteY4" fmla="*/ 3000375 h 3000375"/>
                  <a:gd name="connsiteX5" fmla="*/ 1571625 w 4886325"/>
                  <a:gd name="connsiteY5" fmla="*/ 3000375 h 3000375"/>
                  <a:gd name="connsiteX6" fmla="*/ 9525 w 4886325"/>
                  <a:gd name="connsiteY6" fmla="*/ 1133475 h 3000375"/>
                  <a:gd name="connsiteX7" fmla="*/ 0 w 4886325"/>
                  <a:gd name="connsiteY7" fmla="*/ 962025 h 3000375"/>
                  <a:gd name="connsiteX0" fmla="*/ 0 w 4886325"/>
                  <a:gd name="connsiteY0" fmla="*/ 962025 h 3000375"/>
                  <a:gd name="connsiteX1" fmla="*/ 1571625 w 4886325"/>
                  <a:gd name="connsiteY1" fmla="*/ 0 h 3000375"/>
                  <a:gd name="connsiteX2" fmla="*/ 4886325 w 4886325"/>
                  <a:gd name="connsiteY2" fmla="*/ 0 h 3000375"/>
                  <a:gd name="connsiteX3" fmla="*/ 4886325 w 4886325"/>
                  <a:gd name="connsiteY3" fmla="*/ 3000375 h 3000375"/>
                  <a:gd name="connsiteX4" fmla="*/ 4886325 w 4886325"/>
                  <a:gd name="connsiteY4" fmla="*/ 3000375 h 3000375"/>
                  <a:gd name="connsiteX5" fmla="*/ 1571625 w 4886325"/>
                  <a:gd name="connsiteY5" fmla="*/ 3000375 h 3000375"/>
                  <a:gd name="connsiteX6" fmla="*/ 233363 w 4886325"/>
                  <a:gd name="connsiteY6" fmla="*/ 1152525 h 3000375"/>
                  <a:gd name="connsiteX7" fmla="*/ 0 w 4886325"/>
                  <a:gd name="connsiteY7" fmla="*/ 962025 h 3000375"/>
                  <a:gd name="connsiteX0" fmla="*/ 4762 w 4652962"/>
                  <a:gd name="connsiteY0" fmla="*/ 928688 h 3000375"/>
                  <a:gd name="connsiteX1" fmla="*/ 1338262 w 4652962"/>
                  <a:gd name="connsiteY1" fmla="*/ 0 h 3000375"/>
                  <a:gd name="connsiteX2" fmla="*/ 4652962 w 4652962"/>
                  <a:gd name="connsiteY2" fmla="*/ 0 h 3000375"/>
                  <a:gd name="connsiteX3" fmla="*/ 4652962 w 4652962"/>
                  <a:gd name="connsiteY3" fmla="*/ 3000375 h 3000375"/>
                  <a:gd name="connsiteX4" fmla="*/ 4652962 w 4652962"/>
                  <a:gd name="connsiteY4" fmla="*/ 3000375 h 3000375"/>
                  <a:gd name="connsiteX5" fmla="*/ 1338262 w 4652962"/>
                  <a:gd name="connsiteY5" fmla="*/ 3000375 h 3000375"/>
                  <a:gd name="connsiteX6" fmla="*/ 0 w 4652962"/>
                  <a:gd name="connsiteY6" fmla="*/ 1152525 h 3000375"/>
                  <a:gd name="connsiteX7" fmla="*/ 4762 w 4652962"/>
                  <a:gd name="connsiteY7" fmla="*/ 928688 h 3000375"/>
                  <a:gd name="connsiteX0" fmla="*/ 728662 w 4652962"/>
                  <a:gd name="connsiteY0" fmla="*/ 919163 h 3000375"/>
                  <a:gd name="connsiteX1" fmla="*/ 1338262 w 4652962"/>
                  <a:gd name="connsiteY1" fmla="*/ 0 h 3000375"/>
                  <a:gd name="connsiteX2" fmla="*/ 4652962 w 4652962"/>
                  <a:gd name="connsiteY2" fmla="*/ 0 h 3000375"/>
                  <a:gd name="connsiteX3" fmla="*/ 4652962 w 4652962"/>
                  <a:gd name="connsiteY3" fmla="*/ 3000375 h 3000375"/>
                  <a:gd name="connsiteX4" fmla="*/ 4652962 w 4652962"/>
                  <a:gd name="connsiteY4" fmla="*/ 3000375 h 3000375"/>
                  <a:gd name="connsiteX5" fmla="*/ 1338262 w 4652962"/>
                  <a:gd name="connsiteY5" fmla="*/ 3000375 h 3000375"/>
                  <a:gd name="connsiteX6" fmla="*/ 0 w 4652962"/>
                  <a:gd name="connsiteY6" fmla="*/ 1152525 h 3000375"/>
                  <a:gd name="connsiteX7" fmla="*/ 728662 w 4652962"/>
                  <a:gd name="connsiteY7" fmla="*/ 919163 h 3000375"/>
                  <a:gd name="connsiteX0" fmla="*/ 0 w 3924300"/>
                  <a:gd name="connsiteY0" fmla="*/ 919163 h 3000375"/>
                  <a:gd name="connsiteX1" fmla="*/ 609600 w 3924300"/>
                  <a:gd name="connsiteY1" fmla="*/ 0 h 3000375"/>
                  <a:gd name="connsiteX2" fmla="*/ 3924300 w 3924300"/>
                  <a:gd name="connsiteY2" fmla="*/ 0 h 3000375"/>
                  <a:gd name="connsiteX3" fmla="*/ 3924300 w 3924300"/>
                  <a:gd name="connsiteY3" fmla="*/ 3000375 h 3000375"/>
                  <a:gd name="connsiteX4" fmla="*/ 3924300 w 3924300"/>
                  <a:gd name="connsiteY4" fmla="*/ 3000375 h 3000375"/>
                  <a:gd name="connsiteX5" fmla="*/ 609600 w 3924300"/>
                  <a:gd name="connsiteY5" fmla="*/ 3000375 h 3000375"/>
                  <a:gd name="connsiteX6" fmla="*/ 4763 w 3924300"/>
                  <a:gd name="connsiteY6" fmla="*/ 1119187 h 3000375"/>
                  <a:gd name="connsiteX7" fmla="*/ 0 w 3924300"/>
                  <a:gd name="connsiteY7" fmla="*/ 919163 h 30003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3924300" h="3000375">
                    <a:moveTo>
                      <a:pt x="0" y="919163"/>
                    </a:moveTo>
                    <a:lnTo>
                      <a:pt x="609600" y="0"/>
                    </a:lnTo>
                    <a:lnTo>
                      <a:pt x="3924300" y="0"/>
                    </a:lnTo>
                    <a:lnTo>
                      <a:pt x="3924300" y="3000375"/>
                    </a:lnTo>
                    <a:lnTo>
                      <a:pt x="3924300" y="3000375"/>
                    </a:lnTo>
                    <a:lnTo>
                      <a:pt x="609600" y="3000375"/>
                    </a:lnTo>
                    <a:lnTo>
                      <a:pt x="4763" y="1119187"/>
                    </a:lnTo>
                    <a:lnTo>
                      <a:pt x="0" y="919163"/>
                    </a:lnTo>
                    <a:close/>
                  </a:path>
                </a:pathLst>
              </a:custGeom>
              <a:gradFill flip="none" rotWithShape="1">
                <a:gsLst>
                  <a:gs pos="100000">
                    <a:schemeClr val="accent2">
                      <a:lumMod val="60000"/>
                      <a:lumOff val="40000"/>
                      <a:alpha val="0"/>
                    </a:schemeClr>
                  </a:gs>
                  <a:gs pos="71000">
                    <a:schemeClr val="accent2">
                      <a:lumMod val="60000"/>
                      <a:lumOff val="40000"/>
                      <a:alpha val="40000"/>
                    </a:schemeClr>
                  </a:gs>
                </a:gsLst>
                <a:lin ang="108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3746490" y="4967287"/>
                <a:ext cx="201184" cy="163462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  <a:alpha val="40000"/>
                </a:schemeClr>
              </a:solidFill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</p:grp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89833" y="3904110"/>
              <a:ext cx="3603600" cy="32400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13408269" y="465992"/>
              <a:ext cx="2963008" cy="5560631"/>
              <a:chOff x="4721469" y="465992"/>
              <a:chExt cx="2963008" cy="5560631"/>
            </a:xfrm>
          </p:grpSpPr>
          <p:sp>
            <p:nvSpPr>
              <p:cNvPr id="32" name="Freeform 31"/>
              <p:cNvSpPr/>
              <p:nvPr/>
            </p:nvSpPr>
            <p:spPr>
              <a:xfrm>
                <a:off x="4721469" y="465992"/>
                <a:ext cx="2963008" cy="4564702"/>
              </a:xfrm>
              <a:custGeom>
                <a:avLst/>
                <a:gdLst>
                  <a:gd name="connsiteX0" fmla="*/ 791308 w 2963008"/>
                  <a:gd name="connsiteY0" fmla="*/ 5574323 h 5574323"/>
                  <a:gd name="connsiteX1" fmla="*/ 0 w 2963008"/>
                  <a:gd name="connsiteY1" fmla="*/ 2954216 h 5574323"/>
                  <a:gd name="connsiteX2" fmla="*/ 0 w 2963008"/>
                  <a:gd name="connsiteY2" fmla="*/ 0 h 5574323"/>
                  <a:gd name="connsiteX3" fmla="*/ 2963008 w 2963008"/>
                  <a:gd name="connsiteY3" fmla="*/ 0 h 5574323"/>
                  <a:gd name="connsiteX4" fmla="*/ 2963008 w 2963008"/>
                  <a:gd name="connsiteY4" fmla="*/ 2963008 h 5574323"/>
                  <a:gd name="connsiteX5" fmla="*/ 1811216 w 2963008"/>
                  <a:gd name="connsiteY5" fmla="*/ 5556739 h 5574323"/>
                  <a:gd name="connsiteX6" fmla="*/ 791308 w 2963008"/>
                  <a:gd name="connsiteY6" fmla="*/ 5574323 h 5574323"/>
                  <a:gd name="connsiteX0" fmla="*/ 791308 w 2963008"/>
                  <a:gd name="connsiteY0" fmla="*/ 5574323 h 5574323"/>
                  <a:gd name="connsiteX1" fmla="*/ 474419 w 2963008"/>
                  <a:gd name="connsiteY1" fmla="*/ 4548921 h 5574323"/>
                  <a:gd name="connsiteX2" fmla="*/ 0 w 2963008"/>
                  <a:gd name="connsiteY2" fmla="*/ 2954216 h 5574323"/>
                  <a:gd name="connsiteX3" fmla="*/ 0 w 2963008"/>
                  <a:gd name="connsiteY3" fmla="*/ 0 h 5574323"/>
                  <a:gd name="connsiteX4" fmla="*/ 2963008 w 2963008"/>
                  <a:gd name="connsiteY4" fmla="*/ 0 h 5574323"/>
                  <a:gd name="connsiteX5" fmla="*/ 2963008 w 2963008"/>
                  <a:gd name="connsiteY5" fmla="*/ 2963008 h 5574323"/>
                  <a:gd name="connsiteX6" fmla="*/ 1811216 w 2963008"/>
                  <a:gd name="connsiteY6" fmla="*/ 5556739 h 5574323"/>
                  <a:gd name="connsiteX7" fmla="*/ 791308 w 2963008"/>
                  <a:gd name="connsiteY7" fmla="*/ 5574323 h 5574323"/>
                  <a:gd name="connsiteX0" fmla="*/ 791308 w 2963008"/>
                  <a:gd name="connsiteY0" fmla="*/ 5574323 h 5574323"/>
                  <a:gd name="connsiteX1" fmla="*/ 788744 w 2963008"/>
                  <a:gd name="connsiteY1" fmla="*/ 4563208 h 5574323"/>
                  <a:gd name="connsiteX2" fmla="*/ 0 w 2963008"/>
                  <a:gd name="connsiteY2" fmla="*/ 2954216 h 5574323"/>
                  <a:gd name="connsiteX3" fmla="*/ 0 w 2963008"/>
                  <a:gd name="connsiteY3" fmla="*/ 0 h 5574323"/>
                  <a:gd name="connsiteX4" fmla="*/ 2963008 w 2963008"/>
                  <a:gd name="connsiteY4" fmla="*/ 0 h 5574323"/>
                  <a:gd name="connsiteX5" fmla="*/ 2963008 w 2963008"/>
                  <a:gd name="connsiteY5" fmla="*/ 2963008 h 5574323"/>
                  <a:gd name="connsiteX6" fmla="*/ 1811216 w 2963008"/>
                  <a:gd name="connsiteY6" fmla="*/ 5556739 h 5574323"/>
                  <a:gd name="connsiteX7" fmla="*/ 791308 w 2963008"/>
                  <a:gd name="connsiteY7" fmla="*/ 5574323 h 5574323"/>
                  <a:gd name="connsiteX0" fmla="*/ 791308 w 2963008"/>
                  <a:gd name="connsiteY0" fmla="*/ 5574323 h 5574323"/>
                  <a:gd name="connsiteX1" fmla="*/ 788744 w 2963008"/>
                  <a:gd name="connsiteY1" fmla="*/ 4563208 h 5574323"/>
                  <a:gd name="connsiteX2" fmla="*/ 0 w 2963008"/>
                  <a:gd name="connsiteY2" fmla="*/ 2954216 h 5574323"/>
                  <a:gd name="connsiteX3" fmla="*/ 0 w 2963008"/>
                  <a:gd name="connsiteY3" fmla="*/ 0 h 5574323"/>
                  <a:gd name="connsiteX4" fmla="*/ 2963008 w 2963008"/>
                  <a:gd name="connsiteY4" fmla="*/ 0 h 5574323"/>
                  <a:gd name="connsiteX5" fmla="*/ 2963008 w 2963008"/>
                  <a:gd name="connsiteY5" fmla="*/ 2963008 h 5574323"/>
                  <a:gd name="connsiteX6" fmla="*/ 2250831 w 2963008"/>
                  <a:gd name="connsiteY6" fmla="*/ 4544158 h 5574323"/>
                  <a:gd name="connsiteX7" fmla="*/ 1811216 w 2963008"/>
                  <a:gd name="connsiteY7" fmla="*/ 5556739 h 5574323"/>
                  <a:gd name="connsiteX8" fmla="*/ 791308 w 2963008"/>
                  <a:gd name="connsiteY8" fmla="*/ 5574323 h 5574323"/>
                  <a:gd name="connsiteX0" fmla="*/ 791308 w 2963008"/>
                  <a:gd name="connsiteY0" fmla="*/ 5574323 h 5574323"/>
                  <a:gd name="connsiteX1" fmla="*/ 788744 w 2963008"/>
                  <a:gd name="connsiteY1" fmla="*/ 4563208 h 5574323"/>
                  <a:gd name="connsiteX2" fmla="*/ 0 w 2963008"/>
                  <a:gd name="connsiteY2" fmla="*/ 2954216 h 5574323"/>
                  <a:gd name="connsiteX3" fmla="*/ 0 w 2963008"/>
                  <a:gd name="connsiteY3" fmla="*/ 0 h 5574323"/>
                  <a:gd name="connsiteX4" fmla="*/ 2963008 w 2963008"/>
                  <a:gd name="connsiteY4" fmla="*/ 0 h 5574323"/>
                  <a:gd name="connsiteX5" fmla="*/ 2963008 w 2963008"/>
                  <a:gd name="connsiteY5" fmla="*/ 2963008 h 5574323"/>
                  <a:gd name="connsiteX6" fmla="*/ 1812681 w 2963008"/>
                  <a:gd name="connsiteY6" fmla="*/ 4558446 h 5574323"/>
                  <a:gd name="connsiteX7" fmla="*/ 1811216 w 2963008"/>
                  <a:gd name="connsiteY7" fmla="*/ 5556739 h 5574323"/>
                  <a:gd name="connsiteX8" fmla="*/ 791308 w 2963008"/>
                  <a:gd name="connsiteY8" fmla="*/ 5574323 h 5574323"/>
                  <a:gd name="connsiteX0" fmla="*/ 1811216 w 2963008"/>
                  <a:gd name="connsiteY0" fmla="*/ 5556739 h 5556739"/>
                  <a:gd name="connsiteX1" fmla="*/ 788744 w 2963008"/>
                  <a:gd name="connsiteY1" fmla="*/ 4563208 h 5556739"/>
                  <a:gd name="connsiteX2" fmla="*/ 0 w 2963008"/>
                  <a:gd name="connsiteY2" fmla="*/ 2954216 h 5556739"/>
                  <a:gd name="connsiteX3" fmla="*/ 0 w 2963008"/>
                  <a:gd name="connsiteY3" fmla="*/ 0 h 5556739"/>
                  <a:gd name="connsiteX4" fmla="*/ 2963008 w 2963008"/>
                  <a:gd name="connsiteY4" fmla="*/ 0 h 5556739"/>
                  <a:gd name="connsiteX5" fmla="*/ 2963008 w 2963008"/>
                  <a:gd name="connsiteY5" fmla="*/ 2963008 h 5556739"/>
                  <a:gd name="connsiteX6" fmla="*/ 1812681 w 2963008"/>
                  <a:gd name="connsiteY6" fmla="*/ 4558446 h 5556739"/>
                  <a:gd name="connsiteX7" fmla="*/ 1811216 w 2963008"/>
                  <a:gd name="connsiteY7" fmla="*/ 5556739 h 5556739"/>
                  <a:gd name="connsiteX0" fmla="*/ 1812681 w 2963008"/>
                  <a:gd name="connsiteY0" fmla="*/ 4558446 h 4761122"/>
                  <a:gd name="connsiteX1" fmla="*/ 788744 w 2963008"/>
                  <a:gd name="connsiteY1" fmla="*/ 4563208 h 4761122"/>
                  <a:gd name="connsiteX2" fmla="*/ 0 w 2963008"/>
                  <a:gd name="connsiteY2" fmla="*/ 2954216 h 4761122"/>
                  <a:gd name="connsiteX3" fmla="*/ 0 w 2963008"/>
                  <a:gd name="connsiteY3" fmla="*/ 0 h 4761122"/>
                  <a:gd name="connsiteX4" fmla="*/ 2963008 w 2963008"/>
                  <a:gd name="connsiteY4" fmla="*/ 0 h 4761122"/>
                  <a:gd name="connsiteX5" fmla="*/ 2963008 w 2963008"/>
                  <a:gd name="connsiteY5" fmla="*/ 2963008 h 4761122"/>
                  <a:gd name="connsiteX6" fmla="*/ 1812681 w 2963008"/>
                  <a:gd name="connsiteY6" fmla="*/ 4558446 h 4761122"/>
                  <a:gd name="connsiteX0" fmla="*/ 1812681 w 2963008"/>
                  <a:gd name="connsiteY0" fmla="*/ 4558446 h 4678462"/>
                  <a:gd name="connsiteX1" fmla="*/ 788744 w 2963008"/>
                  <a:gd name="connsiteY1" fmla="*/ 4563208 h 4678462"/>
                  <a:gd name="connsiteX2" fmla="*/ 0 w 2963008"/>
                  <a:gd name="connsiteY2" fmla="*/ 2954216 h 4678462"/>
                  <a:gd name="connsiteX3" fmla="*/ 0 w 2963008"/>
                  <a:gd name="connsiteY3" fmla="*/ 0 h 4678462"/>
                  <a:gd name="connsiteX4" fmla="*/ 2963008 w 2963008"/>
                  <a:gd name="connsiteY4" fmla="*/ 0 h 4678462"/>
                  <a:gd name="connsiteX5" fmla="*/ 2963008 w 2963008"/>
                  <a:gd name="connsiteY5" fmla="*/ 2963008 h 4678462"/>
                  <a:gd name="connsiteX6" fmla="*/ 1812681 w 2963008"/>
                  <a:gd name="connsiteY6" fmla="*/ 4558446 h 4678462"/>
                  <a:gd name="connsiteX0" fmla="*/ 1812681 w 2963008"/>
                  <a:gd name="connsiteY0" fmla="*/ 4558446 h 4564702"/>
                  <a:gd name="connsiteX1" fmla="*/ 788744 w 2963008"/>
                  <a:gd name="connsiteY1" fmla="*/ 4563208 h 4564702"/>
                  <a:gd name="connsiteX2" fmla="*/ 0 w 2963008"/>
                  <a:gd name="connsiteY2" fmla="*/ 2954216 h 4564702"/>
                  <a:gd name="connsiteX3" fmla="*/ 0 w 2963008"/>
                  <a:gd name="connsiteY3" fmla="*/ 0 h 4564702"/>
                  <a:gd name="connsiteX4" fmla="*/ 2963008 w 2963008"/>
                  <a:gd name="connsiteY4" fmla="*/ 0 h 4564702"/>
                  <a:gd name="connsiteX5" fmla="*/ 2963008 w 2963008"/>
                  <a:gd name="connsiteY5" fmla="*/ 2963008 h 4564702"/>
                  <a:gd name="connsiteX6" fmla="*/ 1812681 w 2963008"/>
                  <a:gd name="connsiteY6" fmla="*/ 4558446 h 456470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963008" h="4564702">
                    <a:moveTo>
                      <a:pt x="1812681" y="4558446"/>
                    </a:moveTo>
                    <a:cubicBezTo>
                      <a:pt x="1530203" y="4567694"/>
                      <a:pt x="1552496" y="4564250"/>
                      <a:pt x="788744" y="4563208"/>
                    </a:cubicBezTo>
                    <a:lnTo>
                      <a:pt x="0" y="2954216"/>
                    </a:lnTo>
                    <a:lnTo>
                      <a:pt x="0" y="0"/>
                    </a:lnTo>
                    <a:lnTo>
                      <a:pt x="2963008" y="0"/>
                    </a:lnTo>
                    <a:lnTo>
                      <a:pt x="2963008" y="2963008"/>
                    </a:lnTo>
                    <a:lnTo>
                      <a:pt x="1812681" y="4558446"/>
                    </a:lnTo>
                    <a:close/>
                  </a:path>
                </a:pathLst>
              </a:custGeom>
              <a:gradFill>
                <a:gsLst>
                  <a:gs pos="64000">
                    <a:schemeClr val="accent1">
                      <a:lumMod val="60000"/>
                      <a:lumOff val="40000"/>
                      <a:alpha val="60000"/>
                    </a:schemeClr>
                  </a:gs>
                  <a:gs pos="95000">
                    <a:schemeClr val="accent1">
                      <a:lumMod val="30000"/>
                      <a:lumOff val="70000"/>
                      <a:alpha val="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5504988" y="5033638"/>
                <a:ext cx="1037855" cy="992985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  <a:alpha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-FI"/>
              </a:p>
            </p:txBody>
          </p:sp>
        </p:grp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biLevel thresh="75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72533" y="320090"/>
              <a:ext cx="3238200" cy="324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3880987" y="-85725"/>
              <a:ext cx="201709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3200" dirty="0"/>
                <a:t>Downtown</a:t>
              </a:r>
              <a:endParaRPr lang="fi-FI" sz="3200" dirty="0"/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3227050" y="4019549"/>
              <a:ext cx="3317875" cy="2990851"/>
              <a:chOff x="13227050" y="4019549"/>
              <a:chExt cx="3317875" cy="2990851"/>
            </a:xfrm>
            <a:effectLst>
              <a:glow rad="63500">
                <a:schemeClr val="bg1">
                  <a:alpha val="50000"/>
                </a:schemeClr>
              </a:glow>
            </a:effectLst>
          </p:grpSpPr>
          <p:grpSp>
            <p:nvGrpSpPr>
              <p:cNvPr id="23" name="Group 22"/>
              <p:cNvGrpSpPr/>
              <p:nvPr/>
            </p:nvGrpSpPr>
            <p:grpSpPr>
              <a:xfrm>
                <a:off x="13227050" y="4379049"/>
                <a:ext cx="3317875" cy="1778608"/>
                <a:chOff x="9293233" y="4377894"/>
                <a:chExt cx="4032185" cy="1778608"/>
              </a:xfrm>
            </p:grpSpPr>
            <p:sp>
              <p:nvSpPr>
                <p:cNvPr id="29" name="Freeform 28"/>
                <p:cNvSpPr/>
                <p:nvPr/>
              </p:nvSpPr>
              <p:spPr>
                <a:xfrm>
                  <a:off x="9293233" y="4377894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30" name="Freeform 29"/>
                <p:cNvSpPr/>
                <p:nvPr/>
              </p:nvSpPr>
              <p:spPr>
                <a:xfrm>
                  <a:off x="9293233" y="5267198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31" name="Freeform 30"/>
                <p:cNvSpPr/>
                <p:nvPr/>
              </p:nvSpPr>
              <p:spPr>
                <a:xfrm>
                  <a:off x="9293233" y="6156502"/>
                  <a:ext cx="4032185" cy="0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13735049" y="4019549"/>
                <a:ext cx="2407963" cy="2990851"/>
                <a:chOff x="14058899" y="-360014"/>
                <a:chExt cx="2407963" cy="7218014"/>
              </a:xfrm>
            </p:grpSpPr>
            <p:sp>
              <p:nvSpPr>
                <p:cNvPr id="25" name="Freeform 24"/>
                <p:cNvSpPr/>
                <p:nvPr/>
              </p:nvSpPr>
              <p:spPr>
                <a:xfrm rot="5400000" flipV="1">
                  <a:off x="11184028" y="2514858"/>
                  <a:ext cx="5808126" cy="58383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26" name="Freeform 25"/>
                <p:cNvSpPr/>
                <p:nvPr/>
              </p:nvSpPr>
              <p:spPr>
                <a:xfrm rot="5400000" flipV="1">
                  <a:off x="11967221" y="2514858"/>
                  <a:ext cx="5808126" cy="58383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27" name="Freeform 26"/>
                <p:cNvSpPr/>
                <p:nvPr/>
              </p:nvSpPr>
              <p:spPr>
                <a:xfrm rot="5400000" flipV="1">
                  <a:off x="12044724" y="3219055"/>
                  <a:ext cx="7218014" cy="59875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  <p:sp>
              <p:nvSpPr>
                <p:cNvPr id="28" name="Freeform 27"/>
                <p:cNvSpPr/>
                <p:nvPr/>
              </p:nvSpPr>
              <p:spPr>
                <a:xfrm rot="5400000" flipV="1">
                  <a:off x="12827918" y="3219055"/>
                  <a:ext cx="7218014" cy="59875"/>
                </a:xfrm>
                <a:custGeom>
                  <a:avLst/>
                  <a:gdLst>
                    <a:gd name="connsiteX0" fmla="*/ 0 w 3078866"/>
                    <a:gd name="connsiteY0" fmla="*/ 0 h 0"/>
                    <a:gd name="connsiteX1" fmla="*/ 3078866 w 307886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078866">
                      <a:moveTo>
                        <a:pt x="0" y="0"/>
                      </a:moveTo>
                      <a:lnTo>
                        <a:pt x="3078866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i-FI"/>
                </a:p>
              </p:txBody>
            </p:sp>
          </p:grpSp>
        </p:grpSp>
        <p:sp>
          <p:nvSpPr>
            <p:cNvPr id="20" name="Freeform 19"/>
            <p:cNvSpPr/>
            <p:nvPr/>
          </p:nvSpPr>
          <p:spPr>
            <a:xfrm>
              <a:off x="13408025" y="1150074"/>
              <a:ext cx="2955926" cy="0"/>
            </a:xfrm>
            <a:custGeom>
              <a:avLst/>
              <a:gdLst>
                <a:gd name="connsiteX0" fmla="*/ 0 w 3078866"/>
                <a:gd name="connsiteY0" fmla="*/ 0 h 0"/>
                <a:gd name="connsiteX1" fmla="*/ 3078866 w 3078866"/>
                <a:gd name="connsiteY1" fmla="*/ 0 h 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78866">
                  <a:moveTo>
                    <a:pt x="0" y="0"/>
                  </a:moveTo>
                  <a:lnTo>
                    <a:pt x="3078866" y="0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17" name="Freeform 16"/>
            <p:cNvSpPr/>
            <p:nvPr/>
          </p:nvSpPr>
          <p:spPr>
            <a:xfrm rot="5400000" flipV="1">
              <a:off x="12727413" y="1932212"/>
              <a:ext cx="2990851" cy="59875"/>
            </a:xfrm>
            <a:custGeom>
              <a:avLst/>
              <a:gdLst>
                <a:gd name="connsiteX0" fmla="*/ 0 w 3078866"/>
                <a:gd name="connsiteY0" fmla="*/ 0 h 0"/>
                <a:gd name="connsiteX1" fmla="*/ 3078866 w 3078866"/>
                <a:gd name="connsiteY1" fmla="*/ 0 h 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78866">
                  <a:moveTo>
                    <a:pt x="0" y="0"/>
                  </a:moveTo>
                  <a:lnTo>
                    <a:pt x="3078866" y="0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3361074" y="6387525"/>
              <a:ext cx="154561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3200" dirty="0"/>
                <a:t>Joensuu</a:t>
              </a:r>
              <a:endParaRPr lang="fi-FI" sz="3200" dirty="0"/>
            </a:p>
          </p:txBody>
        </p:sp>
      </p:grpSp>
      <p:sp>
        <p:nvSpPr>
          <p:cNvPr id="53" name="Right Arrow 52"/>
          <p:cNvSpPr/>
          <p:nvPr/>
        </p:nvSpPr>
        <p:spPr>
          <a:xfrm>
            <a:off x="7277100" y="3467100"/>
            <a:ext cx="406400" cy="4445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54" name="TextBox 53"/>
          <p:cNvSpPr txBox="1"/>
          <p:nvPr/>
        </p:nvSpPr>
        <p:spPr>
          <a:xfrm>
            <a:off x="7805786" y="2327275"/>
            <a:ext cx="1530997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b="1" dirty="0">
                <a:solidFill>
                  <a:srgbClr val="0000FF"/>
                </a:solidFill>
              </a:rPr>
              <a:t>1268</a:t>
            </a:r>
          </a:p>
          <a:p>
            <a:pPr algn="ctr"/>
            <a:r>
              <a:rPr lang="en-US" sz="3200" b="1" dirty="0">
                <a:solidFill>
                  <a:srgbClr val="0000FF"/>
                </a:solidFill>
              </a:rPr>
              <a:t>Clusters</a:t>
            </a:r>
          </a:p>
        </p:txBody>
      </p:sp>
    </p:spTree>
    <p:extLst>
      <p:ext uri="{BB962C8B-B14F-4D97-AF65-F5344CB8AC3E}">
        <p14:creationId xmlns:p14="http://schemas.microsoft.com/office/powerpoint/2010/main" val="41251962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448" y="183213"/>
            <a:ext cx="3712464" cy="6577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8919" y="183213"/>
            <a:ext cx="3712430" cy="657713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5783" y="183213"/>
            <a:ext cx="3712464" cy="65772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5783" y="183213"/>
            <a:ext cx="3712464" cy="65772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692052" y="-308428"/>
            <a:ext cx="236846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Cluster Centroids</a:t>
            </a:r>
          </a:p>
        </p:txBody>
      </p:sp>
      <p:sp>
        <p:nvSpPr>
          <p:cNvPr id="9" name="Rectangle 8"/>
          <p:cNvSpPr/>
          <p:nvPr/>
        </p:nvSpPr>
        <p:spPr>
          <a:xfrm>
            <a:off x="4150081" y="-230833"/>
            <a:ext cx="168353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Coarse Tour</a:t>
            </a:r>
          </a:p>
        </p:txBody>
      </p:sp>
      <p:sp>
        <p:nvSpPr>
          <p:cNvPr id="10" name="Rectangle 9"/>
          <p:cNvSpPr/>
          <p:nvPr/>
        </p:nvSpPr>
        <p:spPr>
          <a:xfrm>
            <a:off x="7069266" y="-230833"/>
            <a:ext cx="245112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Linked End-Poin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8520" y="183213"/>
            <a:ext cx="3712464" cy="65772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0637966" y="-308428"/>
            <a:ext cx="211519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/>
              <a:t>Clusters Solved</a:t>
            </a:r>
          </a:p>
        </p:txBody>
      </p:sp>
      <p:sp>
        <p:nvSpPr>
          <p:cNvPr id="3" name="Rectangle 2"/>
          <p:cNvSpPr/>
          <p:nvPr/>
        </p:nvSpPr>
        <p:spPr>
          <a:xfrm>
            <a:off x="11010826" y="43934"/>
            <a:ext cx="140775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/>
              <a:t>120,751 km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054026" y="43934"/>
            <a:ext cx="162538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/>
              <a:t>1,268 clusters</a:t>
            </a:r>
          </a:p>
        </p:txBody>
      </p:sp>
    </p:spTree>
    <p:extLst>
      <p:ext uri="{BB962C8B-B14F-4D97-AF65-F5344CB8AC3E}">
        <p14:creationId xmlns:p14="http://schemas.microsoft.com/office/powerpoint/2010/main" val="29941715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E4D56D7-7BBD-4A42-9112-9442A6A9D33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794" y="855030"/>
            <a:ext cx="2895600" cy="5130000"/>
          </a:xfrm>
          <a:prstGeom prst="rect">
            <a:avLst/>
          </a:prstGeom>
          <a:effectLst>
            <a:glow rad="635000">
              <a:schemeClr val="bg1">
                <a:alpha val="30000"/>
              </a:schemeClr>
            </a:glow>
          </a:effec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CD22007-E60A-4A13-B8CD-EC343831DD5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307" y="855030"/>
            <a:ext cx="2895600" cy="513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3C0E6CA-4BD0-4E57-9FFB-747F50EDCD2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6300" y="855030"/>
            <a:ext cx="2895600" cy="513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2A2D7E5-D613-4D04-A401-0C4C1AD2BC8E}"/>
              </a:ext>
            </a:extLst>
          </p:cNvPr>
          <p:cNvSpPr txBox="1"/>
          <p:nvPr/>
        </p:nvSpPr>
        <p:spPr>
          <a:xfrm>
            <a:off x="5183262" y="5635269"/>
            <a:ext cx="20962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rgbClr val="0000FF"/>
                </a:solidFill>
              </a:rPr>
              <a:t>12,764 Clusters</a:t>
            </a:r>
            <a:endParaRPr lang="fi-FI" sz="2400" dirty="0">
              <a:solidFill>
                <a:srgbClr val="0000FF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CA09D5B-3F16-44C4-9C0E-822D3E1127C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bright="-4000" contras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794" y="855030"/>
            <a:ext cx="2895600" cy="5130000"/>
          </a:xfrm>
          <a:prstGeom prst="rect">
            <a:avLst/>
          </a:prstGeom>
          <a:ln>
            <a:noFill/>
          </a:ln>
          <a:effectLst/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5CB4E1E-FE8D-4833-9F80-3D46FCF8D2A3}"/>
              </a:ext>
            </a:extLst>
          </p:cNvPr>
          <p:cNvSpPr txBox="1"/>
          <p:nvPr/>
        </p:nvSpPr>
        <p:spPr>
          <a:xfrm>
            <a:off x="2998862" y="5635269"/>
            <a:ext cx="17082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rgbClr val="C35D19"/>
                </a:solidFill>
              </a:rPr>
              <a:t>112 Clusters</a:t>
            </a:r>
            <a:endParaRPr lang="fi-FI" sz="2400" dirty="0">
              <a:solidFill>
                <a:srgbClr val="C35D19"/>
              </a:solidFill>
            </a:endParaRPr>
          </a:p>
        </p:txBody>
      </p:sp>
      <p:sp>
        <p:nvSpPr>
          <p:cNvPr id="10" name="Right Arrow 37">
            <a:extLst>
              <a:ext uri="{FF2B5EF4-FFF2-40B4-BE49-F238E27FC236}">
                <a16:creationId xmlns:a16="http://schemas.microsoft.com/office/drawing/2014/main" id="{787FBB00-5C34-444C-81FD-1D0B53B77748}"/>
              </a:ext>
            </a:extLst>
          </p:cNvPr>
          <p:cNvSpPr/>
          <p:nvPr/>
        </p:nvSpPr>
        <p:spPr>
          <a:xfrm>
            <a:off x="2911475" y="3018454"/>
            <a:ext cx="371475" cy="3048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1" name="Right Arrow 38">
            <a:extLst>
              <a:ext uri="{FF2B5EF4-FFF2-40B4-BE49-F238E27FC236}">
                <a16:creationId xmlns:a16="http://schemas.microsoft.com/office/drawing/2014/main" id="{59473999-2E2B-4813-B20C-5F1C989F0CC2}"/>
              </a:ext>
            </a:extLst>
          </p:cNvPr>
          <p:cNvSpPr/>
          <p:nvPr/>
        </p:nvSpPr>
        <p:spPr>
          <a:xfrm>
            <a:off x="5133975" y="3018454"/>
            <a:ext cx="371475" cy="3048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47BD84D-6863-47C2-B4CA-D1CEE205F005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2364" y="2023446"/>
            <a:ext cx="4532434" cy="2811108"/>
          </a:xfrm>
          <a:prstGeom prst="rect">
            <a:avLst/>
          </a:prstGeom>
          <a:noFill/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72AD5BB5-9407-4A87-AAB5-37D3DE1B6738}"/>
              </a:ext>
            </a:extLst>
          </p:cNvPr>
          <p:cNvSpPr/>
          <p:nvPr/>
        </p:nvSpPr>
        <p:spPr>
          <a:xfrm>
            <a:off x="10019211" y="2799378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A1409DE-48B5-49DC-A3A4-807CC98694B7}"/>
              </a:ext>
            </a:extLst>
          </p:cNvPr>
          <p:cNvSpPr/>
          <p:nvPr/>
        </p:nvSpPr>
        <p:spPr>
          <a:xfrm>
            <a:off x="10019211" y="3078779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AAD736C-5630-4208-AF29-4B9D9DC9F5A2}"/>
              </a:ext>
            </a:extLst>
          </p:cNvPr>
          <p:cNvSpPr/>
          <p:nvPr/>
        </p:nvSpPr>
        <p:spPr>
          <a:xfrm>
            <a:off x="10019211" y="3352390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81817D-DEB3-4918-B3D5-1DEC26A26C94}"/>
              </a:ext>
            </a:extLst>
          </p:cNvPr>
          <p:cNvSpPr txBox="1"/>
          <p:nvPr/>
        </p:nvSpPr>
        <p:spPr>
          <a:xfrm>
            <a:off x="9990131" y="2743032"/>
            <a:ext cx="1647246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Avg. 	Size: 113</a:t>
            </a:r>
          </a:p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Min. 	Size: 2</a:t>
            </a:r>
          </a:p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Max.	Size: 722</a:t>
            </a:r>
            <a:endParaRPr lang="en-FI" sz="2000" dirty="0"/>
          </a:p>
        </p:txBody>
      </p:sp>
    </p:spTree>
    <p:extLst>
      <p:ext uri="{BB962C8B-B14F-4D97-AF65-F5344CB8AC3E}">
        <p14:creationId xmlns:p14="http://schemas.microsoft.com/office/powerpoint/2010/main" val="19696357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68" b="8893"/>
          <a:stretch/>
        </p:blipFill>
        <p:spPr bwMode="auto">
          <a:xfrm>
            <a:off x="2195195" y="1819275"/>
            <a:ext cx="7575236" cy="369570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8029575" y="1258419"/>
            <a:ext cx="1566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M Solving × 1</a:t>
            </a:r>
            <a:endParaRPr lang="fi-FI" dirty="0"/>
          </a:p>
        </p:txBody>
      </p:sp>
      <p:sp>
        <p:nvSpPr>
          <p:cNvPr id="6" name="TextBox 5"/>
          <p:cNvSpPr txBox="1"/>
          <p:nvPr/>
        </p:nvSpPr>
        <p:spPr>
          <a:xfrm>
            <a:off x="5191125" y="982194"/>
            <a:ext cx="184563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Linked End-Points</a:t>
            </a:r>
          </a:p>
          <a:p>
            <a:pPr algn="ctr"/>
            <a:r>
              <a:rPr lang="en-US" dirty="0"/>
              <a:t>RM Solving × 112</a:t>
            </a:r>
          </a:p>
          <a:p>
            <a:pPr algn="ctr"/>
            <a:r>
              <a:rPr lang="en-US" dirty="0"/>
              <a:t>Fine-tuning</a:t>
            </a:r>
            <a:endParaRPr lang="fi-FI" dirty="0"/>
          </a:p>
        </p:txBody>
      </p:sp>
      <p:sp>
        <p:nvSpPr>
          <p:cNvPr id="8" name="TextBox 7"/>
          <p:cNvSpPr txBox="1"/>
          <p:nvPr/>
        </p:nvSpPr>
        <p:spPr>
          <a:xfrm>
            <a:off x="2400823" y="982194"/>
            <a:ext cx="209223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Linked End-Points</a:t>
            </a:r>
          </a:p>
          <a:p>
            <a:pPr algn="ctr"/>
            <a:r>
              <a:rPr lang="en-US" dirty="0"/>
              <a:t>RM Solving × 12,764</a:t>
            </a:r>
          </a:p>
          <a:p>
            <a:pPr algn="ctr"/>
            <a:r>
              <a:rPr lang="en-US" dirty="0"/>
              <a:t>Fine-tuning</a:t>
            </a:r>
            <a:endParaRPr lang="fi-FI" dirty="0"/>
          </a:p>
        </p:txBody>
      </p:sp>
      <p:sp>
        <p:nvSpPr>
          <p:cNvPr id="9" name="Right Arrow 8"/>
          <p:cNvSpPr/>
          <p:nvPr/>
        </p:nvSpPr>
        <p:spPr>
          <a:xfrm rot="10800000">
            <a:off x="7324725" y="3419475"/>
            <a:ext cx="371475" cy="3048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" name="Right Arrow 9"/>
          <p:cNvSpPr/>
          <p:nvPr/>
        </p:nvSpPr>
        <p:spPr>
          <a:xfrm rot="10800000">
            <a:off x="4743450" y="3419475"/>
            <a:ext cx="371475" cy="3048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1" name="TextBox 10"/>
          <p:cNvSpPr txBox="1"/>
          <p:nvPr/>
        </p:nvSpPr>
        <p:spPr>
          <a:xfrm>
            <a:off x="8048625" y="292474"/>
            <a:ext cx="143532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/>
              <a:t>Coarse Tour</a:t>
            </a:r>
          </a:p>
          <a:p>
            <a:pPr algn="ctr"/>
            <a:r>
              <a:rPr lang="en-US" sz="2000" dirty="0"/>
              <a:t>(Level 1)</a:t>
            </a:r>
            <a:endParaRPr lang="fi-FI" sz="2000" dirty="0"/>
          </a:p>
        </p:txBody>
      </p:sp>
      <p:sp>
        <p:nvSpPr>
          <p:cNvPr id="14" name="TextBox 13"/>
          <p:cNvSpPr txBox="1"/>
          <p:nvPr/>
        </p:nvSpPr>
        <p:spPr>
          <a:xfrm>
            <a:off x="5353050" y="292474"/>
            <a:ext cx="143532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/>
              <a:t>Coarse Tour</a:t>
            </a:r>
          </a:p>
          <a:p>
            <a:pPr algn="ctr"/>
            <a:r>
              <a:rPr lang="en-US" sz="2000" dirty="0"/>
              <a:t>(Level 2)</a:t>
            </a:r>
            <a:endParaRPr lang="fi-FI" sz="2000" dirty="0"/>
          </a:p>
        </p:txBody>
      </p:sp>
      <p:sp>
        <p:nvSpPr>
          <p:cNvPr id="15" name="TextBox 14"/>
          <p:cNvSpPr txBox="1"/>
          <p:nvPr/>
        </p:nvSpPr>
        <p:spPr>
          <a:xfrm>
            <a:off x="2817505" y="292474"/>
            <a:ext cx="121052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/>
              <a:t>Complete</a:t>
            </a:r>
          </a:p>
          <a:p>
            <a:pPr algn="ctr"/>
            <a:r>
              <a:rPr lang="en-US" sz="2000" b="1" dirty="0"/>
              <a:t>Tour</a:t>
            </a:r>
            <a:endParaRPr lang="fi-FI" sz="2000" dirty="0"/>
          </a:p>
        </p:txBody>
      </p:sp>
    </p:spTree>
    <p:extLst>
      <p:ext uri="{BB962C8B-B14F-4D97-AF65-F5344CB8AC3E}">
        <p14:creationId xmlns:p14="http://schemas.microsoft.com/office/powerpoint/2010/main" val="95367019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547BD84D-6863-47C2-B4CA-D1CEE205F00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2364" y="2023446"/>
            <a:ext cx="4532434" cy="2811108"/>
          </a:xfrm>
          <a:prstGeom prst="rect">
            <a:avLst/>
          </a:prstGeom>
          <a:noFill/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72AD5BB5-9407-4A87-AAB5-37D3DE1B6738}"/>
              </a:ext>
            </a:extLst>
          </p:cNvPr>
          <p:cNvSpPr/>
          <p:nvPr/>
        </p:nvSpPr>
        <p:spPr>
          <a:xfrm>
            <a:off x="10019211" y="2799378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A1409DE-48B5-49DC-A3A4-807CC98694B7}"/>
              </a:ext>
            </a:extLst>
          </p:cNvPr>
          <p:cNvSpPr/>
          <p:nvPr/>
        </p:nvSpPr>
        <p:spPr>
          <a:xfrm>
            <a:off x="10019211" y="3078779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AAD736C-5630-4208-AF29-4B9D9DC9F5A2}"/>
              </a:ext>
            </a:extLst>
          </p:cNvPr>
          <p:cNvSpPr/>
          <p:nvPr/>
        </p:nvSpPr>
        <p:spPr>
          <a:xfrm>
            <a:off x="10019211" y="3352390"/>
            <a:ext cx="1524000" cy="2508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81817D-DEB3-4918-B3D5-1DEC26A26C94}"/>
              </a:ext>
            </a:extLst>
          </p:cNvPr>
          <p:cNvSpPr txBox="1"/>
          <p:nvPr/>
        </p:nvSpPr>
        <p:spPr>
          <a:xfrm>
            <a:off x="9990131" y="2743032"/>
            <a:ext cx="1647246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Avg. 	Size: 113</a:t>
            </a:r>
          </a:p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Min. 	Size: 2</a:t>
            </a:r>
          </a:p>
          <a:p>
            <a:pPr>
              <a:lnSpc>
                <a:spcPts val="2200"/>
              </a:lnSpc>
              <a:tabLst>
                <a:tab pos="539750" algn="l"/>
                <a:tab pos="984250" algn="l"/>
              </a:tabLst>
            </a:pPr>
            <a:r>
              <a:rPr lang="en-US" sz="2000" dirty="0"/>
              <a:t>Max.	Size: 722</a:t>
            </a:r>
            <a:endParaRPr lang="en-FI" sz="20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4569AB1-ED7A-4693-A020-D827F42047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6942" y="-79193"/>
            <a:ext cx="4111508" cy="3556995"/>
          </a:xfrm>
          <a:prstGeom prst="rect">
            <a:avLst/>
          </a:prstGeom>
        </p:spPr>
      </p:pic>
      <p:sp>
        <p:nvSpPr>
          <p:cNvPr id="17" name="Right Arrow 9">
            <a:extLst>
              <a:ext uri="{FF2B5EF4-FFF2-40B4-BE49-F238E27FC236}">
                <a16:creationId xmlns:a16="http://schemas.microsoft.com/office/drawing/2014/main" id="{86FF8D00-1A23-442D-B79C-02B056F961A7}"/>
              </a:ext>
            </a:extLst>
          </p:cNvPr>
          <p:cNvSpPr/>
          <p:nvPr/>
        </p:nvSpPr>
        <p:spPr>
          <a:xfrm rot="10800000">
            <a:off x="2260947" y="3893448"/>
            <a:ext cx="175728" cy="15454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8" name="Right Arrow 9">
            <a:extLst>
              <a:ext uri="{FF2B5EF4-FFF2-40B4-BE49-F238E27FC236}">
                <a16:creationId xmlns:a16="http://schemas.microsoft.com/office/drawing/2014/main" id="{F34434AB-6F57-430A-BA39-4CFD8335394F}"/>
              </a:ext>
            </a:extLst>
          </p:cNvPr>
          <p:cNvSpPr/>
          <p:nvPr/>
        </p:nvSpPr>
        <p:spPr>
          <a:xfrm rot="10800000">
            <a:off x="3483067" y="3893448"/>
            <a:ext cx="175728" cy="15454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751996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36600" y="1282700"/>
            <a:ext cx="8274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/>
              <a:t>LKH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36600" y="2832100"/>
            <a:ext cx="18448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/>
              <a:t>DoLoWir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36600" y="4381500"/>
            <a:ext cx="131760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/>
              <a:t>TSPDiv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3200400" y="1409700"/>
            <a:ext cx="140970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752446" y="469900"/>
            <a:ext cx="235134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Generating candidates,</a:t>
            </a:r>
          </a:p>
          <a:p>
            <a:pPr algn="ctr"/>
            <a:r>
              <a:rPr lang="en-US">
                <a:cs typeface="Arial" panose="020B0604020202020204" pitchFamily="34" charset="0"/>
              </a:rPr>
              <a:t>α-nearness scoring,</a:t>
            </a:r>
          </a:p>
          <a:p>
            <a:pPr algn="ctr"/>
            <a:r>
              <a:rPr lang="en-US">
                <a:cs typeface="Arial" panose="020B0604020202020204" pitchFamily="34" charset="0"/>
              </a:rPr>
              <a:t>and Greedy</a:t>
            </a:r>
            <a:endParaRPr lang="en-US"/>
          </a:p>
        </p:txBody>
      </p:sp>
      <p:sp>
        <p:nvSpPr>
          <p:cNvPr id="13" name="Rounded Rectangle 12"/>
          <p:cNvSpPr/>
          <p:nvPr/>
        </p:nvSpPr>
        <p:spPr>
          <a:xfrm>
            <a:off x="4724400" y="1409700"/>
            <a:ext cx="734060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7848600" y="736600"/>
            <a:ext cx="13447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Local search</a:t>
            </a:r>
          </a:p>
          <a:p>
            <a:pPr algn="ctr"/>
            <a:r>
              <a:rPr lang="en-US"/>
              <a:t>2-5 opt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3200400" y="2946400"/>
            <a:ext cx="15240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2618371" y="2222500"/>
            <a:ext cx="12732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Generating</a:t>
            </a:r>
          </a:p>
          <a:p>
            <a:pPr algn="ctr"/>
            <a:r>
              <a:rPr lang="en-US"/>
              <a:t>coarse tour</a:t>
            </a:r>
          </a:p>
        </p:txBody>
      </p:sp>
      <p:sp>
        <p:nvSpPr>
          <p:cNvPr id="17" name="Rounded Rectangle 16"/>
          <p:cNvSpPr/>
          <p:nvPr/>
        </p:nvSpPr>
        <p:spPr>
          <a:xfrm>
            <a:off x="3467100" y="2946400"/>
            <a:ext cx="613410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5657231" y="2222500"/>
            <a:ext cx="16471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Solving clusters</a:t>
            </a:r>
          </a:p>
          <a:p>
            <a:pPr algn="ctr"/>
            <a:r>
              <a:rPr lang="en-US"/>
              <a:t>2-3 opt</a:t>
            </a:r>
          </a:p>
        </p:txBody>
      </p:sp>
      <p:sp>
        <p:nvSpPr>
          <p:cNvPr id="19" name="Rounded Rectangle 18"/>
          <p:cNvSpPr/>
          <p:nvPr/>
        </p:nvSpPr>
        <p:spPr>
          <a:xfrm>
            <a:off x="9702800" y="2946400"/>
            <a:ext cx="236220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9781444" y="1968500"/>
            <a:ext cx="213635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Fine-tuning</a:t>
            </a:r>
          </a:p>
          <a:p>
            <a:pPr algn="ctr"/>
            <a:r>
              <a:rPr lang="en-US"/>
              <a:t>500 length segments</a:t>
            </a:r>
          </a:p>
          <a:p>
            <a:pPr algn="ctr"/>
            <a:r>
              <a:rPr lang="en-US"/>
              <a:t>in parallel</a:t>
            </a:r>
          </a:p>
        </p:txBody>
      </p:sp>
      <p:sp>
        <p:nvSpPr>
          <p:cNvPr id="21" name="Rounded Rectangle 20"/>
          <p:cNvSpPr/>
          <p:nvPr/>
        </p:nvSpPr>
        <p:spPr>
          <a:xfrm>
            <a:off x="3200401" y="4488873"/>
            <a:ext cx="152399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2657051" y="3774209"/>
            <a:ext cx="12883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Generating</a:t>
            </a:r>
          </a:p>
          <a:p>
            <a:pPr algn="ctr"/>
            <a:r>
              <a:rPr lang="en-US"/>
              <a:t>Level 1 tour</a:t>
            </a:r>
          </a:p>
        </p:txBody>
      </p:sp>
      <p:sp>
        <p:nvSpPr>
          <p:cNvPr id="23" name="Rounded Rectangle 22"/>
          <p:cNvSpPr/>
          <p:nvPr/>
        </p:nvSpPr>
        <p:spPr>
          <a:xfrm>
            <a:off x="3468253" y="4488873"/>
            <a:ext cx="254002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2934141" y="4937991"/>
            <a:ext cx="12883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Generating</a:t>
            </a:r>
          </a:p>
          <a:p>
            <a:pPr algn="ctr"/>
            <a:r>
              <a:rPr lang="en-US"/>
              <a:t>Level 2 tour</a:t>
            </a:r>
          </a:p>
        </p:txBody>
      </p:sp>
      <p:sp>
        <p:nvSpPr>
          <p:cNvPr id="25" name="Rounded Rectangle 24"/>
          <p:cNvSpPr/>
          <p:nvPr/>
        </p:nvSpPr>
        <p:spPr>
          <a:xfrm>
            <a:off x="3823856" y="4488873"/>
            <a:ext cx="5884024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5817606" y="3774209"/>
            <a:ext cx="16215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Solving clusters</a:t>
            </a:r>
          </a:p>
          <a:p>
            <a:pPr algn="ctr"/>
            <a:r>
              <a:rPr lang="en-US"/>
              <a:t>Random-Mix</a:t>
            </a:r>
          </a:p>
        </p:txBody>
      </p:sp>
      <p:sp>
        <p:nvSpPr>
          <p:cNvPr id="28" name="Rounded Rectangle 27"/>
          <p:cNvSpPr/>
          <p:nvPr/>
        </p:nvSpPr>
        <p:spPr>
          <a:xfrm>
            <a:off x="9806940" y="4488873"/>
            <a:ext cx="2258060" cy="34290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9874504" y="3774209"/>
            <a:ext cx="20646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Fine-tuning</a:t>
            </a:r>
          </a:p>
          <a:p>
            <a:pPr algn="ctr"/>
            <a:r>
              <a:rPr lang="en-US"/>
              <a:t>consecutive clusters</a:t>
            </a:r>
          </a:p>
        </p:txBody>
      </p:sp>
    </p:spTree>
    <p:extLst>
      <p:ext uri="{BB962C8B-B14F-4D97-AF65-F5344CB8AC3E}">
        <p14:creationId xmlns:p14="http://schemas.microsoft.com/office/powerpoint/2010/main" val="362219514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FD2000A-C728-4F79-B765-0CA89BF18BC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" r="4154"/>
          <a:stretch/>
        </p:blipFill>
        <p:spPr bwMode="auto">
          <a:xfrm>
            <a:off x="925286" y="-1567104"/>
            <a:ext cx="10244681" cy="977565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22414039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4" t="4305" r="4504" b="4938"/>
          <a:stretch>
            <a:fillRect/>
          </a:stretch>
        </p:blipFill>
        <p:spPr>
          <a:xfrm>
            <a:off x="8448674" y="3724275"/>
            <a:ext cx="3286125" cy="2933700"/>
          </a:xfrm>
          <a:custGeom>
            <a:avLst/>
            <a:gdLst>
              <a:gd name="connsiteX0" fmla="*/ 0 w 3286125"/>
              <a:gd name="connsiteY0" fmla="*/ 0 h 2933700"/>
              <a:gd name="connsiteX1" fmla="*/ 3286125 w 3286125"/>
              <a:gd name="connsiteY1" fmla="*/ 0 h 2933700"/>
              <a:gd name="connsiteX2" fmla="*/ 3286125 w 3286125"/>
              <a:gd name="connsiteY2" fmla="*/ 2933700 h 2933700"/>
              <a:gd name="connsiteX3" fmla="*/ 0 w 3286125"/>
              <a:gd name="connsiteY3" fmla="*/ 2933700 h 2933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86125" h="2933700">
                <a:moveTo>
                  <a:pt x="0" y="0"/>
                </a:moveTo>
                <a:lnTo>
                  <a:pt x="3286125" y="0"/>
                </a:lnTo>
                <a:lnTo>
                  <a:pt x="3286125" y="2933700"/>
                </a:lnTo>
                <a:lnTo>
                  <a:pt x="0" y="2933700"/>
                </a:lnTo>
                <a:close/>
              </a:path>
            </a:pathLst>
          </a:cu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775145" y="-752408"/>
            <a:ext cx="4444249" cy="7873669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653095" y="3717993"/>
            <a:ext cx="4121161" cy="3000375"/>
            <a:chOff x="3746490" y="4019550"/>
            <a:chExt cx="4121161" cy="3000375"/>
          </a:xfrm>
        </p:grpSpPr>
        <p:sp>
          <p:nvSpPr>
            <p:cNvPr id="6" name="Freeform 5"/>
            <p:cNvSpPr/>
            <p:nvPr/>
          </p:nvSpPr>
          <p:spPr>
            <a:xfrm>
              <a:off x="3943351" y="4019550"/>
              <a:ext cx="3924300" cy="3000375"/>
            </a:xfrm>
            <a:custGeom>
              <a:avLst/>
              <a:gdLst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9525 w 4886325"/>
                <a:gd name="connsiteY6" fmla="*/ 1133475 h 3000375"/>
                <a:gd name="connsiteX7" fmla="*/ 0 w 4886325"/>
                <a:gd name="connsiteY7" fmla="*/ 962025 h 3000375"/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233363 w 4886325"/>
                <a:gd name="connsiteY6" fmla="*/ 1152525 h 3000375"/>
                <a:gd name="connsiteX7" fmla="*/ 0 w 4886325"/>
                <a:gd name="connsiteY7" fmla="*/ 962025 h 3000375"/>
                <a:gd name="connsiteX0" fmla="*/ 4762 w 4652962"/>
                <a:gd name="connsiteY0" fmla="*/ 928688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4762 w 4652962"/>
                <a:gd name="connsiteY7" fmla="*/ 928688 h 3000375"/>
                <a:gd name="connsiteX0" fmla="*/ 728662 w 4652962"/>
                <a:gd name="connsiteY0" fmla="*/ 919163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728662 w 4652962"/>
                <a:gd name="connsiteY7" fmla="*/ 919163 h 3000375"/>
                <a:gd name="connsiteX0" fmla="*/ 0 w 3924300"/>
                <a:gd name="connsiteY0" fmla="*/ 919163 h 3000375"/>
                <a:gd name="connsiteX1" fmla="*/ 609600 w 3924300"/>
                <a:gd name="connsiteY1" fmla="*/ 0 h 3000375"/>
                <a:gd name="connsiteX2" fmla="*/ 3924300 w 3924300"/>
                <a:gd name="connsiteY2" fmla="*/ 0 h 3000375"/>
                <a:gd name="connsiteX3" fmla="*/ 3924300 w 3924300"/>
                <a:gd name="connsiteY3" fmla="*/ 3000375 h 3000375"/>
                <a:gd name="connsiteX4" fmla="*/ 3924300 w 3924300"/>
                <a:gd name="connsiteY4" fmla="*/ 3000375 h 3000375"/>
                <a:gd name="connsiteX5" fmla="*/ 609600 w 3924300"/>
                <a:gd name="connsiteY5" fmla="*/ 3000375 h 3000375"/>
                <a:gd name="connsiteX6" fmla="*/ 4763 w 3924300"/>
                <a:gd name="connsiteY6" fmla="*/ 1119187 h 3000375"/>
                <a:gd name="connsiteX7" fmla="*/ 0 w 3924300"/>
                <a:gd name="connsiteY7" fmla="*/ 919163 h 30003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924300" h="3000375">
                  <a:moveTo>
                    <a:pt x="0" y="919163"/>
                  </a:moveTo>
                  <a:lnTo>
                    <a:pt x="609600" y="0"/>
                  </a:lnTo>
                  <a:lnTo>
                    <a:pt x="3924300" y="0"/>
                  </a:lnTo>
                  <a:lnTo>
                    <a:pt x="3924300" y="3000375"/>
                  </a:lnTo>
                  <a:lnTo>
                    <a:pt x="3924300" y="3000375"/>
                  </a:lnTo>
                  <a:lnTo>
                    <a:pt x="609600" y="3000375"/>
                  </a:lnTo>
                  <a:lnTo>
                    <a:pt x="4763" y="1119187"/>
                  </a:lnTo>
                  <a:lnTo>
                    <a:pt x="0" y="919163"/>
                  </a:lnTo>
                  <a:close/>
                </a:path>
              </a:pathLst>
            </a:custGeom>
            <a:gradFill flip="none" rotWithShape="1">
              <a:gsLst>
                <a:gs pos="100000">
                  <a:schemeClr val="accent2">
                    <a:lumMod val="60000"/>
                    <a:lumOff val="40000"/>
                    <a:alpha val="0"/>
                  </a:schemeClr>
                </a:gs>
                <a:gs pos="71000">
                  <a:schemeClr val="accent2">
                    <a:lumMod val="60000"/>
                    <a:lumOff val="40000"/>
                    <a:alpha val="40000"/>
                  </a:scheme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3746490" y="4967287"/>
              <a:ext cx="201184" cy="163462"/>
            </a:xfrm>
            <a:prstGeom prst="rect">
              <a:avLst/>
            </a:prstGeom>
            <a:solidFill>
              <a:schemeClr val="accent2">
                <a:lumMod val="60000"/>
                <a:lumOff val="40000"/>
                <a:alpha val="40000"/>
              </a:schemeClr>
            </a:solidFill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628074" y="164435"/>
            <a:ext cx="2963008" cy="5560631"/>
            <a:chOff x="4721469" y="465992"/>
            <a:chExt cx="2963008" cy="5560631"/>
          </a:xfrm>
        </p:grpSpPr>
        <p:sp>
          <p:nvSpPr>
            <p:cNvPr id="9" name="Freeform 8"/>
            <p:cNvSpPr/>
            <p:nvPr/>
          </p:nvSpPr>
          <p:spPr>
            <a:xfrm>
              <a:off x="4721469" y="465992"/>
              <a:ext cx="2963008" cy="4564702"/>
            </a:xfrm>
            <a:custGeom>
              <a:avLst/>
              <a:gdLst>
                <a:gd name="connsiteX0" fmla="*/ 791308 w 2963008"/>
                <a:gd name="connsiteY0" fmla="*/ 5574323 h 5574323"/>
                <a:gd name="connsiteX1" fmla="*/ 0 w 2963008"/>
                <a:gd name="connsiteY1" fmla="*/ 2954216 h 5574323"/>
                <a:gd name="connsiteX2" fmla="*/ 0 w 2963008"/>
                <a:gd name="connsiteY2" fmla="*/ 0 h 5574323"/>
                <a:gd name="connsiteX3" fmla="*/ 2963008 w 2963008"/>
                <a:gd name="connsiteY3" fmla="*/ 0 h 5574323"/>
                <a:gd name="connsiteX4" fmla="*/ 2963008 w 2963008"/>
                <a:gd name="connsiteY4" fmla="*/ 2963008 h 5574323"/>
                <a:gd name="connsiteX5" fmla="*/ 1811216 w 2963008"/>
                <a:gd name="connsiteY5" fmla="*/ 5556739 h 5574323"/>
                <a:gd name="connsiteX6" fmla="*/ 791308 w 2963008"/>
                <a:gd name="connsiteY6" fmla="*/ 5574323 h 5574323"/>
                <a:gd name="connsiteX0" fmla="*/ 791308 w 2963008"/>
                <a:gd name="connsiteY0" fmla="*/ 5574323 h 5574323"/>
                <a:gd name="connsiteX1" fmla="*/ 474419 w 2963008"/>
                <a:gd name="connsiteY1" fmla="*/ 4548921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2250831 w 2963008"/>
                <a:gd name="connsiteY6" fmla="*/ 4544158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2681 w 2963008"/>
                <a:gd name="connsiteY6" fmla="*/ 4558446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1811216 w 2963008"/>
                <a:gd name="connsiteY0" fmla="*/ 5556739 h 5556739"/>
                <a:gd name="connsiteX1" fmla="*/ 788744 w 2963008"/>
                <a:gd name="connsiteY1" fmla="*/ 4563208 h 5556739"/>
                <a:gd name="connsiteX2" fmla="*/ 0 w 2963008"/>
                <a:gd name="connsiteY2" fmla="*/ 2954216 h 5556739"/>
                <a:gd name="connsiteX3" fmla="*/ 0 w 2963008"/>
                <a:gd name="connsiteY3" fmla="*/ 0 h 5556739"/>
                <a:gd name="connsiteX4" fmla="*/ 2963008 w 2963008"/>
                <a:gd name="connsiteY4" fmla="*/ 0 h 5556739"/>
                <a:gd name="connsiteX5" fmla="*/ 2963008 w 2963008"/>
                <a:gd name="connsiteY5" fmla="*/ 2963008 h 5556739"/>
                <a:gd name="connsiteX6" fmla="*/ 1812681 w 2963008"/>
                <a:gd name="connsiteY6" fmla="*/ 4558446 h 5556739"/>
                <a:gd name="connsiteX7" fmla="*/ 1811216 w 2963008"/>
                <a:gd name="connsiteY7" fmla="*/ 5556739 h 5556739"/>
                <a:gd name="connsiteX0" fmla="*/ 1812681 w 2963008"/>
                <a:gd name="connsiteY0" fmla="*/ 4558446 h 4761122"/>
                <a:gd name="connsiteX1" fmla="*/ 788744 w 2963008"/>
                <a:gd name="connsiteY1" fmla="*/ 4563208 h 4761122"/>
                <a:gd name="connsiteX2" fmla="*/ 0 w 2963008"/>
                <a:gd name="connsiteY2" fmla="*/ 2954216 h 4761122"/>
                <a:gd name="connsiteX3" fmla="*/ 0 w 2963008"/>
                <a:gd name="connsiteY3" fmla="*/ 0 h 4761122"/>
                <a:gd name="connsiteX4" fmla="*/ 2963008 w 2963008"/>
                <a:gd name="connsiteY4" fmla="*/ 0 h 4761122"/>
                <a:gd name="connsiteX5" fmla="*/ 2963008 w 2963008"/>
                <a:gd name="connsiteY5" fmla="*/ 2963008 h 4761122"/>
                <a:gd name="connsiteX6" fmla="*/ 1812681 w 2963008"/>
                <a:gd name="connsiteY6" fmla="*/ 4558446 h 4761122"/>
                <a:gd name="connsiteX0" fmla="*/ 1812681 w 2963008"/>
                <a:gd name="connsiteY0" fmla="*/ 4558446 h 4678462"/>
                <a:gd name="connsiteX1" fmla="*/ 788744 w 2963008"/>
                <a:gd name="connsiteY1" fmla="*/ 4563208 h 4678462"/>
                <a:gd name="connsiteX2" fmla="*/ 0 w 2963008"/>
                <a:gd name="connsiteY2" fmla="*/ 2954216 h 4678462"/>
                <a:gd name="connsiteX3" fmla="*/ 0 w 2963008"/>
                <a:gd name="connsiteY3" fmla="*/ 0 h 4678462"/>
                <a:gd name="connsiteX4" fmla="*/ 2963008 w 2963008"/>
                <a:gd name="connsiteY4" fmla="*/ 0 h 4678462"/>
                <a:gd name="connsiteX5" fmla="*/ 2963008 w 2963008"/>
                <a:gd name="connsiteY5" fmla="*/ 2963008 h 4678462"/>
                <a:gd name="connsiteX6" fmla="*/ 1812681 w 2963008"/>
                <a:gd name="connsiteY6" fmla="*/ 4558446 h 4678462"/>
                <a:gd name="connsiteX0" fmla="*/ 1812681 w 2963008"/>
                <a:gd name="connsiteY0" fmla="*/ 4558446 h 4564702"/>
                <a:gd name="connsiteX1" fmla="*/ 788744 w 2963008"/>
                <a:gd name="connsiteY1" fmla="*/ 4563208 h 4564702"/>
                <a:gd name="connsiteX2" fmla="*/ 0 w 2963008"/>
                <a:gd name="connsiteY2" fmla="*/ 2954216 h 4564702"/>
                <a:gd name="connsiteX3" fmla="*/ 0 w 2963008"/>
                <a:gd name="connsiteY3" fmla="*/ 0 h 4564702"/>
                <a:gd name="connsiteX4" fmla="*/ 2963008 w 2963008"/>
                <a:gd name="connsiteY4" fmla="*/ 0 h 4564702"/>
                <a:gd name="connsiteX5" fmla="*/ 2963008 w 2963008"/>
                <a:gd name="connsiteY5" fmla="*/ 2963008 h 4564702"/>
                <a:gd name="connsiteX6" fmla="*/ 1812681 w 2963008"/>
                <a:gd name="connsiteY6" fmla="*/ 4558446 h 45647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963008" h="4564702">
                  <a:moveTo>
                    <a:pt x="1812681" y="4558446"/>
                  </a:moveTo>
                  <a:cubicBezTo>
                    <a:pt x="1530203" y="4567694"/>
                    <a:pt x="1552496" y="4564250"/>
                    <a:pt x="788744" y="4563208"/>
                  </a:cubicBezTo>
                  <a:lnTo>
                    <a:pt x="0" y="2954216"/>
                  </a:lnTo>
                  <a:lnTo>
                    <a:pt x="0" y="0"/>
                  </a:lnTo>
                  <a:lnTo>
                    <a:pt x="2963008" y="0"/>
                  </a:lnTo>
                  <a:lnTo>
                    <a:pt x="2963008" y="2963008"/>
                  </a:lnTo>
                  <a:lnTo>
                    <a:pt x="1812681" y="4558446"/>
                  </a:lnTo>
                  <a:close/>
                </a:path>
              </a:pathLst>
            </a:custGeom>
            <a:gradFill>
              <a:gsLst>
                <a:gs pos="64000">
                  <a:schemeClr val="accent1">
                    <a:lumMod val="60000"/>
                    <a:lumOff val="40000"/>
                    <a:alpha val="60000"/>
                  </a:schemeClr>
                </a:gs>
                <a:gs pos="95000">
                  <a:schemeClr val="accent1">
                    <a:lumMod val="30000"/>
                    <a:lumOff val="70000"/>
                    <a:alpha val="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5504988" y="5033638"/>
              <a:ext cx="1037855" cy="992985"/>
            </a:xfrm>
            <a:prstGeom prst="rect">
              <a:avLst/>
            </a:prstGeom>
            <a:solidFill>
              <a:schemeClr val="accent1">
                <a:lumMod val="60000"/>
                <a:lumOff val="40000"/>
                <a:alpha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biLevel thresh="75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338" y="18533"/>
            <a:ext cx="3238200" cy="3240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9638" y="3602553"/>
            <a:ext cx="3603600" cy="3240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8" t="4704" r="5053" b="4750"/>
          <a:stretch>
            <a:fillRect/>
          </a:stretch>
        </p:blipFill>
        <p:spPr>
          <a:xfrm>
            <a:off x="5104455" y="206443"/>
            <a:ext cx="2946400" cy="2933700"/>
          </a:xfrm>
          <a:custGeom>
            <a:avLst/>
            <a:gdLst>
              <a:gd name="connsiteX0" fmla="*/ 0 w 2946400"/>
              <a:gd name="connsiteY0" fmla="*/ 0 h 2933700"/>
              <a:gd name="connsiteX1" fmla="*/ 2946400 w 2946400"/>
              <a:gd name="connsiteY1" fmla="*/ 0 h 2933700"/>
              <a:gd name="connsiteX2" fmla="*/ 2946400 w 2946400"/>
              <a:gd name="connsiteY2" fmla="*/ 2933700 h 2933700"/>
              <a:gd name="connsiteX3" fmla="*/ 0 w 2946400"/>
              <a:gd name="connsiteY3" fmla="*/ 2933700 h 2933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46400" h="2933700">
                <a:moveTo>
                  <a:pt x="0" y="0"/>
                </a:moveTo>
                <a:lnTo>
                  <a:pt x="2946400" y="0"/>
                </a:lnTo>
                <a:lnTo>
                  <a:pt x="2946400" y="2933700"/>
                </a:lnTo>
                <a:lnTo>
                  <a:pt x="0" y="2933700"/>
                </a:lnTo>
                <a:close/>
              </a:path>
            </a:pathLst>
          </a:cu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0" t="4358" r="4582" b="4312"/>
          <a:stretch>
            <a:fillRect/>
          </a:stretch>
        </p:blipFill>
        <p:spPr>
          <a:xfrm>
            <a:off x="11968805" y="3724343"/>
            <a:ext cx="3289300" cy="2959100"/>
          </a:xfrm>
          <a:custGeom>
            <a:avLst/>
            <a:gdLst>
              <a:gd name="connsiteX0" fmla="*/ 0 w 3289300"/>
              <a:gd name="connsiteY0" fmla="*/ 0 h 2959100"/>
              <a:gd name="connsiteX1" fmla="*/ 3289300 w 3289300"/>
              <a:gd name="connsiteY1" fmla="*/ 0 h 2959100"/>
              <a:gd name="connsiteX2" fmla="*/ 3289300 w 3289300"/>
              <a:gd name="connsiteY2" fmla="*/ 2959100 h 2959100"/>
              <a:gd name="connsiteX3" fmla="*/ 0 w 3289300"/>
              <a:gd name="connsiteY3" fmla="*/ 2959100 h 295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89300" h="2959100">
                <a:moveTo>
                  <a:pt x="0" y="0"/>
                </a:moveTo>
                <a:lnTo>
                  <a:pt x="3289300" y="0"/>
                </a:lnTo>
                <a:lnTo>
                  <a:pt x="3289300" y="2959100"/>
                </a:lnTo>
                <a:lnTo>
                  <a:pt x="0" y="2959100"/>
                </a:lnTo>
                <a:close/>
              </a:path>
            </a:pathLst>
          </a:cu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" t="4704" r="5313" b="4750"/>
          <a:stretch>
            <a:fillRect/>
          </a:stretch>
        </p:blipFill>
        <p:spPr>
          <a:xfrm>
            <a:off x="12140255" y="206443"/>
            <a:ext cx="2946400" cy="2933700"/>
          </a:xfrm>
          <a:custGeom>
            <a:avLst/>
            <a:gdLst>
              <a:gd name="connsiteX0" fmla="*/ 0 w 2946400"/>
              <a:gd name="connsiteY0" fmla="*/ 0 h 2933700"/>
              <a:gd name="connsiteX1" fmla="*/ 2946400 w 2946400"/>
              <a:gd name="connsiteY1" fmla="*/ 0 h 2933700"/>
              <a:gd name="connsiteX2" fmla="*/ 2946400 w 2946400"/>
              <a:gd name="connsiteY2" fmla="*/ 2933700 h 2933700"/>
              <a:gd name="connsiteX3" fmla="*/ 0 w 2946400"/>
              <a:gd name="connsiteY3" fmla="*/ 2933700 h 2933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46400" h="2933700">
                <a:moveTo>
                  <a:pt x="0" y="0"/>
                </a:moveTo>
                <a:lnTo>
                  <a:pt x="2946400" y="0"/>
                </a:lnTo>
                <a:lnTo>
                  <a:pt x="2946400" y="2933700"/>
                </a:lnTo>
                <a:lnTo>
                  <a:pt x="0" y="2933700"/>
                </a:lnTo>
                <a:close/>
              </a:path>
            </a:pathLst>
          </a:cu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5" t="4358" r="4407" b="4312"/>
          <a:stretch>
            <a:fillRect/>
          </a:stretch>
        </p:blipFill>
        <p:spPr>
          <a:xfrm>
            <a:off x="4933005" y="3724343"/>
            <a:ext cx="3289300" cy="2959100"/>
          </a:xfrm>
          <a:custGeom>
            <a:avLst/>
            <a:gdLst>
              <a:gd name="connsiteX0" fmla="*/ 0 w 3289300"/>
              <a:gd name="connsiteY0" fmla="*/ 0 h 2959100"/>
              <a:gd name="connsiteX1" fmla="*/ 3289300 w 3289300"/>
              <a:gd name="connsiteY1" fmla="*/ 0 h 2959100"/>
              <a:gd name="connsiteX2" fmla="*/ 3289300 w 3289300"/>
              <a:gd name="connsiteY2" fmla="*/ 2959100 h 2959100"/>
              <a:gd name="connsiteX3" fmla="*/ 0 w 3289300"/>
              <a:gd name="connsiteY3" fmla="*/ 2959100 h 295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89300" h="2959100">
                <a:moveTo>
                  <a:pt x="0" y="0"/>
                </a:moveTo>
                <a:lnTo>
                  <a:pt x="3289300" y="0"/>
                </a:lnTo>
                <a:lnTo>
                  <a:pt x="3289300" y="2959100"/>
                </a:lnTo>
                <a:lnTo>
                  <a:pt x="0" y="2959100"/>
                </a:lnTo>
                <a:close/>
              </a:path>
            </a:pathLst>
          </a:custGeom>
        </p:spPr>
      </p:pic>
      <p:sp>
        <p:nvSpPr>
          <p:cNvPr id="19" name="TextBox 18"/>
          <p:cNvSpPr txBox="1"/>
          <p:nvPr/>
        </p:nvSpPr>
        <p:spPr>
          <a:xfrm>
            <a:off x="1580879" y="6085968"/>
            <a:ext cx="15456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/>
              <a:t>Joensuu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100792" y="-387282"/>
            <a:ext cx="20170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/>
              <a:t>Downtown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831905" y="340684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12954653" y="-387282"/>
            <a:ext cx="131760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/>
              <a:t>TSPDiv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160844" y="-387282"/>
            <a:ext cx="186942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/>
              <a:t>Tilo Strutz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313046" y="-387282"/>
            <a:ext cx="25292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/>
              <a:t>Keld Helsgaun</a:t>
            </a:r>
          </a:p>
        </p:txBody>
      </p:sp>
      <p:sp>
        <p:nvSpPr>
          <p:cNvPr id="25" name="Rectangle 24"/>
          <p:cNvSpPr/>
          <p:nvPr/>
        </p:nvSpPr>
        <p:spPr>
          <a:xfrm>
            <a:off x="13072281" y="2727"/>
            <a:ext cx="1082348" cy="523220"/>
          </a:xfrm>
          <a:prstGeom prst="rect">
            <a:avLst/>
          </a:prstGeom>
          <a:effectLst>
            <a:glow rad="736600">
              <a:schemeClr val="bg1"/>
            </a:glow>
          </a:effectLst>
        </p:spPr>
        <p:txBody>
          <a:bodyPr wrap="none">
            <a:spAutoFit/>
          </a:bodyPr>
          <a:lstStyle/>
          <a:p>
            <a:r>
              <a:rPr lang="en-US" sz="2800">
                <a:solidFill>
                  <a:srgbClr val="FF0000"/>
                </a:solidFill>
                <a:effectLst>
                  <a:glow rad="127000">
                    <a:schemeClr val="bg1"/>
                  </a:glow>
                </a:effectLst>
              </a:rPr>
              <a:t>95 km</a:t>
            </a:r>
          </a:p>
        </p:txBody>
      </p:sp>
      <p:sp>
        <p:nvSpPr>
          <p:cNvPr id="26" name="Rectangle 25"/>
          <p:cNvSpPr/>
          <p:nvPr/>
        </p:nvSpPr>
        <p:spPr>
          <a:xfrm>
            <a:off x="12980910" y="3571427"/>
            <a:ext cx="12650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/>
              <a:t>506 km</a:t>
            </a:r>
          </a:p>
        </p:txBody>
      </p:sp>
      <p:sp>
        <p:nvSpPr>
          <p:cNvPr id="27" name="Rectangle 26"/>
          <p:cNvSpPr/>
          <p:nvPr/>
        </p:nvSpPr>
        <p:spPr>
          <a:xfrm>
            <a:off x="9554381" y="2727"/>
            <a:ext cx="1082348" cy="523220"/>
          </a:xfrm>
          <a:prstGeom prst="rect">
            <a:avLst/>
          </a:prstGeom>
          <a:effectLst>
            <a:glow rad="736600">
              <a:schemeClr val="bg1"/>
            </a:glow>
          </a:effectLst>
        </p:spPr>
        <p:txBody>
          <a:bodyPr wrap="none">
            <a:spAutoFit/>
          </a:bodyPr>
          <a:lstStyle/>
          <a:p>
            <a:r>
              <a:rPr lang="en-US" sz="2800">
                <a:effectLst>
                  <a:glow rad="127000">
                    <a:schemeClr val="bg1"/>
                  </a:glow>
                </a:effectLst>
              </a:rPr>
              <a:t>93 km</a:t>
            </a:r>
          </a:p>
        </p:txBody>
      </p:sp>
      <p:sp>
        <p:nvSpPr>
          <p:cNvPr id="28" name="Rectangle 27"/>
          <p:cNvSpPr/>
          <p:nvPr/>
        </p:nvSpPr>
        <p:spPr>
          <a:xfrm>
            <a:off x="9463010" y="3571427"/>
            <a:ext cx="12650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>
                <a:solidFill>
                  <a:srgbClr val="FF0000"/>
                </a:solidFill>
              </a:rPr>
              <a:t>507 km</a:t>
            </a:r>
          </a:p>
        </p:txBody>
      </p:sp>
      <p:sp>
        <p:nvSpPr>
          <p:cNvPr id="29" name="Rectangle 28"/>
          <p:cNvSpPr/>
          <p:nvPr/>
        </p:nvSpPr>
        <p:spPr>
          <a:xfrm>
            <a:off x="6036481" y="2727"/>
            <a:ext cx="1082348" cy="523220"/>
          </a:xfrm>
          <a:prstGeom prst="rect">
            <a:avLst/>
          </a:prstGeom>
          <a:effectLst>
            <a:glow rad="736600">
              <a:schemeClr val="bg1"/>
            </a:glow>
          </a:effectLst>
        </p:spPr>
        <p:txBody>
          <a:bodyPr wrap="none">
            <a:spAutoFit/>
          </a:bodyPr>
          <a:lstStyle/>
          <a:p>
            <a:r>
              <a:rPr lang="en-US" sz="2800">
                <a:solidFill>
                  <a:srgbClr val="0000FF"/>
                </a:solidFill>
                <a:effectLst>
                  <a:glow rad="127000">
                    <a:schemeClr val="bg1"/>
                  </a:glow>
                </a:effectLst>
              </a:rPr>
              <a:t>88 km</a:t>
            </a:r>
          </a:p>
        </p:txBody>
      </p:sp>
      <p:sp>
        <p:nvSpPr>
          <p:cNvPr id="30" name="Rectangle 29"/>
          <p:cNvSpPr/>
          <p:nvPr/>
        </p:nvSpPr>
        <p:spPr>
          <a:xfrm>
            <a:off x="5945110" y="3571427"/>
            <a:ext cx="12650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>
                <a:solidFill>
                  <a:srgbClr val="0000FF"/>
                </a:solidFill>
              </a:rPr>
              <a:t>472 km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3" t="4702" r="5170" b="4541"/>
          <a:stretch>
            <a:fillRect/>
          </a:stretch>
        </p:blipFill>
        <p:spPr>
          <a:xfrm>
            <a:off x="8620125" y="209550"/>
            <a:ext cx="2952750" cy="2933700"/>
          </a:xfrm>
          <a:custGeom>
            <a:avLst/>
            <a:gdLst>
              <a:gd name="connsiteX0" fmla="*/ 0 w 2952750"/>
              <a:gd name="connsiteY0" fmla="*/ 0 h 2933700"/>
              <a:gd name="connsiteX1" fmla="*/ 2952750 w 2952750"/>
              <a:gd name="connsiteY1" fmla="*/ 0 h 2933700"/>
              <a:gd name="connsiteX2" fmla="*/ 2952750 w 2952750"/>
              <a:gd name="connsiteY2" fmla="*/ 2933700 h 2933700"/>
              <a:gd name="connsiteX3" fmla="*/ 0 w 2952750"/>
              <a:gd name="connsiteY3" fmla="*/ 2933700 h 2933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52750" h="2933700">
                <a:moveTo>
                  <a:pt x="0" y="0"/>
                </a:moveTo>
                <a:lnTo>
                  <a:pt x="2952750" y="0"/>
                </a:lnTo>
                <a:lnTo>
                  <a:pt x="2952750" y="2933700"/>
                </a:lnTo>
                <a:lnTo>
                  <a:pt x="0" y="293370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190544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D8FB3E46-7761-4D46-8EA7-0CE00AAF689A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41" b="4234"/>
          <a:stretch/>
        </p:blipFill>
        <p:spPr bwMode="auto">
          <a:xfrm>
            <a:off x="570071" y="774700"/>
            <a:ext cx="11204257" cy="553085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75347224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A108370-258A-4BED-A3E9-5E7B63B56A5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7" t="1493" r="1576" b="3804"/>
          <a:stretch/>
        </p:blipFill>
        <p:spPr bwMode="auto">
          <a:xfrm>
            <a:off x="511629" y="488451"/>
            <a:ext cx="11044010" cy="593356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95076801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Freeform 33"/>
          <p:cNvSpPr/>
          <p:nvPr/>
        </p:nvSpPr>
        <p:spPr>
          <a:xfrm>
            <a:off x="9444039" y="3238759"/>
            <a:ext cx="2505075" cy="2100262"/>
          </a:xfrm>
          <a:custGeom>
            <a:avLst/>
            <a:gdLst>
              <a:gd name="connsiteX0" fmla="*/ 0 w 2505075"/>
              <a:gd name="connsiteY0" fmla="*/ 1314450 h 2100262"/>
              <a:gd name="connsiteX1" fmla="*/ 0 w 2505075"/>
              <a:gd name="connsiteY1" fmla="*/ 0 h 2100262"/>
              <a:gd name="connsiteX2" fmla="*/ 1314450 w 2505075"/>
              <a:gd name="connsiteY2" fmla="*/ 0 h 2100262"/>
              <a:gd name="connsiteX3" fmla="*/ 2505075 w 2505075"/>
              <a:gd name="connsiteY3" fmla="*/ 2100262 h 2100262"/>
              <a:gd name="connsiteX4" fmla="*/ 0 w 2505075"/>
              <a:gd name="connsiteY4" fmla="*/ 1314450 h 21002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5075" h="2100262">
                <a:moveTo>
                  <a:pt x="0" y="1314450"/>
                </a:moveTo>
                <a:lnTo>
                  <a:pt x="0" y="0"/>
                </a:lnTo>
                <a:lnTo>
                  <a:pt x="1314450" y="0"/>
                </a:lnTo>
                <a:lnTo>
                  <a:pt x="2505075" y="2100262"/>
                </a:lnTo>
                <a:lnTo>
                  <a:pt x="0" y="1314450"/>
                </a:lnTo>
                <a:close/>
              </a:path>
            </a:pathLst>
          </a:custGeom>
          <a:gradFill>
            <a:gsLst>
              <a:gs pos="100000">
                <a:schemeClr val="accent1">
                  <a:lumMod val="60000"/>
                  <a:lumOff val="40000"/>
                  <a:alpha val="0"/>
                </a:schemeClr>
              </a:gs>
              <a:gs pos="52000">
                <a:schemeClr val="accent1">
                  <a:lumMod val="75000"/>
                  <a:alpha val="30000"/>
                </a:schemeClr>
              </a:gs>
            </a:gsLst>
            <a:lin ang="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87975" y="1818000"/>
            <a:ext cx="2844800" cy="504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2189" y="1818000"/>
            <a:ext cx="2844800" cy="504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53695" y="1850268"/>
            <a:ext cx="8745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/>
              <a:t>Convex</a:t>
            </a:r>
          </a:p>
          <a:p>
            <a:pPr algn="ctr"/>
            <a:r>
              <a:rPr lang="en-US" b="1"/>
              <a:t>Hull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66432" y="1850268"/>
            <a:ext cx="8294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/>
              <a:t>Coarse</a:t>
            </a:r>
          </a:p>
          <a:p>
            <a:pPr algn="ctr"/>
            <a:r>
              <a:rPr lang="en-US" b="1"/>
              <a:t>Tour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3305" y="1818000"/>
            <a:ext cx="2844800" cy="50400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0543581" y="1684021"/>
            <a:ext cx="12859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/>
              <a:t>147,817 km</a:t>
            </a:r>
          </a:p>
        </p:txBody>
      </p:sp>
      <p:sp>
        <p:nvSpPr>
          <p:cNvPr id="12" name="Rectangle 11"/>
          <p:cNvSpPr/>
          <p:nvPr/>
        </p:nvSpPr>
        <p:spPr>
          <a:xfrm>
            <a:off x="7935815" y="1684021"/>
            <a:ext cx="12859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/>
              <a:t>116,042 km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158109" y="1684021"/>
            <a:ext cx="12859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/>
              <a:t>113,598 km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190626" y="1260524"/>
            <a:ext cx="77638" cy="51758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3200580" y="1260524"/>
            <a:ext cx="77638" cy="51758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 rot="5400000">
            <a:off x="2195019" y="251370"/>
            <a:ext cx="77638" cy="209028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 rot="5400000">
            <a:off x="6630893" y="-3479651"/>
            <a:ext cx="77638" cy="89427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2171880" y="954346"/>
            <a:ext cx="77638" cy="36656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Down Arrow 18"/>
          <p:cNvSpPr/>
          <p:nvPr/>
        </p:nvSpPr>
        <p:spPr>
          <a:xfrm>
            <a:off x="11038802" y="962283"/>
            <a:ext cx="138786" cy="47466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Down Arrow 19"/>
          <p:cNvSpPr/>
          <p:nvPr/>
        </p:nvSpPr>
        <p:spPr>
          <a:xfrm>
            <a:off x="8473402" y="962283"/>
            <a:ext cx="138786" cy="47466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Down Arrow 20"/>
          <p:cNvSpPr/>
          <p:nvPr/>
        </p:nvSpPr>
        <p:spPr>
          <a:xfrm>
            <a:off x="5698452" y="962283"/>
            <a:ext cx="138786" cy="47466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4990469" y="1402081"/>
            <a:ext cx="16535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/>
              <a:t>2-5 opt + alpha</a:t>
            </a:r>
          </a:p>
        </p:txBody>
      </p:sp>
      <p:sp>
        <p:nvSpPr>
          <p:cNvPr id="23" name="Rectangle 22"/>
          <p:cNvSpPr/>
          <p:nvPr/>
        </p:nvSpPr>
        <p:spPr>
          <a:xfrm>
            <a:off x="8107049" y="1402081"/>
            <a:ext cx="8682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/>
              <a:t>2-3 opt</a:t>
            </a:r>
          </a:p>
        </p:txBody>
      </p:sp>
      <p:sp>
        <p:nvSpPr>
          <p:cNvPr id="24" name="Rectangle 23"/>
          <p:cNvSpPr/>
          <p:nvPr/>
        </p:nvSpPr>
        <p:spPr>
          <a:xfrm>
            <a:off x="10469249" y="1402081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/>
              <a:t>Random Mix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6985" y="1818000"/>
            <a:ext cx="2844800" cy="50400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5405" y="1818000"/>
            <a:ext cx="2844800" cy="50400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2" t="4575" r="5006" b="4144"/>
          <a:stretch>
            <a:fillRect/>
          </a:stretch>
        </p:blipFill>
        <p:spPr>
          <a:xfrm>
            <a:off x="9448801" y="3238759"/>
            <a:ext cx="1314450" cy="1314450"/>
          </a:xfrm>
          <a:custGeom>
            <a:avLst/>
            <a:gdLst>
              <a:gd name="connsiteX0" fmla="*/ 0 w 1314450"/>
              <a:gd name="connsiteY0" fmla="*/ 0 h 1314450"/>
              <a:gd name="connsiteX1" fmla="*/ 1314450 w 1314450"/>
              <a:gd name="connsiteY1" fmla="*/ 0 h 1314450"/>
              <a:gd name="connsiteX2" fmla="*/ 1314450 w 1314450"/>
              <a:gd name="connsiteY2" fmla="*/ 1314450 h 1314450"/>
              <a:gd name="connsiteX3" fmla="*/ 0 w 1314450"/>
              <a:gd name="connsiteY3" fmla="*/ 1314450 h 1314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4450" h="1314450">
                <a:moveTo>
                  <a:pt x="0" y="0"/>
                </a:moveTo>
                <a:lnTo>
                  <a:pt x="1314450" y="0"/>
                </a:lnTo>
                <a:lnTo>
                  <a:pt x="1314450" y="1314450"/>
                </a:lnTo>
                <a:lnTo>
                  <a:pt x="0" y="1314450"/>
                </a:lnTo>
                <a:close/>
              </a:path>
            </a:pathLst>
          </a:custGeom>
        </p:spPr>
      </p:pic>
      <p:sp>
        <p:nvSpPr>
          <p:cNvPr id="36" name="Rectangle 35"/>
          <p:cNvSpPr/>
          <p:nvPr/>
        </p:nvSpPr>
        <p:spPr>
          <a:xfrm>
            <a:off x="6549232" y="5286634"/>
            <a:ext cx="80169" cy="82754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FF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11902282" y="5292984"/>
            <a:ext cx="80169" cy="82754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FF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326256" y="2957771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87 km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9686926" y="2957771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114 km</a:t>
            </a:r>
          </a:p>
        </p:txBody>
      </p:sp>
      <p:sp>
        <p:nvSpPr>
          <p:cNvPr id="42" name="Rectangle 41"/>
          <p:cNvSpPr/>
          <p:nvPr/>
        </p:nvSpPr>
        <p:spPr>
          <a:xfrm>
            <a:off x="9301957" y="5292984"/>
            <a:ext cx="80169" cy="82754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FF"/>
              </a:solidFill>
            </a:endParaRPr>
          </a:p>
        </p:txBody>
      </p:sp>
      <p:sp>
        <p:nvSpPr>
          <p:cNvPr id="43" name="Freeform 42"/>
          <p:cNvSpPr/>
          <p:nvPr/>
        </p:nvSpPr>
        <p:spPr>
          <a:xfrm>
            <a:off x="6824664" y="3238759"/>
            <a:ext cx="2505075" cy="2100262"/>
          </a:xfrm>
          <a:custGeom>
            <a:avLst/>
            <a:gdLst>
              <a:gd name="connsiteX0" fmla="*/ 0 w 2505075"/>
              <a:gd name="connsiteY0" fmla="*/ 1314450 h 2100262"/>
              <a:gd name="connsiteX1" fmla="*/ 0 w 2505075"/>
              <a:gd name="connsiteY1" fmla="*/ 0 h 2100262"/>
              <a:gd name="connsiteX2" fmla="*/ 1314450 w 2505075"/>
              <a:gd name="connsiteY2" fmla="*/ 0 h 2100262"/>
              <a:gd name="connsiteX3" fmla="*/ 2505075 w 2505075"/>
              <a:gd name="connsiteY3" fmla="*/ 2100262 h 2100262"/>
              <a:gd name="connsiteX4" fmla="*/ 0 w 2505075"/>
              <a:gd name="connsiteY4" fmla="*/ 1314450 h 21002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5075" h="2100262">
                <a:moveTo>
                  <a:pt x="0" y="1314450"/>
                </a:moveTo>
                <a:lnTo>
                  <a:pt x="0" y="0"/>
                </a:lnTo>
                <a:lnTo>
                  <a:pt x="1314450" y="0"/>
                </a:lnTo>
                <a:lnTo>
                  <a:pt x="2505075" y="2100262"/>
                </a:lnTo>
                <a:lnTo>
                  <a:pt x="0" y="1314450"/>
                </a:lnTo>
                <a:close/>
              </a:path>
            </a:pathLst>
          </a:custGeom>
          <a:gradFill>
            <a:gsLst>
              <a:gs pos="100000">
                <a:schemeClr val="accent1">
                  <a:lumMod val="60000"/>
                  <a:lumOff val="40000"/>
                  <a:alpha val="0"/>
                </a:schemeClr>
              </a:gs>
              <a:gs pos="52000">
                <a:schemeClr val="accent1">
                  <a:lumMod val="75000"/>
                  <a:alpha val="30000"/>
                </a:schemeClr>
              </a:gs>
            </a:gsLst>
            <a:lin ang="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Freeform 44"/>
          <p:cNvSpPr/>
          <p:nvPr/>
        </p:nvSpPr>
        <p:spPr>
          <a:xfrm>
            <a:off x="4071939" y="3238759"/>
            <a:ext cx="2505075" cy="2100262"/>
          </a:xfrm>
          <a:custGeom>
            <a:avLst/>
            <a:gdLst>
              <a:gd name="connsiteX0" fmla="*/ 0 w 2505075"/>
              <a:gd name="connsiteY0" fmla="*/ 1314450 h 2100262"/>
              <a:gd name="connsiteX1" fmla="*/ 0 w 2505075"/>
              <a:gd name="connsiteY1" fmla="*/ 0 h 2100262"/>
              <a:gd name="connsiteX2" fmla="*/ 1314450 w 2505075"/>
              <a:gd name="connsiteY2" fmla="*/ 0 h 2100262"/>
              <a:gd name="connsiteX3" fmla="*/ 2505075 w 2505075"/>
              <a:gd name="connsiteY3" fmla="*/ 2100262 h 2100262"/>
              <a:gd name="connsiteX4" fmla="*/ 0 w 2505075"/>
              <a:gd name="connsiteY4" fmla="*/ 1314450 h 21002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5075" h="2100262">
                <a:moveTo>
                  <a:pt x="0" y="1314450"/>
                </a:moveTo>
                <a:lnTo>
                  <a:pt x="0" y="0"/>
                </a:lnTo>
                <a:lnTo>
                  <a:pt x="1314450" y="0"/>
                </a:lnTo>
                <a:lnTo>
                  <a:pt x="2505075" y="2100262"/>
                </a:lnTo>
                <a:lnTo>
                  <a:pt x="0" y="1314450"/>
                </a:lnTo>
                <a:close/>
              </a:path>
            </a:pathLst>
          </a:custGeom>
          <a:gradFill>
            <a:gsLst>
              <a:gs pos="100000">
                <a:schemeClr val="accent1">
                  <a:lumMod val="60000"/>
                  <a:lumOff val="40000"/>
                  <a:alpha val="0"/>
                </a:schemeClr>
              </a:gs>
              <a:gs pos="52000">
                <a:schemeClr val="accent1">
                  <a:lumMod val="75000"/>
                  <a:alpha val="30000"/>
                </a:schemeClr>
              </a:gs>
            </a:gsLst>
            <a:lin ang="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6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4" t="4575" r="4294" b="4144"/>
          <a:stretch>
            <a:fillRect/>
          </a:stretch>
        </p:blipFill>
        <p:spPr>
          <a:xfrm>
            <a:off x="4074796" y="3238759"/>
            <a:ext cx="1314450" cy="1314450"/>
          </a:xfrm>
          <a:custGeom>
            <a:avLst/>
            <a:gdLst>
              <a:gd name="connsiteX0" fmla="*/ 0 w 1314450"/>
              <a:gd name="connsiteY0" fmla="*/ 0 h 1314450"/>
              <a:gd name="connsiteX1" fmla="*/ 1314450 w 1314450"/>
              <a:gd name="connsiteY1" fmla="*/ 0 h 1314450"/>
              <a:gd name="connsiteX2" fmla="*/ 1314450 w 1314450"/>
              <a:gd name="connsiteY2" fmla="*/ 1314450 h 1314450"/>
              <a:gd name="connsiteX3" fmla="*/ 0 w 1314450"/>
              <a:gd name="connsiteY3" fmla="*/ 1314450 h 1314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4450" h="1314450">
                <a:moveTo>
                  <a:pt x="0" y="0"/>
                </a:moveTo>
                <a:lnTo>
                  <a:pt x="1314450" y="0"/>
                </a:lnTo>
                <a:lnTo>
                  <a:pt x="1314450" y="1314450"/>
                </a:lnTo>
                <a:lnTo>
                  <a:pt x="0" y="1314450"/>
                </a:lnTo>
                <a:close/>
              </a:path>
            </a:pathLst>
          </a:cu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5" t="3991" r="5204" b="5059"/>
          <a:stretch>
            <a:fillRect/>
          </a:stretch>
        </p:blipFill>
        <p:spPr>
          <a:xfrm>
            <a:off x="6824665" y="3238760"/>
            <a:ext cx="1304925" cy="1309687"/>
          </a:xfrm>
          <a:custGeom>
            <a:avLst/>
            <a:gdLst>
              <a:gd name="connsiteX0" fmla="*/ 0 w 1304925"/>
              <a:gd name="connsiteY0" fmla="*/ 0 h 1309687"/>
              <a:gd name="connsiteX1" fmla="*/ 1304925 w 1304925"/>
              <a:gd name="connsiteY1" fmla="*/ 0 h 1309687"/>
              <a:gd name="connsiteX2" fmla="*/ 1304925 w 1304925"/>
              <a:gd name="connsiteY2" fmla="*/ 1309687 h 1309687"/>
              <a:gd name="connsiteX3" fmla="*/ 0 w 1304925"/>
              <a:gd name="connsiteY3" fmla="*/ 1309687 h 13096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04925" h="1309687">
                <a:moveTo>
                  <a:pt x="0" y="0"/>
                </a:moveTo>
                <a:lnTo>
                  <a:pt x="1304925" y="0"/>
                </a:lnTo>
                <a:lnTo>
                  <a:pt x="1304925" y="1309687"/>
                </a:lnTo>
                <a:lnTo>
                  <a:pt x="0" y="1309687"/>
                </a:lnTo>
                <a:close/>
              </a:path>
            </a:pathLst>
          </a:custGeom>
        </p:spPr>
      </p:pic>
      <p:sp>
        <p:nvSpPr>
          <p:cNvPr id="46" name="TextBox 45"/>
          <p:cNvSpPr txBox="1"/>
          <p:nvPr/>
        </p:nvSpPr>
        <p:spPr>
          <a:xfrm>
            <a:off x="7160896" y="2957771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89 km</a:t>
            </a:r>
          </a:p>
        </p:txBody>
      </p:sp>
    </p:spTree>
    <p:extLst>
      <p:ext uri="{BB962C8B-B14F-4D97-AF65-F5344CB8AC3E}">
        <p14:creationId xmlns:p14="http://schemas.microsoft.com/office/powerpoint/2010/main" val="139325002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F669EBE-5195-4C58-9F2D-96760B84A6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" r="2229"/>
          <a:stretch/>
        </p:blipFill>
        <p:spPr bwMode="auto">
          <a:xfrm>
            <a:off x="1393371" y="140463"/>
            <a:ext cx="9818233" cy="657707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00473721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6C60060-9670-4401-82DD-5F67B644AE9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3094" y="433433"/>
            <a:ext cx="10205811" cy="617974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35144732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9B42966-3141-4F6A-BA2C-7E677139B09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8" t="1" b="2883"/>
          <a:stretch/>
        </p:blipFill>
        <p:spPr bwMode="auto">
          <a:xfrm>
            <a:off x="794657" y="314642"/>
            <a:ext cx="10380345" cy="637762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4082610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762138E-A3EA-4CF6-ADA8-7FB88503793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1" y="924877"/>
            <a:ext cx="10567352" cy="4768544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029048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15">
            <a:extLst>
              <a:ext uri="{FF2B5EF4-FFF2-40B4-BE49-F238E27FC236}">
                <a16:creationId xmlns:a16="http://schemas.microsoft.com/office/drawing/2014/main" id="{7C5A0B85-E2E0-41C0-8944-55AF276660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8207" y="871927"/>
            <a:ext cx="6457954" cy="27602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02" name="Line 126">
            <a:extLst>
              <a:ext uri="{FF2B5EF4-FFF2-40B4-BE49-F238E27FC236}">
                <a16:creationId xmlns:a16="http://schemas.microsoft.com/office/drawing/2014/main" id="{6F5D8A15-79DE-4303-8B70-2166AD85748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679728" y="2340864"/>
            <a:ext cx="512065" cy="658369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3" name="Line 126">
            <a:extLst>
              <a:ext uri="{FF2B5EF4-FFF2-40B4-BE49-F238E27FC236}">
                <a16:creationId xmlns:a16="http://schemas.microsoft.com/office/drawing/2014/main" id="{65603086-BBE2-4860-99AD-58FBB683B08A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229239" y="2340864"/>
            <a:ext cx="512064" cy="3657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4" name="Line 126">
            <a:extLst>
              <a:ext uri="{FF2B5EF4-FFF2-40B4-BE49-F238E27FC236}">
                <a16:creationId xmlns:a16="http://schemas.microsoft.com/office/drawing/2014/main" id="{C0CD771C-A6C2-4467-B6DA-562CA066FCF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648992" y="2369508"/>
            <a:ext cx="129755" cy="504322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5" name="Line 126">
            <a:extLst>
              <a:ext uri="{FF2B5EF4-FFF2-40B4-BE49-F238E27FC236}">
                <a16:creationId xmlns:a16="http://schemas.microsoft.com/office/drawing/2014/main" id="{9F46DF97-02D2-4EB2-9ACA-E15274A8BE35}"/>
              </a:ext>
            </a:extLst>
          </p:cNvPr>
          <p:cNvSpPr>
            <a:spLocks noChangeShapeType="1"/>
          </p:cNvSpPr>
          <p:nvPr/>
        </p:nvSpPr>
        <p:spPr bwMode="auto">
          <a:xfrm>
            <a:off x="7710563" y="1719072"/>
            <a:ext cx="950981" cy="203785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6" name="Line 126">
            <a:extLst>
              <a:ext uri="{FF2B5EF4-FFF2-40B4-BE49-F238E27FC236}">
                <a16:creationId xmlns:a16="http://schemas.microsoft.com/office/drawing/2014/main" id="{5C50FC80-D25E-4312-828F-0B13628E976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187177" y="1990779"/>
            <a:ext cx="178519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7" name="Line 126">
            <a:extLst>
              <a:ext uri="{FF2B5EF4-FFF2-40B4-BE49-F238E27FC236}">
                <a16:creationId xmlns:a16="http://schemas.microsoft.com/office/drawing/2014/main" id="{5E6164EC-0236-4131-97B8-C980C394F43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675112" y="2274715"/>
            <a:ext cx="512066" cy="59911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8" name="Line 126">
            <a:extLst>
              <a:ext uri="{FF2B5EF4-FFF2-40B4-BE49-F238E27FC236}">
                <a16:creationId xmlns:a16="http://schemas.microsoft.com/office/drawing/2014/main" id="{E911AC07-3A33-4ED8-AF21-E856072D080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365695" y="1714501"/>
            <a:ext cx="346615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9" name="Line 126">
            <a:extLst>
              <a:ext uri="{FF2B5EF4-FFF2-40B4-BE49-F238E27FC236}">
                <a16:creationId xmlns:a16="http://schemas.microsoft.com/office/drawing/2014/main" id="{E7A97CCD-3292-4992-968F-E53E1B731BF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025694" y="2617798"/>
            <a:ext cx="588568" cy="833238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 dirty="0"/>
          </a:p>
        </p:txBody>
      </p:sp>
      <p:sp>
        <p:nvSpPr>
          <p:cNvPr id="60" name="Line 126">
            <a:extLst>
              <a:ext uri="{FF2B5EF4-FFF2-40B4-BE49-F238E27FC236}">
                <a16:creationId xmlns:a16="http://schemas.microsoft.com/office/drawing/2014/main" id="{D0A7FBCD-CF05-4126-974A-6E9C9C4616EE}"/>
              </a:ext>
            </a:extLst>
          </p:cNvPr>
          <p:cNvSpPr>
            <a:spLocks noChangeShapeType="1"/>
          </p:cNvSpPr>
          <p:nvPr/>
        </p:nvSpPr>
        <p:spPr bwMode="auto">
          <a:xfrm>
            <a:off x="8240048" y="2191635"/>
            <a:ext cx="796099" cy="1237365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1" name="Line 126">
            <a:extLst>
              <a:ext uri="{FF2B5EF4-FFF2-40B4-BE49-F238E27FC236}">
                <a16:creationId xmlns:a16="http://schemas.microsoft.com/office/drawing/2014/main" id="{9EFCFB45-B032-4D66-9954-32897F891A2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8240049" y="1922857"/>
            <a:ext cx="421496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2" name="Line 126">
            <a:extLst>
              <a:ext uri="{FF2B5EF4-FFF2-40B4-BE49-F238E27FC236}">
                <a16:creationId xmlns:a16="http://schemas.microsoft.com/office/drawing/2014/main" id="{7EEEE960-20D8-4FE8-9F15-EEE9C172BFB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143354" y="1122286"/>
            <a:ext cx="331059" cy="633363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3" name="Line 126">
            <a:extLst>
              <a:ext uri="{FF2B5EF4-FFF2-40B4-BE49-F238E27FC236}">
                <a16:creationId xmlns:a16="http://schemas.microsoft.com/office/drawing/2014/main" id="{F40234CD-492C-417A-9251-78393CB136D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563494" y="1122286"/>
            <a:ext cx="579859" cy="398231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4" name="Line 126">
            <a:extLst>
              <a:ext uri="{FF2B5EF4-FFF2-40B4-BE49-F238E27FC236}">
                <a16:creationId xmlns:a16="http://schemas.microsoft.com/office/drawing/2014/main" id="{8511ECA9-4A12-453B-B01F-B5073CDD433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371572" y="1755649"/>
            <a:ext cx="1091659" cy="900450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5" name="Line 126">
            <a:extLst>
              <a:ext uri="{FF2B5EF4-FFF2-40B4-BE49-F238E27FC236}">
                <a16:creationId xmlns:a16="http://schemas.microsoft.com/office/drawing/2014/main" id="{20760976-346E-4216-9FC4-20AF67F22C8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14260" y="1499403"/>
            <a:ext cx="938051" cy="110449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pic>
        <p:nvPicPr>
          <p:cNvPr id="66" name="Picture 15">
            <a:extLst>
              <a:ext uri="{FF2B5EF4-FFF2-40B4-BE49-F238E27FC236}">
                <a16:creationId xmlns:a16="http://schemas.microsoft.com/office/drawing/2014/main" id="{67AC8779-1993-4515-82D3-F97D15308D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1212" y="3905548"/>
            <a:ext cx="6457954" cy="27602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7" name="Line 126">
            <a:extLst>
              <a:ext uri="{FF2B5EF4-FFF2-40B4-BE49-F238E27FC236}">
                <a16:creationId xmlns:a16="http://schemas.microsoft.com/office/drawing/2014/main" id="{C49D4D17-A07A-4C51-AC34-934ABA0B9FB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702733" y="5374485"/>
            <a:ext cx="512065" cy="658369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8" name="Line 126">
            <a:extLst>
              <a:ext uri="{FF2B5EF4-FFF2-40B4-BE49-F238E27FC236}">
                <a16:creationId xmlns:a16="http://schemas.microsoft.com/office/drawing/2014/main" id="{C9763BAA-EB7F-4525-906C-3D37B1ABBFB2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279055" y="5384839"/>
            <a:ext cx="369937" cy="522611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prstDash val="solid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69" name="Line 126">
            <a:extLst>
              <a:ext uri="{FF2B5EF4-FFF2-40B4-BE49-F238E27FC236}">
                <a16:creationId xmlns:a16="http://schemas.microsoft.com/office/drawing/2014/main" id="{8D1529AD-3542-438D-AE1D-17FA0207241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671997" y="5403129"/>
            <a:ext cx="129755" cy="504322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0" name="Line 126">
            <a:extLst>
              <a:ext uri="{FF2B5EF4-FFF2-40B4-BE49-F238E27FC236}">
                <a16:creationId xmlns:a16="http://schemas.microsoft.com/office/drawing/2014/main" id="{90158AA3-5B84-43E3-87BC-A3FAD25DC0D2}"/>
              </a:ext>
            </a:extLst>
          </p:cNvPr>
          <p:cNvSpPr>
            <a:spLocks noChangeShapeType="1"/>
          </p:cNvSpPr>
          <p:nvPr/>
        </p:nvSpPr>
        <p:spPr bwMode="auto">
          <a:xfrm>
            <a:off x="7733568" y="4752693"/>
            <a:ext cx="950981" cy="203785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1" name="Line 126">
            <a:extLst>
              <a:ext uri="{FF2B5EF4-FFF2-40B4-BE49-F238E27FC236}">
                <a16:creationId xmlns:a16="http://schemas.microsoft.com/office/drawing/2014/main" id="{1D587CC5-16C6-4C8C-8FC4-53F167447C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210182" y="5024400"/>
            <a:ext cx="178519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2" name="Line 126">
            <a:extLst>
              <a:ext uri="{FF2B5EF4-FFF2-40B4-BE49-F238E27FC236}">
                <a16:creationId xmlns:a16="http://schemas.microsoft.com/office/drawing/2014/main" id="{9752AC35-9EBD-433E-BBEC-5491D7808A1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824757" y="5308336"/>
            <a:ext cx="385426" cy="94793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3" name="Line 126">
            <a:extLst>
              <a:ext uri="{FF2B5EF4-FFF2-40B4-BE49-F238E27FC236}">
                <a16:creationId xmlns:a16="http://schemas.microsoft.com/office/drawing/2014/main" id="{8AC00F8A-F288-4C78-A483-E9613C4DC82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388700" y="4748122"/>
            <a:ext cx="346615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4" name="Line 126">
            <a:extLst>
              <a:ext uri="{FF2B5EF4-FFF2-40B4-BE49-F238E27FC236}">
                <a16:creationId xmlns:a16="http://schemas.microsoft.com/office/drawing/2014/main" id="{106387EA-D08A-4953-BAF0-B5097680649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048699" y="5651419"/>
            <a:ext cx="588568" cy="833238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5" name="Line 126">
            <a:extLst>
              <a:ext uri="{FF2B5EF4-FFF2-40B4-BE49-F238E27FC236}">
                <a16:creationId xmlns:a16="http://schemas.microsoft.com/office/drawing/2014/main" id="{8C272253-8BE1-4256-A0DF-F3A117211600}"/>
              </a:ext>
            </a:extLst>
          </p:cNvPr>
          <p:cNvSpPr>
            <a:spLocks noChangeShapeType="1"/>
          </p:cNvSpPr>
          <p:nvPr/>
        </p:nvSpPr>
        <p:spPr bwMode="auto">
          <a:xfrm>
            <a:off x="8263053" y="5225256"/>
            <a:ext cx="796099" cy="1237365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6" name="Line 126">
            <a:extLst>
              <a:ext uri="{FF2B5EF4-FFF2-40B4-BE49-F238E27FC236}">
                <a16:creationId xmlns:a16="http://schemas.microsoft.com/office/drawing/2014/main" id="{6CD4BB46-EE43-430C-A9B4-77E3FB436FC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8263054" y="4956478"/>
            <a:ext cx="421496" cy="283936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7" name="Line 126">
            <a:extLst>
              <a:ext uri="{FF2B5EF4-FFF2-40B4-BE49-F238E27FC236}">
                <a16:creationId xmlns:a16="http://schemas.microsoft.com/office/drawing/2014/main" id="{E0829877-6707-4794-A280-D6DFE6BC7E1E}"/>
              </a:ext>
            </a:extLst>
          </p:cNvPr>
          <p:cNvSpPr>
            <a:spLocks noChangeShapeType="1"/>
          </p:cNvSpPr>
          <p:nvPr/>
        </p:nvSpPr>
        <p:spPr bwMode="auto">
          <a:xfrm>
            <a:off x="11166359" y="4155907"/>
            <a:ext cx="331059" cy="633363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8" name="Line 126">
            <a:extLst>
              <a:ext uri="{FF2B5EF4-FFF2-40B4-BE49-F238E27FC236}">
                <a16:creationId xmlns:a16="http://schemas.microsoft.com/office/drawing/2014/main" id="{8675B968-573E-4C71-B64A-AFE69FF6A8E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389595" y="4576316"/>
            <a:ext cx="198649" cy="1106454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79" name="Line 126">
            <a:extLst>
              <a:ext uri="{FF2B5EF4-FFF2-40B4-BE49-F238E27FC236}">
                <a16:creationId xmlns:a16="http://schemas.microsoft.com/office/drawing/2014/main" id="{BA8CB170-EDA0-4836-94BB-2AE7C767DFF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88245" y="4178083"/>
            <a:ext cx="578114" cy="376057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80" name="Line 126">
            <a:extLst>
              <a:ext uri="{FF2B5EF4-FFF2-40B4-BE49-F238E27FC236}">
                <a16:creationId xmlns:a16="http://schemas.microsoft.com/office/drawing/2014/main" id="{1FB0B6CD-43A8-4B36-B235-BCFB7C54CF25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9637265" y="5637520"/>
            <a:ext cx="718143" cy="45250"/>
          </a:xfrm>
          <a:prstGeom prst="line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/>
          </a:p>
        </p:txBody>
      </p:sp>
      <p:sp>
        <p:nvSpPr>
          <p:cNvPr id="542" name="Arrow: Right 97">
            <a:extLst>
              <a:ext uri="{FF2B5EF4-FFF2-40B4-BE49-F238E27FC236}">
                <a16:creationId xmlns:a16="http://schemas.microsoft.com/office/drawing/2014/main" id="{6D0DDDD2-B43A-4883-9DA3-5643CA9A56FF}"/>
              </a:ext>
            </a:extLst>
          </p:cNvPr>
          <p:cNvSpPr>
            <a:spLocks noChangeArrowheads="1"/>
          </p:cNvSpPr>
          <p:nvPr/>
        </p:nvSpPr>
        <p:spPr bwMode="auto">
          <a:xfrm rot="5400000">
            <a:off x="8282316" y="3611808"/>
            <a:ext cx="496382" cy="325767"/>
          </a:xfrm>
          <a:prstGeom prst="rightArrow">
            <a:avLst>
              <a:gd name="adj1" fmla="val 50000"/>
              <a:gd name="adj2" fmla="val 49934"/>
            </a:avLst>
          </a:prstGeom>
          <a:solidFill>
            <a:schemeClr val="accent1"/>
          </a:solidFill>
          <a:ln w="38100" algn="ctr">
            <a:noFill/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777A1303-9D07-42FA-A98E-74C8E632C001}"/>
              </a:ext>
            </a:extLst>
          </p:cNvPr>
          <p:cNvSpPr/>
          <p:nvPr/>
        </p:nvSpPr>
        <p:spPr>
          <a:xfrm>
            <a:off x="10094610" y="2405187"/>
            <a:ext cx="521595" cy="504322"/>
          </a:xfrm>
          <a:prstGeom prst="ellipse">
            <a:avLst/>
          </a:prstGeom>
          <a:solidFill>
            <a:srgbClr val="0000FF">
              <a:alpha val="20000"/>
            </a:srgbClr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C791CF50-13C1-49EE-8F53-2860370FBBF3}"/>
              </a:ext>
            </a:extLst>
          </p:cNvPr>
          <p:cNvSpPr/>
          <p:nvPr/>
        </p:nvSpPr>
        <p:spPr>
          <a:xfrm>
            <a:off x="10109647" y="5451841"/>
            <a:ext cx="521595" cy="504322"/>
          </a:xfrm>
          <a:prstGeom prst="ellipse">
            <a:avLst/>
          </a:prstGeom>
          <a:solidFill>
            <a:srgbClr val="0000FF">
              <a:alpha val="20000"/>
            </a:srgbClr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5" name="Line 126">
            <a:extLst>
              <a:ext uri="{FF2B5EF4-FFF2-40B4-BE49-F238E27FC236}">
                <a16:creationId xmlns:a16="http://schemas.microsoft.com/office/drawing/2014/main" id="{6436C983-7A38-4BDF-9ED9-447E8ACEA2D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247186" y="2831250"/>
            <a:ext cx="890892" cy="457300"/>
          </a:xfrm>
          <a:prstGeom prst="line">
            <a:avLst/>
          </a:prstGeom>
          <a:noFill/>
          <a:ln w="38100">
            <a:solidFill>
              <a:srgbClr val="FF0000"/>
            </a:solidFill>
            <a:prstDash val="sysDot"/>
            <a:round/>
            <a:headEnd/>
            <a:tailEnd type="triangle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06" name="Line 126">
            <a:extLst>
              <a:ext uri="{FF2B5EF4-FFF2-40B4-BE49-F238E27FC236}">
                <a16:creationId xmlns:a16="http://schemas.microsoft.com/office/drawing/2014/main" id="{55D9DA18-7382-4E38-AE19-73FD7B6B6ADD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9761679" y="2603899"/>
            <a:ext cx="321605" cy="35164"/>
          </a:xfrm>
          <a:prstGeom prst="line">
            <a:avLst/>
          </a:prstGeom>
          <a:noFill/>
          <a:ln w="38100">
            <a:solidFill>
              <a:srgbClr val="FF0000"/>
            </a:solidFill>
            <a:prstDash val="sysDot"/>
            <a:round/>
            <a:headEnd/>
            <a:tailEnd type="triangle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07" name="Line 126">
            <a:extLst>
              <a:ext uri="{FF2B5EF4-FFF2-40B4-BE49-F238E27FC236}">
                <a16:creationId xmlns:a16="http://schemas.microsoft.com/office/drawing/2014/main" id="{B75FBA4A-2387-4709-9AE9-8F3A4F59F83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415040" y="1643070"/>
            <a:ext cx="82408" cy="734370"/>
          </a:xfrm>
          <a:prstGeom prst="line">
            <a:avLst/>
          </a:prstGeom>
          <a:noFill/>
          <a:ln w="38100">
            <a:solidFill>
              <a:srgbClr val="FF0000"/>
            </a:solidFill>
            <a:prstDash val="sysDot"/>
            <a:round/>
            <a:headEnd/>
            <a:tailEnd type="triangle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endParaRPr lang="en-US" dirty="0">
              <a:highlight>
                <a:srgbClr val="FF00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378003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9" name="Picture 1038">
            <a:extLst>
              <a:ext uri="{FF2B5EF4-FFF2-40B4-BE49-F238E27FC236}">
                <a16:creationId xmlns:a16="http://schemas.microsoft.com/office/drawing/2014/main" id="{7ED46E18-CA0D-4036-B58F-4A675F7299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5638" y="753591"/>
            <a:ext cx="5799600" cy="5270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4309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7D72D39-2475-4BD5-A136-C06D0D0A31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4" t="1901" b="2861"/>
          <a:stretch/>
        </p:blipFill>
        <p:spPr bwMode="auto">
          <a:xfrm>
            <a:off x="962025" y="428942"/>
            <a:ext cx="10433050" cy="603782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7353144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5" name="Group 284">
            <a:extLst>
              <a:ext uri="{FF2B5EF4-FFF2-40B4-BE49-F238E27FC236}">
                <a16:creationId xmlns:a16="http://schemas.microsoft.com/office/drawing/2014/main" id="{41129D9C-EF46-4950-B411-41E23282CF8C}"/>
              </a:ext>
            </a:extLst>
          </p:cNvPr>
          <p:cNvGrpSpPr/>
          <p:nvPr/>
        </p:nvGrpSpPr>
        <p:grpSpPr>
          <a:xfrm>
            <a:off x="10594584" y="1423593"/>
            <a:ext cx="788340" cy="1025921"/>
            <a:chOff x="11032734" y="1137843"/>
            <a:chExt cx="788340" cy="1025921"/>
          </a:xfrm>
        </p:grpSpPr>
        <p:sp>
          <p:nvSpPr>
            <p:cNvPr id="282" name="Freeform: Shape 281">
              <a:extLst>
                <a:ext uri="{FF2B5EF4-FFF2-40B4-BE49-F238E27FC236}">
                  <a16:creationId xmlns:a16="http://schemas.microsoft.com/office/drawing/2014/main" id="{45FC31B8-4622-45E1-AA72-1FA1FA58BC5E}"/>
                </a:ext>
              </a:extLst>
            </p:cNvPr>
            <p:cNvSpPr/>
            <p:nvPr/>
          </p:nvSpPr>
          <p:spPr>
            <a:xfrm>
              <a:off x="11032734" y="1674202"/>
              <a:ext cx="25198" cy="489562"/>
            </a:xfrm>
            <a:custGeom>
              <a:avLst/>
              <a:gdLst>
                <a:gd name="connsiteX0" fmla="*/ 0 w 33338"/>
                <a:gd name="connsiteY0" fmla="*/ 0 h 647700"/>
                <a:gd name="connsiteX1" fmla="*/ 33338 w 33338"/>
                <a:gd name="connsiteY1" fmla="*/ 647700 h 647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338" h="647700">
                  <a:moveTo>
                    <a:pt x="0" y="0"/>
                  </a:moveTo>
                  <a:lnTo>
                    <a:pt x="33338" y="647700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Freeform: Shape 282">
              <a:extLst>
                <a:ext uri="{FF2B5EF4-FFF2-40B4-BE49-F238E27FC236}">
                  <a16:creationId xmlns:a16="http://schemas.microsoft.com/office/drawing/2014/main" id="{1C8B7B31-4118-43D3-B9B1-3EC07C407AA1}"/>
                </a:ext>
              </a:extLst>
            </p:cNvPr>
            <p:cNvSpPr/>
            <p:nvPr/>
          </p:nvSpPr>
          <p:spPr>
            <a:xfrm>
              <a:off x="11345910" y="1764195"/>
              <a:ext cx="475164" cy="273579"/>
            </a:xfrm>
            <a:custGeom>
              <a:avLst/>
              <a:gdLst>
                <a:gd name="connsiteX0" fmla="*/ 628650 w 628650"/>
                <a:gd name="connsiteY0" fmla="*/ 361950 h 361950"/>
                <a:gd name="connsiteX1" fmla="*/ 0 w 628650"/>
                <a:gd name="connsiteY1" fmla="*/ 0 h 3619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28650" h="361950">
                  <a:moveTo>
                    <a:pt x="628650" y="361950"/>
                  </a:moveTo>
                  <a:lnTo>
                    <a:pt x="0" y="0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4" name="Freeform: Shape 283">
              <a:extLst>
                <a:ext uri="{FF2B5EF4-FFF2-40B4-BE49-F238E27FC236}">
                  <a16:creationId xmlns:a16="http://schemas.microsoft.com/office/drawing/2014/main" id="{7DE3A132-5055-41FB-9B45-C6A3DFEE4C7B}"/>
                </a:ext>
              </a:extLst>
            </p:cNvPr>
            <p:cNvSpPr/>
            <p:nvPr/>
          </p:nvSpPr>
          <p:spPr>
            <a:xfrm>
              <a:off x="11039934" y="1137843"/>
              <a:ext cx="219584" cy="547158"/>
            </a:xfrm>
            <a:custGeom>
              <a:avLst/>
              <a:gdLst>
                <a:gd name="connsiteX0" fmla="*/ 290513 w 290513"/>
                <a:gd name="connsiteY0" fmla="*/ 0 h 723900"/>
                <a:gd name="connsiteX1" fmla="*/ 0 w 290513"/>
                <a:gd name="connsiteY1" fmla="*/ 723900 h 7239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0513" h="723900">
                  <a:moveTo>
                    <a:pt x="290513" y="0"/>
                  </a:moveTo>
                  <a:lnTo>
                    <a:pt x="0" y="723900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9" name="Freeform: Shape 168">
            <a:extLst>
              <a:ext uri="{FF2B5EF4-FFF2-40B4-BE49-F238E27FC236}">
                <a16:creationId xmlns:a16="http://schemas.microsoft.com/office/drawing/2014/main" id="{83AE80EA-23F5-4C57-9936-C3EEB6F5FA49}"/>
              </a:ext>
            </a:extLst>
          </p:cNvPr>
          <p:cNvSpPr/>
          <p:nvPr/>
        </p:nvSpPr>
        <p:spPr>
          <a:xfrm>
            <a:off x="219040" y="2526500"/>
            <a:ext cx="2159834" cy="2023045"/>
          </a:xfrm>
          <a:custGeom>
            <a:avLst/>
            <a:gdLst>
              <a:gd name="connsiteX0" fmla="*/ 1219200 w 2857500"/>
              <a:gd name="connsiteY0" fmla="*/ 138112 h 2676525"/>
              <a:gd name="connsiteX1" fmla="*/ 1628775 w 2857500"/>
              <a:gd name="connsiteY1" fmla="*/ 0 h 2676525"/>
              <a:gd name="connsiteX2" fmla="*/ 1652588 w 2857500"/>
              <a:gd name="connsiteY2" fmla="*/ 504825 h 2676525"/>
              <a:gd name="connsiteX3" fmla="*/ 1347788 w 2857500"/>
              <a:gd name="connsiteY3" fmla="*/ 1214437 h 2676525"/>
              <a:gd name="connsiteX4" fmla="*/ 1757363 w 2857500"/>
              <a:gd name="connsiteY4" fmla="*/ 1323975 h 2676525"/>
              <a:gd name="connsiteX5" fmla="*/ 2405063 w 2857500"/>
              <a:gd name="connsiteY5" fmla="*/ 1690687 h 2676525"/>
              <a:gd name="connsiteX6" fmla="*/ 2857500 w 2857500"/>
              <a:gd name="connsiteY6" fmla="*/ 1671637 h 2676525"/>
              <a:gd name="connsiteX7" fmla="*/ 2571750 w 2857500"/>
              <a:gd name="connsiteY7" fmla="*/ 2333625 h 2676525"/>
              <a:gd name="connsiteX8" fmla="*/ 2276475 w 2857500"/>
              <a:gd name="connsiteY8" fmla="*/ 2043112 h 2676525"/>
              <a:gd name="connsiteX9" fmla="*/ 1381125 w 2857500"/>
              <a:gd name="connsiteY9" fmla="*/ 1847850 h 2676525"/>
              <a:gd name="connsiteX10" fmla="*/ 1071563 w 2857500"/>
              <a:gd name="connsiteY10" fmla="*/ 1824037 h 2676525"/>
              <a:gd name="connsiteX11" fmla="*/ 642938 w 2857500"/>
              <a:gd name="connsiteY11" fmla="*/ 2205037 h 2676525"/>
              <a:gd name="connsiteX12" fmla="*/ 504825 w 2857500"/>
              <a:gd name="connsiteY12" fmla="*/ 2519362 h 2676525"/>
              <a:gd name="connsiteX13" fmla="*/ 138113 w 2857500"/>
              <a:gd name="connsiteY13" fmla="*/ 2676525 h 2676525"/>
              <a:gd name="connsiteX14" fmla="*/ 0 w 2857500"/>
              <a:gd name="connsiteY14" fmla="*/ 2200275 h 2676525"/>
              <a:gd name="connsiteX15" fmla="*/ 1219200 w 2857500"/>
              <a:gd name="connsiteY15" fmla="*/ 138112 h 2676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857500" h="2676525">
                <a:moveTo>
                  <a:pt x="1219200" y="138112"/>
                </a:moveTo>
                <a:lnTo>
                  <a:pt x="1628775" y="0"/>
                </a:lnTo>
                <a:lnTo>
                  <a:pt x="1652588" y="504825"/>
                </a:lnTo>
                <a:lnTo>
                  <a:pt x="1347788" y="1214437"/>
                </a:lnTo>
                <a:lnTo>
                  <a:pt x="1757363" y="1323975"/>
                </a:lnTo>
                <a:lnTo>
                  <a:pt x="2405063" y="1690687"/>
                </a:lnTo>
                <a:lnTo>
                  <a:pt x="2857500" y="1671637"/>
                </a:lnTo>
                <a:lnTo>
                  <a:pt x="2571750" y="2333625"/>
                </a:lnTo>
                <a:lnTo>
                  <a:pt x="2276475" y="2043112"/>
                </a:lnTo>
                <a:lnTo>
                  <a:pt x="1381125" y="1847850"/>
                </a:lnTo>
                <a:lnTo>
                  <a:pt x="1071563" y="1824037"/>
                </a:lnTo>
                <a:lnTo>
                  <a:pt x="642938" y="2205037"/>
                </a:lnTo>
                <a:lnTo>
                  <a:pt x="504825" y="2519362"/>
                </a:lnTo>
                <a:lnTo>
                  <a:pt x="138113" y="2676525"/>
                </a:lnTo>
                <a:lnTo>
                  <a:pt x="0" y="2200275"/>
                </a:lnTo>
                <a:lnTo>
                  <a:pt x="1219200" y="138112"/>
                </a:lnTo>
                <a:close/>
              </a:path>
            </a:pathLst>
          </a:custGeom>
          <a:noFill/>
          <a:ln w="254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3CAF9B77-3A22-4D2D-B668-B980FC8F5257}"/>
              </a:ext>
            </a:extLst>
          </p:cNvPr>
          <p:cNvGrpSpPr/>
          <p:nvPr/>
        </p:nvGrpSpPr>
        <p:grpSpPr>
          <a:xfrm>
            <a:off x="6160832" y="834943"/>
            <a:ext cx="3004691" cy="2630863"/>
            <a:chOff x="187441" y="1575815"/>
            <a:chExt cx="3975260" cy="3892990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12930E29-4E6E-4DA7-AA97-20EF601A244F}"/>
                </a:ext>
              </a:extLst>
            </p:cNvPr>
            <p:cNvCxnSpPr/>
            <p:nvPr/>
          </p:nvCxnSpPr>
          <p:spPr>
            <a:xfrm>
              <a:off x="2190939" y="1575815"/>
              <a:ext cx="0" cy="3892990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14CB465-5B5D-4EF3-9217-B6276C54E965}"/>
                </a:ext>
              </a:extLst>
            </p:cNvPr>
            <p:cNvCxnSpPr>
              <a:cxnSpLocks/>
            </p:cNvCxnSpPr>
            <p:nvPr/>
          </p:nvCxnSpPr>
          <p:spPr>
            <a:xfrm>
              <a:off x="187441" y="3548543"/>
              <a:ext cx="397526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7C09DE2-2FA3-4C64-99F5-8C82FACAEDE0}"/>
              </a:ext>
            </a:extLst>
          </p:cNvPr>
          <p:cNvGrpSpPr/>
          <p:nvPr/>
        </p:nvGrpSpPr>
        <p:grpSpPr>
          <a:xfrm>
            <a:off x="6503660" y="997317"/>
            <a:ext cx="2261318" cy="2124530"/>
            <a:chOff x="5682793" y="1639519"/>
            <a:chExt cx="2991765" cy="2810791"/>
          </a:xfrm>
        </p:grpSpPr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E4DBEE16-7B0A-41D1-84F4-AFA66C5B9673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AE3C08AD-833D-40EC-AFD9-2AF9F5650448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605B3813-9DFE-4B0A-B778-BBB581D984C6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C23E4997-2928-4E89-BD9F-79366D8C6EF8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25CB3468-3805-41D0-A629-6ECA1AF9C1F5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31D5248C-D59A-4B1E-AE29-A410A7087767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DE572C36-FEF9-4129-8E69-81A60B39D3DF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D7B904F8-38A6-4379-BC0F-89D80B434176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921288F5-3413-4BC0-B41C-248B1F857052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539DF38F-B94B-4EDC-BD57-5A392C96DD6D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3D864075-82B5-42BB-9CEC-F1BDC4F7C339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7096CDE5-D0B0-46FE-9427-420A504CDB83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E76CFFB6-A632-4B4D-A093-E972534345B3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91A24114-2E2E-4F02-B353-BF5734AF7BB1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4AA177A7-7983-49CA-9EF2-6EC5FA1E37F1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0A35C34C-F5C7-49D4-B27B-E11DBF2DC16F}"/>
              </a:ext>
            </a:extLst>
          </p:cNvPr>
          <p:cNvGrpSpPr/>
          <p:nvPr/>
        </p:nvGrpSpPr>
        <p:grpSpPr>
          <a:xfrm>
            <a:off x="160418" y="2479124"/>
            <a:ext cx="2261318" cy="2124530"/>
            <a:chOff x="5682793" y="1639519"/>
            <a:chExt cx="2991765" cy="2810791"/>
          </a:xfrm>
        </p:grpSpPr>
        <p:sp>
          <p:nvSpPr>
            <p:cNvPr id="96" name="Oval 95">
              <a:extLst>
                <a:ext uri="{FF2B5EF4-FFF2-40B4-BE49-F238E27FC236}">
                  <a16:creationId xmlns:a16="http://schemas.microsoft.com/office/drawing/2014/main" id="{F4A50AA1-011D-4502-867B-410D0096FCDD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Oval 96">
              <a:extLst>
                <a:ext uri="{FF2B5EF4-FFF2-40B4-BE49-F238E27FC236}">
                  <a16:creationId xmlns:a16="http://schemas.microsoft.com/office/drawing/2014/main" id="{8C4F5DE8-3FD7-4520-A76F-107B43C7172A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8C95A4FE-7600-4475-8FBA-891A8A610304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Oval 98">
              <a:extLst>
                <a:ext uri="{FF2B5EF4-FFF2-40B4-BE49-F238E27FC236}">
                  <a16:creationId xmlns:a16="http://schemas.microsoft.com/office/drawing/2014/main" id="{F426E76A-44FA-4D97-AF7F-68F85382AED6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Oval 99">
              <a:extLst>
                <a:ext uri="{FF2B5EF4-FFF2-40B4-BE49-F238E27FC236}">
                  <a16:creationId xmlns:a16="http://schemas.microsoft.com/office/drawing/2014/main" id="{924D9D55-1EBF-4B59-B392-8AC357DF0126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Oval 100">
              <a:extLst>
                <a:ext uri="{FF2B5EF4-FFF2-40B4-BE49-F238E27FC236}">
                  <a16:creationId xmlns:a16="http://schemas.microsoft.com/office/drawing/2014/main" id="{B7F9A046-15E2-4F19-BEA9-518748D37A99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Oval 101">
              <a:extLst>
                <a:ext uri="{FF2B5EF4-FFF2-40B4-BE49-F238E27FC236}">
                  <a16:creationId xmlns:a16="http://schemas.microsoft.com/office/drawing/2014/main" id="{95B79DA8-2683-4BE7-A897-31E9FBBBBDB3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Oval 102">
              <a:extLst>
                <a:ext uri="{FF2B5EF4-FFF2-40B4-BE49-F238E27FC236}">
                  <a16:creationId xmlns:a16="http://schemas.microsoft.com/office/drawing/2014/main" id="{F5F85C11-8C34-4876-8798-CD31D843172F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Oval 103">
              <a:extLst>
                <a:ext uri="{FF2B5EF4-FFF2-40B4-BE49-F238E27FC236}">
                  <a16:creationId xmlns:a16="http://schemas.microsoft.com/office/drawing/2014/main" id="{819A4A05-E9C9-480F-A053-F35391AE2D07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Oval 104">
              <a:extLst>
                <a:ext uri="{FF2B5EF4-FFF2-40B4-BE49-F238E27FC236}">
                  <a16:creationId xmlns:a16="http://schemas.microsoft.com/office/drawing/2014/main" id="{099C9853-7996-4A8B-BF42-A3C937F8B946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Oval 105">
              <a:extLst>
                <a:ext uri="{FF2B5EF4-FFF2-40B4-BE49-F238E27FC236}">
                  <a16:creationId xmlns:a16="http://schemas.microsoft.com/office/drawing/2014/main" id="{FCBAD78D-BE86-48C5-A5AA-A4DB0F7D4EC1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Oval 106">
              <a:extLst>
                <a:ext uri="{FF2B5EF4-FFF2-40B4-BE49-F238E27FC236}">
                  <a16:creationId xmlns:a16="http://schemas.microsoft.com/office/drawing/2014/main" id="{BA646F01-EC71-4466-A363-5CD9A4B5C0EE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Oval 107">
              <a:extLst>
                <a:ext uri="{FF2B5EF4-FFF2-40B4-BE49-F238E27FC236}">
                  <a16:creationId xmlns:a16="http://schemas.microsoft.com/office/drawing/2014/main" id="{C457EB06-BDDB-4EAC-BB84-0C59CB96214C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A41A2BEC-8691-4DBA-ABAF-6CC5891805AE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61378BAA-AD15-4518-909F-16AC47156FCA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97E498C5-7B6C-4194-9CE3-FCF79D0FE446}"/>
              </a:ext>
            </a:extLst>
          </p:cNvPr>
          <p:cNvGrpSpPr/>
          <p:nvPr/>
        </p:nvGrpSpPr>
        <p:grpSpPr>
          <a:xfrm>
            <a:off x="3360633" y="994797"/>
            <a:ext cx="2261318" cy="2124530"/>
            <a:chOff x="5682793" y="1639519"/>
            <a:chExt cx="2991765" cy="2810791"/>
          </a:xfrm>
        </p:grpSpPr>
        <p:sp>
          <p:nvSpPr>
            <p:cNvPr id="113" name="Oval 112">
              <a:extLst>
                <a:ext uri="{FF2B5EF4-FFF2-40B4-BE49-F238E27FC236}">
                  <a16:creationId xmlns:a16="http://schemas.microsoft.com/office/drawing/2014/main" id="{80B21501-AC7E-4D9C-BA59-C114E22175E9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Oval 113">
              <a:extLst>
                <a:ext uri="{FF2B5EF4-FFF2-40B4-BE49-F238E27FC236}">
                  <a16:creationId xmlns:a16="http://schemas.microsoft.com/office/drawing/2014/main" id="{491047F9-0C86-4D2B-B8CA-708F2CFD610F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Oval 114">
              <a:extLst>
                <a:ext uri="{FF2B5EF4-FFF2-40B4-BE49-F238E27FC236}">
                  <a16:creationId xmlns:a16="http://schemas.microsoft.com/office/drawing/2014/main" id="{26208779-9053-4540-8195-79CDAA75F2DD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C28E84BA-DD0A-454A-A204-4CA4004523C9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EC135486-E82D-449A-AD43-17D5E683CED2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74610062-F828-4AC5-B8F4-0580D8DD2726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8617D616-D85E-45BC-8AE7-E4358FB3407A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61BA3381-4131-48AB-8276-4484548094DC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4778E521-33EE-4ED2-A080-9236F1D55AEC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Oval 121">
              <a:extLst>
                <a:ext uri="{FF2B5EF4-FFF2-40B4-BE49-F238E27FC236}">
                  <a16:creationId xmlns:a16="http://schemas.microsoft.com/office/drawing/2014/main" id="{0195D668-829C-4997-B374-CCA103B6FD46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Oval 122">
              <a:extLst>
                <a:ext uri="{FF2B5EF4-FFF2-40B4-BE49-F238E27FC236}">
                  <a16:creationId xmlns:a16="http://schemas.microsoft.com/office/drawing/2014/main" id="{458AC7EB-CF55-4F29-AA29-5AE1829DF3CC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Oval 123">
              <a:extLst>
                <a:ext uri="{FF2B5EF4-FFF2-40B4-BE49-F238E27FC236}">
                  <a16:creationId xmlns:a16="http://schemas.microsoft.com/office/drawing/2014/main" id="{84C8E255-6CD9-40F4-A254-A4CCD5DBFDE9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Oval 124">
              <a:extLst>
                <a:ext uri="{FF2B5EF4-FFF2-40B4-BE49-F238E27FC236}">
                  <a16:creationId xmlns:a16="http://schemas.microsoft.com/office/drawing/2014/main" id="{E602CA7C-5670-4887-8A61-7E9367C2AF69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Oval 125">
              <a:extLst>
                <a:ext uri="{FF2B5EF4-FFF2-40B4-BE49-F238E27FC236}">
                  <a16:creationId xmlns:a16="http://schemas.microsoft.com/office/drawing/2014/main" id="{A5BD3E82-8ABF-4E0B-B419-59E9BE528945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Oval 126">
              <a:extLst>
                <a:ext uri="{FF2B5EF4-FFF2-40B4-BE49-F238E27FC236}">
                  <a16:creationId xmlns:a16="http://schemas.microsoft.com/office/drawing/2014/main" id="{0AE930DF-E5A5-404C-98BD-0F3697DE5EFD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8" name="Oval 127">
            <a:extLst>
              <a:ext uri="{FF2B5EF4-FFF2-40B4-BE49-F238E27FC236}">
                <a16:creationId xmlns:a16="http://schemas.microsoft.com/office/drawing/2014/main" id="{E993A297-B62F-477B-A272-DE7A03CD006D}"/>
              </a:ext>
            </a:extLst>
          </p:cNvPr>
          <p:cNvSpPr/>
          <p:nvPr/>
        </p:nvSpPr>
        <p:spPr>
          <a:xfrm>
            <a:off x="3582189" y="2772370"/>
            <a:ext cx="152755" cy="152755"/>
          </a:xfrm>
          <a:prstGeom prst="ellipse">
            <a:avLst/>
          </a:prstGeom>
          <a:solidFill>
            <a:srgbClr val="0000FF">
              <a:alpha val="44000"/>
            </a:srgbClr>
          </a:solidFill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351FBB29-75F6-46B7-AE24-3D86BB86B3E2}"/>
              </a:ext>
            </a:extLst>
          </p:cNvPr>
          <p:cNvSpPr/>
          <p:nvPr/>
        </p:nvSpPr>
        <p:spPr>
          <a:xfrm>
            <a:off x="4388871" y="2134972"/>
            <a:ext cx="152755" cy="152755"/>
          </a:xfrm>
          <a:prstGeom prst="ellipse">
            <a:avLst/>
          </a:prstGeom>
          <a:solidFill>
            <a:srgbClr val="0000FF">
              <a:alpha val="44000"/>
            </a:srgbClr>
          </a:solidFill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Oval 129">
            <a:extLst>
              <a:ext uri="{FF2B5EF4-FFF2-40B4-BE49-F238E27FC236}">
                <a16:creationId xmlns:a16="http://schemas.microsoft.com/office/drawing/2014/main" id="{B0137506-A8F1-4F28-BACB-894FED1EB196}"/>
              </a:ext>
            </a:extLst>
          </p:cNvPr>
          <p:cNvSpPr/>
          <p:nvPr/>
        </p:nvSpPr>
        <p:spPr>
          <a:xfrm>
            <a:off x="4465248" y="1148375"/>
            <a:ext cx="152755" cy="152755"/>
          </a:xfrm>
          <a:prstGeom prst="ellipse">
            <a:avLst/>
          </a:prstGeom>
          <a:solidFill>
            <a:srgbClr val="0000FF">
              <a:alpha val="44000"/>
            </a:srgbClr>
          </a:solidFill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DC2BB7A0-0613-4435-A28C-AAF165886D68}"/>
              </a:ext>
            </a:extLst>
          </p:cNvPr>
          <p:cNvSpPr/>
          <p:nvPr/>
        </p:nvSpPr>
        <p:spPr>
          <a:xfrm>
            <a:off x="5245872" y="2446625"/>
            <a:ext cx="152755" cy="152755"/>
          </a:xfrm>
          <a:prstGeom prst="ellipse">
            <a:avLst/>
          </a:prstGeom>
          <a:solidFill>
            <a:srgbClr val="0000FF">
              <a:alpha val="44000"/>
            </a:srgbClr>
          </a:solidFill>
          <a:ln>
            <a:solidFill>
              <a:srgbClr val="0000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81" name="Group 280">
            <a:extLst>
              <a:ext uri="{FF2B5EF4-FFF2-40B4-BE49-F238E27FC236}">
                <a16:creationId xmlns:a16="http://schemas.microsoft.com/office/drawing/2014/main" id="{AA9DB2A0-FF7C-49A4-89D8-C973FF1237A3}"/>
              </a:ext>
            </a:extLst>
          </p:cNvPr>
          <p:cNvGrpSpPr/>
          <p:nvPr/>
        </p:nvGrpSpPr>
        <p:grpSpPr>
          <a:xfrm>
            <a:off x="3131618" y="1435444"/>
            <a:ext cx="2603629" cy="1938049"/>
            <a:chOff x="3569768" y="1149694"/>
            <a:chExt cx="2603629" cy="1938049"/>
          </a:xfrm>
        </p:grpSpPr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69C957EF-2FC2-43A3-96A4-7D8AE585193B}"/>
                </a:ext>
              </a:extLst>
            </p:cNvPr>
            <p:cNvCxnSpPr>
              <a:cxnSpLocks/>
            </p:cNvCxnSpPr>
            <p:nvPr/>
          </p:nvCxnSpPr>
          <p:spPr>
            <a:xfrm>
              <a:off x="3802727" y="1365418"/>
              <a:ext cx="1813474" cy="86306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024DFCCE-F10B-43A9-84D1-BCE2AFFA500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30234" y="1469568"/>
              <a:ext cx="587351" cy="1403334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0BDAA033-F8BA-4294-9E78-F881EB078F9D}"/>
                </a:ext>
              </a:extLst>
            </p:cNvPr>
            <p:cNvCxnSpPr>
              <a:cxnSpLocks/>
            </p:cNvCxnSpPr>
            <p:nvPr/>
          </p:nvCxnSpPr>
          <p:spPr>
            <a:xfrm>
              <a:off x="3802727" y="1393332"/>
              <a:ext cx="1193138" cy="147721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E333E551-437C-4B62-AE5D-8DD199BDF18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30813" y="1149694"/>
              <a:ext cx="542584" cy="302030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464A1B34-86AB-48A2-ADA4-33591E98A6C9}"/>
                </a:ext>
              </a:extLst>
            </p:cNvPr>
            <p:cNvCxnSpPr>
              <a:cxnSpLocks/>
            </p:cNvCxnSpPr>
            <p:nvPr/>
          </p:nvCxnSpPr>
          <p:spPr>
            <a:xfrm>
              <a:off x="5023636" y="2891322"/>
              <a:ext cx="32517" cy="196421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C12CED7C-4CEE-4D1D-B4B7-B40E25A3DFA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69768" y="1237539"/>
              <a:ext cx="216700" cy="129041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4" name="TextBox 163">
            <a:extLst>
              <a:ext uri="{FF2B5EF4-FFF2-40B4-BE49-F238E27FC236}">
                <a16:creationId xmlns:a16="http://schemas.microsoft.com/office/drawing/2014/main" id="{034243F5-B2A2-4611-BAB1-AF6FBC0B81CA}"/>
              </a:ext>
            </a:extLst>
          </p:cNvPr>
          <p:cNvSpPr txBox="1"/>
          <p:nvPr/>
        </p:nvSpPr>
        <p:spPr>
          <a:xfrm>
            <a:off x="3723259" y="285750"/>
            <a:ext cx="1500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/>
              <a:t>K-Means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37991F51-35A8-43F7-A51B-9ABD65673F5D}"/>
              </a:ext>
            </a:extLst>
          </p:cNvPr>
          <p:cNvSpPr txBox="1"/>
          <p:nvPr/>
        </p:nvSpPr>
        <p:spPr>
          <a:xfrm>
            <a:off x="7251050" y="285750"/>
            <a:ext cx="8226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/>
              <a:t>Grid</a:t>
            </a:r>
          </a:p>
        </p:txBody>
      </p:sp>
      <p:grpSp>
        <p:nvGrpSpPr>
          <p:cNvPr id="167" name="Group 166">
            <a:extLst>
              <a:ext uri="{FF2B5EF4-FFF2-40B4-BE49-F238E27FC236}">
                <a16:creationId xmlns:a16="http://schemas.microsoft.com/office/drawing/2014/main" id="{1719DC99-B296-4CF1-A35B-B86F95C35820}"/>
              </a:ext>
            </a:extLst>
          </p:cNvPr>
          <p:cNvGrpSpPr/>
          <p:nvPr/>
        </p:nvGrpSpPr>
        <p:grpSpPr>
          <a:xfrm>
            <a:off x="9519121" y="285750"/>
            <a:ext cx="2261318" cy="2834928"/>
            <a:chOff x="9680978" y="0"/>
            <a:chExt cx="2261318" cy="2834928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77849247-C850-47ED-932A-2C89954EA6D4}"/>
                </a:ext>
              </a:extLst>
            </p:cNvPr>
            <p:cNvGrpSpPr/>
            <p:nvPr/>
          </p:nvGrpSpPr>
          <p:grpSpPr>
            <a:xfrm>
              <a:off x="9730520" y="759872"/>
              <a:ext cx="2163434" cy="2026645"/>
              <a:chOff x="5748338" y="1704975"/>
              <a:chExt cx="2862262" cy="2681288"/>
            </a:xfrm>
          </p:grpSpPr>
          <p:sp>
            <p:nvSpPr>
              <p:cNvPr id="84" name="Freeform: Shape 83">
                <a:extLst>
                  <a:ext uri="{FF2B5EF4-FFF2-40B4-BE49-F238E27FC236}">
                    <a16:creationId xmlns:a16="http://schemas.microsoft.com/office/drawing/2014/main" id="{16C11D50-2EBC-4687-85DF-6857D9EA0AD8}"/>
                  </a:ext>
                </a:extLst>
              </p:cNvPr>
              <p:cNvSpPr/>
              <p:nvPr/>
            </p:nvSpPr>
            <p:spPr>
              <a:xfrm>
                <a:off x="6972300" y="1704975"/>
                <a:ext cx="428625" cy="509588"/>
              </a:xfrm>
              <a:custGeom>
                <a:avLst/>
                <a:gdLst>
                  <a:gd name="connsiteX0" fmla="*/ 0 w 428625"/>
                  <a:gd name="connsiteY0" fmla="*/ 147638 h 509588"/>
                  <a:gd name="connsiteX1" fmla="*/ 404813 w 428625"/>
                  <a:gd name="connsiteY1" fmla="*/ 0 h 509588"/>
                  <a:gd name="connsiteX2" fmla="*/ 428625 w 428625"/>
                  <a:gd name="connsiteY2" fmla="*/ 509588 h 5095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28625" h="509588">
                    <a:moveTo>
                      <a:pt x="0" y="147638"/>
                    </a:moveTo>
                    <a:lnTo>
                      <a:pt x="404813" y="0"/>
                    </a:lnTo>
                    <a:lnTo>
                      <a:pt x="428625" y="509588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Freeform: Shape 84">
                <a:extLst>
                  <a:ext uri="{FF2B5EF4-FFF2-40B4-BE49-F238E27FC236}">
                    <a16:creationId xmlns:a16="http://schemas.microsoft.com/office/drawing/2014/main" id="{B7B1B1CA-03F3-462E-B0E2-940168ADAA17}"/>
                  </a:ext>
                </a:extLst>
              </p:cNvPr>
              <p:cNvSpPr/>
              <p:nvPr/>
            </p:nvSpPr>
            <p:spPr>
              <a:xfrm>
                <a:off x="7100888" y="2914650"/>
                <a:ext cx="419100" cy="123825"/>
              </a:xfrm>
              <a:custGeom>
                <a:avLst/>
                <a:gdLst>
                  <a:gd name="connsiteX0" fmla="*/ 0 w 419100"/>
                  <a:gd name="connsiteY0" fmla="*/ 0 h 123825"/>
                  <a:gd name="connsiteX1" fmla="*/ 419100 w 419100"/>
                  <a:gd name="connsiteY1" fmla="*/ 123825 h 1238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19100" h="123825">
                    <a:moveTo>
                      <a:pt x="0" y="0"/>
                    </a:moveTo>
                    <a:lnTo>
                      <a:pt x="419100" y="123825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Freeform: Shape 85">
                <a:extLst>
                  <a:ext uri="{FF2B5EF4-FFF2-40B4-BE49-F238E27FC236}">
                    <a16:creationId xmlns:a16="http://schemas.microsoft.com/office/drawing/2014/main" id="{B6FBFF11-AB9E-4378-8576-77E1C1ABA57F}"/>
                  </a:ext>
                </a:extLst>
              </p:cNvPr>
              <p:cNvSpPr/>
              <p:nvPr/>
            </p:nvSpPr>
            <p:spPr>
              <a:xfrm>
                <a:off x="8029575" y="3371850"/>
                <a:ext cx="581025" cy="666750"/>
              </a:xfrm>
              <a:custGeom>
                <a:avLst/>
                <a:gdLst>
                  <a:gd name="connsiteX0" fmla="*/ 581025 w 581025"/>
                  <a:gd name="connsiteY0" fmla="*/ 0 h 666750"/>
                  <a:gd name="connsiteX1" fmla="*/ 123825 w 581025"/>
                  <a:gd name="connsiteY1" fmla="*/ 33338 h 666750"/>
                  <a:gd name="connsiteX2" fmla="*/ 0 w 581025"/>
                  <a:gd name="connsiteY2" fmla="*/ 390525 h 666750"/>
                  <a:gd name="connsiteX3" fmla="*/ 295275 w 581025"/>
                  <a:gd name="connsiteY3" fmla="*/ 666750 h 6667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581025" h="666750">
                    <a:moveTo>
                      <a:pt x="581025" y="0"/>
                    </a:moveTo>
                    <a:lnTo>
                      <a:pt x="123825" y="33338"/>
                    </a:lnTo>
                    <a:lnTo>
                      <a:pt x="0" y="390525"/>
                    </a:lnTo>
                    <a:lnTo>
                      <a:pt x="295275" y="666750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Freeform: Shape 86">
                <a:extLst>
                  <a:ext uri="{FF2B5EF4-FFF2-40B4-BE49-F238E27FC236}">
                    <a16:creationId xmlns:a16="http://schemas.microsoft.com/office/drawing/2014/main" id="{9C0E33C8-679E-4856-9CB4-4BC4B7DFA6F8}"/>
                  </a:ext>
                </a:extLst>
              </p:cNvPr>
              <p:cNvSpPr/>
              <p:nvPr/>
            </p:nvSpPr>
            <p:spPr>
              <a:xfrm>
                <a:off x="5748338" y="3538538"/>
                <a:ext cx="1385887" cy="847725"/>
              </a:xfrm>
              <a:custGeom>
                <a:avLst/>
                <a:gdLst>
                  <a:gd name="connsiteX0" fmla="*/ 0 w 1385887"/>
                  <a:gd name="connsiteY0" fmla="*/ 361950 h 847725"/>
                  <a:gd name="connsiteX1" fmla="*/ 142875 w 1385887"/>
                  <a:gd name="connsiteY1" fmla="*/ 847725 h 847725"/>
                  <a:gd name="connsiteX2" fmla="*/ 509587 w 1385887"/>
                  <a:gd name="connsiteY2" fmla="*/ 690562 h 847725"/>
                  <a:gd name="connsiteX3" fmla="*/ 647700 w 1385887"/>
                  <a:gd name="connsiteY3" fmla="*/ 376237 h 847725"/>
                  <a:gd name="connsiteX4" fmla="*/ 1076325 w 1385887"/>
                  <a:gd name="connsiteY4" fmla="*/ 0 h 847725"/>
                  <a:gd name="connsiteX5" fmla="*/ 1385887 w 1385887"/>
                  <a:gd name="connsiteY5" fmla="*/ 23812 h 8477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385887" h="847725">
                    <a:moveTo>
                      <a:pt x="0" y="361950"/>
                    </a:moveTo>
                    <a:lnTo>
                      <a:pt x="142875" y="847725"/>
                    </a:lnTo>
                    <a:lnTo>
                      <a:pt x="509587" y="690562"/>
                    </a:lnTo>
                    <a:lnTo>
                      <a:pt x="647700" y="376237"/>
                    </a:lnTo>
                    <a:lnTo>
                      <a:pt x="1076325" y="0"/>
                    </a:lnTo>
                    <a:lnTo>
                      <a:pt x="1385887" y="23812"/>
                    </a:lnTo>
                  </a:path>
                </a:pathLst>
              </a:custGeom>
              <a:noFill/>
              <a:ln w="254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53CE77E5-F0B9-499D-9AC6-7B476BA21A98}"/>
                </a:ext>
              </a:extLst>
            </p:cNvPr>
            <p:cNvGrpSpPr/>
            <p:nvPr/>
          </p:nvGrpSpPr>
          <p:grpSpPr>
            <a:xfrm>
              <a:off x="9680978" y="710398"/>
              <a:ext cx="2261318" cy="2124530"/>
              <a:chOff x="5682793" y="1639519"/>
              <a:chExt cx="2991765" cy="2810791"/>
            </a:xfrm>
          </p:grpSpPr>
          <p:sp>
            <p:nvSpPr>
              <p:cNvPr id="68" name="Oval 67">
                <a:extLst>
                  <a:ext uri="{FF2B5EF4-FFF2-40B4-BE49-F238E27FC236}">
                    <a16:creationId xmlns:a16="http://schemas.microsoft.com/office/drawing/2014/main" id="{2976646B-718B-42B1-8092-6B303E0D71FB}"/>
                  </a:ext>
                </a:extLst>
              </p:cNvPr>
              <p:cNvSpPr/>
              <p:nvPr/>
            </p:nvSpPr>
            <p:spPr>
              <a:xfrm rot="20234264">
                <a:off x="6905168" y="1788744"/>
                <a:ext cx="134265" cy="134265"/>
              </a:xfrm>
              <a:prstGeom prst="ellipse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Oval 68">
                <a:extLst>
                  <a:ext uri="{FF2B5EF4-FFF2-40B4-BE49-F238E27FC236}">
                    <a16:creationId xmlns:a16="http://schemas.microsoft.com/office/drawing/2014/main" id="{5DA6F189-4663-4F42-85E3-3D8F337A31A6}"/>
                  </a:ext>
                </a:extLst>
              </p:cNvPr>
              <p:cNvSpPr/>
              <p:nvPr/>
            </p:nvSpPr>
            <p:spPr>
              <a:xfrm rot="20234264">
                <a:off x="7311569" y="1639519"/>
                <a:ext cx="134265" cy="134265"/>
              </a:xfrm>
              <a:prstGeom prst="ellipse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Oval 69">
                <a:extLst>
                  <a:ext uri="{FF2B5EF4-FFF2-40B4-BE49-F238E27FC236}">
                    <a16:creationId xmlns:a16="http://schemas.microsoft.com/office/drawing/2014/main" id="{C2B21966-681D-4022-8F8C-6B4D98901AC9}"/>
                  </a:ext>
                </a:extLst>
              </p:cNvPr>
              <p:cNvSpPr/>
              <p:nvPr/>
            </p:nvSpPr>
            <p:spPr>
              <a:xfrm rot="20234264">
                <a:off x="7333794" y="2144344"/>
                <a:ext cx="134265" cy="134265"/>
              </a:xfrm>
              <a:prstGeom prst="ellipse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Oval 70">
                <a:extLst>
                  <a:ext uri="{FF2B5EF4-FFF2-40B4-BE49-F238E27FC236}">
                    <a16:creationId xmlns:a16="http://schemas.microsoft.com/office/drawing/2014/main" id="{7C4D1046-0EF9-4B8E-B97F-D777EFBF034F}"/>
                  </a:ext>
                </a:extLst>
              </p:cNvPr>
              <p:cNvSpPr/>
              <p:nvPr/>
            </p:nvSpPr>
            <p:spPr>
              <a:xfrm rot="20234264">
                <a:off x="7035344" y="2852369"/>
                <a:ext cx="134265" cy="134265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Oval 71">
                <a:extLst>
                  <a:ext uri="{FF2B5EF4-FFF2-40B4-BE49-F238E27FC236}">
                    <a16:creationId xmlns:a16="http://schemas.microsoft.com/office/drawing/2014/main" id="{0889A556-F79E-4110-9911-481CAD009301}"/>
                  </a:ext>
                </a:extLst>
              </p:cNvPr>
              <p:cNvSpPr/>
              <p:nvPr/>
            </p:nvSpPr>
            <p:spPr>
              <a:xfrm rot="20234264">
                <a:off x="7444919" y="2963495"/>
                <a:ext cx="134265" cy="134265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Oval 72">
                <a:extLst>
                  <a:ext uri="{FF2B5EF4-FFF2-40B4-BE49-F238E27FC236}">
                    <a16:creationId xmlns:a16="http://schemas.microsoft.com/office/drawing/2014/main" id="{D4223F67-47AA-4DAC-8606-3D89A9F92999}"/>
                  </a:ext>
                </a:extLst>
              </p:cNvPr>
              <p:cNvSpPr/>
              <p:nvPr/>
            </p:nvSpPr>
            <p:spPr>
              <a:xfrm rot="20234264">
                <a:off x="8087856" y="3334970"/>
                <a:ext cx="134265" cy="134265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530277A2-DAED-4349-849D-EFB97508920E}"/>
                  </a:ext>
                </a:extLst>
              </p:cNvPr>
              <p:cNvSpPr/>
              <p:nvPr/>
            </p:nvSpPr>
            <p:spPr>
              <a:xfrm rot="20234264">
                <a:off x="8540293" y="3311158"/>
                <a:ext cx="134265" cy="134265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Oval 74">
                <a:extLst>
                  <a:ext uri="{FF2B5EF4-FFF2-40B4-BE49-F238E27FC236}">
                    <a16:creationId xmlns:a16="http://schemas.microsoft.com/office/drawing/2014/main" id="{FFD85482-3A24-44E7-8AB0-CE46A9BB8C51}"/>
                  </a:ext>
                </a:extLst>
              </p:cNvPr>
              <p:cNvSpPr/>
              <p:nvPr/>
            </p:nvSpPr>
            <p:spPr>
              <a:xfrm rot="20234264">
                <a:off x="8254543" y="3968382"/>
                <a:ext cx="134265" cy="134265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Oval 75">
                <a:extLst>
                  <a:ext uri="{FF2B5EF4-FFF2-40B4-BE49-F238E27FC236}">
                    <a16:creationId xmlns:a16="http://schemas.microsoft.com/office/drawing/2014/main" id="{A74CF9BF-348E-4C82-AE53-309C30172A0F}"/>
                  </a:ext>
                </a:extLst>
              </p:cNvPr>
              <p:cNvSpPr/>
              <p:nvPr/>
            </p:nvSpPr>
            <p:spPr>
              <a:xfrm rot="20234264">
                <a:off x="7959267" y="3687394"/>
                <a:ext cx="134265" cy="134265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Oval 76">
                <a:extLst>
                  <a:ext uri="{FF2B5EF4-FFF2-40B4-BE49-F238E27FC236}">
                    <a16:creationId xmlns:a16="http://schemas.microsoft.com/office/drawing/2014/main" id="{8C68FA85-D97D-4EA5-B33F-997690A9EC67}"/>
                  </a:ext>
                </a:extLst>
              </p:cNvPr>
              <p:cNvSpPr/>
              <p:nvPr/>
            </p:nvSpPr>
            <p:spPr>
              <a:xfrm rot="20234264">
                <a:off x="7063917" y="3492131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Oval 77">
                <a:extLst>
                  <a:ext uri="{FF2B5EF4-FFF2-40B4-BE49-F238E27FC236}">
                    <a16:creationId xmlns:a16="http://schemas.microsoft.com/office/drawing/2014/main" id="{A242F46C-728E-4C8A-B470-EA01E4AEEB35}"/>
                  </a:ext>
                </a:extLst>
              </p:cNvPr>
              <p:cNvSpPr/>
              <p:nvPr/>
            </p:nvSpPr>
            <p:spPr>
              <a:xfrm rot="20234264">
                <a:off x="6754354" y="3468319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" name="Oval 78">
                <a:extLst>
                  <a:ext uri="{FF2B5EF4-FFF2-40B4-BE49-F238E27FC236}">
                    <a16:creationId xmlns:a16="http://schemas.microsoft.com/office/drawing/2014/main" id="{53887D1B-96E3-41D5-AE84-E6DC69DA7EA7}"/>
                  </a:ext>
                </a:extLst>
              </p:cNvPr>
              <p:cNvSpPr/>
              <p:nvPr/>
            </p:nvSpPr>
            <p:spPr>
              <a:xfrm rot="20234264">
                <a:off x="6330492" y="3849319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Oval 79">
                <a:extLst>
                  <a:ext uri="{FF2B5EF4-FFF2-40B4-BE49-F238E27FC236}">
                    <a16:creationId xmlns:a16="http://schemas.microsoft.com/office/drawing/2014/main" id="{B5A57984-6297-48E3-9D82-71D81740368A}"/>
                  </a:ext>
                </a:extLst>
              </p:cNvPr>
              <p:cNvSpPr/>
              <p:nvPr/>
            </p:nvSpPr>
            <p:spPr>
              <a:xfrm rot="20234264">
                <a:off x="6187617" y="4158881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1" name="Oval 80">
                <a:extLst>
                  <a:ext uri="{FF2B5EF4-FFF2-40B4-BE49-F238E27FC236}">
                    <a16:creationId xmlns:a16="http://schemas.microsoft.com/office/drawing/2014/main" id="{E205321E-F4FE-4AF2-96A7-986A766F431F}"/>
                  </a:ext>
                </a:extLst>
              </p:cNvPr>
              <p:cNvSpPr/>
              <p:nvPr/>
            </p:nvSpPr>
            <p:spPr>
              <a:xfrm rot="20234264">
                <a:off x="5820904" y="4316045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Oval 81">
                <a:extLst>
                  <a:ext uri="{FF2B5EF4-FFF2-40B4-BE49-F238E27FC236}">
                    <a16:creationId xmlns:a16="http://schemas.microsoft.com/office/drawing/2014/main" id="{AB01803B-92A0-4DA2-AE5E-E5C90E57CCA4}"/>
                  </a:ext>
                </a:extLst>
              </p:cNvPr>
              <p:cNvSpPr/>
              <p:nvPr/>
            </p:nvSpPr>
            <p:spPr>
              <a:xfrm rot="20234264">
                <a:off x="5682793" y="3839795"/>
                <a:ext cx="134265" cy="134265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9C9A22A3-175E-4810-854A-2E3FB3853370}"/>
                </a:ext>
              </a:extLst>
            </p:cNvPr>
            <p:cNvSpPr txBox="1"/>
            <p:nvPr/>
          </p:nvSpPr>
          <p:spPr>
            <a:xfrm>
              <a:off x="9961051" y="0"/>
              <a:ext cx="176202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/>
                <a:t>Single Link</a:t>
              </a:r>
            </a:p>
          </p:txBody>
        </p:sp>
      </p:grpSp>
      <p:sp>
        <p:nvSpPr>
          <p:cNvPr id="168" name="TextBox 167">
            <a:extLst>
              <a:ext uri="{FF2B5EF4-FFF2-40B4-BE49-F238E27FC236}">
                <a16:creationId xmlns:a16="http://schemas.microsoft.com/office/drawing/2014/main" id="{82088CE2-4797-49FE-804C-FD9E1A011908}"/>
              </a:ext>
            </a:extLst>
          </p:cNvPr>
          <p:cNvSpPr txBox="1"/>
          <p:nvPr/>
        </p:nvSpPr>
        <p:spPr>
          <a:xfrm>
            <a:off x="753680" y="1780876"/>
            <a:ext cx="11208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/>
              <a:t>INPUT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0B5B9802-F291-402B-A159-3DFB45B0608E}"/>
              </a:ext>
            </a:extLst>
          </p:cNvPr>
          <p:cNvSpPr txBox="1"/>
          <p:nvPr/>
        </p:nvSpPr>
        <p:spPr>
          <a:xfrm>
            <a:off x="932738" y="4225861"/>
            <a:ext cx="11999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solidFill>
                  <a:schemeClr val="bg1">
                    <a:lumMod val="65000"/>
                  </a:schemeClr>
                </a:solidFill>
              </a:rPr>
              <a:t>Optimum</a:t>
            </a:r>
          </a:p>
        </p:txBody>
      </p:sp>
      <p:sp>
        <p:nvSpPr>
          <p:cNvPr id="171" name="Arrow: Right 170">
            <a:extLst>
              <a:ext uri="{FF2B5EF4-FFF2-40B4-BE49-F238E27FC236}">
                <a16:creationId xmlns:a16="http://schemas.microsoft.com/office/drawing/2014/main" id="{FFF8E2D5-2C70-47DD-B39D-95D358017B76}"/>
              </a:ext>
            </a:extLst>
          </p:cNvPr>
          <p:cNvSpPr/>
          <p:nvPr/>
        </p:nvSpPr>
        <p:spPr>
          <a:xfrm rot="13982367">
            <a:off x="846922" y="4107434"/>
            <a:ext cx="249695" cy="196421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Freeform: Shape 176">
            <a:extLst>
              <a:ext uri="{FF2B5EF4-FFF2-40B4-BE49-F238E27FC236}">
                <a16:creationId xmlns:a16="http://schemas.microsoft.com/office/drawing/2014/main" id="{785B4DB7-DFC5-446E-BB63-837125FA659A}"/>
              </a:ext>
            </a:extLst>
          </p:cNvPr>
          <p:cNvSpPr/>
          <p:nvPr/>
        </p:nvSpPr>
        <p:spPr>
          <a:xfrm>
            <a:off x="9587877" y="3721319"/>
            <a:ext cx="2159834" cy="2023045"/>
          </a:xfrm>
          <a:custGeom>
            <a:avLst/>
            <a:gdLst>
              <a:gd name="connsiteX0" fmla="*/ 1219200 w 2857500"/>
              <a:gd name="connsiteY0" fmla="*/ 138112 h 2676525"/>
              <a:gd name="connsiteX1" fmla="*/ 1628775 w 2857500"/>
              <a:gd name="connsiteY1" fmla="*/ 0 h 2676525"/>
              <a:gd name="connsiteX2" fmla="*/ 1652588 w 2857500"/>
              <a:gd name="connsiteY2" fmla="*/ 504825 h 2676525"/>
              <a:gd name="connsiteX3" fmla="*/ 1347788 w 2857500"/>
              <a:gd name="connsiteY3" fmla="*/ 1214437 h 2676525"/>
              <a:gd name="connsiteX4" fmla="*/ 1757363 w 2857500"/>
              <a:gd name="connsiteY4" fmla="*/ 1323975 h 2676525"/>
              <a:gd name="connsiteX5" fmla="*/ 2405063 w 2857500"/>
              <a:gd name="connsiteY5" fmla="*/ 1690687 h 2676525"/>
              <a:gd name="connsiteX6" fmla="*/ 2857500 w 2857500"/>
              <a:gd name="connsiteY6" fmla="*/ 1671637 h 2676525"/>
              <a:gd name="connsiteX7" fmla="*/ 2571750 w 2857500"/>
              <a:gd name="connsiteY7" fmla="*/ 2333625 h 2676525"/>
              <a:gd name="connsiteX8" fmla="*/ 2276475 w 2857500"/>
              <a:gd name="connsiteY8" fmla="*/ 2043112 h 2676525"/>
              <a:gd name="connsiteX9" fmla="*/ 1381125 w 2857500"/>
              <a:gd name="connsiteY9" fmla="*/ 1847850 h 2676525"/>
              <a:gd name="connsiteX10" fmla="*/ 1071563 w 2857500"/>
              <a:gd name="connsiteY10" fmla="*/ 1824037 h 2676525"/>
              <a:gd name="connsiteX11" fmla="*/ 642938 w 2857500"/>
              <a:gd name="connsiteY11" fmla="*/ 2205037 h 2676525"/>
              <a:gd name="connsiteX12" fmla="*/ 504825 w 2857500"/>
              <a:gd name="connsiteY12" fmla="*/ 2519362 h 2676525"/>
              <a:gd name="connsiteX13" fmla="*/ 138113 w 2857500"/>
              <a:gd name="connsiteY13" fmla="*/ 2676525 h 2676525"/>
              <a:gd name="connsiteX14" fmla="*/ 0 w 2857500"/>
              <a:gd name="connsiteY14" fmla="*/ 2200275 h 2676525"/>
              <a:gd name="connsiteX15" fmla="*/ 1219200 w 2857500"/>
              <a:gd name="connsiteY15" fmla="*/ 138112 h 2676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857500" h="2676525">
                <a:moveTo>
                  <a:pt x="1219200" y="138112"/>
                </a:moveTo>
                <a:lnTo>
                  <a:pt x="1628775" y="0"/>
                </a:lnTo>
                <a:lnTo>
                  <a:pt x="1652588" y="504825"/>
                </a:lnTo>
                <a:lnTo>
                  <a:pt x="1347788" y="1214437"/>
                </a:lnTo>
                <a:lnTo>
                  <a:pt x="1757363" y="1323975"/>
                </a:lnTo>
                <a:lnTo>
                  <a:pt x="2405063" y="1690687"/>
                </a:lnTo>
                <a:lnTo>
                  <a:pt x="2857500" y="1671637"/>
                </a:lnTo>
                <a:lnTo>
                  <a:pt x="2571750" y="2333625"/>
                </a:lnTo>
                <a:lnTo>
                  <a:pt x="2276475" y="2043112"/>
                </a:lnTo>
                <a:lnTo>
                  <a:pt x="1381125" y="1847850"/>
                </a:lnTo>
                <a:lnTo>
                  <a:pt x="1071563" y="1824037"/>
                </a:lnTo>
                <a:lnTo>
                  <a:pt x="642938" y="2205037"/>
                </a:lnTo>
                <a:lnTo>
                  <a:pt x="504825" y="2519362"/>
                </a:lnTo>
                <a:lnTo>
                  <a:pt x="138113" y="2676525"/>
                </a:lnTo>
                <a:lnTo>
                  <a:pt x="0" y="2200275"/>
                </a:lnTo>
                <a:lnTo>
                  <a:pt x="1219200" y="138112"/>
                </a:lnTo>
                <a:close/>
              </a:path>
            </a:pathLst>
          </a:custGeom>
          <a:noFill/>
          <a:ln w="254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Freeform: Shape 177">
            <a:extLst>
              <a:ext uri="{FF2B5EF4-FFF2-40B4-BE49-F238E27FC236}">
                <a16:creationId xmlns:a16="http://schemas.microsoft.com/office/drawing/2014/main" id="{3FD61413-0EE4-463C-A40C-79666AEFCDC2}"/>
              </a:ext>
            </a:extLst>
          </p:cNvPr>
          <p:cNvSpPr/>
          <p:nvPr/>
        </p:nvSpPr>
        <p:spPr>
          <a:xfrm>
            <a:off x="6555441" y="3721319"/>
            <a:ext cx="2159834" cy="2023045"/>
          </a:xfrm>
          <a:custGeom>
            <a:avLst/>
            <a:gdLst>
              <a:gd name="connsiteX0" fmla="*/ 1219200 w 2857500"/>
              <a:gd name="connsiteY0" fmla="*/ 138112 h 2676525"/>
              <a:gd name="connsiteX1" fmla="*/ 1628775 w 2857500"/>
              <a:gd name="connsiteY1" fmla="*/ 0 h 2676525"/>
              <a:gd name="connsiteX2" fmla="*/ 1652588 w 2857500"/>
              <a:gd name="connsiteY2" fmla="*/ 504825 h 2676525"/>
              <a:gd name="connsiteX3" fmla="*/ 1347788 w 2857500"/>
              <a:gd name="connsiteY3" fmla="*/ 1214437 h 2676525"/>
              <a:gd name="connsiteX4" fmla="*/ 1757363 w 2857500"/>
              <a:gd name="connsiteY4" fmla="*/ 1323975 h 2676525"/>
              <a:gd name="connsiteX5" fmla="*/ 2405063 w 2857500"/>
              <a:gd name="connsiteY5" fmla="*/ 1690687 h 2676525"/>
              <a:gd name="connsiteX6" fmla="*/ 2857500 w 2857500"/>
              <a:gd name="connsiteY6" fmla="*/ 1671637 h 2676525"/>
              <a:gd name="connsiteX7" fmla="*/ 2571750 w 2857500"/>
              <a:gd name="connsiteY7" fmla="*/ 2333625 h 2676525"/>
              <a:gd name="connsiteX8" fmla="*/ 2276475 w 2857500"/>
              <a:gd name="connsiteY8" fmla="*/ 2043112 h 2676525"/>
              <a:gd name="connsiteX9" fmla="*/ 1381125 w 2857500"/>
              <a:gd name="connsiteY9" fmla="*/ 1847850 h 2676525"/>
              <a:gd name="connsiteX10" fmla="*/ 1071563 w 2857500"/>
              <a:gd name="connsiteY10" fmla="*/ 1824037 h 2676525"/>
              <a:gd name="connsiteX11" fmla="*/ 642938 w 2857500"/>
              <a:gd name="connsiteY11" fmla="*/ 2205037 h 2676525"/>
              <a:gd name="connsiteX12" fmla="*/ 504825 w 2857500"/>
              <a:gd name="connsiteY12" fmla="*/ 2519362 h 2676525"/>
              <a:gd name="connsiteX13" fmla="*/ 138113 w 2857500"/>
              <a:gd name="connsiteY13" fmla="*/ 2676525 h 2676525"/>
              <a:gd name="connsiteX14" fmla="*/ 0 w 2857500"/>
              <a:gd name="connsiteY14" fmla="*/ 2200275 h 2676525"/>
              <a:gd name="connsiteX15" fmla="*/ 1219200 w 2857500"/>
              <a:gd name="connsiteY15" fmla="*/ 138112 h 2676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857500" h="2676525">
                <a:moveTo>
                  <a:pt x="1219200" y="138112"/>
                </a:moveTo>
                <a:lnTo>
                  <a:pt x="1628775" y="0"/>
                </a:lnTo>
                <a:lnTo>
                  <a:pt x="1652588" y="504825"/>
                </a:lnTo>
                <a:lnTo>
                  <a:pt x="1347788" y="1214437"/>
                </a:lnTo>
                <a:lnTo>
                  <a:pt x="1757363" y="1323975"/>
                </a:lnTo>
                <a:lnTo>
                  <a:pt x="2405063" y="1690687"/>
                </a:lnTo>
                <a:lnTo>
                  <a:pt x="2857500" y="1671637"/>
                </a:lnTo>
                <a:lnTo>
                  <a:pt x="2571750" y="2333625"/>
                </a:lnTo>
                <a:lnTo>
                  <a:pt x="2276475" y="2043112"/>
                </a:lnTo>
                <a:lnTo>
                  <a:pt x="1381125" y="1847850"/>
                </a:lnTo>
                <a:lnTo>
                  <a:pt x="1071563" y="1824037"/>
                </a:lnTo>
                <a:lnTo>
                  <a:pt x="642938" y="2205037"/>
                </a:lnTo>
                <a:lnTo>
                  <a:pt x="504825" y="2519362"/>
                </a:lnTo>
                <a:lnTo>
                  <a:pt x="138113" y="2676525"/>
                </a:lnTo>
                <a:lnTo>
                  <a:pt x="0" y="2200275"/>
                </a:lnTo>
                <a:lnTo>
                  <a:pt x="1219200" y="138112"/>
                </a:lnTo>
                <a:close/>
              </a:path>
            </a:pathLst>
          </a:custGeom>
          <a:noFill/>
          <a:ln w="254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Freeform: Shape 178">
            <a:extLst>
              <a:ext uri="{FF2B5EF4-FFF2-40B4-BE49-F238E27FC236}">
                <a16:creationId xmlns:a16="http://schemas.microsoft.com/office/drawing/2014/main" id="{7C4A32C2-669B-4230-B42E-362F165D2079}"/>
              </a:ext>
            </a:extLst>
          </p:cNvPr>
          <p:cNvSpPr/>
          <p:nvPr/>
        </p:nvSpPr>
        <p:spPr>
          <a:xfrm>
            <a:off x="3415453" y="3721319"/>
            <a:ext cx="2159834" cy="2023045"/>
          </a:xfrm>
          <a:custGeom>
            <a:avLst/>
            <a:gdLst>
              <a:gd name="connsiteX0" fmla="*/ 1219200 w 2857500"/>
              <a:gd name="connsiteY0" fmla="*/ 138112 h 2676525"/>
              <a:gd name="connsiteX1" fmla="*/ 1628775 w 2857500"/>
              <a:gd name="connsiteY1" fmla="*/ 0 h 2676525"/>
              <a:gd name="connsiteX2" fmla="*/ 1652588 w 2857500"/>
              <a:gd name="connsiteY2" fmla="*/ 504825 h 2676525"/>
              <a:gd name="connsiteX3" fmla="*/ 1347788 w 2857500"/>
              <a:gd name="connsiteY3" fmla="*/ 1214437 h 2676525"/>
              <a:gd name="connsiteX4" fmla="*/ 1757363 w 2857500"/>
              <a:gd name="connsiteY4" fmla="*/ 1323975 h 2676525"/>
              <a:gd name="connsiteX5" fmla="*/ 2405063 w 2857500"/>
              <a:gd name="connsiteY5" fmla="*/ 1690687 h 2676525"/>
              <a:gd name="connsiteX6" fmla="*/ 2857500 w 2857500"/>
              <a:gd name="connsiteY6" fmla="*/ 1671637 h 2676525"/>
              <a:gd name="connsiteX7" fmla="*/ 2571750 w 2857500"/>
              <a:gd name="connsiteY7" fmla="*/ 2333625 h 2676525"/>
              <a:gd name="connsiteX8" fmla="*/ 2276475 w 2857500"/>
              <a:gd name="connsiteY8" fmla="*/ 2043112 h 2676525"/>
              <a:gd name="connsiteX9" fmla="*/ 1381125 w 2857500"/>
              <a:gd name="connsiteY9" fmla="*/ 1847850 h 2676525"/>
              <a:gd name="connsiteX10" fmla="*/ 1071563 w 2857500"/>
              <a:gd name="connsiteY10" fmla="*/ 1824037 h 2676525"/>
              <a:gd name="connsiteX11" fmla="*/ 642938 w 2857500"/>
              <a:gd name="connsiteY11" fmla="*/ 2205037 h 2676525"/>
              <a:gd name="connsiteX12" fmla="*/ 504825 w 2857500"/>
              <a:gd name="connsiteY12" fmla="*/ 2519362 h 2676525"/>
              <a:gd name="connsiteX13" fmla="*/ 138113 w 2857500"/>
              <a:gd name="connsiteY13" fmla="*/ 2676525 h 2676525"/>
              <a:gd name="connsiteX14" fmla="*/ 0 w 2857500"/>
              <a:gd name="connsiteY14" fmla="*/ 2200275 h 2676525"/>
              <a:gd name="connsiteX15" fmla="*/ 1219200 w 2857500"/>
              <a:gd name="connsiteY15" fmla="*/ 138112 h 2676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857500" h="2676525">
                <a:moveTo>
                  <a:pt x="1219200" y="138112"/>
                </a:moveTo>
                <a:lnTo>
                  <a:pt x="1628775" y="0"/>
                </a:lnTo>
                <a:lnTo>
                  <a:pt x="1652588" y="504825"/>
                </a:lnTo>
                <a:lnTo>
                  <a:pt x="1347788" y="1214437"/>
                </a:lnTo>
                <a:lnTo>
                  <a:pt x="1757363" y="1323975"/>
                </a:lnTo>
                <a:lnTo>
                  <a:pt x="2405063" y="1690687"/>
                </a:lnTo>
                <a:lnTo>
                  <a:pt x="2857500" y="1671637"/>
                </a:lnTo>
                <a:lnTo>
                  <a:pt x="2571750" y="2333625"/>
                </a:lnTo>
                <a:lnTo>
                  <a:pt x="2276475" y="2043112"/>
                </a:lnTo>
                <a:lnTo>
                  <a:pt x="1381125" y="1847850"/>
                </a:lnTo>
                <a:lnTo>
                  <a:pt x="1071563" y="1824037"/>
                </a:lnTo>
                <a:lnTo>
                  <a:pt x="642938" y="2205037"/>
                </a:lnTo>
                <a:lnTo>
                  <a:pt x="504825" y="2519362"/>
                </a:lnTo>
                <a:lnTo>
                  <a:pt x="138113" y="2676525"/>
                </a:lnTo>
                <a:lnTo>
                  <a:pt x="0" y="2200275"/>
                </a:lnTo>
                <a:lnTo>
                  <a:pt x="1219200" y="138112"/>
                </a:lnTo>
                <a:close/>
              </a:path>
            </a:pathLst>
          </a:custGeom>
          <a:noFill/>
          <a:ln w="254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85ACF279-DD92-4103-95AD-17893C0FEF7E}"/>
              </a:ext>
            </a:extLst>
          </p:cNvPr>
          <p:cNvGrpSpPr/>
          <p:nvPr/>
        </p:nvGrpSpPr>
        <p:grpSpPr>
          <a:xfrm>
            <a:off x="6503660" y="3687262"/>
            <a:ext cx="2261318" cy="2124530"/>
            <a:chOff x="5682793" y="1639519"/>
            <a:chExt cx="2991765" cy="2810791"/>
          </a:xfrm>
        </p:grpSpPr>
        <p:sp>
          <p:nvSpPr>
            <p:cNvPr id="184" name="Oval 183">
              <a:extLst>
                <a:ext uri="{FF2B5EF4-FFF2-40B4-BE49-F238E27FC236}">
                  <a16:creationId xmlns:a16="http://schemas.microsoft.com/office/drawing/2014/main" id="{2D361890-09D7-4C4B-B373-098AC77288C8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5" name="Oval 184">
              <a:extLst>
                <a:ext uri="{FF2B5EF4-FFF2-40B4-BE49-F238E27FC236}">
                  <a16:creationId xmlns:a16="http://schemas.microsoft.com/office/drawing/2014/main" id="{3A608431-0350-43BE-B354-1E9A3BD76539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Oval 185">
              <a:extLst>
                <a:ext uri="{FF2B5EF4-FFF2-40B4-BE49-F238E27FC236}">
                  <a16:creationId xmlns:a16="http://schemas.microsoft.com/office/drawing/2014/main" id="{2104950B-9E63-486E-A459-24453BAE2714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7" name="Oval 186">
              <a:extLst>
                <a:ext uri="{FF2B5EF4-FFF2-40B4-BE49-F238E27FC236}">
                  <a16:creationId xmlns:a16="http://schemas.microsoft.com/office/drawing/2014/main" id="{70A9B0F2-0D55-4A43-A459-955D2B10C33B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8" name="Oval 187">
              <a:extLst>
                <a:ext uri="{FF2B5EF4-FFF2-40B4-BE49-F238E27FC236}">
                  <a16:creationId xmlns:a16="http://schemas.microsoft.com/office/drawing/2014/main" id="{DB892B3D-4353-4AAB-AC22-B8E5D576DD8C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9" name="Oval 188">
              <a:extLst>
                <a:ext uri="{FF2B5EF4-FFF2-40B4-BE49-F238E27FC236}">
                  <a16:creationId xmlns:a16="http://schemas.microsoft.com/office/drawing/2014/main" id="{B97EFF4A-1579-42D5-82EF-D5159FBBB87B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0" name="Oval 189">
              <a:extLst>
                <a:ext uri="{FF2B5EF4-FFF2-40B4-BE49-F238E27FC236}">
                  <a16:creationId xmlns:a16="http://schemas.microsoft.com/office/drawing/2014/main" id="{3C9A3334-F808-40C6-A2E8-AD869C85E5CA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1" name="Oval 190">
              <a:extLst>
                <a:ext uri="{FF2B5EF4-FFF2-40B4-BE49-F238E27FC236}">
                  <a16:creationId xmlns:a16="http://schemas.microsoft.com/office/drawing/2014/main" id="{A34BB23E-93A2-4F9E-A908-C3D612462828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2" name="Oval 191">
              <a:extLst>
                <a:ext uri="{FF2B5EF4-FFF2-40B4-BE49-F238E27FC236}">
                  <a16:creationId xmlns:a16="http://schemas.microsoft.com/office/drawing/2014/main" id="{341948E8-68C7-4EDA-89B7-0EE220B2A118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3" name="Oval 192">
              <a:extLst>
                <a:ext uri="{FF2B5EF4-FFF2-40B4-BE49-F238E27FC236}">
                  <a16:creationId xmlns:a16="http://schemas.microsoft.com/office/drawing/2014/main" id="{AABB9F36-DEF9-4651-AD17-63C4FBB31903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4" name="Oval 193">
              <a:extLst>
                <a:ext uri="{FF2B5EF4-FFF2-40B4-BE49-F238E27FC236}">
                  <a16:creationId xmlns:a16="http://schemas.microsoft.com/office/drawing/2014/main" id="{A28F7B99-5B25-4FA6-876B-8F37404A2E64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5" name="Oval 194">
              <a:extLst>
                <a:ext uri="{FF2B5EF4-FFF2-40B4-BE49-F238E27FC236}">
                  <a16:creationId xmlns:a16="http://schemas.microsoft.com/office/drawing/2014/main" id="{8B5B250B-EFFF-479C-A647-93593ED862F3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6" name="Oval 195">
              <a:extLst>
                <a:ext uri="{FF2B5EF4-FFF2-40B4-BE49-F238E27FC236}">
                  <a16:creationId xmlns:a16="http://schemas.microsoft.com/office/drawing/2014/main" id="{1D574551-D94B-4067-9200-C6493EF39FF2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7" name="Oval 196">
              <a:extLst>
                <a:ext uri="{FF2B5EF4-FFF2-40B4-BE49-F238E27FC236}">
                  <a16:creationId xmlns:a16="http://schemas.microsoft.com/office/drawing/2014/main" id="{5A682A53-469E-4F93-B507-1DDAE0741410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8" name="Oval 197">
              <a:extLst>
                <a:ext uri="{FF2B5EF4-FFF2-40B4-BE49-F238E27FC236}">
                  <a16:creationId xmlns:a16="http://schemas.microsoft.com/office/drawing/2014/main" id="{5A01B8C3-FFED-4869-AA01-F656441967ED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4C7025B8-7B5B-4EDB-B569-17E94291E302}"/>
              </a:ext>
            </a:extLst>
          </p:cNvPr>
          <p:cNvGrpSpPr/>
          <p:nvPr/>
        </p:nvGrpSpPr>
        <p:grpSpPr>
          <a:xfrm>
            <a:off x="3360633" y="3684742"/>
            <a:ext cx="2261318" cy="2124530"/>
            <a:chOff x="5682793" y="1639519"/>
            <a:chExt cx="2991765" cy="2810791"/>
          </a:xfrm>
        </p:grpSpPr>
        <p:sp>
          <p:nvSpPr>
            <p:cNvPr id="200" name="Oval 199">
              <a:extLst>
                <a:ext uri="{FF2B5EF4-FFF2-40B4-BE49-F238E27FC236}">
                  <a16:creationId xmlns:a16="http://schemas.microsoft.com/office/drawing/2014/main" id="{F216DBAF-E68C-4A4E-A0E4-D124D3A4E9D8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1" name="Oval 200">
              <a:extLst>
                <a:ext uri="{FF2B5EF4-FFF2-40B4-BE49-F238E27FC236}">
                  <a16:creationId xmlns:a16="http://schemas.microsoft.com/office/drawing/2014/main" id="{13C34329-56D0-4C8C-B14D-4C278A57CAA3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2" name="Oval 201">
              <a:extLst>
                <a:ext uri="{FF2B5EF4-FFF2-40B4-BE49-F238E27FC236}">
                  <a16:creationId xmlns:a16="http://schemas.microsoft.com/office/drawing/2014/main" id="{151F561B-C0DC-467A-8F07-B4C7BE0A188F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Oval 202">
              <a:extLst>
                <a:ext uri="{FF2B5EF4-FFF2-40B4-BE49-F238E27FC236}">
                  <a16:creationId xmlns:a16="http://schemas.microsoft.com/office/drawing/2014/main" id="{EF4DF4E0-A8A8-4811-9AB2-841272D4BBB9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Oval 203">
              <a:extLst>
                <a:ext uri="{FF2B5EF4-FFF2-40B4-BE49-F238E27FC236}">
                  <a16:creationId xmlns:a16="http://schemas.microsoft.com/office/drawing/2014/main" id="{25840B61-CA4F-4FC1-B7FA-44E3031DF975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Oval 204">
              <a:extLst>
                <a:ext uri="{FF2B5EF4-FFF2-40B4-BE49-F238E27FC236}">
                  <a16:creationId xmlns:a16="http://schemas.microsoft.com/office/drawing/2014/main" id="{9C58DBB5-B3C6-4085-AF95-C69F73FC025B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Oval 205">
              <a:extLst>
                <a:ext uri="{FF2B5EF4-FFF2-40B4-BE49-F238E27FC236}">
                  <a16:creationId xmlns:a16="http://schemas.microsoft.com/office/drawing/2014/main" id="{825C3C91-54C4-4F12-8B6B-DD621826530B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7" name="Oval 206">
              <a:extLst>
                <a:ext uri="{FF2B5EF4-FFF2-40B4-BE49-F238E27FC236}">
                  <a16:creationId xmlns:a16="http://schemas.microsoft.com/office/drawing/2014/main" id="{94376AD3-558E-47D7-8E32-4DDEA37FC661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Oval 207">
              <a:extLst>
                <a:ext uri="{FF2B5EF4-FFF2-40B4-BE49-F238E27FC236}">
                  <a16:creationId xmlns:a16="http://schemas.microsoft.com/office/drawing/2014/main" id="{521F4A89-E58C-42BE-9F43-1DF078C36364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Oval 208">
              <a:extLst>
                <a:ext uri="{FF2B5EF4-FFF2-40B4-BE49-F238E27FC236}">
                  <a16:creationId xmlns:a16="http://schemas.microsoft.com/office/drawing/2014/main" id="{3F9C884A-8982-4727-AD83-0AD02D2BD582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0" name="Oval 209">
              <a:extLst>
                <a:ext uri="{FF2B5EF4-FFF2-40B4-BE49-F238E27FC236}">
                  <a16:creationId xmlns:a16="http://schemas.microsoft.com/office/drawing/2014/main" id="{08909A97-D77E-4756-885A-D1916255748E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1" name="Oval 210">
              <a:extLst>
                <a:ext uri="{FF2B5EF4-FFF2-40B4-BE49-F238E27FC236}">
                  <a16:creationId xmlns:a16="http://schemas.microsoft.com/office/drawing/2014/main" id="{D1B4D848-FE3F-424B-A123-A7F6EBAFB39A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2" name="Oval 211">
              <a:extLst>
                <a:ext uri="{FF2B5EF4-FFF2-40B4-BE49-F238E27FC236}">
                  <a16:creationId xmlns:a16="http://schemas.microsoft.com/office/drawing/2014/main" id="{967BE655-67AB-4E7C-B3B2-1F326C4C4386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3" name="Oval 212">
              <a:extLst>
                <a:ext uri="{FF2B5EF4-FFF2-40B4-BE49-F238E27FC236}">
                  <a16:creationId xmlns:a16="http://schemas.microsoft.com/office/drawing/2014/main" id="{17BF6876-240F-4512-BA48-A00D14549A33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Oval 213">
              <a:extLst>
                <a:ext uri="{FF2B5EF4-FFF2-40B4-BE49-F238E27FC236}">
                  <a16:creationId xmlns:a16="http://schemas.microsoft.com/office/drawing/2014/main" id="{72E36DC3-1B70-4189-82ED-B78830EFC559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1" name="Group 250">
            <a:extLst>
              <a:ext uri="{FF2B5EF4-FFF2-40B4-BE49-F238E27FC236}">
                <a16:creationId xmlns:a16="http://schemas.microsoft.com/office/drawing/2014/main" id="{56317993-D760-4C14-AD46-6DDB641524E6}"/>
              </a:ext>
            </a:extLst>
          </p:cNvPr>
          <p:cNvGrpSpPr/>
          <p:nvPr/>
        </p:nvGrpSpPr>
        <p:grpSpPr>
          <a:xfrm>
            <a:off x="9525120" y="3687262"/>
            <a:ext cx="2261318" cy="2124530"/>
            <a:chOff x="5682793" y="1639519"/>
            <a:chExt cx="2991765" cy="2810791"/>
          </a:xfrm>
        </p:grpSpPr>
        <p:sp>
          <p:nvSpPr>
            <p:cNvPr id="252" name="Oval 251">
              <a:extLst>
                <a:ext uri="{FF2B5EF4-FFF2-40B4-BE49-F238E27FC236}">
                  <a16:creationId xmlns:a16="http://schemas.microsoft.com/office/drawing/2014/main" id="{8EAC6B66-F9AF-4AE7-A220-627DE4B88579}"/>
                </a:ext>
              </a:extLst>
            </p:cNvPr>
            <p:cNvSpPr/>
            <p:nvPr/>
          </p:nvSpPr>
          <p:spPr>
            <a:xfrm rot="20234264">
              <a:off x="6905168" y="17887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3" name="Oval 252">
              <a:extLst>
                <a:ext uri="{FF2B5EF4-FFF2-40B4-BE49-F238E27FC236}">
                  <a16:creationId xmlns:a16="http://schemas.microsoft.com/office/drawing/2014/main" id="{710AC645-F47F-4304-AE29-04AF819E1A60}"/>
                </a:ext>
              </a:extLst>
            </p:cNvPr>
            <p:cNvSpPr/>
            <p:nvPr/>
          </p:nvSpPr>
          <p:spPr>
            <a:xfrm rot="20234264">
              <a:off x="7311569" y="1639519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Oval 253">
              <a:extLst>
                <a:ext uri="{FF2B5EF4-FFF2-40B4-BE49-F238E27FC236}">
                  <a16:creationId xmlns:a16="http://schemas.microsoft.com/office/drawing/2014/main" id="{25F91DC1-BC94-4F26-A80F-88483CCE1F92}"/>
                </a:ext>
              </a:extLst>
            </p:cNvPr>
            <p:cNvSpPr/>
            <p:nvPr/>
          </p:nvSpPr>
          <p:spPr>
            <a:xfrm rot="20234264">
              <a:off x="7333794" y="2144344"/>
              <a:ext cx="134265" cy="134265"/>
            </a:xfrm>
            <a:prstGeom prst="ellipse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5" name="Oval 254">
              <a:extLst>
                <a:ext uri="{FF2B5EF4-FFF2-40B4-BE49-F238E27FC236}">
                  <a16:creationId xmlns:a16="http://schemas.microsoft.com/office/drawing/2014/main" id="{33943B51-ED9B-43C4-8A40-FAABBC1873B3}"/>
                </a:ext>
              </a:extLst>
            </p:cNvPr>
            <p:cNvSpPr/>
            <p:nvPr/>
          </p:nvSpPr>
          <p:spPr>
            <a:xfrm rot="20234264">
              <a:off x="7035344" y="2852369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Oval 255">
              <a:extLst>
                <a:ext uri="{FF2B5EF4-FFF2-40B4-BE49-F238E27FC236}">
                  <a16:creationId xmlns:a16="http://schemas.microsoft.com/office/drawing/2014/main" id="{C3B5B0B5-B94B-4DB3-BAD2-742171B337EC}"/>
                </a:ext>
              </a:extLst>
            </p:cNvPr>
            <p:cNvSpPr/>
            <p:nvPr/>
          </p:nvSpPr>
          <p:spPr>
            <a:xfrm rot="20234264">
              <a:off x="7444919" y="2963495"/>
              <a:ext cx="134265" cy="13426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7" name="Oval 256">
              <a:extLst>
                <a:ext uri="{FF2B5EF4-FFF2-40B4-BE49-F238E27FC236}">
                  <a16:creationId xmlns:a16="http://schemas.microsoft.com/office/drawing/2014/main" id="{74395F52-589A-4DAE-8044-B332D31354EA}"/>
                </a:ext>
              </a:extLst>
            </p:cNvPr>
            <p:cNvSpPr/>
            <p:nvPr/>
          </p:nvSpPr>
          <p:spPr>
            <a:xfrm rot="20234264">
              <a:off x="8087856" y="3334970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8" name="Oval 257">
              <a:extLst>
                <a:ext uri="{FF2B5EF4-FFF2-40B4-BE49-F238E27FC236}">
                  <a16:creationId xmlns:a16="http://schemas.microsoft.com/office/drawing/2014/main" id="{7B01373C-1066-424D-AF26-437E5AD50C5D}"/>
                </a:ext>
              </a:extLst>
            </p:cNvPr>
            <p:cNvSpPr/>
            <p:nvPr/>
          </p:nvSpPr>
          <p:spPr>
            <a:xfrm rot="20234264">
              <a:off x="8540293" y="3311158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" name="Oval 258">
              <a:extLst>
                <a:ext uri="{FF2B5EF4-FFF2-40B4-BE49-F238E27FC236}">
                  <a16:creationId xmlns:a16="http://schemas.microsoft.com/office/drawing/2014/main" id="{85E734B3-91EB-4649-9A77-F66602850C2F}"/>
                </a:ext>
              </a:extLst>
            </p:cNvPr>
            <p:cNvSpPr/>
            <p:nvPr/>
          </p:nvSpPr>
          <p:spPr>
            <a:xfrm rot="20234264">
              <a:off x="8254543" y="3968382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0" name="Oval 259">
              <a:extLst>
                <a:ext uri="{FF2B5EF4-FFF2-40B4-BE49-F238E27FC236}">
                  <a16:creationId xmlns:a16="http://schemas.microsoft.com/office/drawing/2014/main" id="{F74B34A0-4E83-4C20-8474-583BD09083FC}"/>
                </a:ext>
              </a:extLst>
            </p:cNvPr>
            <p:cNvSpPr/>
            <p:nvPr/>
          </p:nvSpPr>
          <p:spPr>
            <a:xfrm rot="20234264">
              <a:off x="7959267" y="3687394"/>
              <a:ext cx="134265" cy="134265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1" name="Oval 260">
              <a:extLst>
                <a:ext uri="{FF2B5EF4-FFF2-40B4-BE49-F238E27FC236}">
                  <a16:creationId xmlns:a16="http://schemas.microsoft.com/office/drawing/2014/main" id="{4DF05A9B-1496-4EC6-8FE2-BC9128D76F29}"/>
                </a:ext>
              </a:extLst>
            </p:cNvPr>
            <p:cNvSpPr/>
            <p:nvPr/>
          </p:nvSpPr>
          <p:spPr>
            <a:xfrm rot="20234264">
              <a:off x="7063917" y="349213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2" name="Oval 261">
              <a:extLst>
                <a:ext uri="{FF2B5EF4-FFF2-40B4-BE49-F238E27FC236}">
                  <a16:creationId xmlns:a16="http://schemas.microsoft.com/office/drawing/2014/main" id="{607C67AA-7F96-4E66-AE6F-41C8E142DE50}"/>
                </a:ext>
              </a:extLst>
            </p:cNvPr>
            <p:cNvSpPr/>
            <p:nvPr/>
          </p:nvSpPr>
          <p:spPr>
            <a:xfrm rot="20234264">
              <a:off x="6754354" y="3468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3" name="Oval 262">
              <a:extLst>
                <a:ext uri="{FF2B5EF4-FFF2-40B4-BE49-F238E27FC236}">
                  <a16:creationId xmlns:a16="http://schemas.microsoft.com/office/drawing/2014/main" id="{D61A01A5-FE2A-4D96-B327-1E478390D98A}"/>
                </a:ext>
              </a:extLst>
            </p:cNvPr>
            <p:cNvSpPr/>
            <p:nvPr/>
          </p:nvSpPr>
          <p:spPr>
            <a:xfrm rot="20234264">
              <a:off x="6330492" y="3849319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Oval 263">
              <a:extLst>
                <a:ext uri="{FF2B5EF4-FFF2-40B4-BE49-F238E27FC236}">
                  <a16:creationId xmlns:a16="http://schemas.microsoft.com/office/drawing/2014/main" id="{FE994AA8-B3D3-4960-B2DD-F6EF3185365C}"/>
                </a:ext>
              </a:extLst>
            </p:cNvPr>
            <p:cNvSpPr/>
            <p:nvPr/>
          </p:nvSpPr>
          <p:spPr>
            <a:xfrm rot="20234264">
              <a:off x="6187617" y="4158881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5" name="Oval 264">
              <a:extLst>
                <a:ext uri="{FF2B5EF4-FFF2-40B4-BE49-F238E27FC236}">
                  <a16:creationId xmlns:a16="http://schemas.microsoft.com/office/drawing/2014/main" id="{BA453D71-6066-4421-A6B1-34213B429453}"/>
                </a:ext>
              </a:extLst>
            </p:cNvPr>
            <p:cNvSpPr/>
            <p:nvPr/>
          </p:nvSpPr>
          <p:spPr>
            <a:xfrm rot="20234264">
              <a:off x="5820904" y="431604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6" name="Oval 265">
              <a:extLst>
                <a:ext uri="{FF2B5EF4-FFF2-40B4-BE49-F238E27FC236}">
                  <a16:creationId xmlns:a16="http://schemas.microsoft.com/office/drawing/2014/main" id="{0B78AE8E-1E7B-4BDA-A9CC-8DFAD2A475C3}"/>
                </a:ext>
              </a:extLst>
            </p:cNvPr>
            <p:cNvSpPr/>
            <p:nvPr/>
          </p:nvSpPr>
          <p:spPr>
            <a:xfrm rot="20234264">
              <a:off x="5682793" y="3839795"/>
              <a:ext cx="134265" cy="134265"/>
            </a:xfrm>
            <a:prstGeom prst="ellips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FBD6F49D-D585-48A2-B46B-F821284A24AA}"/>
              </a:ext>
            </a:extLst>
          </p:cNvPr>
          <p:cNvGrpSpPr/>
          <p:nvPr/>
        </p:nvGrpSpPr>
        <p:grpSpPr>
          <a:xfrm>
            <a:off x="5481346" y="5986867"/>
            <a:ext cx="4511656" cy="472551"/>
            <a:chOff x="2100397" y="9501285"/>
            <a:chExt cx="4511656" cy="472551"/>
          </a:xfrm>
        </p:grpSpPr>
        <p:sp>
          <p:nvSpPr>
            <p:cNvPr id="273" name="Oval 272">
              <a:extLst>
                <a:ext uri="{FF2B5EF4-FFF2-40B4-BE49-F238E27FC236}">
                  <a16:creationId xmlns:a16="http://schemas.microsoft.com/office/drawing/2014/main" id="{7FEA3560-81CD-42CC-A55D-ACAF50E4F2DE}"/>
                </a:ext>
              </a:extLst>
            </p:cNvPr>
            <p:cNvSpPr/>
            <p:nvPr/>
          </p:nvSpPr>
          <p:spPr>
            <a:xfrm>
              <a:off x="2100397" y="9638445"/>
              <a:ext cx="220980" cy="220980"/>
            </a:xfrm>
            <a:prstGeom prst="ellipse">
              <a:avLst/>
            </a:prstGeom>
            <a:solidFill>
              <a:srgbClr val="0000FF">
                <a:alpha val="44000"/>
              </a:srgbClr>
            </a:solidFill>
            <a:ln>
              <a:solidFill>
                <a:srgbClr val="0000FF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0DCFE562-6A27-44F9-90B5-33F0E0B48638}"/>
                </a:ext>
              </a:extLst>
            </p:cNvPr>
            <p:cNvSpPr txBox="1"/>
            <p:nvPr/>
          </p:nvSpPr>
          <p:spPr>
            <a:xfrm>
              <a:off x="2397577" y="9501285"/>
              <a:ext cx="14075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/>
                <a:t>Centroids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D3F99D64-920F-442A-B06C-10A85571F172}"/>
                </a:ext>
              </a:extLst>
            </p:cNvPr>
            <p:cNvSpPr txBox="1"/>
            <p:nvPr/>
          </p:nvSpPr>
          <p:spPr>
            <a:xfrm>
              <a:off x="4652734" y="9512171"/>
              <a:ext cx="195931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/>
                <a:t>Borders / Cuts</a:t>
              </a:r>
            </a:p>
          </p:txBody>
        </p:sp>
        <p:sp>
          <p:nvSpPr>
            <p:cNvPr id="276" name="Freeform 202">
              <a:extLst>
                <a:ext uri="{FF2B5EF4-FFF2-40B4-BE49-F238E27FC236}">
                  <a16:creationId xmlns:a16="http://schemas.microsoft.com/office/drawing/2014/main" id="{BD9A80DB-AA09-49F3-8506-7C16FED8B194}"/>
                </a:ext>
              </a:extLst>
            </p:cNvPr>
            <p:cNvSpPr/>
            <p:nvPr/>
          </p:nvSpPr>
          <p:spPr>
            <a:xfrm rot="10800000">
              <a:off x="4332718" y="9639171"/>
              <a:ext cx="243816" cy="252690"/>
            </a:xfrm>
            <a:custGeom>
              <a:avLst/>
              <a:gdLst>
                <a:gd name="connsiteX0" fmla="*/ 0 w 830580"/>
                <a:gd name="connsiteY0" fmla="*/ 1173480 h 1173480"/>
                <a:gd name="connsiteX1" fmla="*/ 830580 w 830580"/>
                <a:gd name="connsiteY1" fmla="*/ 0 h 1173480"/>
                <a:gd name="connsiteX0" fmla="*/ 0 w 1219200"/>
                <a:gd name="connsiteY0" fmla="*/ 1234440 h 1234440"/>
                <a:gd name="connsiteX1" fmla="*/ 1219200 w 1219200"/>
                <a:gd name="connsiteY1" fmla="*/ 0 h 12344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19200" h="1234440">
                  <a:moveTo>
                    <a:pt x="0" y="1234440"/>
                  </a:moveTo>
                  <a:lnTo>
                    <a:pt x="1219200" y="0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C9DEAF32-A626-457A-BF27-F36B843F4AB6}"/>
              </a:ext>
            </a:extLst>
          </p:cNvPr>
          <p:cNvCxnSpPr>
            <a:cxnSpLocks/>
          </p:cNvCxnSpPr>
          <p:nvPr/>
        </p:nvCxnSpPr>
        <p:spPr>
          <a:xfrm>
            <a:off x="2771775" y="222250"/>
            <a:ext cx="0" cy="6226282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TextBox 285">
            <a:extLst>
              <a:ext uri="{FF2B5EF4-FFF2-40B4-BE49-F238E27FC236}">
                <a16:creationId xmlns:a16="http://schemas.microsoft.com/office/drawing/2014/main" id="{1B233FE3-700B-4DC7-BFBA-B3EAD7088579}"/>
              </a:ext>
            </a:extLst>
          </p:cNvPr>
          <p:cNvSpPr txBox="1"/>
          <p:nvPr/>
        </p:nvSpPr>
        <p:spPr>
          <a:xfrm>
            <a:off x="4570174" y="3615199"/>
            <a:ext cx="135139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/>
              <a:t>Optimum</a:t>
            </a:r>
          </a:p>
          <a:p>
            <a:pPr algn="ctr"/>
            <a:r>
              <a:rPr lang="en-US" sz="2000"/>
              <a:t>Not </a:t>
            </a:r>
          </a:p>
          <a:p>
            <a:pPr algn="ctr"/>
            <a:r>
              <a:rPr lang="en-US" sz="2000"/>
              <a:t>Achievable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B4935C31-9FCC-4BA3-B043-C7DED7815954}"/>
              </a:ext>
            </a:extLst>
          </p:cNvPr>
          <p:cNvSpPr txBox="1"/>
          <p:nvPr/>
        </p:nvSpPr>
        <p:spPr>
          <a:xfrm>
            <a:off x="7737339" y="3615199"/>
            <a:ext cx="135139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/>
              <a:t>Optimum</a:t>
            </a:r>
          </a:p>
          <a:p>
            <a:pPr algn="ctr"/>
            <a:r>
              <a:rPr lang="en-US" sz="2000"/>
              <a:t>Not </a:t>
            </a:r>
          </a:p>
          <a:p>
            <a:pPr algn="ctr"/>
            <a:r>
              <a:rPr lang="en-US" sz="2000"/>
              <a:t>Achievable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0ECEC5C1-4BB5-4029-AFC8-E42D430753E0}"/>
              </a:ext>
            </a:extLst>
          </p:cNvPr>
          <p:cNvSpPr txBox="1"/>
          <p:nvPr/>
        </p:nvSpPr>
        <p:spPr>
          <a:xfrm>
            <a:off x="10778449" y="3788300"/>
            <a:ext cx="135139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/>
              <a:t>Optimum </a:t>
            </a:r>
          </a:p>
          <a:p>
            <a:pPr algn="ctr"/>
            <a:r>
              <a:rPr lang="en-US" sz="2000"/>
              <a:t>Achievable</a:t>
            </a:r>
          </a:p>
        </p:txBody>
      </p:sp>
    </p:spTree>
    <p:extLst>
      <p:ext uri="{BB962C8B-B14F-4D97-AF65-F5344CB8AC3E}">
        <p14:creationId xmlns:p14="http://schemas.microsoft.com/office/powerpoint/2010/main" val="18416348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07"/>
          <p:cNvSpPr txBox="1"/>
          <p:nvPr/>
        </p:nvSpPr>
        <p:spPr>
          <a:xfrm>
            <a:off x="3819026" y="2641147"/>
            <a:ext cx="38511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/>
              <a:t>Pseudo node strategy</a:t>
            </a:r>
          </a:p>
        </p:txBody>
      </p:sp>
      <p:grpSp>
        <p:nvGrpSpPr>
          <p:cNvPr id="97" name="Group 96"/>
          <p:cNvGrpSpPr/>
          <p:nvPr/>
        </p:nvGrpSpPr>
        <p:grpSpPr>
          <a:xfrm>
            <a:off x="482600" y="3710807"/>
            <a:ext cx="3068414" cy="2539966"/>
            <a:chOff x="235029" y="190500"/>
            <a:chExt cx="4166885" cy="3449256"/>
          </a:xfrm>
        </p:grpSpPr>
        <p:grpSp>
          <p:nvGrpSpPr>
            <p:cNvPr id="4" name="Group 3"/>
            <p:cNvGrpSpPr/>
            <p:nvPr/>
          </p:nvGrpSpPr>
          <p:grpSpPr>
            <a:xfrm>
              <a:off x="408651" y="398844"/>
              <a:ext cx="3819645" cy="3078866"/>
              <a:chOff x="7292051" y="2037144"/>
              <a:chExt cx="3819645" cy="3078866"/>
            </a:xfrm>
          </p:grpSpPr>
          <p:sp>
            <p:nvSpPr>
              <p:cNvPr id="5" name="Freeform 4"/>
              <p:cNvSpPr/>
              <p:nvPr/>
            </p:nvSpPr>
            <p:spPr>
              <a:xfrm>
                <a:off x="7315200" y="2037144"/>
                <a:ext cx="3796496" cy="1956122"/>
              </a:xfrm>
              <a:custGeom>
                <a:avLst/>
                <a:gdLst>
                  <a:gd name="connsiteX0" fmla="*/ 0 w 3796496"/>
                  <a:gd name="connsiteY0" fmla="*/ 324091 h 1956122"/>
                  <a:gd name="connsiteX1" fmla="*/ 752354 w 3796496"/>
                  <a:gd name="connsiteY1" fmla="*/ 1076446 h 1956122"/>
                  <a:gd name="connsiteX2" fmla="*/ 1527858 w 3796496"/>
                  <a:gd name="connsiteY2" fmla="*/ 0 h 1956122"/>
                  <a:gd name="connsiteX3" fmla="*/ 3240911 w 3796496"/>
                  <a:gd name="connsiteY3" fmla="*/ 625033 h 1956122"/>
                  <a:gd name="connsiteX4" fmla="*/ 2569580 w 3796496"/>
                  <a:gd name="connsiteY4" fmla="*/ 1759352 h 1956122"/>
                  <a:gd name="connsiteX5" fmla="*/ 3796496 w 3796496"/>
                  <a:gd name="connsiteY5" fmla="*/ 1956122 h 19561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796496" h="1956122">
                    <a:moveTo>
                      <a:pt x="0" y="324091"/>
                    </a:moveTo>
                    <a:lnTo>
                      <a:pt x="752354" y="1076446"/>
                    </a:lnTo>
                    <a:lnTo>
                      <a:pt x="1527858" y="0"/>
                    </a:lnTo>
                    <a:lnTo>
                      <a:pt x="3240911" y="625033"/>
                    </a:lnTo>
                    <a:lnTo>
                      <a:pt x="2569580" y="1759352"/>
                    </a:lnTo>
                    <a:lnTo>
                      <a:pt x="3796496" y="1956122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6" name="Freeform 5"/>
              <p:cNvSpPr/>
              <p:nvPr/>
            </p:nvSpPr>
            <p:spPr>
              <a:xfrm>
                <a:off x="7292051" y="2361235"/>
                <a:ext cx="567159" cy="2685327"/>
              </a:xfrm>
              <a:custGeom>
                <a:avLst/>
                <a:gdLst>
                  <a:gd name="connsiteX0" fmla="*/ 0 w 567159"/>
                  <a:gd name="connsiteY0" fmla="*/ 0 h 2685327"/>
                  <a:gd name="connsiteX1" fmla="*/ 567159 w 567159"/>
                  <a:gd name="connsiteY1" fmla="*/ 2685327 h 26853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67159" h="2685327">
                    <a:moveTo>
                      <a:pt x="0" y="0"/>
                    </a:moveTo>
                    <a:lnTo>
                      <a:pt x="567159" y="2685327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7" name="Freeform 6"/>
              <p:cNvSpPr/>
              <p:nvPr/>
            </p:nvSpPr>
            <p:spPr>
              <a:xfrm>
                <a:off x="7905509" y="3981691"/>
                <a:ext cx="3206187" cy="1134319"/>
              </a:xfrm>
              <a:custGeom>
                <a:avLst/>
                <a:gdLst>
                  <a:gd name="connsiteX0" fmla="*/ 3206187 w 3206187"/>
                  <a:gd name="connsiteY0" fmla="*/ 0 h 1134319"/>
                  <a:gd name="connsiteX1" fmla="*/ 0 w 3206187"/>
                  <a:gd name="connsiteY1" fmla="*/ 1134319 h 11343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06187" h="1134319">
                    <a:moveTo>
                      <a:pt x="3206187" y="0"/>
                    </a:moveTo>
                    <a:lnTo>
                      <a:pt x="0" y="1134319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8" name="Oval 7"/>
            <p:cNvSpPr/>
            <p:nvPr/>
          </p:nvSpPr>
          <p:spPr>
            <a:xfrm>
              <a:off x="235029" y="526166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9" name="Oval 8"/>
            <p:cNvSpPr/>
            <p:nvPr/>
          </p:nvSpPr>
          <p:spPr>
            <a:xfrm>
              <a:off x="1751313" y="190500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0" name="Oval 9"/>
            <p:cNvSpPr/>
            <p:nvPr/>
          </p:nvSpPr>
          <p:spPr>
            <a:xfrm>
              <a:off x="2816184" y="1938277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" name="Oval 10"/>
            <p:cNvSpPr/>
            <p:nvPr/>
          </p:nvSpPr>
          <p:spPr>
            <a:xfrm>
              <a:off x="987384" y="1255372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3" name="Oval 12"/>
            <p:cNvSpPr/>
            <p:nvPr/>
          </p:nvSpPr>
          <p:spPr>
            <a:xfrm>
              <a:off x="3441216" y="827108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397938" y="1348445"/>
              <a:ext cx="2826053" cy="2291311"/>
              <a:chOff x="7281338" y="2986745"/>
              <a:chExt cx="2826053" cy="2291311"/>
            </a:xfrm>
          </p:grpSpPr>
          <p:sp>
            <p:nvSpPr>
              <p:cNvPr id="15" name="Oval 14"/>
              <p:cNvSpPr/>
              <p:nvPr/>
            </p:nvSpPr>
            <p:spPr>
              <a:xfrm>
                <a:off x="7685589" y="4861368"/>
                <a:ext cx="416688" cy="416688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" name="Freeform 15"/>
              <p:cNvSpPr/>
              <p:nvPr/>
            </p:nvSpPr>
            <p:spPr>
              <a:xfrm rot="15473100">
                <a:off x="7852161" y="2664074"/>
                <a:ext cx="1920530" cy="2565871"/>
              </a:xfrm>
              <a:custGeom>
                <a:avLst/>
                <a:gdLst>
                  <a:gd name="connsiteX0" fmla="*/ 436992 w 2050316"/>
                  <a:gd name="connsiteY0" fmla="*/ 2301200 h 2565871"/>
                  <a:gd name="connsiteX1" fmla="*/ 345987 w 2050316"/>
                  <a:gd name="connsiteY1" fmla="*/ 2565871 h 2565871"/>
                  <a:gd name="connsiteX2" fmla="*/ 184879 w 2050316"/>
                  <a:gd name="connsiteY2" fmla="*/ 2337010 h 2565871"/>
                  <a:gd name="connsiteX3" fmla="*/ 259978 w 2050316"/>
                  <a:gd name="connsiteY3" fmla="*/ 2326343 h 2565871"/>
                  <a:gd name="connsiteX4" fmla="*/ 0 w 2050316"/>
                  <a:gd name="connsiteY4" fmla="*/ 496074 h 2565871"/>
                  <a:gd name="connsiteX5" fmla="*/ 20439 w 2050316"/>
                  <a:gd name="connsiteY5" fmla="*/ 507572 h 2565871"/>
                  <a:gd name="connsiteX6" fmla="*/ 95725 w 2050316"/>
                  <a:gd name="connsiteY6" fmla="*/ 531848 h 2565871"/>
                  <a:gd name="connsiteX7" fmla="*/ 109267 w 2050316"/>
                  <a:gd name="connsiteY7" fmla="*/ 533357 h 2565871"/>
                  <a:gd name="connsiteX8" fmla="*/ 361893 w 2050316"/>
                  <a:gd name="connsiteY8" fmla="*/ 2311868 h 2565871"/>
                  <a:gd name="connsiteX9" fmla="*/ 816287 w 2050316"/>
                  <a:gd name="connsiteY9" fmla="*/ 1952484 h 2565871"/>
                  <a:gd name="connsiteX10" fmla="*/ 598957 w 2050316"/>
                  <a:gd name="connsiteY10" fmla="*/ 1776131 h 2565871"/>
                  <a:gd name="connsiteX11" fmla="*/ 668315 w 2050316"/>
                  <a:gd name="connsiteY11" fmla="*/ 1745420 h 2565871"/>
                  <a:gd name="connsiteX12" fmla="*/ 132793 w 2050316"/>
                  <a:gd name="connsiteY12" fmla="*/ 535978 h 2565871"/>
                  <a:gd name="connsiteX13" fmla="*/ 174342 w 2050316"/>
                  <a:gd name="connsiteY13" fmla="*/ 540608 h 2565871"/>
                  <a:gd name="connsiteX14" fmla="*/ 244626 w 2050316"/>
                  <a:gd name="connsiteY14" fmla="*/ 534298 h 2565871"/>
                  <a:gd name="connsiteX15" fmla="*/ 762438 w 2050316"/>
                  <a:gd name="connsiteY15" fmla="*/ 1703744 h 2565871"/>
                  <a:gd name="connsiteX16" fmla="*/ 831796 w 2050316"/>
                  <a:gd name="connsiteY16" fmla="*/ 1673033 h 2565871"/>
                  <a:gd name="connsiteX17" fmla="*/ 1571197 w 2050316"/>
                  <a:gd name="connsiteY17" fmla="*/ 587395 h 2565871"/>
                  <a:gd name="connsiteX18" fmla="*/ 1294897 w 2050316"/>
                  <a:gd name="connsiteY18" fmla="*/ 632023 h 2565871"/>
                  <a:gd name="connsiteX19" fmla="*/ 1318192 w 2050316"/>
                  <a:gd name="connsiteY19" fmla="*/ 559835 h 2565871"/>
                  <a:gd name="connsiteX20" fmla="*/ 535263 w 2050316"/>
                  <a:gd name="connsiteY20" fmla="*/ 307193 h 2565871"/>
                  <a:gd name="connsiteX21" fmla="*/ 559514 w 2050316"/>
                  <a:gd name="connsiteY21" fmla="*/ 231982 h 2565871"/>
                  <a:gd name="connsiteX22" fmla="*/ 562217 w 2050316"/>
                  <a:gd name="connsiteY22" fmla="*/ 207726 h 2565871"/>
                  <a:gd name="connsiteX23" fmla="*/ 1349803 w 2050316"/>
                  <a:gd name="connsiteY23" fmla="*/ 461872 h 2565871"/>
                  <a:gd name="connsiteX24" fmla="*/ 1373098 w 2050316"/>
                  <a:gd name="connsiteY24" fmla="*/ 389684 h 2565871"/>
                  <a:gd name="connsiteX25" fmla="*/ 1486953 w 2050316"/>
                  <a:gd name="connsiteY25" fmla="*/ 2398127 h 2565871"/>
                  <a:gd name="connsiteX26" fmla="*/ 1248437 w 2050316"/>
                  <a:gd name="connsiteY26" fmla="*/ 2251693 h 2565871"/>
                  <a:gd name="connsiteX27" fmla="*/ 1313186 w 2050316"/>
                  <a:gd name="connsiteY27" fmla="*/ 2212181 h 2565871"/>
                  <a:gd name="connsiteX28" fmla="*/ 283147 w 2050316"/>
                  <a:gd name="connsiteY28" fmla="*/ 524236 h 2565871"/>
                  <a:gd name="connsiteX29" fmla="*/ 323206 w 2050316"/>
                  <a:gd name="connsiteY29" fmla="*/ 512463 h 2565871"/>
                  <a:gd name="connsiteX30" fmla="*/ 378923 w 2050316"/>
                  <a:gd name="connsiteY30" fmla="*/ 483570 h 2565871"/>
                  <a:gd name="connsiteX31" fmla="*/ 1401056 w 2050316"/>
                  <a:gd name="connsiteY31" fmla="*/ 2158559 h 2565871"/>
                  <a:gd name="connsiteX32" fmla="*/ 1465805 w 2050316"/>
                  <a:gd name="connsiteY32" fmla="*/ 2119047 h 2565871"/>
                  <a:gd name="connsiteX33" fmla="*/ 2050316 w 2050316"/>
                  <a:gd name="connsiteY33" fmla="*/ 127322 h 2565871"/>
                  <a:gd name="connsiteX34" fmla="*/ 1801073 w 2050316"/>
                  <a:gd name="connsiteY34" fmla="*/ 254644 h 2565871"/>
                  <a:gd name="connsiteX35" fmla="*/ 1801073 w 2050316"/>
                  <a:gd name="connsiteY35" fmla="*/ 178791 h 2565871"/>
                  <a:gd name="connsiteX36" fmla="*/ 565441 w 2050316"/>
                  <a:gd name="connsiteY36" fmla="*/ 178791 h 2565871"/>
                  <a:gd name="connsiteX37" fmla="*/ 568275 w 2050316"/>
                  <a:gd name="connsiteY37" fmla="*/ 153365 h 2565871"/>
                  <a:gd name="connsiteX38" fmla="*/ 561411 w 2050316"/>
                  <a:gd name="connsiteY38" fmla="*/ 76916 h 2565871"/>
                  <a:gd name="connsiteX39" fmla="*/ 561099 w 2050316"/>
                  <a:gd name="connsiteY39" fmla="*/ 75853 h 2565871"/>
                  <a:gd name="connsiteX40" fmla="*/ 1801073 w 2050316"/>
                  <a:gd name="connsiteY40" fmla="*/ 75853 h 2565871"/>
                  <a:gd name="connsiteX41" fmla="*/ 1801073 w 2050316"/>
                  <a:gd name="connsiteY41" fmla="*/ 0 h 2565871"/>
                  <a:gd name="connsiteX42" fmla="*/ 2013800 w 2050316"/>
                  <a:gd name="connsiteY42" fmla="*/ 1217013 h 2565871"/>
                  <a:gd name="connsiteX43" fmla="*/ 1734039 w 2050316"/>
                  <a:gd name="connsiteY43" fmla="*/ 1208839 h 2565871"/>
                  <a:gd name="connsiteX44" fmla="*/ 1770504 w 2050316"/>
                  <a:gd name="connsiteY44" fmla="*/ 1142326 h 2565871"/>
                  <a:gd name="connsiteX45" fmla="*/ 456596 w 2050316"/>
                  <a:gd name="connsiteY45" fmla="*/ 421999 h 2565871"/>
                  <a:gd name="connsiteX46" fmla="*/ 497605 w 2050316"/>
                  <a:gd name="connsiteY46" fmla="*/ 374165 h 2565871"/>
                  <a:gd name="connsiteX47" fmla="*/ 517846 w 2050316"/>
                  <a:gd name="connsiteY47" fmla="*/ 338185 h 2565871"/>
                  <a:gd name="connsiteX48" fmla="*/ 1819989 w 2050316"/>
                  <a:gd name="connsiteY48" fmla="*/ 1052063 h 2565871"/>
                  <a:gd name="connsiteX49" fmla="*/ 1856454 w 2050316"/>
                  <a:gd name="connsiteY49" fmla="*/ 985550 h 25658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</a:cxnLst>
                <a:rect l="l" t="t" r="r" b="b"/>
                <a:pathLst>
                  <a:path w="2050316" h="2565871">
                    <a:moveTo>
                      <a:pt x="436992" y="2301200"/>
                    </a:moveTo>
                    <a:lnTo>
                      <a:pt x="345987" y="2565871"/>
                    </a:lnTo>
                    <a:lnTo>
                      <a:pt x="184879" y="2337010"/>
                    </a:lnTo>
                    <a:lnTo>
                      <a:pt x="259978" y="2326343"/>
                    </a:lnTo>
                    <a:lnTo>
                      <a:pt x="0" y="496074"/>
                    </a:lnTo>
                    <a:lnTo>
                      <a:pt x="20439" y="507572"/>
                    </a:lnTo>
                    <a:cubicBezTo>
                      <a:pt x="44203" y="517994"/>
                      <a:pt x="69366" y="526189"/>
                      <a:pt x="95725" y="531848"/>
                    </a:cubicBezTo>
                    <a:lnTo>
                      <a:pt x="109267" y="533357"/>
                    </a:lnTo>
                    <a:lnTo>
                      <a:pt x="361893" y="2311868"/>
                    </a:lnTo>
                    <a:close/>
                    <a:moveTo>
                      <a:pt x="816287" y="1952484"/>
                    </a:moveTo>
                    <a:lnTo>
                      <a:pt x="598957" y="1776131"/>
                    </a:lnTo>
                    <a:lnTo>
                      <a:pt x="668315" y="1745420"/>
                    </a:lnTo>
                    <a:lnTo>
                      <a:pt x="132793" y="535978"/>
                    </a:lnTo>
                    <a:lnTo>
                      <a:pt x="174342" y="540608"/>
                    </a:lnTo>
                    <a:lnTo>
                      <a:pt x="244626" y="534298"/>
                    </a:lnTo>
                    <a:lnTo>
                      <a:pt x="762438" y="1703744"/>
                    </a:lnTo>
                    <a:lnTo>
                      <a:pt x="831796" y="1673033"/>
                    </a:lnTo>
                    <a:close/>
                    <a:moveTo>
                      <a:pt x="1571197" y="587395"/>
                    </a:moveTo>
                    <a:lnTo>
                      <a:pt x="1294897" y="632023"/>
                    </a:lnTo>
                    <a:lnTo>
                      <a:pt x="1318192" y="559835"/>
                    </a:lnTo>
                    <a:lnTo>
                      <a:pt x="535263" y="307193"/>
                    </a:lnTo>
                    <a:lnTo>
                      <a:pt x="559514" y="231982"/>
                    </a:lnTo>
                    <a:lnTo>
                      <a:pt x="562217" y="207726"/>
                    </a:lnTo>
                    <a:lnTo>
                      <a:pt x="1349803" y="461872"/>
                    </a:lnTo>
                    <a:lnTo>
                      <a:pt x="1373098" y="389684"/>
                    </a:lnTo>
                    <a:close/>
                    <a:moveTo>
                      <a:pt x="1486953" y="2398127"/>
                    </a:moveTo>
                    <a:lnTo>
                      <a:pt x="1248437" y="2251693"/>
                    </a:lnTo>
                    <a:lnTo>
                      <a:pt x="1313186" y="2212181"/>
                    </a:lnTo>
                    <a:lnTo>
                      <a:pt x="283147" y="524236"/>
                    </a:lnTo>
                    <a:lnTo>
                      <a:pt x="323206" y="512463"/>
                    </a:lnTo>
                    <a:lnTo>
                      <a:pt x="378923" y="483570"/>
                    </a:lnTo>
                    <a:lnTo>
                      <a:pt x="1401056" y="2158559"/>
                    </a:lnTo>
                    <a:lnTo>
                      <a:pt x="1465805" y="2119047"/>
                    </a:lnTo>
                    <a:close/>
                    <a:moveTo>
                      <a:pt x="2050316" y="127322"/>
                    </a:moveTo>
                    <a:lnTo>
                      <a:pt x="1801073" y="254644"/>
                    </a:lnTo>
                    <a:lnTo>
                      <a:pt x="1801073" y="178791"/>
                    </a:lnTo>
                    <a:lnTo>
                      <a:pt x="565441" y="178791"/>
                    </a:lnTo>
                    <a:lnTo>
                      <a:pt x="568275" y="153365"/>
                    </a:lnTo>
                    <a:cubicBezTo>
                      <a:pt x="568524" y="127417"/>
                      <a:pt x="566169" y="101831"/>
                      <a:pt x="561411" y="76916"/>
                    </a:cubicBezTo>
                    <a:lnTo>
                      <a:pt x="561099" y="75853"/>
                    </a:lnTo>
                    <a:lnTo>
                      <a:pt x="1801073" y="75853"/>
                    </a:lnTo>
                    <a:lnTo>
                      <a:pt x="1801073" y="0"/>
                    </a:lnTo>
                    <a:close/>
                    <a:moveTo>
                      <a:pt x="2013800" y="1217013"/>
                    </a:moveTo>
                    <a:lnTo>
                      <a:pt x="1734039" y="1208839"/>
                    </a:lnTo>
                    <a:lnTo>
                      <a:pt x="1770504" y="1142326"/>
                    </a:lnTo>
                    <a:lnTo>
                      <a:pt x="456596" y="421999"/>
                    </a:lnTo>
                    <a:lnTo>
                      <a:pt x="497605" y="374165"/>
                    </a:lnTo>
                    <a:lnTo>
                      <a:pt x="517846" y="338185"/>
                    </a:lnTo>
                    <a:lnTo>
                      <a:pt x="1819989" y="1052063"/>
                    </a:lnTo>
                    <a:lnTo>
                      <a:pt x="1856454" y="985550"/>
                    </a:lnTo>
                    <a:close/>
                  </a:path>
                </a:pathLst>
              </a:custGeom>
              <a:solidFill>
                <a:srgbClr val="F4B183">
                  <a:alpha val="82000"/>
                </a:srgbClr>
              </a:solidFill>
              <a:ln>
                <a:solidFill>
                  <a:srgbClr val="C05208"/>
                </a:solidFill>
              </a:ln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281338" y="3336724"/>
                <a:ext cx="601251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7684906" y="3636814"/>
                <a:ext cx="601252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8140214" y="3088375"/>
                <a:ext cx="601252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9206049" y="3274637"/>
                <a:ext cx="601252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8885264" y="3926555"/>
                <a:ext cx="601252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9506139" y="4123165"/>
                <a:ext cx="601252" cy="6269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>
                    <a:solidFill>
                      <a:srgbClr val="FF0000"/>
                    </a:solidFill>
                    <a:effectLst>
                      <a:glow rad="127000">
                        <a:schemeClr val="bg1"/>
                      </a:glow>
                    </a:effectLst>
                  </a:rPr>
                  <a:t>∞</a:t>
                </a:r>
              </a:p>
            </p:txBody>
          </p:sp>
        </p:grpSp>
        <p:sp>
          <p:nvSpPr>
            <p:cNvPr id="12" name="Oval 11"/>
            <p:cNvSpPr/>
            <p:nvPr/>
          </p:nvSpPr>
          <p:spPr>
            <a:xfrm>
              <a:off x="3985226" y="2123474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sp>
        <p:nvSpPr>
          <p:cNvPr id="109" name="TextBox 108"/>
          <p:cNvSpPr txBox="1"/>
          <p:nvPr/>
        </p:nvSpPr>
        <p:spPr>
          <a:xfrm>
            <a:off x="1057275" y="3114675"/>
            <a:ext cx="17780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Open Loop</a:t>
            </a:r>
          </a:p>
        </p:txBody>
      </p:sp>
      <p:grpSp>
        <p:nvGrpSpPr>
          <p:cNvPr id="98" name="Group 97"/>
          <p:cNvGrpSpPr/>
          <p:nvPr/>
        </p:nvGrpSpPr>
        <p:grpSpPr>
          <a:xfrm>
            <a:off x="4291640" y="3710807"/>
            <a:ext cx="3068414" cy="2539966"/>
            <a:chOff x="5505529" y="520700"/>
            <a:chExt cx="4166885" cy="3449256"/>
          </a:xfrm>
        </p:grpSpPr>
        <p:grpSp>
          <p:nvGrpSpPr>
            <p:cNvPr id="42" name="Group 41"/>
            <p:cNvGrpSpPr/>
            <p:nvPr/>
          </p:nvGrpSpPr>
          <p:grpSpPr>
            <a:xfrm>
              <a:off x="5694391" y="720725"/>
              <a:ext cx="3798859" cy="3017737"/>
              <a:chOff x="7307291" y="2028825"/>
              <a:chExt cx="3798859" cy="3017737"/>
            </a:xfrm>
          </p:grpSpPr>
          <p:sp>
            <p:nvSpPr>
              <p:cNvPr id="43" name="Freeform 42"/>
              <p:cNvSpPr/>
              <p:nvPr/>
            </p:nvSpPr>
            <p:spPr>
              <a:xfrm>
                <a:off x="7315200" y="2028825"/>
                <a:ext cx="3790950" cy="1990725"/>
              </a:xfrm>
              <a:custGeom>
                <a:avLst/>
                <a:gdLst>
                  <a:gd name="connsiteX0" fmla="*/ 0 w 3796496"/>
                  <a:gd name="connsiteY0" fmla="*/ 324091 h 1956122"/>
                  <a:gd name="connsiteX1" fmla="*/ 752354 w 3796496"/>
                  <a:gd name="connsiteY1" fmla="*/ 1076446 h 1956122"/>
                  <a:gd name="connsiteX2" fmla="*/ 1527858 w 3796496"/>
                  <a:gd name="connsiteY2" fmla="*/ 0 h 1956122"/>
                  <a:gd name="connsiteX3" fmla="*/ 3240911 w 3796496"/>
                  <a:gd name="connsiteY3" fmla="*/ 625033 h 1956122"/>
                  <a:gd name="connsiteX4" fmla="*/ 2569580 w 3796496"/>
                  <a:gd name="connsiteY4" fmla="*/ 1759352 h 1956122"/>
                  <a:gd name="connsiteX5" fmla="*/ 3796496 w 3796496"/>
                  <a:gd name="connsiteY5" fmla="*/ 1956122 h 1956122"/>
                  <a:gd name="connsiteX0" fmla="*/ 0 w 3796496"/>
                  <a:gd name="connsiteY0" fmla="*/ 324091 h 1956122"/>
                  <a:gd name="connsiteX1" fmla="*/ 752354 w 3796496"/>
                  <a:gd name="connsiteY1" fmla="*/ 1076446 h 1956122"/>
                  <a:gd name="connsiteX2" fmla="*/ 1527858 w 3796496"/>
                  <a:gd name="connsiteY2" fmla="*/ 0 h 1956122"/>
                  <a:gd name="connsiteX3" fmla="*/ 1783586 w 3796496"/>
                  <a:gd name="connsiteY3" fmla="*/ 967933 h 1956122"/>
                  <a:gd name="connsiteX4" fmla="*/ 2569580 w 3796496"/>
                  <a:gd name="connsiteY4" fmla="*/ 1759352 h 1956122"/>
                  <a:gd name="connsiteX5" fmla="*/ 3796496 w 3796496"/>
                  <a:gd name="connsiteY5" fmla="*/ 1956122 h 1956122"/>
                  <a:gd name="connsiteX0" fmla="*/ 0 w 3205946"/>
                  <a:gd name="connsiteY0" fmla="*/ 324091 h 1759352"/>
                  <a:gd name="connsiteX1" fmla="*/ 752354 w 3205946"/>
                  <a:gd name="connsiteY1" fmla="*/ 1076446 h 1759352"/>
                  <a:gd name="connsiteX2" fmla="*/ 1527858 w 3205946"/>
                  <a:gd name="connsiteY2" fmla="*/ 0 h 1759352"/>
                  <a:gd name="connsiteX3" fmla="*/ 1783586 w 3205946"/>
                  <a:gd name="connsiteY3" fmla="*/ 967933 h 1759352"/>
                  <a:gd name="connsiteX4" fmla="*/ 2569580 w 3205946"/>
                  <a:gd name="connsiteY4" fmla="*/ 1759352 h 1759352"/>
                  <a:gd name="connsiteX5" fmla="*/ 3205946 w 3205946"/>
                  <a:gd name="connsiteY5" fmla="*/ 632147 h 1759352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1783586 w 3769730"/>
                  <a:gd name="connsiteY3" fmla="*/ 967933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2593211 w 3769730"/>
                  <a:gd name="connsiteY3" fmla="*/ 1739458 h 1978427"/>
                  <a:gd name="connsiteX4" fmla="*/ 3769730 w 3769730"/>
                  <a:gd name="connsiteY4" fmla="*/ 1978427 h 1978427"/>
                  <a:gd name="connsiteX5" fmla="*/ 3205946 w 3769730"/>
                  <a:gd name="connsiteY5" fmla="*/ 632147 h 1978427"/>
                  <a:gd name="connsiteX0" fmla="*/ 0 w 3769730"/>
                  <a:gd name="connsiteY0" fmla="*/ 324091 h 1978427"/>
                  <a:gd name="connsiteX1" fmla="*/ 752354 w 3769730"/>
                  <a:gd name="connsiteY1" fmla="*/ 1076446 h 1978427"/>
                  <a:gd name="connsiteX2" fmla="*/ 1527858 w 3769730"/>
                  <a:gd name="connsiteY2" fmla="*/ 0 h 1978427"/>
                  <a:gd name="connsiteX3" fmla="*/ 3769730 w 3769730"/>
                  <a:gd name="connsiteY3" fmla="*/ 1978427 h 1978427"/>
                  <a:gd name="connsiteX4" fmla="*/ 3205946 w 3769730"/>
                  <a:gd name="connsiteY4" fmla="*/ 632147 h 1978427"/>
                  <a:gd name="connsiteX0" fmla="*/ 0 w 3205946"/>
                  <a:gd name="connsiteY0" fmla="*/ 330651 h 1083006"/>
                  <a:gd name="connsiteX1" fmla="*/ 752354 w 3205946"/>
                  <a:gd name="connsiteY1" fmla="*/ 1083006 h 1083006"/>
                  <a:gd name="connsiteX2" fmla="*/ 1527858 w 3205946"/>
                  <a:gd name="connsiteY2" fmla="*/ 6560 h 1083006"/>
                  <a:gd name="connsiteX3" fmla="*/ 3205946 w 3205946"/>
                  <a:gd name="connsiteY3" fmla="*/ 638707 h 1083006"/>
                  <a:gd name="connsiteX0" fmla="*/ 0 w 3205946"/>
                  <a:gd name="connsiteY0" fmla="*/ 0 h 752355"/>
                  <a:gd name="connsiteX1" fmla="*/ 752354 w 3205946"/>
                  <a:gd name="connsiteY1" fmla="*/ 752355 h 752355"/>
                  <a:gd name="connsiteX2" fmla="*/ 3205946 w 3205946"/>
                  <a:gd name="connsiteY2" fmla="*/ 308056 h 752355"/>
                  <a:gd name="connsiteX0" fmla="*/ 0 w 3205946"/>
                  <a:gd name="connsiteY0" fmla="*/ 0 h 752355"/>
                  <a:gd name="connsiteX1" fmla="*/ 752354 w 3205946"/>
                  <a:gd name="connsiteY1" fmla="*/ 752355 h 752355"/>
                  <a:gd name="connsiteX2" fmla="*/ 2266950 w 3205946"/>
                  <a:gd name="connsiteY2" fmla="*/ 477215 h 752355"/>
                  <a:gd name="connsiteX3" fmla="*/ 3205946 w 3205946"/>
                  <a:gd name="connsiteY3" fmla="*/ 308056 h 752355"/>
                  <a:gd name="connsiteX0" fmla="*/ 0 w 3790950"/>
                  <a:gd name="connsiteY0" fmla="*/ 0 h 1658315"/>
                  <a:gd name="connsiteX1" fmla="*/ 752354 w 3790950"/>
                  <a:gd name="connsiteY1" fmla="*/ 752355 h 1658315"/>
                  <a:gd name="connsiteX2" fmla="*/ 3790950 w 3790950"/>
                  <a:gd name="connsiteY2" fmla="*/ 1658315 h 1658315"/>
                  <a:gd name="connsiteX3" fmla="*/ 3205946 w 3790950"/>
                  <a:gd name="connsiteY3" fmla="*/ 308056 h 1658315"/>
                  <a:gd name="connsiteX0" fmla="*/ 0 w 3790950"/>
                  <a:gd name="connsiteY0" fmla="*/ 0 h 1658315"/>
                  <a:gd name="connsiteX1" fmla="*/ 752354 w 3790950"/>
                  <a:gd name="connsiteY1" fmla="*/ 752355 h 1658315"/>
                  <a:gd name="connsiteX2" fmla="*/ 1590675 w 3790950"/>
                  <a:gd name="connsiteY2" fmla="*/ 982040 h 1658315"/>
                  <a:gd name="connsiteX3" fmla="*/ 3790950 w 3790950"/>
                  <a:gd name="connsiteY3" fmla="*/ 1658315 h 1658315"/>
                  <a:gd name="connsiteX4" fmla="*/ 3205946 w 3790950"/>
                  <a:gd name="connsiteY4" fmla="*/ 308056 h 1658315"/>
                  <a:gd name="connsiteX0" fmla="*/ 0 w 3790950"/>
                  <a:gd name="connsiteY0" fmla="*/ 332410 h 1990725"/>
                  <a:gd name="connsiteX1" fmla="*/ 752354 w 3790950"/>
                  <a:gd name="connsiteY1" fmla="*/ 1084765 h 1990725"/>
                  <a:gd name="connsiteX2" fmla="*/ 1524000 w 3790950"/>
                  <a:gd name="connsiteY2" fmla="*/ 0 h 1990725"/>
                  <a:gd name="connsiteX3" fmla="*/ 3790950 w 3790950"/>
                  <a:gd name="connsiteY3" fmla="*/ 1990725 h 1990725"/>
                  <a:gd name="connsiteX4" fmla="*/ 3205946 w 3790950"/>
                  <a:gd name="connsiteY4" fmla="*/ 640466 h 1990725"/>
                  <a:gd name="connsiteX0" fmla="*/ 0 w 3790950"/>
                  <a:gd name="connsiteY0" fmla="*/ 332410 h 1990725"/>
                  <a:gd name="connsiteX1" fmla="*/ 752354 w 3790950"/>
                  <a:gd name="connsiteY1" fmla="*/ 1084765 h 1990725"/>
                  <a:gd name="connsiteX2" fmla="*/ 1524000 w 3790950"/>
                  <a:gd name="connsiteY2" fmla="*/ 0 h 1990725"/>
                  <a:gd name="connsiteX3" fmla="*/ 2905125 w 3790950"/>
                  <a:gd name="connsiteY3" fmla="*/ 1238250 h 1990725"/>
                  <a:gd name="connsiteX4" fmla="*/ 3790950 w 3790950"/>
                  <a:gd name="connsiteY4" fmla="*/ 1990725 h 1990725"/>
                  <a:gd name="connsiteX5" fmla="*/ 3205946 w 3790950"/>
                  <a:gd name="connsiteY5" fmla="*/ 640466 h 1990725"/>
                  <a:gd name="connsiteX0" fmla="*/ 0 w 3790950"/>
                  <a:gd name="connsiteY0" fmla="*/ 332410 h 1990725"/>
                  <a:gd name="connsiteX1" fmla="*/ 752354 w 3790950"/>
                  <a:gd name="connsiteY1" fmla="*/ 1084765 h 1990725"/>
                  <a:gd name="connsiteX2" fmla="*/ 1524000 w 3790950"/>
                  <a:gd name="connsiteY2" fmla="*/ 0 h 1990725"/>
                  <a:gd name="connsiteX3" fmla="*/ 2581275 w 3790950"/>
                  <a:gd name="connsiteY3" fmla="*/ 1762125 h 1990725"/>
                  <a:gd name="connsiteX4" fmla="*/ 3790950 w 3790950"/>
                  <a:gd name="connsiteY4" fmla="*/ 1990725 h 1990725"/>
                  <a:gd name="connsiteX5" fmla="*/ 3205946 w 3790950"/>
                  <a:gd name="connsiteY5" fmla="*/ 640466 h 19907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790950" h="1990725">
                    <a:moveTo>
                      <a:pt x="0" y="332410"/>
                    </a:moveTo>
                    <a:lnTo>
                      <a:pt x="752354" y="1084765"/>
                    </a:lnTo>
                    <a:lnTo>
                      <a:pt x="1524000" y="0"/>
                    </a:lnTo>
                    <a:lnTo>
                      <a:pt x="2581275" y="1762125"/>
                    </a:lnTo>
                    <a:lnTo>
                      <a:pt x="3790950" y="1990725"/>
                    </a:lnTo>
                    <a:lnTo>
                      <a:pt x="3205946" y="640466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44" name="Freeform 43"/>
              <p:cNvSpPr/>
              <p:nvPr/>
            </p:nvSpPr>
            <p:spPr>
              <a:xfrm>
                <a:off x="7307291" y="2437435"/>
                <a:ext cx="551919" cy="2609127"/>
              </a:xfrm>
              <a:custGeom>
                <a:avLst/>
                <a:gdLst>
                  <a:gd name="connsiteX0" fmla="*/ 0 w 567159"/>
                  <a:gd name="connsiteY0" fmla="*/ 0 h 2685327"/>
                  <a:gd name="connsiteX1" fmla="*/ 567159 w 567159"/>
                  <a:gd name="connsiteY1" fmla="*/ 2685327 h 2685327"/>
                  <a:gd name="connsiteX0" fmla="*/ 240561 w 240561"/>
                  <a:gd name="connsiteY0" fmla="*/ 0 h 1961427"/>
                  <a:gd name="connsiteX1" fmla="*/ 0 w 240561"/>
                  <a:gd name="connsiteY1" fmla="*/ 1961427 h 1961427"/>
                  <a:gd name="connsiteX0" fmla="*/ 0 w 551919"/>
                  <a:gd name="connsiteY0" fmla="*/ 0 h 2609127"/>
                  <a:gd name="connsiteX1" fmla="*/ 551919 w 551919"/>
                  <a:gd name="connsiteY1" fmla="*/ 2609127 h 26091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1919" h="2609127">
                    <a:moveTo>
                      <a:pt x="0" y="0"/>
                    </a:moveTo>
                    <a:lnTo>
                      <a:pt x="551919" y="2609127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45" name="Freeform 44"/>
              <p:cNvSpPr/>
              <p:nvPr/>
            </p:nvSpPr>
            <p:spPr>
              <a:xfrm>
                <a:off x="7852169" y="2587231"/>
                <a:ext cx="2756607" cy="2437339"/>
              </a:xfrm>
              <a:custGeom>
                <a:avLst/>
                <a:gdLst>
                  <a:gd name="connsiteX0" fmla="*/ 3206187 w 3206187"/>
                  <a:gd name="connsiteY0" fmla="*/ 0 h 1134319"/>
                  <a:gd name="connsiteX1" fmla="*/ 0 w 3206187"/>
                  <a:gd name="connsiteY1" fmla="*/ 1134319 h 1134319"/>
                  <a:gd name="connsiteX0" fmla="*/ 2642307 w 2642307"/>
                  <a:gd name="connsiteY0" fmla="*/ 0 h 2544019"/>
                  <a:gd name="connsiteX1" fmla="*/ 0 w 2642307"/>
                  <a:gd name="connsiteY1" fmla="*/ 2544019 h 2544019"/>
                  <a:gd name="connsiteX0" fmla="*/ 2695647 w 2695647"/>
                  <a:gd name="connsiteY0" fmla="*/ 0 h 2452579"/>
                  <a:gd name="connsiteX1" fmla="*/ 0 w 2695647"/>
                  <a:gd name="connsiteY1" fmla="*/ 2452579 h 2452579"/>
                  <a:gd name="connsiteX0" fmla="*/ 2756607 w 2756607"/>
                  <a:gd name="connsiteY0" fmla="*/ 0 h 2437339"/>
                  <a:gd name="connsiteX1" fmla="*/ 0 w 2756607"/>
                  <a:gd name="connsiteY1" fmla="*/ 2437339 h 24373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56607" h="2437339">
                    <a:moveTo>
                      <a:pt x="2756607" y="0"/>
                    </a:moveTo>
                    <a:lnTo>
                      <a:pt x="0" y="2437339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46" name="Oval 45"/>
            <p:cNvSpPr/>
            <p:nvPr/>
          </p:nvSpPr>
          <p:spPr>
            <a:xfrm>
              <a:off x="5505529" y="856366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47" name="Oval 46"/>
            <p:cNvSpPr/>
            <p:nvPr/>
          </p:nvSpPr>
          <p:spPr>
            <a:xfrm>
              <a:off x="7021813" y="520700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48" name="Oval 47"/>
            <p:cNvSpPr/>
            <p:nvPr/>
          </p:nvSpPr>
          <p:spPr>
            <a:xfrm>
              <a:off x="8086684" y="2268477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49" name="Oval 48"/>
            <p:cNvSpPr/>
            <p:nvPr/>
          </p:nvSpPr>
          <p:spPr>
            <a:xfrm>
              <a:off x="6257884" y="1585572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50" name="Oval 49"/>
            <p:cNvSpPr/>
            <p:nvPr/>
          </p:nvSpPr>
          <p:spPr>
            <a:xfrm>
              <a:off x="9255726" y="2453674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51" name="Oval 50"/>
            <p:cNvSpPr/>
            <p:nvPr/>
          </p:nvSpPr>
          <p:spPr>
            <a:xfrm>
              <a:off x="8711716" y="1157308"/>
              <a:ext cx="416688" cy="4166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52" name="Oval 51"/>
            <p:cNvSpPr/>
            <p:nvPr/>
          </p:nvSpPr>
          <p:spPr>
            <a:xfrm>
              <a:off x="6072689" y="3553268"/>
              <a:ext cx="416688" cy="416688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53" name="Freeform 52"/>
            <p:cNvSpPr/>
            <p:nvPr/>
          </p:nvSpPr>
          <p:spPr>
            <a:xfrm rot="15473100">
              <a:off x="6239261" y="1355974"/>
              <a:ext cx="1920530" cy="2565871"/>
            </a:xfrm>
            <a:custGeom>
              <a:avLst/>
              <a:gdLst>
                <a:gd name="connsiteX0" fmla="*/ 436992 w 2050316"/>
                <a:gd name="connsiteY0" fmla="*/ 2301200 h 2565871"/>
                <a:gd name="connsiteX1" fmla="*/ 345987 w 2050316"/>
                <a:gd name="connsiteY1" fmla="*/ 2565871 h 2565871"/>
                <a:gd name="connsiteX2" fmla="*/ 184879 w 2050316"/>
                <a:gd name="connsiteY2" fmla="*/ 2337010 h 2565871"/>
                <a:gd name="connsiteX3" fmla="*/ 259978 w 2050316"/>
                <a:gd name="connsiteY3" fmla="*/ 2326343 h 2565871"/>
                <a:gd name="connsiteX4" fmla="*/ 0 w 2050316"/>
                <a:gd name="connsiteY4" fmla="*/ 496074 h 2565871"/>
                <a:gd name="connsiteX5" fmla="*/ 20439 w 2050316"/>
                <a:gd name="connsiteY5" fmla="*/ 507572 h 2565871"/>
                <a:gd name="connsiteX6" fmla="*/ 95725 w 2050316"/>
                <a:gd name="connsiteY6" fmla="*/ 531848 h 2565871"/>
                <a:gd name="connsiteX7" fmla="*/ 109267 w 2050316"/>
                <a:gd name="connsiteY7" fmla="*/ 533357 h 2565871"/>
                <a:gd name="connsiteX8" fmla="*/ 361893 w 2050316"/>
                <a:gd name="connsiteY8" fmla="*/ 2311868 h 2565871"/>
                <a:gd name="connsiteX9" fmla="*/ 816287 w 2050316"/>
                <a:gd name="connsiteY9" fmla="*/ 1952484 h 2565871"/>
                <a:gd name="connsiteX10" fmla="*/ 598957 w 2050316"/>
                <a:gd name="connsiteY10" fmla="*/ 1776131 h 2565871"/>
                <a:gd name="connsiteX11" fmla="*/ 668315 w 2050316"/>
                <a:gd name="connsiteY11" fmla="*/ 1745420 h 2565871"/>
                <a:gd name="connsiteX12" fmla="*/ 132793 w 2050316"/>
                <a:gd name="connsiteY12" fmla="*/ 535978 h 2565871"/>
                <a:gd name="connsiteX13" fmla="*/ 174342 w 2050316"/>
                <a:gd name="connsiteY13" fmla="*/ 540608 h 2565871"/>
                <a:gd name="connsiteX14" fmla="*/ 244626 w 2050316"/>
                <a:gd name="connsiteY14" fmla="*/ 534298 h 2565871"/>
                <a:gd name="connsiteX15" fmla="*/ 762438 w 2050316"/>
                <a:gd name="connsiteY15" fmla="*/ 1703744 h 2565871"/>
                <a:gd name="connsiteX16" fmla="*/ 831796 w 2050316"/>
                <a:gd name="connsiteY16" fmla="*/ 1673033 h 2565871"/>
                <a:gd name="connsiteX17" fmla="*/ 1571197 w 2050316"/>
                <a:gd name="connsiteY17" fmla="*/ 587395 h 2565871"/>
                <a:gd name="connsiteX18" fmla="*/ 1294897 w 2050316"/>
                <a:gd name="connsiteY18" fmla="*/ 632023 h 2565871"/>
                <a:gd name="connsiteX19" fmla="*/ 1318192 w 2050316"/>
                <a:gd name="connsiteY19" fmla="*/ 559835 h 2565871"/>
                <a:gd name="connsiteX20" fmla="*/ 535263 w 2050316"/>
                <a:gd name="connsiteY20" fmla="*/ 307193 h 2565871"/>
                <a:gd name="connsiteX21" fmla="*/ 559514 w 2050316"/>
                <a:gd name="connsiteY21" fmla="*/ 231982 h 2565871"/>
                <a:gd name="connsiteX22" fmla="*/ 562217 w 2050316"/>
                <a:gd name="connsiteY22" fmla="*/ 207726 h 2565871"/>
                <a:gd name="connsiteX23" fmla="*/ 1349803 w 2050316"/>
                <a:gd name="connsiteY23" fmla="*/ 461872 h 2565871"/>
                <a:gd name="connsiteX24" fmla="*/ 1373098 w 2050316"/>
                <a:gd name="connsiteY24" fmla="*/ 389684 h 2565871"/>
                <a:gd name="connsiteX25" fmla="*/ 1486953 w 2050316"/>
                <a:gd name="connsiteY25" fmla="*/ 2398127 h 2565871"/>
                <a:gd name="connsiteX26" fmla="*/ 1248437 w 2050316"/>
                <a:gd name="connsiteY26" fmla="*/ 2251693 h 2565871"/>
                <a:gd name="connsiteX27" fmla="*/ 1313186 w 2050316"/>
                <a:gd name="connsiteY27" fmla="*/ 2212181 h 2565871"/>
                <a:gd name="connsiteX28" fmla="*/ 283147 w 2050316"/>
                <a:gd name="connsiteY28" fmla="*/ 524236 h 2565871"/>
                <a:gd name="connsiteX29" fmla="*/ 323206 w 2050316"/>
                <a:gd name="connsiteY29" fmla="*/ 512463 h 2565871"/>
                <a:gd name="connsiteX30" fmla="*/ 378923 w 2050316"/>
                <a:gd name="connsiteY30" fmla="*/ 483570 h 2565871"/>
                <a:gd name="connsiteX31" fmla="*/ 1401056 w 2050316"/>
                <a:gd name="connsiteY31" fmla="*/ 2158559 h 2565871"/>
                <a:gd name="connsiteX32" fmla="*/ 1465805 w 2050316"/>
                <a:gd name="connsiteY32" fmla="*/ 2119047 h 2565871"/>
                <a:gd name="connsiteX33" fmla="*/ 2050316 w 2050316"/>
                <a:gd name="connsiteY33" fmla="*/ 127322 h 2565871"/>
                <a:gd name="connsiteX34" fmla="*/ 1801073 w 2050316"/>
                <a:gd name="connsiteY34" fmla="*/ 254644 h 2565871"/>
                <a:gd name="connsiteX35" fmla="*/ 1801073 w 2050316"/>
                <a:gd name="connsiteY35" fmla="*/ 178791 h 2565871"/>
                <a:gd name="connsiteX36" fmla="*/ 565441 w 2050316"/>
                <a:gd name="connsiteY36" fmla="*/ 178791 h 2565871"/>
                <a:gd name="connsiteX37" fmla="*/ 568275 w 2050316"/>
                <a:gd name="connsiteY37" fmla="*/ 153365 h 2565871"/>
                <a:gd name="connsiteX38" fmla="*/ 561411 w 2050316"/>
                <a:gd name="connsiteY38" fmla="*/ 76916 h 2565871"/>
                <a:gd name="connsiteX39" fmla="*/ 561099 w 2050316"/>
                <a:gd name="connsiteY39" fmla="*/ 75853 h 2565871"/>
                <a:gd name="connsiteX40" fmla="*/ 1801073 w 2050316"/>
                <a:gd name="connsiteY40" fmla="*/ 75853 h 2565871"/>
                <a:gd name="connsiteX41" fmla="*/ 1801073 w 2050316"/>
                <a:gd name="connsiteY41" fmla="*/ 0 h 2565871"/>
                <a:gd name="connsiteX42" fmla="*/ 2013800 w 2050316"/>
                <a:gd name="connsiteY42" fmla="*/ 1217013 h 2565871"/>
                <a:gd name="connsiteX43" fmla="*/ 1734039 w 2050316"/>
                <a:gd name="connsiteY43" fmla="*/ 1208839 h 2565871"/>
                <a:gd name="connsiteX44" fmla="*/ 1770504 w 2050316"/>
                <a:gd name="connsiteY44" fmla="*/ 1142326 h 2565871"/>
                <a:gd name="connsiteX45" fmla="*/ 456596 w 2050316"/>
                <a:gd name="connsiteY45" fmla="*/ 421999 h 2565871"/>
                <a:gd name="connsiteX46" fmla="*/ 497605 w 2050316"/>
                <a:gd name="connsiteY46" fmla="*/ 374165 h 2565871"/>
                <a:gd name="connsiteX47" fmla="*/ 517846 w 2050316"/>
                <a:gd name="connsiteY47" fmla="*/ 338185 h 2565871"/>
                <a:gd name="connsiteX48" fmla="*/ 1819989 w 2050316"/>
                <a:gd name="connsiteY48" fmla="*/ 1052063 h 2565871"/>
                <a:gd name="connsiteX49" fmla="*/ 1856454 w 2050316"/>
                <a:gd name="connsiteY49" fmla="*/ 985550 h 25658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</a:cxnLst>
              <a:rect l="l" t="t" r="r" b="b"/>
              <a:pathLst>
                <a:path w="2050316" h="2565871">
                  <a:moveTo>
                    <a:pt x="436992" y="2301200"/>
                  </a:moveTo>
                  <a:lnTo>
                    <a:pt x="345987" y="2565871"/>
                  </a:lnTo>
                  <a:lnTo>
                    <a:pt x="184879" y="2337010"/>
                  </a:lnTo>
                  <a:lnTo>
                    <a:pt x="259978" y="2326343"/>
                  </a:lnTo>
                  <a:lnTo>
                    <a:pt x="0" y="496074"/>
                  </a:lnTo>
                  <a:lnTo>
                    <a:pt x="20439" y="507572"/>
                  </a:lnTo>
                  <a:cubicBezTo>
                    <a:pt x="44203" y="517994"/>
                    <a:pt x="69366" y="526189"/>
                    <a:pt x="95725" y="531848"/>
                  </a:cubicBezTo>
                  <a:lnTo>
                    <a:pt x="109267" y="533357"/>
                  </a:lnTo>
                  <a:lnTo>
                    <a:pt x="361893" y="2311868"/>
                  </a:lnTo>
                  <a:close/>
                  <a:moveTo>
                    <a:pt x="816287" y="1952484"/>
                  </a:moveTo>
                  <a:lnTo>
                    <a:pt x="598957" y="1776131"/>
                  </a:lnTo>
                  <a:lnTo>
                    <a:pt x="668315" y="1745420"/>
                  </a:lnTo>
                  <a:lnTo>
                    <a:pt x="132793" y="535978"/>
                  </a:lnTo>
                  <a:lnTo>
                    <a:pt x="174342" y="540608"/>
                  </a:lnTo>
                  <a:lnTo>
                    <a:pt x="244626" y="534298"/>
                  </a:lnTo>
                  <a:lnTo>
                    <a:pt x="762438" y="1703744"/>
                  </a:lnTo>
                  <a:lnTo>
                    <a:pt x="831796" y="1673033"/>
                  </a:lnTo>
                  <a:close/>
                  <a:moveTo>
                    <a:pt x="1571197" y="587395"/>
                  </a:moveTo>
                  <a:lnTo>
                    <a:pt x="1294897" y="632023"/>
                  </a:lnTo>
                  <a:lnTo>
                    <a:pt x="1318192" y="559835"/>
                  </a:lnTo>
                  <a:lnTo>
                    <a:pt x="535263" y="307193"/>
                  </a:lnTo>
                  <a:lnTo>
                    <a:pt x="559514" y="231982"/>
                  </a:lnTo>
                  <a:lnTo>
                    <a:pt x="562217" y="207726"/>
                  </a:lnTo>
                  <a:lnTo>
                    <a:pt x="1349803" y="461872"/>
                  </a:lnTo>
                  <a:lnTo>
                    <a:pt x="1373098" y="389684"/>
                  </a:lnTo>
                  <a:close/>
                  <a:moveTo>
                    <a:pt x="1486953" y="2398127"/>
                  </a:moveTo>
                  <a:lnTo>
                    <a:pt x="1248437" y="2251693"/>
                  </a:lnTo>
                  <a:lnTo>
                    <a:pt x="1313186" y="2212181"/>
                  </a:lnTo>
                  <a:lnTo>
                    <a:pt x="283147" y="524236"/>
                  </a:lnTo>
                  <a:lnTo>
                    <a:pt x="323206" y="512463"/>
                  </a:lnTo>
                  <a:lnTo>
                    <a:pt x="378923" y="483570"/>
                  </a:lnTo>
                  <a:lnTo>
                    <a:pt x="1401056" y="2158559"/>
                  </a:lnTo>
                  <a:lnTo>
                    <a:pt x="1465805" y="2119047"/>
                  </a:lnTo>
                  <a:close/>
                  <a:moveTo>
                    <a:pt x="2050316" y="127322"/>
                  </a:moveTo>
                  <a:lnTo>
                    <a:pt x="1801073" y="254644"/>
                  </a:lnTo>
                  <a:lnTo>
                    <a:pt x="1801073" y="178791"/>
                  </a:lnTo>
                  <a:lnTo>
                    <a:pt x="565441" y="178791"/>
                  </a:lnTo>
                  <a:lnTo>
                    <a:pt x="568275" y="153365"/>
                  </a:lnTo>
                  <a:cubicBezTo>
                    <a:pt x="568524" y="127417"/>
                    <a:pt x="566169" y="101831"/>
                    <a:pt x="561411" y="76916"/>
                  </a:cubicBezTo>
                  <a:lnTo>
                    <a:pt x="561099" y="75853"/>
                  </a:lnTo>
                  <a:lnTo>
                    <a:pt x="1801073" y="75853"/>
                  </a:lnTo>
                  <a:lnTo>
                    <a:pt x="1801073" y="0"/>
                  </a:lnTo>
                  <a:close/>
                  <a:moveTo>
                    <a:pt x="2013800" y="1217013"/>
                  </a:moveTo>
                  <a:lnTo>
                    <a:pt x="1734039" y="1208839"/>
                  </a:lnTo>
                  <a:lnTo>
                    <a:pt x="1770504" y="1142326"/>
                  </a:lnTo>
                  <a:lnTo>
                    <a:pt x="456596" y="421999"/>
                  </a:lnTo>
                  <a:lnTo>
                    <a:pt x="497605" y="374165"/>
                  </a:lnTo>
                  <a:lnTo>
                    <a:pt x="517846" y="338185"/>
                  </a:lnTo>
                  <a:lnTo>
                    <a:pt x="1819989" y="1052063"/>
                  </a:lnTo>
                  <a:lnTo>
                    <a:pt x="1856454" y="985550"/>
                  </a:lnTo>
                  <a:close/>
                </a:path>
              </a:pathLst>
            </a:custGeom>
            <a:solidFill>
              <a:srgbClr val="F4B183">
                <a:alpha val="82000"/>
              </a:srgbClr>
            </a:solidFill>
            <a:ln>
              <a:solidFill>
                <a:srgbClr val="C05208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658090" y="2038973"/>
              <a:ext cx="601251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6264420" y="1132498"/>
              <a:ext cx="2874139" cy="1720678"/>
              <a:chOff x="7877320" y="2440598"/>
              <a:chExt cx="2874140" cy="1720678"/>
            </a:xfrm>
          </p:grpSpPr>
          <p:sp>
            <p:nvSpPr>
              <p:cNvPr id="62" name="Right Arrow 61"/>
              <p:cNvSpPr/>
              <p:nvPr/>
            </p:nvSpPr>
            <p:spPr>
              <a:xfrm rot="19100900">
                <a:off x="7877320" y="3801520"/>
                <a:ext cx="2272798" cy="359756"/>
              </a:xfrm>
              <a:prstGeom prst="rightArrow">
                <a:avLst>
                  <a:gd name="adj1" fmla="val 40424"/>
                  <a:gd name="adj2" fmla="val 97879"/>
                </a:avLst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63" name="Oval 62"/>
              <p:cNvSpPr/>
              <p:nvPr/>
            </p:nvSpPr>
            <p:spPr>
              <a:xfrm>
                <a:off x="10307764" y="2440598"/>
                <a:ext cx="443696" cy="443696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5400">
                <a:solidFill>
                  <a:srgbClr val="C0520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7561073" y="2008235"/>
              <a:ext cx="461932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6072006" y="2349410"/>
              <a:ext cx="601251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537662" y="1811319"/>
              <a:ext cx="601251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7293060" y="2618456"/>
              <a:ext cx="601251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7913934" y="2815066"/>
              <a:ext cx="601251" cy="6269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4876346" y="3114675"/>
            <a:ext cx="17241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Fixed Start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9178924" y="3116489"/>
            <a:ext cx="10020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2-TSP</a:t>
            </a:r>
          </a:p>
        </p:txBody>
      </p:sp>
      <p:grpSp>
        <p:nvGrpSpPr>
          <p:cNvPr id="225" name="Group 224"/>
          <p:cNvGrpSpPr/>
          <p:nvPr/>
        </p:nvGrpSpPr>
        <p:grpSpPr>
          <a:xfrm>
            <a:off x="8129709" y="3712621"/>
            <a:ext cx="3068414" cy="3008053"/>
            <a:chOff x="8129709" y="3712621"/>
            <a:chExt cx="3068414" cy="3008053"/>
          </a:xfrm>
        </p:grpSpPr>
        <p:sp>
          <p:nvSpPr>
            <p:cNvPr id="144" name="Freeform 143"/>
            <p:cNvSpPr/>
            <p:nvPr/>
          </p:nvSpPr>
          <p:spPr>
            <a:xfrm>
              <a:off x="10181771" y="4327434"/>
              <a:ext cx="876300" cy="960120"/>
            </a:xfrm>
            <a:custGeom>
              <a:avLst/>
              <a:gdLst>
                <a:gd name="connsiteX0" fmla="*/ 457200 w 876300"/>
                <a:gd name="connsiteY0" fmla="*/ 0 h 960120"/>
                <a:gd name="connsiteX1" fmla="*/ 0 w 876300"/>
                <a:gd name="connsiteY1" fmla="*/ 830580 h 960120"/>
                <a:gd name="connsiteX2" fmla="*/ 876300 w 876300"/>
                <a:gd name="connsiteY2" fmla="*/ 960120 h 9601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876300" h="960120">
                  <a:moveTo>
                    <a:pt x="457200" y="0"/>
                  </a:moveTo>
                  <a:lnTo>
                    <a:pt x="0" y="830580"/>
                  </a:lnTo>
                  <a:lnTo>
                    <a:pt x="876300" y="960120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Freeform 139"/>
            <p:cNvSpPr/>
            <p:nvPr/>
          </p:nvSpPr>
          <p:spPr>
            <a:xfrm>
              <a:off x="8290105" y="4157889"/>
              <a:ext cx="348615" cy="1838325"/>
            </a:xfrm>
            <a:custGeom>
              <a:avLst/>
              <a:gdLst>
                <a:gd name="connsiteX0" fmla="*/ 200025 w 200025"/>
                <a:gd name="connsiteY0" fmla="*/ 0 h 1343025"/>
                <a:gd name="connsiteX1" fmla="*/ 0 w 200025"/>
                <a:gd name="connsiteY1" fmla="*/ 1343025 h 1343025"/>
                <a:gd name="connsiteX0" fmla="*/ 0 w 348615"/>
                <a:gd name="connsiteY0" fmla="*/ 0 h 1838325"/>
                <a:gd name="connsiteX1" fmla="*/ 348615 w 348615"/>
                <a:gd name="connsiteY1" fmla="*/ 1838325 h 18383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8615" h="1838325">
                  <a:moveTo>
                    <a:pt x="0" y="0"/>
                  </a:moveTo>
                  <a:lnTo>
                    <a:pt x="348615" y="1838325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Freeform 140"/>
            <p:cNvSpPr/>
            <p:nvPr/>
          </p:nvSpPr>
          <p:spPr>
            <a:xfrm>
              <a:off x="8679996" y="3881664"/>
              <a:ext cx="682625" cy="2219325"/>
            </a:xfrm>
            <a:custGeom>
              <a:avLst/>
              <a:gdLst>
                <a:gd name="connsiteX0" fmla="*/ 200025 w 200025"/>
                <a:gd name="connsiteY0" fmla="*/ 0 h 1343025"/>
                <a:gd name="connsiteX1" fmla="*/ 0 w 200025"/>
                <a:gd name="connsiteY1" fmla="*/ 1343025 h 1343025"/>
                <a:gd name="connsiteX0" fmla="*/ 682625 w 682625"/>
                <a:gd name="connsiteY0" fmla="*/ 0 h 2219325"/>
                <a:gd name="connsiteX1" fmla="*/ 0 w 682625"/>
                <a:gd name="connsiteY1" fmla="*/ 2219325 h 22193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82625" h="2219325">
                  <a:moveTo>
                    <a:pt x="682625" y="0"/>
                  </a:moveTo>
                  <a:lnTo>
                    <a:pt x="0" y="2219325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Freeform 141"/>
            <p:cNvSpPr/>
            <p:nvPr/>
          </p:nvSpPr>
          <p:spPr>
            <a:xfrm>
              <a:off x="9129576" y="4326164"/>
              <a:ext cx="1515745" cy="1792605"/>
            </a:xfrm>
            <a:custGeom>
              <a:avLst/>
              <a:gdLst>
                <a:gd name="connsiteX0" fmla="*/ 200025 w 200025"/>
                <a:gd name="connsiteY0" fmla="*/ 0 h 1343025"/>
                <a:gd name="connsiteX1" fmla="*/ 0 w 200025"/>
                <a:gd name="connsiteY1" fmla="*/ 1343025 h 1343025"/>
                <a:gd name="connsiteX0" fmla="*/ 682625 w 682625"/>
                <a:gd name="connsiteY0" fmla="*/ 0 h 2219325"/>
                <a:gd name="connsiteX1" fmla="*/ 0 w 682625"/>
                <a:gd name="connsiteY1" fmla="*/ 2219325 h 2219325"/>
                <a:gd name="connsiteX0" fmla="*/ 1216025 w 1216025"/>
                <a:gd name="connsiteY0" fmla="*/ 0 h 1774825"/>
                <a:gd name="connsiteX1" fmla="*/ 0 w 1216025"/>
                <a:gd name="connsiteY1" fmla="*/ 1774825 h 1774825"/>
                <a:gd name="connsiteX0" fmla="*/ 1622425 w 1622425"/>
                <a:gd name="connsiteY0" fmla="*/ 0 h 1762125"/>
                <a:gd name="connsiteX1" fmla="*/ 0 w 1622425"/>
                <a:gd name="connsiteY1" fmla="*/ 1762125 h 1762125"/>
                <a:gd name="connsiteX0" fmla="*/ 1515745 w 1515745"/>
                <a:gd name="connsiteY0" fmla="*/ 0 h 1792605"/>
                <a:gd name="connsiteX1" fmla="*/ 0 w 1515745"/>
                <a:gd name="connsiteY1" fmla="*/ 1792605 h 17926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15745" h="1792605">
                  <a:moveTo>
                    <a:pt x="1515745" y="0"/>
                  </a:moveTo>
                  <a:lnTo>
                    <a:pt x="0" y="1792605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Freeform 142"/>
            <p:cNvSpPr/>
            <p:nvPr/>
          </p:nvSpPr>
          <p:spPr>
            <a:xfrm>
              <a:off x="9180376" y="5296444"/>
              <a:ext cx="1881505" cy="855345"/>
            </a:xfrm>
            <a:custGeom>
              <a:avLst/>
              <a:gdLst>
                <a:gd name="connsiteX0" fmla="*/ 200025 w 200025"/>
                <a:gd name="connsiteY0" fmla="*/ 0 h 1343025"/>
                <a:gd name="connsiteX1" fmla="*/ 0 w 200025"/>
                <a:gd name="connsiteY1" fmla="*/ 1343025 h 1343025"/>
                <a:gd name="connsiteX0" fmla="*/ 682625 w 682625"/>
                <a:gd name="connsiteY0" fmla="*/ 0 h 2219325"/>
                <a:gd name="connsiteX1" fmla="*/ 0 w 682625"/>
                <a:gd name="connsiteY1" fmla="*/ 2219325 h 2219325"/>
                <a:gd name="connsiteX0" fmla="*/ 1216025 w 1216025"/>
                <a:gd name="connsiteY0" fmla="*/ 0 h 1774825"/>
                <a:gd name="connsiteX1" fmla="*/ 0 w 1216025"/>
                <a:gd name="connsiteY1" fmla="*/ 1774825 h 1774825"/>
                <a:gd name="connsiteX0" fmla="*/ 1622425 w 1622425"/>
                <a:gd name="connsiteY0" fmla="*/ 0 h 1762125"/>
                <a:gd name="connsiteX1" fmla="*/ 0 w 1622425"/>
                <a:gd name="connsiteY1" fmla="*/ 1762125 h 1762125"/>
                <a:gd name="connsiteX0" fmla="*/ 1050925 w 1050925"/>
                <a:gd name="connsiteY0" fmla="*/ 0 h 923925"/>
                <a:gd name="connsiteX1" fmla="*/ 0 w 1050925"/>
                <a:gd name="connsiteY1" fmla="*/ 923925 h 923925"/>
                <a:gd name="connsiteX0" fmla="*/ 982345 w 982345"/>
                <a:gd name="connsiteY0" fmla="*/ 0 h 1000125"/>
                <a:gd name="connsiteX1" fmla="*/ 0 w 982345"/>
                <a:gd name="connsiteY1" fmla="*/ 1000125 h 1000125"/>
                <a:gd name="connsiteX0" fmla="*/ 1881505 w 1881505"/>
                <a:gd name="connsiteY0" fmla="*/ 0 h 855345"/>
                <a:gd name="connsiteX1" fmla="*/ 0 w 1881505"/>
                <a:gd name="connsiteY1" fmla="*/ 855345 h 8553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81505" h="855345">
                  <a:moveTo>
                    <a:pt x="1881505" y="0"/>
                  </a:moveTo>
                  <a:lnTo>
                    <a:pt x="0" y="855345"/>
                  </a:lnTo>
                </a:path>
              </a:pathLst>
            </a:custGeom>
            <a:noFill/>
            <a:ln w="254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Freeform 132"/>
            <p:cNvSpPr/>
            <p:nvPr/>
          </p:nvSpPr>
          <p:spPr>
            <a:xfrm>
              <a:off x="8315559" y="3859914"/>
              <a:ext cx="1081291" cy="822409"/>
            </a:xfrm>
            <a:custGeom>
              <a:avLst/>
              <a:gdLst>
                <a:gd name="connsiteX0" fmla="*/ 0 w 3796496"/>
                <a:gd name="connsiteY0" fmla="*/ 324091 h 1956122"/>
                <a:gd name="connsiteX1" fmla="*/ 752354 w 3796496"/>
                <a:gd name="connsiteY1" fmla="*/ 1076446 h 1956122"/>
                <a:gd name="connsiteX2" fmla="*/ 1527858 w 3796496"/>
                <a:gd name="connsiteY2" fmla="*/ 0 h 1956122"/>
                <a:gd name="connsiteX3" fmla="*/ 3240911 w 3796496"/>
                <a:gd name="connsiteY3" fmla="*/ 625033 h 1956122"/>
                <a:gd name="connsiteX4" fmla="*/ 2569580 w 3796496"/>
                <a:gd name="connsiteY4" fmla="*/ 1759352 h 1956122"/>
                <a:gd name="connsiteX5" fmla="*/ 3796496 w 3796496"/>
                <a:gd name="connsiteY5" fmla="*/ 1956122 h 1956122"/>
                <a:gd name="connsiteX0" fmla="*/ 0 w 3796496"/>
                <a:gd name="connsiteY0" fmla="*/ 324091 h 1956122"/>
                <a:gd name="connsiteX1" fmla="*/ 752354 w 3796496"/>
                <a:gd name="connsiteY1" fmla="*/ 1076446 h 1956122"/>
                <a:gd name="connsiteX2" fmla="*/ 1527858 w 3796496"/>
                <a:gd name="connsiteY2" fmla="*/ 0 h 1956122"/>
                <a:gd name="connsiteX3" fmla="*/ 1783586 w 3796496"/>
                <a:gd name="connsiteY3" fmla="*/ 967933 h 1956122"/>
                <a:gd name="connsiteX4" fmla="*/ 2569580 w 3796496"/>
                <a:gd name="connsiteY4" fmla="*/ 1759352 h 1956122"/>
                <a:gd name="connsiteX5" fmla="*/ 3796496 w 3796496"/>
                <a:gd name="connsiteY5" fmla="*/ 1956122 h 1956122"/>
                <a:gd name="connsiteX0" fmla="*/ 0 w 3205946"/>
                <a:gd name="connsiteY0" fmla="*/ 324091 h 1759352"/>
                <a:gd name="connsiteX1" fmla="*/ 752354 w 3205946"/>
                <a:gd name="connsiteY1" fmla="*/ 1076446 h 1759352"/>
                <a:gd name="connsiteX2" fmla="*/ 1527858 w 3205946"/>
                <a:gd name="connsiteY2" fmla="*/ 0 h 1759352"/>
                <a:gd name="connsiteX3" fmla="*/ 1783586 w 3205946"/>
                <a:gd name="connsiteY3" fmla="*/ 967933 h 1759352"/>
                <a:gd name="connsiteX4" fmla="*/ 2569580 w 3205946"/>
                <a:gd name="connsiteY4" fmla="*/ 1759352 h 1759352"/>
                <a:gd name="connsiteX5" fmla="*/ 3205946 w 3205946"/>
                <a:gd name="connsiteY5" fmla="*/ 632147 h 1759352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1783586 w 3769730"/>
                <a:gd name="connsiteY3" fmla="*/ 967933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2593211 w 3769730"/>
                <a:gd name="connsiteY3" fmla="*/ 1739458 h 1978427"/>
                <a:gd name="connsiteX4" fmla="*/ 3769730 w 3769730"/>
                <a:gd name="connsiteY4" fmla="*/ 1978427 h 1978427"/>
                <a:gd name="connsiteX5" fmla="*/ 3205946 w 3769730"/>
                <a:gd name="connsiteY5" fmla="*/ 632147 h 1978427"/>
                <a:gd name="connsiteX0" fmla="*/ 0 w 3769730"/>
                <a:gd name="connsiteY0" fmla="*/ 324091 h 1978427"/>
                <a:gd name="connsiteX1" fmla="*/ 752354 w 3769730"/>
                <a:gd name="connsiteY1" fmla="*/ 1076446 h 1978427"/>
                <a:gd name="connsiteX2" fmla="*/ 1527858 w 3769730"/>
                <a:gd name="connsiteY2" fmla="*/ 0 h 1978427"/>
                <a:gd name="connsiteX3" fmla="*/ 3769730 w 3769730"/>
                <a:gd name="connsiteY3" fmla="*/ 1978427 h 1978427"/>
                <a:gd name="connsiteX4" fmla="*/ 3205946 w 3769730"/>
                <a:gd name="connsiteY4" fmla="*/ 632147 h 1978427"/>
                <a:gd name="connsiteX0" fmla="*/ 0 w 3205946"/>
                <a:gd name="connsiteY0" fmla="*/ 330651 h 1083006"/>
                <a:gd name="connsiteX1" fmla="*/ 752354 w 3205946"/>
                <a:gd name="connsiteY1" fmla="*/ 1083006 h 1083006"/>
                <a:gd name="connsiteX2" fmla="*/ 1527858 w 3205946"/>
                <a:gd name="connsiteY2" fmla="*/ 6560 h 1083006"/>
                <a:gd name="connsiteX3" fmla="*/ 3205946 w 3205946"/>
                <a:gd name="connsiteY3" fmla="*/ 638707 h 1083006"/>
                <a:gd name="connsiteX0" fmla="*/ 0 w 3205946"/>
                <a:gd name="connsiteY0" fmla="*/ 0 h 752355"/>
                <a:gd name="connsiteX1" fmla="*/ 752354 w 3205946"/>
                <a:gd name="connsiteY1" fmla="*/ 752355 h 752355"/>
                <a:gd name="connsiteX2" fmla="*/ 3205946 w 3205946"/>
                <a:gd name="connsiteY2" fmla="*/ 308056 h 752355"/>
                <a:gd name="connsiteX0" fmla="*/ 0 w 3205946"/>
                <a:gd name="connsiteY0" fmla="*/ 0 h 752355"/>
                <a:gd name="connsiteX1" fmla="*/ 752354 w 3205946"/>
                <a:gd name="connsiteY1" fmla="*/ 752355 h 752355"/>
                <a:gd name="connsiteX2" fmla="*/ 2266950 w 3205946"/>
                <a:gd name="connsiteY2" fmla="*/ 477215 h 752355"/>
                <a:gd name="connsiteX3" fmla="*/ 3205946 w 3205946"/>
                <a:gd name="connsiteY3" fmla="*/ 308056 h 752355"/>
                <a:gd name="connsiteX0" fmla="*/ 0 w 3790950"/>
                <a:gd name="connsiteY0" fmla="*/ 0 h 1658315"/>
                <a:gd name="connsiteX1" fmla="*/ 752354 w 3790950"/>
                <a:gd name="connsiteY1" fmla="*/ 752355 h 1658315"/>
                <a:gd name="connsiteX2" fmla="*/ 3790950 w 3790950"/>
                <a:gd name="connsiteY2" fmla="*/ 1658315 h 1658315"/>
                <a:gd name="connsiteX3" fmla="*/ 3205946 w 3790950"/>
                <a:gd name="connsiteY3" fmla="*/ 308056 h 1658315"/>
                <a:gd name="connsiteX0" fmla="*/ 0 w 3790950"/>
                <a:gd name="connsiteY0" fmla="*/ 0 h 1658315"/>
                <a:gd name="connsiteX1" fmla="*/ 752354 w 3790950"/>
                <a:gd name="connsiteY1" fmla="*/ 752355 h 1658315"/>
                <a:gd name="connsiteX2" fmla="*/ 1590675 w 3790950"/>
                <a:gd name="connsiteY2" fmla="*/ 982040 h 1658315"/>
                <a:gd name="connsiteX3" fmla="*/ 3790950 w 3790950"/>
                <a:gd name="connsiteY3" fmla="*/ 1658315 h 1658315"/>
                <a:gd name="connsiteX4" fmla="*/ 3205946 w 3790950"/>
                <a:gd name="connsiteY4" fmla="*/ 308056 h 1658315"/>
                <a:gd name="connsiteX0" fmla="*/ 0 w 3790950"/>
                <a:gd name="connsiteY0" fmla="*/ 332410 h 1990725"/>
                <a:gd name="connsiteX1" fmla="*/ 752354 w 3790950"/>
                <a:gd name="connsiteY1" fmla="*/ 1084765 h 1990725"/>
                <a:gd name="connsiteX2" fmla="*/ 1524000 w 3790950"/>
                <a:gd name="connsiteY2" fmla="*/ 0 h 1990725"/>
                <a:gd name="connsiteX3" fmla="*/ 3790950 w 3790950"/>
                <a:gd name="connsiteY3" fmla="*/ 1990725 h 1990725"/>
                <a:gd name="connsiteX4" fmla="*/ 3205946 w 3790950"/>
                <a:gd name="connsiteY4" fmla="*/ 640466 h 1990725"/>
                <a:gd name="connsiteX0" fmla="*/ 0 w 3790950"/>
                <a:gd name="connsiteY0" fmla="*/ 332410 h 1990725"/>
                <a:gd name="connsiteX1" fmla="*/ 752354 w 3790950"/>
                <a:gd name="connsiteY1" fmla="*/ 1084765 h 1990725"/>
                <a:gd name="connsiteX2" fmla="*/ 1524000 w 3790950"/>
                <a:gd name="connsiteY2" fmla="*/ 0 h 1990725"/>
                <a:gd name="connsiteX3" fmla="*/ 2905125 w 3790950"/>
                <a:gd name="connsiteY3" fmla="*/ 1238250 h 1990725"/>
                <a:gd name="connsiteX4" fmla="*/ 3790950 w 3790950"/>
                <a:gd name="connsiteY4" fmla="*/ 1990725 h 1990725"/>
                <a:gd name="connsiteX5" fmla="*/ 3205946 w 3790950"/>
                <a:gd name="connsiteY5" fmla="*/ 640466 h 1990725"/>
                <a:gd name="connsiteX0" fmla="*/ 0 w 3790950"/>
                <a:gd name="connsiteY0" fmla="*/ 332410 h 1990725"/>
                <a:gd name="connsiteX1" fmla="*/ 752354 w 3790950"/>
                <a:gd name="connsiteY1" fmla="*/ 1084765 h 1990725"/>
                <a:gd name="connsiteX2" fmla="*/ 1524000 w 3790950"/>
                <a:gd name="connsiteY2" fmla="*/ 0 h 1990725"/>
                <a:gd name="connsiteX3" fmla="*/ 2581275 w 3790950"/>
                <a:gd name="connsiteY3" fmla="*/ 1762125 h 1990725"/>
                <a:gd name="connsiteX4" fmla="*/ 3790950 w 3790950"/>
                <a:gd name="connsiteY4" fmla="*/ 1990725 h 1990725"/>
                <a:gd name="connsiteX5" fmla="*/ 3205946 w 3790950"/>
                <a:gd name="connsiteY5" fmla="*/ 640466 h 1990725"/>
                <a:gd name="connsiteX0" fmla="*/ 0 w 3790950"/>
                <a:gd name="connsiteY0" fmla="*/ 332410 h 1990725"/>
                <a:gd name="connsiteX1" fmla="*/ 622814 w 3790950"/>
                <a:gd name="connsiteY1" fmla="*/ 139885 h 1990725"/>
                <a:gd name="connsiteX2" fmla="*/ 1524000 w 3790950"/>
                <a:gd name="connsiteY2" fmla="*/ 0 h 1990725"/>
                <a:gd name="connsiteX3" fmla="*/ 2581275 w 3790950"/>
                <a:gd name="connsiteY3" fmla="*/ 1762125 h 1990725"/>
                <a:gd name="connsiteX4" fmla="*/ 3790950 w 3790950"/>
                <a:gd name="connsiteY4" fmla="*/ 1990725 h 1990725"/>
                <a:gd name="connsiteX5" fmla="*/ 3205946 w 3790950"/>
                <a:gd name="connsiteY5" fmla="*/ 640466 h 1990725"/>
                <a:gd name="connsiteX0" fmla="*/ 146806 w 3168136"/>
                <a:gd name="connsiteY0" fmla="*/ 1063930 h 1990725"/>
                <a:gd name="connsiteX1" fmla="*/ 0 w 3168136"/>
                <a:gd name="connsiteY1" fmla="*/ 139885 h 1990725"/>
                <a:gd name="connsiteX2" fmla="*/ 901186 w 3168136"/>
                <a:gd name="connsiteY2" fmla="*/ 0 h 1990725"/>
                <a:gd name="connsiteX3" fmla="*/ 1958461 w 3168136"/>
                <a:gd name="connsiteY3" fmla="*/ 1762125 h 1990725"/>
                <a:gd name="connsiteX4" fmla="*/ 3168136 w 3168136"/>
                <a:gd name="connsiteY4" fmla="*/ 1990725 h 1990725"/>
                <a:gd name="connsiteX5" fmla="*/ 2583132 w 3168136"/>
                <a:gd name="connsiteY5" fmla="*/ 640466 h 1990725"/>
                <a:gd name="connsiteX0" fmla="*/ 779266 w 3800596"/>
                <a:gd name="connsiteY0" fmla="*/ 1063930 h 1990725"/>
                <a:gd name="connsiteX1" fmla="*/ 0 w 3800596"/>
                <a:gd name="connsiteY1" fmla="*/ 330385 h 1990725"/>
                <a:gd name="connsiteX2" fmla="*/ 1533646 w 3800596"/>
                <a:gd name="connsiteY2" fmla="*/ 0 h 1990725"/>
                <a:gd name="connsiteX3" fmla="*/ 2590921 w 3800596"/>
                <a:gd name="connsiteY3" fmla="*/ 1762125 h 1990725"/>
                <a:gd name="connsiteX4" fmla="*/ 3800596 w 3800596"/>
                <a:gd name="connsiteY4" fmla="*/ 1990725 h 1990725"/>
                <a:gd name="connsiteX5" fmla="*/ 3215592 w 3800596"/>
                <a:gd name="connsiteY5" fmla="*/ 640466 h 1990725"/>
                <a:gd name="connsiteX0" fmla="*/ 779266 w 3800596"/>
                <a:gd name="connsiteY0" fmla="*/ 1063930 h 1990725"/>
                <a:gd name="connsiteX1" fmla="*/ 0 w 3800596"/>
                <a:gd name="connsiteY1" fmla="*/ 330385 h 1990725"/>
                <a:gd name="connsiteX2" fmla="*/ 1533646 w 3800596"/>
                <a:gd name="connsiteY2" fmla="*/ 0 h 1990725"/>
                <a:gd name="connsiteX3" fmla="*/ 2590921 w 3800596"/>
                <a:gd name="connsiteY3" fmla="*/ 1762125 h 1990725"/>
                <a:gd name="connsiteX4" fmla="*/ 3800596 w 3800596"/>
                <a:gd name="connsiteY4" fmla="*/ 1990725 h 1990725"/>
                <a:gd name="connsiteX0" fmla="*/ 779266 w 2590922"/>
                <a:gd name="connsiteY0" fmla="*/ 1063930 h 1762125"/>
                <a:gd name="connsiteX1" fmla="*/ 0 w 2590922"/>
                <a:gd name="connsiteY1" fmla="*/ 330385 h 1762125"/>
                <a:gd name="connsiteX2" fmla="*/ 1533646 w 2590922"/>
                <a:gd name="connsiteY2" fmla="*/ 0 h 1762125"/>
                <a:gd name="connsiteX3" fmla="*/ 2590921 w 2590922"/>
                <a:gd name="connsiteY3" fmla="*/ 1762125 h 1762125"/>
                <a:gd name="connsiteX0" fmla="*/ 779266 w 1533646"/>
                <a:gd name="connsiteY0" fmla="*/ 1063930 h 1063931"/>
                <a:gd name="connsiteX1" fmla="*/ 0 w 1533646"/>
                <a:gd name="connsiteY1" fmla="*/ 330385 h 1063931"/>
                <a:gd name="connsiteX2" fmla="*/ 1533646 w 1533646"/>
                <a:gd name="connsiteY2" fmla="*/ 0 h 1063931"/>
                <a:gd name="connsiteX0" fmla="*/ 0 w 2379002"/>
                <a:gd name="connsiteY0" fmla="*/ 308532 h 330385"/>
                <a:gd name="connsiteX1" fmla="*/ 845356 w 2379002"/>
                <a:gd name="connsiteY1" fmla="*/ 330385 h 330385"/>
                <a:gd name="connsiteX2" fmla="*/ 2379002 w 2379002"/>
                <a:gd name="connsiteY2" fmla="*/ 0 h 330385"/>
                <a:gd name="connsiteX0" fmla="*/ 0 w 2379002"/>
                <a:gd name="connsiteY0" fmla="*/ 308532 h 1116826"/>
                <a:gd name="connsiteX1" fmla="*/ 1611102 w 2379002"/>
                <a:gd name="connsiteY1" fmla="*/ 1116826 h 1116826"/>
                <a:gd name="connsiteX2" fmla="*/ 2379002 w 2379002"/>
                <a:gd name="connsiteY2" fmla="*/ 0 h 1116826"/>
                <a:gd name="connsiteX0" fmla="*/ 0 w 1468386"/>
                <a:gd name="connsiteY0" fmla="*/ 370619 h 1116826"/>
                <a:gd name="connsiteX1" fmla="*/ 700486 w 1468386"/>
                <a:gd name="connsiteY1" fmla="*/ 1116826 h 1116826"/>
                <a:gd name="connsiteX2" fmla="*/ 1468386 w 1468386"/>
                <a:gd name="connsiteY2" fmla="*/ 0 h 11168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68386" h="1116826">
                  <a:moveTo>
                    <a:pt x="0" y="370619"/>
                  </a:moveTo>
                  <a:lnTo>
                    <a:pt x="700486" y="1116826"/>
                  </a:lnTo>
                  <a:lnTo>
                    <a:pt x="1468386" y="0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4" name="Oval 113"/>
            <p:cNvSpPr/>
            <p:nvPr/>
          </p:nvSpPr>
          <p:spPr>
            <a:xfrm>
              <a:off x="8129709" y="3959799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5" name="Oval 114"/>
            <p:cNvSpPr/>
            <p:nvPr/>
          </p:nvSpPr>
          <p:spPr>
            <a:xfrm>
              <a:off x="9246271" y="3712621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6" name="Oval 115"/>
            <p:cNvSpPr/>
            <p:nvPr/>
          </p:nvSpPr>
          <p:spPr>
            <a:xfrm>
              <a:off x="10030422" y="4999650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7" name="Oval 116"/>
            <p:cNvSpPr/>
            <p:nvPr/>
          </p:nvSpPr>
          <p:spPr>
            <a:xfrm>
              <a:off x="8683729" y="4496772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8" name="Oval 117"/>
            <p:cNvSpPr/>
            <p:nvPr/>
          </p:nvSpPr>
          <p:spPr>
            <a:xfrm>
              <a:off x="10891282" y="5136026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19" name="Oval 118"/>
            <p:cNvSpPr/>
            <p:nvPr/>
          </p:nvSpPr>
          <p:spPr>
            <a:xfrm>
              <a:off x="10490683" y="4181407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20" name="Oval 119"/>
            <p:cNvSpPr/>
            <p:nvPr/>
          </p:nvSpPr>
          <p:spPr>
            <a:xfrm>
              <a:off x="8478775" y="5945746"/>
              <a:ext cx="306841" cy="306841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8243957" y="4813503"/>
              <a:ext cx="1847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2400" b="1">
                <a:solidFill>
                  <a:srgbClr val="FF0000"/>
                </a:solidFill>
                <a:effectLst>
                  <a:glow rad="127000">
                    <a:schemeClr val="bg1"/>
                  </a:glow>
                </a:effectLst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8696615" y="6259009"/>
              <a:ext cx="44275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>
                  <a:solidFill>
                    <a:srgbClr val="FF0000"/>
                  </a:solidFill>
                  <a:effectLst>
                    <a:glow rad="127000">
                      <a:schemeClr val="bg1"/>
                    </a:glow>
                  </a:effectLst>
                </a:rPr>
                <a:t>∞</a:t>
              </a:r>
            </a:p>
          </p:txBody>
        </p:sp>
        <p:grpSp>
          <p:nvGrpSpPr>
            <p:cNvPr id="126" name="Group 125"/>
            <p:cNvGrpSpPr/>
            <p:nvPr/>
          </p:nvGrpSpPr>
          <p:grpSpPr>
            <a:xfrm>
              <a:off x="8667720" y="4163137"/>
              <a:ext cx="2137283" cy="648439"/>
              <a:chOff x="7849044" y="2440598"/>
              <a:chExt cx="2902416" cy="880576"/>
            </a:xfrm>
            <a:solidFill>
              <a:schemeClr val="tx1"/>
            </a:solidFill>
          </p:grpSpPr>
          <p:sp>
            <p:nvSpPr>
              <p:cNvPr id="130" name="Oval 129"/>
              <p:cNvSpPr/>
              <p:nvPr/>
            </p:nvSpPr>
            <p:spPr>
              <a:xfrm>
                <a:off x="10307764" y="2440598"/>
                <a:ext cx="443696" cy="443696"/>
              </a:xfrm>
              <a:prstGeom prst="ellipse">
                <a:avLst/>
              </a:prstGeom>
              <a:grpFill/>
              <a:ln w="254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32" name="Oval 131"/>
              <p:cNvSpPr/>
              <p:nvPr/>
            </p:nvSpPr>
            <p:spPr>
              <a:xfrm>
                <a:off x="7849044" y="2877478"/>
                <a:ext cx="443696" cy="443696"/>
              </a:xfrm>
              <a:prstGeom prst="ellipse">
                <a:avLst/>
              </a:prstGeom>
              <a:grpFill/>
              <a:ln w="254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137" name="Oval 136"/>
            <p:cNvSpPr/>
            <p:nvPr/>
          </p:nvSpPr>
          <p:spPr>
            <a:xfrm>
              <a:off x="9050275" y="5945746"/>
              <a:ext cx="306841" cy="306841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38" name="Left-Right Arrow 137"/>
            <p:cNvSpPr/>
            <p:nvPr/>
          </p:nvSpPr>
          <p:spPr>
            <a:xfrm flipV="1">
              <a:off x="8719366" y="6151523"/>
              <a:ext cx="387350" cy="239973"/>
            </a:xfrm>
            <a:prstGeom prst="leftRightArrow">
              <a:avLst/>
            </a:prstGeom>
            <a:solidFill>
              <a:srgbClr val="F4B183"/>
            </a:solidFill>
            <a:ln>
              <a:solidFill>
                <a:srgbClr val="C0520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7" name="Freeform 166"/>
            <p:cNvSpPr/>
            <p:nvPr/>
          </p:nvSpPr>
          <p:spPr>
            <a:xfrm rot="15545462">
              <a:off x="8558903" y="4339000"/>
              <a:ext cx="1614942" cy="1850956"/>
            </a:xfrm>
            <a:custGeom>
              <a:avLst/>
              <a:gdLst>
                <a:gd name="connsiteX0" fmla="*/ 319307 w 1614942"/>
                <a:gd name="connsiteY0" fmla="*/ 507641 h 1850956"/>
                <a:gd name="connsiteX1" fmla="*/ 289907 w 1614942"/>
                <a:gd name="connsiteY1" fmla="*/ 420159 h 1850956"/>
                <a:gd name="connsiteX2" fmla="*/ 297865 w 1614942"/>
                <a:gd name="connsiteY2" fmla="*/ 512566 h 1850956"/>
                <a:gd name="connsiteX3" fmla="*/ 347079 w 1614942"/>
                <a:gd name="connsiteY3" fmla="*/ 590280 h 1850956"/>
                <a:gd name="connsiteX4" fmla="*/ 339210 w 1614942"/>
                <a:gd name="connsiteY4" fmla="*/ 566862 h 1850956"/>
                <a:gd name="connsiteX5" fmla="*/ 303252 w 1614942"/>
                <a:gd name="connsiteY5" fmla="*/ 575120 h 1850956"/>
                <a:gd name="connsiteX6" fmla="*/ 304898 w 1614942"/>
                <a:gd name="connsiteY6" fmla="*/ 594230 h 1850956"/>
                <a:gd name="connsiteX7" fmla="*/ 421356 w 1614942"/>
                <a:gd name="connsiteY7" fmla="*/ 484205 h 1850956"/>
                <a:gd name="connsiteX8" fmla="*/ 304361 w 1614942"/>
                <a:gd name="connsiteY8" fmla="*/ 268001 h 1850956"/>
                <a:gd name="connsiteX9" fmla="*/ 380198 w 1614942"/>
                <a:gd name="connsiteY9" fmla="*/ 493657 h 1850956"/>
                <a:gd name="connsiteX10" fmla="*/ 381556 w 1614942"/>
                <a:gd name="connsiteY10" fmla="*/ 692867 h 1850956"/>
                <a:gd name="connsiteX11" fmla="*/ 367425 w 1614942"/>
                <a:gd name="connsiteY11" fmla="*/ 650819 h 1850956"/>
                <a:gd name="connsiteX12" fmla="*/ 310233 w 1614942"/>
                <a:gd name="connsiteY12" fmla="*/ 656175 h 1850956"/>
                <a:gd name="connsiteX13" fmla="*/ 311730 w 1614942"/>
                <a:gd name="connsiteY13" fmla="*/ 673566 h 1850956"/>
                <a:gd name="connsiteX14" fmla="*/ 472405 w 1614942"/>
                <a:gd name="connsiteY14" fmla="*/ 578541 h 1850956"/>
                <a:gd name="connsiteX15" fmla="*/ 452060 w 1614942"/>
                <a:gd name="connsiteY15" fmla="*/ 540945 h 1850956"/>
                <a:gd name="connsiteX16" fmla="*/ 400100 w 1614942"/>
                <a:gd name="connsiteY16" fmla="*/ 552878 h 1850956"/>
                <a:gd name="connsiteX17" fmla="*/ 410668 w 1614942"/>
                <a:gd name="connsiteY17" fmla="*/ 584324 h 1850956"/>
                <a:gd name="connsiteX18" fmla="*/ 321171 w 1614942"/>
                <a:gd name="connsiteY18" fmla="*/ 1686262 h 1850956"/>
                <a:gd name="connsiteX19" fmla="*/ 283063 w 1614942"/>
                <a:gd name="connsiteY19" fmla="*/ 1850956 h 1850956"/>
                <a:gd name="connsiteX20" fmla="*/ 171957 w 1614942"/>
                <a:gd name="connsiteY20" fmla="*/ 1723552 h 1850956"/>
                <a:gd name="connsiteX21" fmla="*/ 216405 w 1614942"/>
                <a:gd name="connsiteY21" fmla="*/ 1712444 h 1850956"/>
                <a:gd name="connsiteX22" fmla="*/ 0 w 1614942"/>
                <a:gd name="connsiteY22" fmla="*/ 846517 h 1850956"/>
                <a:gd name="connsiteX23" fmla="*/ 27897 w 1614942"/>
                <a:gd name="connsiteY23" fmla="*/ 849033 h 1850956"/>
                <a:gd name="connsiteX24" fmla="*/ 63721 w 1614942"/>
                <a:gd name="connsiteY24" fmla="*/ 845055 h 1850956"/>
                <a:gd name="connsiteX25" fmla="*/ 276723 w 1614942"/>
                <a:gd name="connsiteY25" fmla="*/ 1697370 h 1850956"/>
                <a:gd name="connsiteX26" fmla="*/ 561133 w 1614942"/>
                <a:gd name="connsiteY26" fmla="*/ 742506 h 1850956"/>
                <a:gd name="connsiteX27" fmla="*/ 504567 w 1614942"/>
                <a:gd name="connsiteY27" fmla="*/ 637974 h 1850956"/>
                <a:gd name="connsiteX28" fmla="*/ 431014 w 1614942"/>
                <a:gd name="connsiteY28" fmla="*/ 644862 h 1850956"/>
                <a:gd name="connsiteX29" fmla="*/ 453864 w 1614942"/>
                <a:gd name="connsiteY29" fmla="*/ 712854 h 1850956"/>
                <a:gd name="connsiteX30" fmla="*/ 669138 w 1614942"/>
                <a:gd name="connsiteY30" fmla="*/ 427299 h 1850956"/>
                <a:gd name="connsiteX31" fmla="*/ 376391 w 1614942"/>
                <a:gd name="connsiteY31" fmla="*/ 270475 h 1850956"/>
                <a:gd name="connsiteX32" fmla="*/ 484234 w 1614942"/>
                <a:gd name="connsiteY32" fmla="*/ 469764 h 1850956"/>
                <a:gd name="connsiteX33" fmla="*/ 1252125 w 1614942"/>
                <a:gd name="connsiteY33" fmla="*/ 965764 h 1850956"/>
                <a:gd name="connsiteX34" fmla="*/ 1086537 w 1614942"/>
                <a:gd name="connsiteY34" fmla="*/ 999777 h 1850956"/>
                <a:gd name="connsiteX35" fmla="*/ 1098743 w 1614942"/>
                <a:gd name="connsiteY35" fmla="*/ 955618 h 1850956"/>
                <a:gd name="connsiteX36" fmla="*/ 685305 w 1614942"/>
                <a:gd name="connsiteY36" fmla="*/ 841334 h 1850956"/>
                <a:gd name="connsiteX37" fmla="*/ 838218 w 1614942"/>
                <a:gd name="connsiteY37" fmla="*/ 1123912 h 1850956"/>
                <a:gd name="connsiteX38" fmla="*/ 878512 w 1614942"/>
                <a:gd name="connsiteY38" fmla="*/ 1102108 h 1850956"/>
                <a:gd name="connsiteX39" fmla="*/ 882524 w 1614942"/>
                <a:gd name="connsiteY39" fmla="*/ 1271107 h 1850956"/>
                <a:gd name="connsiteX40" fmla="*/ 743244 w 1614942"/>
                <a:gd name="connsiteY40" fmla="*/ 1175306 h 1850956"/>
                <a:gd name="connsiteX41" fmla="*/ 783538 w 1614942"/>
                <a:gd name="connsiteY41" fmla="*/ 1153502 h 1850956"/>
                <a:gd name="connsiteX42" fmla="*/ 602178 w 1614942"/>
                <a:gd name="connsiteY42" fmla="*/ 818356 h 1850956"/>
                <a:gd name="connsiteX43" fmla="*/ 477762 w 1614942"/>
                <a:gd name="connsiteY43" fmla="*/ 783965 h 1850956"/>
                <a:gd name="connsiteX44" fmla="*/ 534420 w 1614942"/>
                <a:gd name="connsiteY44" fmla="*/ 952551 h 1850956"/>
                <a:gd name="connsiteX45" fmla="*/ 577848 w 1614942"/>
                <a:gd name="connsiteY45" fmla="*/ 937956 h 1850956"/>
                <a:gd name="connsiteX46" fmla="*/ 552909 w 1614942"/>
                <a:gd name="connsiteY46" fmla="*/ 1105152 h 1850956"/>
                <a:gd name="connsiteX47" fmla="*/ 432058 w 1614942"/>
                <a:gd name="connsiteY47" fmla="*/ 986952 h 1850956"/>
                <a:gd name="connsiteX48" fmla="*/ 475486 w 1614942"/>
                <a:gd name="connsiteY48" fmla="*/ 972357 h 1850956"/>
                <a:gd name="connsiteX49" fmla="*/ 405455 w 1614942"/>
                <a:gd name="connsiteY49" fmla="*/ 763977 h 1850956"/>
                <a:gd name="connsiteX50" fmla="*/ 317421 w 1614942"/>
                <a:gd name="connsiteY50" fmla="*/ 739643 h 1850956"/>
                <a:gd name="connsiteX51" fmla="*/ 328811 w 1614942"/>
                <a:gd name="connsiteY51" fmla="*/ 871898 h 1850956"/>
                <a:gd name="connsiteX52" fmla="*/ 653621 w 1614942"/>
                <a:gd name="connsiteY52" fmla="*/ 1279202 h 1850956"/>
                <a:gd name="connsiteX53" fmla="*/ 689441 w 1614942"/>
                <a:gd name="connsiteY53" fmla="*/ 1250636 h 1850956"/>
                <a:gd name="connsiteX54" fmla="*/ 723177 w 1614942"/>
                <a:gd name="connsiteY54" fmla="*/ 1416281 h 1850956"/>
                <a:gd name="connsiteX55" fmla="*/ 569193 w 1614942"/>
                <a:gd name="connsiteY55" fmla="*/ 1346530 h 1850956"/>
                <a:gd name="connsiteX56" fmla="*/ 605012 w 1614942"/>
                <a:gd name="connsiteY56" fmla="*/ 1317966 h 1850956"/>
                <a:gd name="connsiteX57" fmla="*/ 338439 w 1614942"/>
                <a:gd name="connsiteY57" fmla="*/ 983690 h 1850956"/>
                <a:gd name="connsiteX58" fmla="*/ 339160 w 1614942"/>
                <a:gd name="connsiteY58" fmla="*/ 992062 h 1850956"/>
                <a:gd name="connsiteX59" fmla="*/ 479824 w 1614942"/>
                <a:gd name="connsiteY59" fmla="*/ 1236494 h 1850956"/>
                <a:gd name="connsiteX60" fmla="*/ 519533 w 1614942"/>
                <a:gd name="connsiteY60" fmla="*/ 1213643 h 1850956"/>
                <a:gd name="connsiteX61" fmla="*/ 527968 w 1614942"/>
                <a:gd name="connsiteY61" fmla="*/ 1382477 h 1850956"/>
                <a:gd name="connsiteX62" fmla="*/ 386228 w 1614942"/>
                <a:gd name="connsiteY62" fmla="*/ 1290356 h 1850956"/>
                <a:gd name="connsiteX63" fmla="*/ 425937 w 1614942"/>
                <a:gd name="connsiteY63" fmla="*/ 1267505 h 1850956"/>
                <a:gd name="connsiteX64" fmla="*/ 351784 w 1614942"/>
                <a:gd name="connsiteY64" fmla="*/ 1138651 h 1850956"/>
                <a:gd name="connsiteX65" fmla="*/ 380456 w 1614942"/>
                <a:gd name="connsiteY65" fmla="*/ 1471574 h 1850956"/>
                <a:gd name="connsiteX66" fmla="*/ 426102 w 1614942"/>
                <a:gd name="connsiteY66" fmla="*/ 1467643 h 1850956"/>
                <a:gd name="connsiteX67" fmla="*/ 362401 w 1614942"/>
                <a:gd name="connsiteY67" fmla="*/ 1624228 h 1850956"/>
                <a:gd name="connsiteX68" fmla="*/ 272867 w 1614942"/>
                <a:gd name="connsiteY68" fmla="*/ 1480840 h 1850956"/>
                <a:gd name="connsiteX69" fmla="*/ 318513 w 1614942"/>
                <a:gd name="connsiteY69" fmla="*/ 1476910 h 1850956"/>
                <a:gd name="connsiteX70" fmla="*/ 278399 w 1614942"/>
                <a:gd name="connsiteY70" fmla="*/ 1011128 h 1850956"/>
                <a:gd name="connsiteX71" fmla="*/ 160012 w 1614942"/>
                <a:gd name="connsiteY71" fmla="*/ 805408 h 1850956"/>
                <a:gd name="connsiteX72" fmla="*/ 190301 w 1614942"/>
                <a:gd name="connsiteY72" fmla="*/ 780381 h 1850956"/>
                <a:gd name="connsiteX73" fmla="*/ 218930 w 1614942"/>
                <a:gd name="connsiteY73" fmla="*/ 745530 h 1850956"/>
                <a:gd name="connsiteX74" fmla="*/ 222587 w 1614942"/>
                <a:gd name="connsiteY74" fmla="*/ 738696 h 1850956"/>
                <a:gd name="connsiteX75" fmla="*/ 258853 w 1614942"/>
                <a:gd name="connsiteY75" fmla="*/ 784172 h 1850956"/>
                <a:gd name="connsiteX76" fmla="*/ 253496 w 1614942"/>
                <a:gd name="connsiteY76" fmla="*/ 721972 h 1850956"/>
                <a:gd name="connsiteX77" fmla="*/ 234367 w 1614942"/>
                <a:gd name="connsiteY77" fmla="*/ 716685 h 1850956"/>
                <a:gd name="connsiteX78" fmla="*/ 240572 w 1614942"/>
                <a:gd name="connsiteY78" fmla="*/ 705090 h 1850956"/>
                <a:gd name="connsiteX79" fmla="*/ 254128 w 1614942"/>
                <a:gd name="connsiteY79" fmla="*/ 659806 h 1850956"/>
                <a:gd name="connsiteX80" fmla="*/ 239686 w 1614942"/>
                <a:gd name="connsiteY80" fmla="*/ 524145 h 1850956"/>
                <a:gd name="connsiteX81" fmla="*/ 235854 w 1614942"/>
                <a:gd name="connsiteY81" fmla="*/ 517121 h 1850956"/>
                <a:gd name="connsiteX82" fmla="*/ 213996 w 1614942"/>
                <a:gd name="connsiteY82" fmla="*/ 263318 h 1850956"/>
                <a:gd name="connsiteX83" fmla="*/ 270418 w 1614942"/>
                <a:gd name="connsiteY83" fmla="*/ 239276 h 1850956"/>
                <a:gd name="connsiteX84" fmla="*/ 304935 w 1614942"/>
                <a:gd name="connsiteY84" fmla="*/ 210756 h 1850956"/>
                <a:gd name="connsiteX85" fmla="*/ 332939 w 1614942"/>
                <a:gd name="connsiteY85" fmla="*/ 176665 h 1850956"/>
                <a:gd name="connsiteX86" fmla="*/ 761293 w 1614942"/>
                <a:gd name="connsiteY86" fmla="*/ 406134 h 1850956"/>
                <a:gd name="connsiteX87" fmla="*/ 1164479 w 1614942"/>
                <a:gd name="connsiteY87" fmla="*/ 313538 h 1850956"/>
                <a:gd name="connsiteX88" fmla="*/ 1154224 w 1614942"/>
                <a:gd name="connsiteY88" fmla="*/ 268885 h 1850956"/>
                <a:gd name="connsiteX89" fmla="*/ 1318158 w 1614942"/>
                <a:gd name="connsiteY89" fmla="*/ 310138 h 1850956"/>
                <a:gd name="connsiteX90" fmla="*/ 1188650 w 1614942"/>
                <a:gd name="connsiteY90" fmla="*/ 418785 h 1850956"/>
                <a:gd name="connsiteX91" fmla="*/ 1178395 w 1614942"/>
                <a:gd name="connsiteY91" fmla="*/ 374132 h 1850956"/>
                <a:gd name="connsiteX92" fmla="*/ 844641 w 1614942"/>
                <a:gd name="connsiteY92" fmla="*/ 450784 h 1850956"/>
                <a:gd name="connsiteX93" fmla="*/ 1110730 w 1614942"/>
                <a:gd name="connsiteY93" fmla="*/ 593328 h 1850956"/>
                <a:gd name="connsiteX94" fmla="*/ 1132364 w 1614942"/>
                <a:gd name="connsiteY94" fmla="*/ 552942 h 1850956"/>
                <a:gd name="connsiteX95" fmla="*/ 1228750 w 1614942"/>
                <a:gd name="connsiteY95" fmla="*/ 691818 h 1850956"/>
                <a:gd name="connsiteX96" fmla="*/ 1059736 w 1614942"/>
                <a:gd name="connsiteY96" fmla="*/ 688518 h 1850956"/>
                <a:gd name="connsiteX97" fmla="*/ 1081371 w 1614942"/>
                <a:gd name="connsiteY97" fmla="*/ 648132 h 1850956"/>
                <a:gd name="connsiteX98" fmla="*/ 752486 w 1614942"/>
                <a:gd name="connsiteY98" fmla="*/ 471948 h 1850956"/>
                <a:gd name="connsiteX99" fmla="*/ 514938 w 1614942"/>
                <a:gd name="connsiteY99" fmla="*/ 526504 h 1850956"/>
                <a:gd name="connsiteX100" fmla="*/ 539687 w 1614942"/>
                <a:gd name="connsiteY100" fmla="*/ 572239 h 1850956"/>
                <a:gd name="connsiteX101" fmla="*/ 719006 w 1614942"/>
                <a:gd name="connsiteY101" fmla="*/ 555444 h 1850956"/>
                <a:gd name="connsiteX102" fmla="*/ 714734 w 1614942"/>
                <a:gd name="connsiteY102" fmla="*/ 509829 h 1850956"/>
                <a:gd name="connsiteX103" fmla="*/ 871790 w 1614942"/>
                <a:gd name="connsiteY103" fmla="*/ 572357 h 1850956"/>
                <a:gd name="connsiteX104" fmla="*/ 729076 w 1614942"/>
                <a:gd name="connsiteY104" fmla="*/ 662962 h 1850956"/>
                <a:gd name="connsiteX105" fmla="*/ 724804 w 1614942"/>
                <a:gd name="connsiteY105" fmla="*/ 617347 h 1850956"/>
                <a:gd name="connsiteX106" fmla="*/ 571849 w 1614942"/>
                <a:gd name="connsiteY106" fmla="*/ 631673 h 1850956"/>
                <a:gd name="connsiteX107" fmla="*/ 644259 w 1614942"/>
                <a:gd name="connsiteY107" fmla="*/ 765484 h 1850956"/>
                <a:gd name="connsiteX108" fmla="*/ 1115308 w 1614942"/>
                <a:gd name="connsiteY108" fmla="*/ 895692 h 1850956"/>
                <a:gd name="connsiteX109" fmla="*/ 1127515 w 1614942"/>
                <a:gd name="connsiteY109" fmla="*/ 851533 h 1850956"/>
                <a:gd name="connsiteX110" fmla="*/ 1614942 w 1614942"/>
                <a:gd name="connsiteY110" fmla="*/ 76902 h 1850956"/>
                <a:gd name="connsiteX111" fmla="*/ 1464401 w 1614942"/>
                <a:gd name="connsiteY111" fmla="*/ 153803 h 1850956"/>
                <a:gd name="connsiteX112" fmla="*/ 1464401 w 1614942"/>
                <a:gd name="connsiteY112" fmla="*/ 107988 h 1850956"/>
                <a:gd name="connsiteX113" fmla="*/ 390478 w 1614942"/>
                <a:gd name="connsiteY113" fmla="*/ 107987 h 1850956"/>
                <a:gd name="connsiteX114" fmla="*/ 794851 w 1614942"/>
                <a:gd name="connsiteY114" fmla="*/ 243547 h 1850956"/>
                <a:gd name="connsiteX115" fmla="*/ 809414 w 1614942"/>
                <a:gd name="connsiteY115" fmla="*/ 200108 h 1850956"/>
                <a:gd name="connsiteX116" fmla="*/ 927704 w 1614942"/>
                <a:gd name="connsiteY116" fmla="*/ 320872 h 1850956"/>
                <a:gd name="connsiteX117" fmla="*/ 760527 w 1614942"/>
                <a:gd name="connsiteY117" fmla="*/ 345936 h 1850956"/>
                <a:gd name="connsiteX118" fmla="*/ 775090 w 1614942"/>
                <a:gd name="connsiteY118" fmla="*/ 302497 h 1850956"/>
                <a:gd name="connsiteX119" fmla="*/ 343285 w 1614942"/>
                <a:gd name="connsiteY119" fmla="*/ 157740 h 1850956"/>
                <a:gd name="connsiteX120" fmla="*/ 355206 w 1614942"/>
                <a:gd name="connsiteY120" fmla="*/ 135464 h 1850956"/>
                <a:gd name="connsiteX121" fmla="*/ 368762 w 1614942"/>
                <a:gd name="connsiteY121" fmla="*/ 90180 h 1850956"/>
                <a:gd name="connsiteX122" fmla="*/ 372762 w 1614942"/>
                <a:gd name="connsiteY122" fmla="*/ 45815 h 1850956"/>
                <a:gd name="connsiteX123" fmla="*/ 1464401 w 1614942"/>
                <a:gd name="connsiteY123" fmla="*/ 45815 h 1850956"/>
                <a:gd name="connsiteX124" fmla="*/ 1464401 w 1614942"/>
                <a:gd name="connsiteY124" fmla="*/ 0 h 18509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</a:cxnLst>
              <a:rect l="l" t="t" r="r" b="b"/>
              <a:pathLst>
                <a:path w="1614942" h="1850956">
                  <a:moveTo>
                    <a:pt x="319307" y="507641"/>
                  </a:moveTo>
                  <a:lnTo>
                    <a:pt x="289907" y="420159"/>
                  </a:lnTo>
                  <a:lnTo>
                    <a:pt x="297865" y="512566"/>
                  </a:lnTo>
                  <a:close/>
                  <a:moveTo>
                    <a:pt x="347079" y="590280"/>
                  </a:moveTo>
                  <a:lnTo>
                    <a:pt x="339210" y="566862"/>
                  </a:lnTo>
                  <a:lnTo>
                    <a:pt x="303252" y="575120"/>
                  </a:lnTo>
                  <a:lnTo>
                    <a:pt x="304898" y="594230"/>
                  </a:lnTo>
                  <a:close/>
                  <a:moveTo>
                    <a:pt x="421356" y="484205"/>
                  </a:moveTo>
                  <a:lnTo>
                    <a:pt x="304361" y="268001"/>
                  </a:lnTo>
                  <a:lnTo>
                    <a:pt x="380198" y="493657"/>
                  </a:lnTo>
                  <a:close/>
                  <a:moveTo>
                    <a:pt x="381556" y="692867"/>
                  </a:moveTo>
                  <a:lnTo>
                    <a:pt x="367425" y="650819"/>
                  </a:lnTo>
                  <a:lnTo>
                    <a:pt x="310233" y="656175"/>
                  </a:lnTo>
                  <a:lnTo>
                    <a:pt x="311730" y="673566"/>
                  </a:lnTo>
                  <a:close/>
                  <a:moveTo>
                    <a:pt x="472405" y="578541"/>
                  </a:moveTo>
                  <a:lnTo>
                    <a:pt x="452060" y="540945"/>
                  </a:lnTo>
                  <a:lnTo>
                    <a:pt x="400100" y="552878"/>
                  </a:lnTo>
                  <a:lnTo>
                    <a:pt x="410668" y="584324"/>
                  </a:lnTo>
                  <a:close/>
                  <a:moveTo>
                    <a:pt x="321171" y="1686262"/>
                  </a:moveTo>
                  <a:lnTo>
                    <a:pt x="283063" y="1850956"/>
                  </a:lnTo>
                  <a:lnTo>
                    <a:pt x="171957" y="1723552"/>
                  </a:lnTo>
                  <a:lnTo>
                    <a:pt x="216405" y="1712444"/>
                  </a:lnTo>
                  <a:lnTo>
                    <a:pt x="0" y="846517"/>
                  </a:lnTo>
                  <a:lnTo>
                    <a:pt x="27897" y="849033"/>
                  </a:lnTo>
                  <a:lnTo>
                    <a:pt x="63721" y="845055"/>
                  </a:lnTo>
                  <a:lnTo>
                    <a:pt x="276723" y="1697370"/>
                  </a:lnTo>
                  <a:close/>
                  <a:moveTo>
                    <a:pt x="561133" y="742506"/>
                  </a:moveTo>
                  <a:lnTo>
                    <a:pt x="504567" y="637974"/>
                  </a:lnTo>
                  <a:lnTo>
                    <a:pt x="431014" y="644862"/>
                  </a:lnTo>
                  <a:lnTo>
                    <a:pt x="453864" y="712854"/>
                  </a:lnTo>
                  <a:close/>
                  <a:moveTo>
                    <a:pt x="669138" y="427299"/>
                  </a:moveTo>
                  <a:lnTo>
                    <a:pt x="376391" y="270475"/>
                  </a:lnTo>
                  <a:lnTo>
                    <a:pt x="484234" y="469764"/>
                  </a:lnTo>
                  <a:close/>
                  <a:moveTo>
                    <a:pt x="1252125" y="965764"/>
                  </a:moveTo>
                  <a:lnTo>
                    <a:pt x="1086537" y="999777"/>
                  </a:lnTo>
                  <a:lnTo>
                    <a:pt x="1098743" y="955618"/>
                  </a:lnTo>
                  <a:lnTo>
                    <a:pt x="685305" y="841334"/>
                  </a:lnTo>
                  <a:lnTo>
                    <a:pt x="838218" y="1123912"/>
                  </a:lnTo>
                  <a:lnTo>
                    <a:pt x="878512" y="1102108"/>
                  </a:lnTo>
                  <a:lnTo>
                    <a:pt x="882524" y="1271107"/>
                  </a:lnTo>
                  <a:lnTo>
                    <a:pt x="743244" y="1175306"/>
                  </a:lnTo>
                  <a:lnTo>
                    <a:pt x="783538" y="1153502"/>
                  </a:lnTo>
                  <a:lnTo>
                    <a:pt x="602178" y="818356"/>
                  </a:lnTo>
                  <a:lnTo>
                    <a:pt x="477762" y="783965"/>
                  </a:lnTo>
                  <a:lnTo>
                    <a:pt x="534420" y="952551"/>
                  </a:lnTo>
                  <a:lnTo>
                    <a:pt x="577848" y="937956"/>
                  </a:lnTo>
                  <a:lnTo>
                    <a:pt x="552909" y="1105152"/>
                  </a:lnTo>
                  <a:lnTo>
                    <a:pt x="432058" y="986952"/>
                  </a:lnTo>
                  <a:lnTo>
                    <a:pt x="475486" y="972357"/>
                  </a:lnTo>
                  <a:lnTo>
                    <a:pt x="405455" y="763977"/>
                  </a:lnTo>
                  <a:lnTo>
                    <a:pt x="317421" y="739643"/>
                  </a:lnTo>
                  <a:lnTo>
                    <a:pt x="328811" y="871898"/>
                  </a:lnTo>
                  <a:lnTo>
                    <a:pt x="653621" y="1279202"/>
                  </a:lnTo>
                  <a:lnTo>
                    <a:pt x="689441" y="1250636"/>
                  </a:lnTo>
                  <a:lnTo>
                    <a:pt x="723177" y="1416281"/>
                  </a:lnTo>
                  <a:lnTo>
                    <a:pt x="569193" y="1346530"/>
                  </a:lnTo>
                  <a:lnTo>
                    <a:pt x="605012" y="1317966"/>
                  </a:lnTo>
                  <a:lnTo>
                    <a:pt x="338439" y="983690"/>
                  </a:lnTo>
                  <a:lnTo>
                    <a:pt x="339160" y="992062"/>
                  </a:lnTo>
                  <a:lnTo>
                    <a:pt x="479824" y="1236494"/>
                  </a:lnTo>
                  <a:lnTo>
                    <a:pt x="519533" y="1213643"/>
                  </a:lnTo>
                  <a:lnTo>
                    <a:pt x="527968" y="1382477"/>
                  </a:lnTo>
                  <a:lnTo>
                    <a:pt x="386228" y="1290356"/>
                  </a:lnTo>
                  <a:lnTo>
                    <a:pt x="425937" y="1267505"/>
                  </a:lnTo>
                  <a:lnTo>
                    <a:pt x="351784" y="1138651"/>
                  </a:lnTo>
                  <a:lnTo>
                    <a:pt x="380456" y="1471574"/>
                  </a:lnTo>
                  <a:lnTo>
                    <a:pt x="426102" y="1467643"/>
                  </a:lnTo>
                  <a:lnTo>
                    <a:pt x="362401" y="1624228"/>
                  </a:lnTo>
                  <a:lnTo>
                    <a:pt x="272867" y="1480840"/>
                  </a:lnTo>
                  <a:lnTo>
                    <a:pt x="318513" y="1476910"/>
                  </a:lnTo>
                  <a:lnTo>
                    <a:pt x="278399" y="1011128"/>
                  </a:lnTo>
                  <a:lnTo>
                    <a:pt x="160012" y="805408"/>
                  </a:lnTo>
                  <a:lnTo>
                    <a:pt x="190301" y="780381"/>
                  </a:lnTo>
                  <a:cubicBezTo>
                    <a:pt x="200887" y="769778"/>
                    <a:pt x="210491" y="758119"/>
                    <a:pt x="218930" y="745530"/>
                  </a:cubicBezTo>
                  <a:lnTo>
                    <a:pt x="222587" y="738696"/>
                  </a:lnTo>
                  <a:lnTo>
                    <a:pt x="258853" y="784172"/>
                  </a:lnTo>
                  <a:lnTo>
                    <a:pt x="253496" y="721972"/>
                  </a:lnTo>
                  <a:lnTo>
                    <a:pt x="234367" y="716685"/>
                  </a:lnTo>
                  <a:lnTo>
                    <a:pt x="240572" y="705090"/>
                  </a:lnTo>
                  <a:cubicBezTo>
                    <a:pt x="246500" y="690760"/>
                    <a:pt x="251080" y="675625"/>
                    <a:pt x="254128" y="659806"/>
                  </a:cubicBezTo>
                  <a:cubicBezTo>
                    <a:pt x="263275" y="612348"/>
                    <a:pt x="257345" y="565479"/>
                    <a:pt x="239686" y="524145"/>
                  </a:cubicBezTo>
                  <a:lnTo>
                    <a:pt x="235854" y="517121"/>
                  </a:lnTo>
                  <a:lnTo>
                    <a:pt x="213996" y="263318"/>
                  </a:lnTo>
                  <a:lnTo>
                    <a:pt x="270418" y="239276"/>
                  </a:lnTo>
                  <a:cubicBezTo>
                    <a:pt x="282783" y="230907"/>
                    <a:pt x="294350" y="221359"/>
                    <a:pt x="304935" y="210756"/>
                  </a:cubicBezTo>
                  <a:lnTo>
                    <a:pt x="332939" y="176665"/>
                  </a:lnTo>
                  <a:lnTo>
                    <a:pt x="761293" y="406134"/>
                  </a:lnTo>
                  <a:lnTo>
                    <a:pt x="1164479" y="313538"/>
                  </a:lnTo>
                  <a:lnTo>
                    <a:pt x="1154224" y="268885"/>
                  </a:lnTo>
                  <a:lnTo>
                    <a:pt x="1318158" y="310138"/>
                  </a:lnTo>
                  <a:lnTo>
                    <a:pt x="1188650" y="418785"/>
                  </a:lnTo>
                  <a:lnTo>
                    <a:pt x="1178395" y="374132"/>
                  </a:lnTo>
                  <a:lnTo>
                    <a:pt x="844641" y="450784"/>
                  </a:lnTo>
                  <a:lnTo>
                    <a:pt x="1110730" y="593328"/>
                  </a:lnTo>
                  <a:lnTo>
                    <a:pt x="1132364" y="552942"/>
                  </a:lnTo>
                  <a:lnTo>
                    <a:pt x="1228750" y="691818"/>
                  </a:lnTo>
                  <a:lnTo>
                    <a:pt x="1059736" y="688518"/>
                  </a:lnTo>
                  <a:lnTo>
                    <a:pt x="1081371" y="648132"/>
                  </a:lnTo>
                  <a:lnTo>
                    <a:pt x="752486" y="471948"/>
                  </a:lnTo>
                  <a:lnTo>
                    <a:pt x="514938" y="526504"/>
                  </a:lnTo>
                  <a:lnTo>
                    <a:pt x="539687" y="572239"/>
                  </a:lnTo>
                  <a:lnTo>
                    <a:pt x="719006" y="555444"/>
                  </a:lnTo>
                  <a:lnTo>
                    <a:pt x="714734" y="509829"/>
                  </a:lnTo>
                  <a:lnTo>
                    <a:pt x="871790" y="572357"/>
                  </a:lnTo>
                  <a:lnTo>
                    <a:pt x="729076" y="662962"/>
                  </a:lnTo>
                  <a:lnTo>
                    <a:pt x="724804" y="617347"/>
                  </a:lnTo>
                  <a:lnTo>
                    <a:pt x="571849" y="631673"/>
                  </a:lnTo>
                  <a:lnTo>
                    <a:pt x="644259" y="765484"/>
                  </a:lnTo>
                  <a:lnTo>
                    <a:pt x="1115308" y="895692"/>
                  </a:lnTo>
                  <a:lnTo>
                    <a:pt x="1127515" y="851533"/>
                  </a:lnTo>
                  <a:close/>
                  <a:moveTo>
                    <a:pt x="1614942" y="76902"/>
                  </a:moveTo>
                  <a:lnTo>
                    <a:pt x="1464401" y="153803"/>
                  </a:lnTo>
                  <a:lnTo>
                    <a:pt x="1464401" y="107988"/>
                  </a:lnTo>
                  <a:lnTo>
                    <a:pt x="390478" y="107987"/>
                  </a:lnTo>
                  <a:lnTo>
                    <a:pt x="794851" y="243547"/>
                  </a:lnTo>
                  <a:lnTo>
                    <a:pt x="809414" y="200108"/>
                  </a:lnTo>
                  <a:lnTo>
                    <a:pt x="927704" y="320872"/>
                  </a:lnTo>
                  <a:lnTo>
                    <a:pt x="760527" y="345936"/>
                  </a:lnTo>
                  <a:lnTo>
                    <a:pt x="775090" y="302497"/>
                  </a:lnTo>
                  <a:lnTo>
                    <a:pt x="343285" y="157740"/>
                  </a:lnTo>
                  <a:lnTo>
                    <a:pt x="355206" y="135464"/>
                  </a:lnTo>
                  <a:cubicBezTo>
                    <a:pt x="361133" y="121135"/>
                    <a:pt x="365713" y="105999"/>
                    <a:pt x="368762" y="90180"/>
                  </a:cubicBezTo>
                  <a:lnTo>
                    <a:pt x="372762" y="45815"/>
                  </a:lnTo>
                  <a:lnTo>
                    <a:pt x="1464401" y="45815"/>
                  </a:lnTo>
                  <a:lnTo>
                    <a:pt x="1464401" y="0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  <a:alpha val="99000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sz="1400"/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8281803" y="4763563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8548503" y="5296963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8592953" y="4929414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8796153" y="4967514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8907278" y="531358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9129528" y="4891314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9307328" y="507863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9167628" y="537708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9504178" y="522468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9504178" y="540248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9739128" y="5418364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9961378" y="5504089"/>
              <a:ext cx="3401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>
                  <a:solidFill>
                    <a:srgbClr val="0000FF"/>
                  </a:solidFill>
                  <a:effectLst>
                    <a:glow rad="127000">
                      <a:schemeClr val="bg1"/>
                    </a:glow>
                  </a:effectLst>
                </a:rPr>
                <a:t>0</a:t>
              </a:r>
            </a:p>
          </p:txBody>
        </p:sp>
      </p:grpSp>
      <p:sp>
        <p:nvSpPr>
          <p:cNvPr id="184" name="TextBox 183"/>
          <p:cNvSpPr txBox="1"/>
          <p:nvPr/>
        </p:nvSpPr>
        <p:spPr>
          <a:xfrm>
            <a:off x="4304928" y="-2569481"/>
            <a:ext cx="28793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/>
              <a:t>Cutting strategy</a:t>
            </a:r>
          </a:p>
        </p:txBody>
      </p:sp>
      <p:grpSp>
        <p:nvGrpSpPr>
          <p:cNvPr id="191" name="Group 190"/>
          <p:cNvGrpSpPr/>
          <p:nvPr/>
        </p:nvGrpSpPr>
        <p:grpSpPr>
          <a:xfrm>
            <a:off x="475343" y="555764"/>
            <a:ext cx="3068414" cy="1730246"/>
            <a:chOff x="475343" y="3703549"/>
            <a:chExt cx="3068414" cy="1730246"/>
          </a:xfrm>
        </p:grpSpPr>
        <p:sp>
          <p:nvSpPr>
            <p:cNvPr id="185" name="Oval 184"/>
            <p:cNvSpPr/>
            <p:nvPr/>
          </p:nvSpPr>
          <p:spPr>
            <a:xfrm>
              <a:off x="475343" y="3950727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86" name="Oval 185"/>
            <p:cNvSpPr/>
            <p:nvPr/>
          </p:nvSpPr>
          <p:spPr>
            <a:xfrm>
              <a:off x="1591905" y="3703549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87" name="Oval 186"/>
            <p:cNvSpPr/>
            <p:nvPr/>
          </p:nvSpPr>
          <p:spPr>
            <a:xfrm>
              <a:off x="2376056" y="4990578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88" name="Oval 187"/>
            <p:cNvSpPr/>
            <p:nvPr/>
          </p:nvSpPr>
          <p:spPr>
            <a:xfrm>
              <a:off x="1029363" y="4487700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89" name="Oval 188"/>
            <p:cNvSpPr/>
            <p:nvPr/>
          </p:nvSpPr>
          <p:spPr>
            <a:xfrm>
              <a:off x="2836317" y="4172335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90" name="Oval 189"/>
            <p:cNvSpPr/>
            <p:nvPr/>
          </p:nvSpPr>
          <p:spPr>
            <a:xfrm>
              <a:off x="3236916" y="5126954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grpSp>
        <p:nvGrpSpPr>
          <p:cNvPr id="218" name="Group 217"/>
          <p:cNvGrpSpPr/>
          <p:nvPr/>
        </p:nvGrpSpPr>
        <p:grpSpPr>
          <a:xfrm>
            <a:off x="4307114" y="-1911665"/>
            <a:ext cx="3068414" cy="1730246"/>
            <a:chOff x="4002314" y="-2973022"/>
            <a:chExt cx="3068414" cy="1730246"/>
          </a:xfrm>
        </p:grpSpPr>
        <p:grpSp>
          <p:nvGrpSpPr>
            <p:cNvPr id="192" name="Group 191"/>
            <p:cNvGrpSpPr/>
            <p:nvPr/>
          </p:nvGrpSpPr>
          <p:grpSpPr>
            <a:xfrm>
              <a:off x="4002314" y="-2973022"/>
              <a:ext cx="3068414" cy="1730246"/>
              <a:chOff x="475343" y="3703549"/>
              <a:chExt cx="3068414" cy="1730246"/>
            </a:xfrm>
          </p:grpSpPr>
          <p:sp>
            <p:nvSpPr>
              <p:cNvPr id="193" name="Oval 192"/>
              <p:cNvSpPr/>
              <p:nvPr/>
            </p:nvSpPr>
            <p:spPr>
              <a:xfrm>
                <a:off x="475343" y="3950727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94" name="Oval 193"/>
              <p:cNvSpPr/>
              <p:nvPr/>
            </p:nvSpPr>
            <p:spPr>
              <a:xfrm>
                <a:off x="1591905" y="3703549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95" name="Oval 194"/>
              <p:cNvSpPr/>
              <p:nvPr/>
            </p:nvSpPr>
            <p:spPr>
              <a:xfrm>
                <a:off x="2376056" y="4990578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96" name="Oval 195"/>
              <p:cNvSpPr/>
              <p:nvPr/>
            </p:nvSpPr>
            <p:spPr>
              <a:xfrm>
                <a:off x="1029363" y="4487700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97" name="Oval 196"/>
              <p:cNvSpPr/>
              <p:nvPr/>
            </p:nvSpPr>
            <p:spPr>
              <a:xfrm>
                <a:off x="2836317" y="4172335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98" name="Oval 197"/>
              <p:cNvSpPr/>
              <p:nvPr/>
            </p:nvSpPr>
            <p:spPr>
              <a:xfrm>
                <a:off x="3236916" y="5126954"/>
                <a:ext cx="306841" cy="306841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sp>
          <p:nvSpPr>
            <p:cNvPr id="200" name="Freeform 199"/>
            <p:cNvSpPr/>
            <p:nvPr/>
          </p:nvSpPr>
          <p:spPr>
            <a:xfrm>
              <a:off x="4151086" y="-2815771"/>
              <a:ext cx="2772228" cy="1422400"/>
            </a:xfrm>
            <a:custGeom>
              <a:avLst/>
              <a:gdLst>
                <a:gd name="connsiteX0" fmla="*/ 0 w 2772228"/>
                <a:gd name="connsiteY0" fmla="*/ 232228 h 1422400"/>
                <a:gd name="connsiteX1" fmla="*/ 551543 w 2772228"/>
                <a:gd name="connsiteY1" fmla="*/ 783771 h 1422400"/>
                <a:gd name="connsiteX2" fmla="*/ 1901371 w 2772228"/>
                <a:gd name="connsiteY2" fmla="*/ 1291771 h 1422400"/>
                <a:gd name="connsiteX3" fmla="*/ 2772228 w 2772228"/>
                <a:gd name="connsiteY3" fmla="*/ 1422400 h 1422400"/>
                <a:gd name="connsiteX4" fmla="*/ 2365828 w 2772228"/>
                <a:gd name="connsiteY4" fmla="*/ 464457 h 1422400"/>
                <a:gd name="connsiteX5" fmla="*/ 1132114 w 2772228"/>
                <a:gd name="connsiteY5" fmla="*/ 0 h 1422400"/>
                <a:gd name="connsiteX6" fmla="*/ 0 w 2772228"/>
                <a:gd name="connsiteY6" fmla="*/ 232228 h 1422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772228" h="1422400">
                  <a:moveTo>
                    <a:pt x="0" y="232228"/>
                  </a:moveTo>
                  <a:lnTo>
                    <a:pt x="551543" y="783771"/>
                  </a:lnTo>
                  <a:lnTo>
                    <a:pt x="1901371" y="1291771"/>
                  </a:lnTo>
                  <a:lnTo>
                    <a:pt x="2772228" y="1422400"/>
                  </a:lnTo>
                  <a:lnTo>
                    <a:pt x="2365828" y="464457"/>
                  </a:lnTo>
                  <a:lnTo>
                    <a:pt x="1132114" y="0"/>
                  </a:lnTo>
                  <a:lnTo>
                    <a:pt x="0" y="232228"/>
                  </a:lnTo>
                  <a:close/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1" name="Group 200"/>
          <p:cNvGrpSpPr/>
          <p:nvPr/>
        </p:nvGrpSpPr>
        <p:grpSpPr>
          <a:xfrm>
            <a:off x="4307113" y="555764"/>
            <a:ext cx="3068414" cy="1730246"/>
            <a:chOff x="475343" y="3703549"/>
            <a:chExt cx="3068414" cy="1730246"/>
          </a:xfrm>
        </p:grpSpPr>
        <p:sp>
          <p:nvSpPr>
            <p:cNvPr id="202" name="Oval 201"/>
            <p:cNvSpPr/>
            <p:nvPr/>
          </p:nvSpPr>
          <p:spPr>
            <a:xfrm>
              <a:off x="475343" y="3950727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03" name="Oval 202"/>
            <p:cNvSpPr/>
            <p:nvPr/>
          </p:nvSpPr>
          <p:spPr>
            <a:xfrm>
              <a:off x="1591905" y="3703549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04" name="Oval 203"/>
            <p:cNvSpPr/>
            <p:nvPr/>
          </p:nvSpPr>
          <p:spPr>
            <a:xfrm>
              <a:off x="2376056" y="4990578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05" name="Oval 204"/>
            <p:cNvSpPr/>
            <p:nvPr/>
          </p:nvSpPr>
          <p:spPr>
            <a:xfrm>
              <a:off x="1029363" y="4487700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06" name="Oval 205"/>
            <p:cNvSpPr/>
            <p:nvPr/>
          </p:nvSpPr>
          <p:spPr>
            <a:xfrm>
              <a:off x="2836317" y="4172335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07" name="Oval 206"/>
            <p:cNvSpPr/>
            <p:nvPr/>
          </p:nvSpPr>
          <p:spPr>
            <a:xfrm>
              <a:off x="3236916" y="5126954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grpSp>
        <p:nvGrpSpPr>
          <p:cNvPr id="208" name="Group 207"/>
          <p:cNvGrpSpPr/>
          <p:nvPr/>
        </p:nvGrpSpPr>
        <p:grpSpPr>
          <a:xfrm>
            <a:off x="8138884" y="555764"/>
            <a:ext cx="3068414" cy="1730246"/>
            <a:chOff x="475343" y="3703549"/>
            <a:chExt cx="3068414" cy="1730246"/>
          </a:xfrm>
        </p:grpSpPr>
        <p:sp>
          <p:nvSpPr>
            <p:cNvPr id="209" name="Oval 208"/>
            <p:cNvSpPr/>
            <p:nvPr/>
          </p:nvSpPr>
          <p:spPr>
            <a:xfrm>
              <a:off x="475343" y="3950727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0" name="Oval 209"/>
            <p:cNvSpPr/>
            <p:nvPr/>
          </p:nvSpPr>
          <p:spPr>
            <a:xfrm>
              <a:off x="1591905" y="3703549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1" name="Oval 210"/>
            <p:cNvSpPr/>
            <p:nvPr/>
          </p:nvSpPr>
          <p:spPr>
            <a:xfrm>
              <a:off x="2376056" y="4990578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2" name="Oval 211"/>
            <p:cNvSpPr/>
            <p:nvPr/>
          </p:nvSpPr>
          <p:spPr>
            <a:xfrm>
              <a:off x="1029363" y="4487700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3" name="Oval 212"/>
            <p:cNvSpPr/>
            <p:nvPr/>
          </p:nvSpPr>
          <p:spPr>
            <a:xfrm>
              <a:off x="2836317" y="4172335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4" name="Oval 213"/>
            <p:cNvSpPr/>
            <p:nvPr/>
          </p:nvSpPr>
          <p:spPr>
            <a:xfrm>
              <a:off x="3236916" y="5126954"/>
              <a:ext cx="306841" cy="30684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sp>
        <p:nvSpPr>
          <p:cNvPr id="215" name="TextBox 214"/>
          <p:cNvSpPr txBox="1"/>
          <p:nvPr/>
        </p:nvSpPr>
        <p:spPr>
          <a:xfrm>
            <a:off x="1489075" y="795766"/>
            <a:ext cx="97815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/>
              <a:t>Open</a:t>
            </a:r>
          </a:p>
          <a:p>
            <a:pPr algn="ctr"/>
            <a:r>
              <a:rPr lang="en-US" sz="2800"/>
              <a:t>Loop</a:t>
            </a:r>
          </a:p>
        </p:txBody>
      </p:sp>
      <p:sp>
        <p:nvSpPr>
          <p:cNvPr id="216" name="TextBox 215"/>
          <p:cNvSpPr txBox="1"/>
          <p:nvPr/>
        </p:nvSpPr>
        <p:spPr>
          <a:xfrm>
            <a:off x="5447846" y="795766"/>
            <a:ext cx="944618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/>
              <a:t>Fixed</a:t>
            </a:r>
          </a:p>
          <a:p>
            <a:pPr algn="ctr"/>
            <a:r>
              <a:rPr lang="en-US" sz="2800"/>
              <a:t>Start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9280524" y="1013480"/>
            <a:ext cx="10020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2-TSP</a:t>
            </a:r>
          </a:p>
        </p:txBody>
      </p:sp>
      <p:sp>
        <p:nvSpPr>
          <p:cNvPr id="220" name="Freeform 219"/>
          <p:cNvSpPr/>
          <p:nvPr/>
        </p:nvSpPr>
        <p:spPr>
          <a:xfrm>
            <a:off x="622300" y="711200"/>
            <a:ext cx="2768600" cy="1422400"/>
          </a:xfrm>
          <a:custGeom>
            <a:avLst/>
            <a:gdLst>
              <a:gd name="connsiteX0" fmla="*/ 546100 w 2768600"/>
              <a:gd name="connsiteY0" fmla="*/ 774700 h 1422400"/>
              <a:gd name="connsiteX1" fmla="*/ 0 w 2768600"/>
              <a:gd name="connsiteY1" fmla="*/ 241300 h 1422400"/>
              <a:gd name="connsiteX2" fmla="*/ 1130300 w 2768600"/>
              <a:gd name="connsiteY2" fmla="*/ 0 h 1422400"/>
              <a:gd name="connsiteX3" fmla="*/ 2362200 w 2768600"/>
              <a:gd name="connsiteY3" fmla="*/ 469900 h 1422400"/>
              <a:gd name="connsiteX4" fmla="*/ 2768600 w 2768600"/>
              <a:gd name="connsiteY4" fmla="*/ 1422400 h 1422400"/>
              <a:gd name="connsiteX5" fmla="*/ 1905000 w 2768600"/>
              <a:gd name="connsiteY5" fmla="*/ 1282700 h 142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768600" h="1422400">
                <a:moveTo>
                  <a:pt x="546100" y="774700"/>
                </a:moveTo>
                <a:lnTo>
                  <a:pt x="0" y="241300"/>
                </a:lnTo>
                <a:lnTo>
                  <a:pt x="1130300" y="0"/>
                </a:lnTo>
                <a:lnTo>
                  <a:pt x="2362200" y="469900"/>
                </a:lnTo>
                <a:lnTo>
                  <a:pt x="2768600" y="1422400"/>
                </a:lnTo>
                <a:lnTo>
                  <a:pt x="1905000" y="1282700"/>
                </a:lnTo>
              </a:path>
            </a:pathLst>
          </a:cu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Freeform 220"/>
          <p:cNvSpPr/>
          <p:nvPr/>
        </p:nvSpPr>
        <p:spPr>
          <a:xfrm>
            <a:off x="4457700" y="711200"/>
            <a:ext cx="2755900" cy="1422400"/>
          </a:xfrm>
          <a:custGeom>
            <a:avLst/>
            <a:gdLst>
              <a:gd name="connsiteX0" fmla="*/ 2362200 w 2755900"/>
              <a:gd name="connsiteY0" fmla="*/ 457200 h 1422400"/>
              <a:gd name="connsiteX1" fmla="*/ 2755900 w 2755900"/>
              <a:gd name="connsiteY1" fmla="*/ 1422400 h 1422400"/>
              <a:gd name="connsiteX2" fmla="*/ 1905000 w 2755900"/>
              <a:gd name="connsiteY2" fmla="*/ 1282700 h 1422400"/>
              <a:gd name="connsiteX3" fmla="*/ 546100 w 2755900"/>
              <a:gd name="connsiteY3" fmla="*/ 787400 h 1422400"/>
              <a:gd name="connsiteX4" fmla="*/ 0 w 2755900"/>
              <a:gd name="connsiteY4" fmla="*/ 228600 h 1422400"/>
              <a:gd name="connsiteX5" fmla="*/ 1130300 w 2755900"/>
              <a:gd name="connsiteY5" fmla="*/ 0 h 142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755900" h="1422400">
                <a:moveTo>
                  <a:pt x="2362200" y="457200"/>
                </a:moveTo>
                <a:lnTo>
                  <a:pt x="2755900" y="1422400"/>
                </a:lnTo>
                <a:lnTo>
                  <a:pt x="1905000" y="1282700"/>
                </a:lnTo>
                <a:lnTo>
                  <a:pt x="546100" y="787400"/>
                </a:lnTo>
                <a:lnTo>
                  <a:pt x="0" y="228600"/>
                </a:lnTo>
                <a:lnTo>
                  <a:pt x="1130300" y="0"/>
                </a:lnTo>
              </a:path>
            </a:pathLst>
          </a:cu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Freeform 221"/>
          <p:cNvSpPr/>
          <p:nvPr/>
        </p:nvSpPr>
        <p:spPr>
          <a:xfrm>
            <a:off x="8293100" y="698500"/>
            <a:ext cx="1117600" cy="800100"/>
          </a:xfrm>
          <a:custGeom>
            <a:avLst/>
            <a:gdLst>
              <a:gd name="connsiteX0" fmla="*/ 546100 w 1117600"/>
              <a:gd name="connsiteY0" fmla="*/ 800100 h 800100"/>
              <a:gd name="connsiteX1" fmla="*/ 0 w 1117600"/>
              <a:gd name="connsiteY1" fmla="*/ 254000 h 800100"/>
              <a:gd name="connsiteX2" fmla="*/ 1117600 w 1117600"/>
              <a:gd name="connsiteY2" fmla="*/ 0 h 800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117600" h="800100">
                <a:moveTo>
                  <a:pt x="546100" y="800100"/>
                </a:moveTo>
                <a:lnTo>
                  <a:pt x="0" y="254000"/>
                </a:lnTo>
                <a:lnTo>
                  <a:pt x="1117600" y="0"/>
                </a:lnTo>
              </a:path>
            </a:pathLst>
          </a:cu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Freeform 222"/>
          <p:cNvSpPr/>
          <p:nvPr/>
        </p:nvSpPr>
        <p:spPr>
          <a:xfrm>
            <a:off x="10198100" y="1168400"/>
            <a:ext cx="838200" cy="965200"/>
          </a:xfrm>
          <a:custGeom>
            <a:avLst/>
            <a:gdLst>
              <a:gd name="connsiteX0" fmla="*/ 444500 w 838200"/>
              <a:gd name="connsiteY0" fmla="*/ 0 h 965200"/>
              <a:gd name="connsiteX1" fmla="*/ 838200 w 838200"/>
              <a:gd name="connsiteY1" fmla="*/ 965200 h 965200"/>
              <a:gd name="connsiteX2" fmla="*/ 0 w 838200"/>
              <a:gd name="connsiteY2" fmla="*/ 825500 h 965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38200" h="965200">
                <a:moveTo>
                  <a:pt x="444500" y="0"/>
                </a:moveTo>
                <a:lnTo>
                  <a:pt x="838200" y="965200"/>
                </a:lnTo>
                <a:lnTo>
                  <a:pt x="0" y="825500"/>
                </a:lnTo>
              </a:path>
            </a:pathLst>
          </a:cu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Down Arrow 226"/>
          <p:cNvSpPr/>
          <p:nvPr/>
        </p:nvSpPr>
        <p:spPr>
          <a:xfrm rot="2378454">
            <a:off x="3657597" y="-323849"/>
            <a:ext cx="285750" cy="647700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Down Arrow 227"/>
          <p:cNvSpPr/>
          <p:nvPr/>
        </p:nvSpPr>
        <p:spPr>
          <a:xfrm rot="19221546" flipH="1">
            <a:off x="7988297" y="-323849"/>
            <a:ext cx="285750" cy="647700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Down Arrow 228"/>
          <p:cNvSpPr/>
          <p:nvPr/>
        </p:nvSpPr>
        <p:spPr>
          <a:xfrm flipH="1">
            <a:off x="5822947" y="-1"/>
            <a:ext cx="285750" cy="495301"/>
          </a:xfrm>
          <a:prstGeom prst="down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TextBox 229"/>
          <p:cNvSpPr txBox="1"/>
          <p:nvPr/>
        </p:nvSpPr>
        <p:spPr>
          <a:xfrm>
            <a:off x="5312510" y="-1591834"/>
            <a:ext cx="115448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/>
              <a:t>Closed</a:t>
            </a:r>
          </a:p>
          <a:p>
            <a:pPr algn="ctr"/>
            <a:r>
              <a:rPr lang="en-US" sz="2800"/>
              <a:t>Loop</a:t>
            </a:r>
          </a:p>
        </p:txBody>
      </p:sp>
      <p:sp>
        <p:nvSpPr>
          <p:cNvPr id="231" name="Oval 230"/>
          <p:cNvSpPr/>
          <p:nvPr/>
        </p:nvSpPr>
        <p:spPr>
          <a:xfrm>
            <a:off x="6652905" y="1024423"/>
            <a:ext cx="326729" cy="326729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25400">
            <a:solidFill>
              <a:srgbClr val="C0520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/>
          </a:p>
        </p:txBody>
      </p:sp>
      <p:sp>
        <p:nvSpPr>
          <p:cNvPr id="232" name="TextBox 231"/>
          <p:cNvSpPr txBox="1"/>
          <p:nvPr/>
        </p:nvSpPr>
        <p:spPr>
          <a:xfrm rot="1260586">
            <a:off x="821997" y="2046715"/>
            <a:ext cx="16646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>
                <a:solidFill>
                  <a:srgbClr val="FF0000"/>
                </a:solidFill>
              </a:rPr>
              <a:t>Longest link</a:t>
            </a:r>
          </a:p>
        </p:txBody>
      </p:sp>
      <p:sp>
        <p:nvSpPr>
          <p:cNvPr id="233" name="Right Brace 232"/>
          <p:cNvSpPr/>
          <p:nvPr/>
        </p:nvSpPr>
        <p:spPr>
          <a:xfrm rot="6688048">
            <a:off x="1656907" y="1332460"/>
            <a:ext cx="155245" cy="1435100"/>
          </a:xfrm>
          <a:prstGeom prst="rightBrace">
            <a:avLst/>
          </a:prstGeom>
          <a:ln w="25400" cap="rnd"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TextBox 233"/>
          <p:cNvSpPr txBox="1"/>
          <p:nvPr/>
        </p:nvSpPr>
        <p:spPr>
          <a:xfrm rot="1260586">
            <a:off x="8502958" y="1997186"/>
            <a:ext cx="16646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>
                <a:solidFill>
                  <a:srgbClr val="FF0000"/>
                </a:solidFill>
              </a:rPr>
              <a:t>Longest link</a:t>
            </a:r>
          </a:p>
        </p:txBody>
      </p:sp>
      <p:sp>
        <p:nvSpPr>
          <p:cNvPr id="235" name="Right Brace 234"/>
          <p:cNvSpPr/>
          <p:nvPr/>
        </p:nvSpPr>
        <p:spPr>
          <a:xfrm rot="6688048">
            <a:off x="9322628" y="1336270"/>
            <a:ext cx="155245" cy="1435100"/>
          </a:xfrm>
          <a:prstGeom prst="rightBrace">
            <a:avLst/>
          </a:prstGeom>
          <a:ln w="25400" cap="rnd"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TextBox 235"/>
          <p:cNvSpPr txBox="1"/>
          <p:nvPr/>
        </p:nvSpPr>
        <p:spPr>
          <a:xfrm rot="1260586">
            <a:off x="9237752" y="219820"/>
            <a:ext cx="21038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>
                <a:solidFill>
                  <a:srgbClr val="FF0000"/>
                </a:solidFill>
              </a:rPr>
              <a:t>2</a:t>
            </a:r>
            <a:r>
              <a:rPr lang="en-US" sz="2400" baseline="30000">
                <a:solidFill>
                  <a:srgbClr val="FF0000"/>
                </a:solidFill>
              </a:rPr>
              <a:t>nd</a:t>
            </a:r>
            <a:r>
              <a:rPr lang="en-US" sz="2400">
                <a:solidFill>
                  <a:srgbClr val="FF0000"/>
                </a:solidFill>
              </a:rPr>
              <a:t> Longest link</a:t>
            </a:r>
          </a:p>
        </p:txBody>
      </p:sp>
      <p:sp>
        <p:nvSpPr>
          <p:cNvPr id="237" name="Right Brace 236"/>
          <p:cNvSpPr/>
          <p:nvPr/>
        </p:nvSpPr>
        <p:spPr>
          <a:xfrm rot="17458309">
            <a:off x="10060539" y="20519"/>
            <a:ext cx="155245" cy="1324661"/>
          </a:xfrm>
          <a:prstGeom prst="rightBrace">
            <a:avLst/>
          </a:prstGeom>
          <a:ln w="25400" cap="rnd"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TextBox 237"/>
          <p:cNvSpPr txBox="1"/>
          <p:nvPr/>
        </p:nvSpPr>
        <p:spPr>
          <a:xfrm rot="1800000">
            <a:off x="6353885" y="193270"/>
            <a:ext cx="175272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>
                <a:solidFill>
                  <a:srgbClr val="FF0000"/>
                </a:solidFill>
              </a:rPr>
              <a:t>Longest </a:t>
            </a:r>
          </a:p>
          <a:p>
            <a:pPr algn="ctr"/>
            <a:r>
              <a:rPr lang="en-US" sz="2400">
                <a:solidFill>
                  <a:srgbClr val="FF0000"/>
                </a:solidFill>
              </a:rPr>
              <a:t>of these two</a:t>
            </a:r>
          </a:p>
        </p:txBody>
      </p:sp>
      <p:sp>
        <p:nvSpPr>
          <p:cNvPr id="247" name="Freeform 246"/>
          <p:cNvSpPr/>
          <p:nvPr/>
        </p:nvSpPr>
        <p:spPr>
          <a:xfrm rot="13500000">
            <a:off x="6207817" y="497704"/>
            <a:ext cx="402365" cy="388160"/>
          </a:xfrm>
          <a:custGeom>
            <a:avLst/>
            <a:gdLst>
              <a:gd name="connsiteX0" fmla="*/ 402365 w 402365"/>
              <a:gd name="connsiteY0" fmla="*/ 161925 h 388160"/>
              <a:gd name="connsiteX1" fmla="*/ 321402 w 402365"/>
              <a:gd name="connsiteY1" fmla="*/ 161925 h 388160"/>
              <a:gd name="connsiteX2" fmla="*/ 273596 w 402365"/>
              <a:gd name="connsiteY2" fmla="*/ 258648 h 388160"/>
              <a:gd name="connsiteX3" fmla="*/ 271113 w 402365"/>
              <a:gd name="connsiteY3" fmla="*/ 261905 h 388160"/>
              <a:gd name="connsiteX4" fmla="*/ 269605 w 402365"/>
              <a:gd name="connsiteY4" fmla="*/ 264903 h 388160"/>
              <a:gd name="connsiteX5" fmla="*/ 248920 w 402365"/>
              <a:gd name="connsiteY5" fmla="*/ 291010 h 388160"/>
              <a:gd name="connsiteX6" fmla="*/ 220194 w 402365"/>
              <a:gd name="connsiteY6" fmla="*/ 328681 h 388160"/>
              <a:gd name="connsiteX7" fmla="*/ 0 w 402365"/>
              <a:gd name="connsiteY7" fmla="*/ 388160 h 388160"/>
              <a:gd name="connsiteX8" fmla="*/ 23557 w 402365"/>
              <a:gd name="connsiteY8" fmla="*/ 366170 h 388160"/>
              <a:gd name="connsiteX9" fmla="*/ 52486 w 402365"/>
              <a:gd name="connsiteY9" fmla="*/ 336284 h 388160"/>
              <a:gd name="connsiteX10" fmla="*/ 71482 w 402365"/>
              <a:gd name="connsiteY10" fmla="*/ 311313 h 388160"/>
              <a:gd name="connsiteX11" fmla="*/ 159477 w 402365"/>
              <a:gd name="connsiteY11" fmla="*/ 161925 h 388160"/>
              <a:gd name="connsiteX12" fmla="*/ 80072 w 402365"/>
              <a:gd name="connsiteY12" fmla="*/ 161925 h 388160"/>
              <a:gd name="connsiteX13" fmla="*/ 78515 w 402365"/>
              <a:gd name="connsiteY13" fmla="*/ 161925 h 388160"/>
              <a:gd name="connsiteX14" fmla="*/ 270005 w 402365"/>
              <a:gd name="connsiteY14" fmla="*/ 0 h 388160"/>
              <a:gd name="connsiteX0" fmla="*/ 0 w 402365"/>
              <a:gd name="connsiteY0" fmla="*/ 388160 h 479600"/>
              <a:gd name="connsiteX1" fmla="*/ 23557 w 402365"/>
              <a:gd name="connsiteY1" fmla="*/ 366170 h 479600"/>
              <a:gd name="connsiteX2" fmla="*/ 52486 w 402365"/>
              <a:gd name="connsiteY2" fmla="*/ 336284 h 479600"/>
              <a:gd name="connsiteX3" fmla="*/ 71482 w 402365"/>
              <a:gd name="connsiteY3" fmla="*/ 311313 h 479600"/>
              <a:gd name="connsiteX4" fmla="*/ 159477 w 402365"/>
              <a:gd name="connsiteY4" fmla="*/ 161925 h 479600"/>
              <a:gd name="connsiteX5" fmla="*/ 80072 w 402365"/>
              <a:gd name="connsiteY5" fmla="*/ 161925 h 479600"/>
              <a:gd name="connsiteX6" fmla="*/ 78515 w 402365"/>
              <a:gd name="connsiteY6" fmla="*/ 161925 h 479600"/>
              <a:gd name="connsiteX7" fmla="*/ 270005 w 402365"/>
              <a:gd name="connsiteY7" fmla="*/ 0 h 479600"/>
              <a:gd name="connsiteX8" fmla="*/ 402365 w 402365"/>
              <a:gd name="connsiteY8" fmla="*/ 161925 h 479600"/>
              <a:gd name="connsiteX9" fmla="*/ 321402 w 402365"/>
              <a:gd name="connsiteY9" fmla="*/ 161925 h 479600"/>
              <a:gd name="connsiteX10" fmla="*/ 273596 w 402365"/>
              <a:gd name="connsiteY10" fmla="*/ 258648 h 479600"/>
              <a:gd name="connsiteX11" fmla="*/ 271113 w 402365"/>
              <a:gd name="connsiteY11" fmla="*/ 261905 h 479600"/>
              <a:gd name="connsiteX12" fmla="*/ 269605 w 402365"/>
              <a:gd name="connsiteY12" fmla="*/ 264903 h 479600"/>
              <a:gd name="connsiteX13" fmla="*/ 248920 w 402365"/>
              <a:gd name="connsiteY13" fmla="*/ 291010 h 479600"/>
              <a:gd name="connsiteX14" fmla="*/ 220194 w 402365"/>
              <a:gd name="connsiteY14" fmla="*/ 328681 h 479600"/>
              <a:gd name="connsiteX15" fmla="*/ 91440 w 402365"/>
              <a:gd name="connsiteY15" fmla="*/ 479600 h 479600"/>
              <a:gd name="connsiteX0" fmla="*/ 0 w 402365"/>
              <a:gd name="connsiteY0" fmla="*/ 388160 h 388160"/>
              <a:gd name="connsiteX1" fmla="*/ 23557 w 402365"/>
              <a:gd name="connsiteY1" fmla="*/ 366170 h 388160"/>
              <a:gd name="connsiteX2" fmla="*/ 52486 w 402365"/>
              <a:gd name="connsiteY2" fmla="*/ 336284 h 388160"/>
              <a:gd name="connsiteX3" fmla="*/ 71482 w 402365"/>
              <a:gd name="connsiteY3" fmla="*/ 311313 h 388160"/>
              <a:gd name="connsiteX4" fmla="*/ 159477 w 402365"/>
              <a:gd name="connsiteY4" fmla="*/ 161925 h 388160"/>
              <a:gd name="connsiteX5" fmla="*/ 80072 w 402365"/>
              <a:gd name="connsiteY5" fmla="*/ 161925 h 388160"/>
              <a:gd name="connsiteX6" fmla="*/ 78515 w 402365"/>
              <a:gd name="connsiteY6" fmla="*/ 161925 h 388160"/>
              <a:gd name="connsiteX7" fmla="*/ 270005 w 402365"/>
              <a:gd name="connsiteY7" fmla="*/ 0 h 388160"/>
              <a:gd name="connsiteX8" fmla="*/ 402365 w 402365"/>
              <a:gd name="connsiteY8" fmla="*/ 161925 h 388160"/>
              <a:gd name="connsiteX9" fmla="*/ 321402 w 402365"/>
              <a:gd name="connsiteY9" fmla="*/ 161925 h 388160"/>
              <a:gd name="connsiteX10" fmla="*/ 273596 w 402365"/>
              <a:gd name="connsiteY10" fmla="*/ 258648 h 388160"/>
              <a:gd name="connsiteX11" fmla="*/ 271113 w 402365"/>
              <a:gd name="connsiteY11" fmla="*/ 261905 h 388160"/>
              <a:gd name="connsiteX12" fmla="*/ 269605 w 402365"/>
              <a:gd name="connsiteY12" fmla="*/ 264903 h 388160"/>
              <a:gd name="connsiteX13" fmla="*/ 248920 w 402365"/>
              <a:gd name="connsiteY13" fmla="*/ 291010 h 388160"/>
              <a:gd name="connsiteX14" fmla="*/ 220194 w 402365"/>
              <a:gd name="connsiteY14" fmla="*/ 328681 h 3881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402365" h="388160">
                <a:moveTo>
                  <a:pt x="0" y="388160"/>
                </a:moveTo>
                <a:lnTo>
                  <a:pt x="23557" y="366170"/>
                </a:lnTo>
                <a:lnTo>
                  <a:pt x="52486" y="336284"/>
                </a:lnTo>
                <a:lnTo>
                  <a:pt x="71482" y="311313"/>
                </a:lnTo>
                <a:lnTo>
                  <a:pt x="159477" y="161925"/>
                </a:lnTo>
                <a:lnTo>
                  <a:pt x="80072" y="161925"/>
                </a:lnTo>
                <a:lnTo>
                  <a:pt x="78515" y="161925"/>
                </a:lnTo>
                <a:lnTo>
                  <a:pt x="270005" y="0"/>
                </a:lnTo>
                <a:lnTo>
                  <a:pt x="402365" y="161925"/>
                </a:lnTo>
                <a:lnTo>
                  <a:pt x="321402" y="161925"/>
                </a:lnTo>
                <a:cubicBezTo>
                  <a:pt x="308961" y="195444"/>
                  <a:pt x="292911" y="227741"/>
                  <a:pt x="273596" y="258648"/>
                </a:cubicBezTo>
                <a:lnTo>
                  <a:pt x="271113" y="261905"/>
                </a:lnTo>
                <a:lnTo>
                  <a:pt x="269605" y="264903"/>
                </a:lnTo>
                <a:lnTo>
                  <a:pt x="248920" y="291010"/>
                </a:lnTo>
                <a:lnTo>
                  <a:pt x="220194" y="328681"/>
                </a:lnTo>
              </a:path>
            </a:pathLst>
          </a:custGeom>
          <a:solidFill>
            <a:schemeClr val="bg1"/>
          </a:solidFill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48" name="Freeform 247"/>
          <p:cNvSpPr/>
          <p:nvPr/>
        </p:nvSpPr>
        <p:spPr>
          <a:xfrm rot="15412828" flipH="1">
            <a:off x="7047412" y="1227411"/>
            <a:ext cx="545207" cy="552338"/>
          </a:xfrm>
          <a:custGeom>
            <a:avLst/>
            <a:gdLst>
              <a:gd name="connsiteX0" fmla="*/ 0 w 548807"/>
              <a:gd name="connsiteY0" fmla="*/ 496109 h 552338"/>
              <a:gd name="connsiteX1" fmla="*/ 52441 w 548807"/>
              <a:gd name="connsiteY1" fmla="*/ 552338 h 552338"/>
              <a:gd name="connsiteX2" fmla="*/ 53690 w 548807"/>
              <a:gd name="connsiteY2" fmla="*/ 551891 h 552338"/>
              <a:gd name="connsiteX3" fmla="*/ 99274 w 548807"/>
              <a:gd name="connsiteY3" fmla="*/ 528951 h 552338"/>
              <a:gd name="connsiteX4" fmla="*/ 136501 w 548807"/>
              <a:gd name="connsiteY4" fmla="*/ 512051 h 552338"/>
              <a:gd name="connsiteX5" fmla="*/ 150413 w 548807"/>
              <a:gd name="connsiteY5" fmla="*/ 503216 h 552338"/>
              <a:gd name="connsiteX6" fmla="*/ 167402 w 548807"/>
              <a:gd name="connsiteY6" fmla="*/ 494667 h 552338"/>
              <a:gd name="connsiteX7" fmla="*/ 213291 w 548807"/>
              <a:gd name="connsiteY7" fmla="*/ 463281 h 552338"/>
              <a:gd name="connsiteX8" fmla="*/ 247904 w 548807"/>
              <a:gd name="connsiteY8" fmla="*/ 441298 h 552338"/>
              <a:gd name="connsiteX9" fmla="*/ 256476 w 548807"/>
              <a:gd name="connsiteY9" fmla="*/ 433746 h 552338"/>
              <a:gd name="connsiteX10" fmla="*/ 267745 w 548807"/>
              <a:gd name="connsiteY10" fmla="*/ 426038 h 552338"/>
              <a:gd name="connsiteX11" fmla="*/ 312593 w 548807"/>
              <a:gd name="connsiteY11" fmla="*/ 384302 h 552338"/>
              <a:gd name="connsiteX12" fmla="*/ 341910 w 548807"/>
              <a:gd name="connsiteY12" fmla="*/ 358471 h 552338"/>
              <a:gd name="connsiteX13" fmla="*/ 346292 w 548807"/>
              <a:gd name="connsiteY13" fmla="*/ 352941 h 552338"/>
              <a:gd name="connsiteX14" fmla="*/ 352648 w 548807"/>
              <a:gd name="connsiteY14" fmla="*/ 347026 h 552338"/>
              <a:gd name="connsiteX15" fmla="*/ 395362 w 548807"/>
              <a:gd name="connsiteY15" fmla="*/ 291010 h 552338"/>
              <a:gd name="connsiteX16" fmla="*/ 416047 w 548807"/>
              <a:gd name="connsiteY16" fmla="*/ 264903 h 552338"/>
              <a:gd name="connsiteX17" fmla="*/ 417555 w 548807"/>
              <a:gd name="connsiteY17" fmla="*/ 261905 h 552338"/>
              <a:gd name="connsiteX18" fmla="*/ 420038 w 548807"/>
              <a:gd name="connsiteY18" fmla="*/ 258648 h 552338"/>
              <a:gd name="connsiteX19" fmla="*/ 467844 w 548807"/>
              <a:gd name="connsiteY19" fmla="*/ 161925 h 552338"/>
              <a:gd name="connsiteX20" fmla="*/ 548807 w 548807"/>
              <a:gd name="connsiteY20" fmla="*/ 161925 h 552338"/>
              <a:gd name="connsiteX21" fmla="*/ 416447 w 548807"/>
              <a:gd name="connsiteY21" fmla="*/ 0 h 552338"/>
              <a:gd name="connsiteX22" fmla="*/ 224957 w 548807"/>
              <a:gd name="connsiteY22" fmla="*/ 161925 h 552338"/>
              <a:gd name="connsiteX23" fmla="*/ 226514 w 548807"/>
              <a:gd name="connsiteY23" fmla="*/ 161925 h 552338"/>
              <a:gd name="connsiteX24" fmla="*/ 305918 w 548807"/>
              <a:gd name="connsiteY24" fmla="*/ 161925 h 552338"/>
              <a:gd name="connsiteX25" fmla="*/ 217924 w 548807"/>
              <a:gd name="connsiteY25" fmla="*/ 311313 h 552338"/>
              <a:gd name="connsiteX26" fmla="*/ 198929 w 548807"/>
              <a:gd name="connsiteY26" fmla="*/ 336284 h 552338"/>
              <a:gd name="connsiteX27" fmla="*/ 169998 w 548807"/>
              <a:gd name="connsiteY27" fmla="*/ 366170 h 552338"/>
              <a:gd name="connsiteX28" fmla="*/ 120665 w 548807"/>
              <a:gd name="connsiteY28" fmla="*/ 412223 h 552338"/>
              <a:gd name="connsiteX29" fmla="*/ 84948 w 548807"/>
              <a:gd name="connsiteY29" fmla="*/ 440206 h 552338"/>
              <a:gd name="connsiteX30" fmla="*/ 27616 w 548807"/>
              <a:gd name="connsiteY30" fmla="*/ 479528 h 552338"/>
              <a:gd name="connsiteX0" fmla="*/ 0 w 548807"/>
              <a:gd name="connsiteY0" fmla="*/ 496109 h 587549"/>
              <a:gd name="connsiteX1" fmla="*/ 52441 w 548807"/>
              <a:gd name="connsiteY1" fmla="*/ 552338 h 587549"/>
              <a:gd name="connsiteX2" fmla="*/ 53690 w 548807"/>
              <a:gd name="connsiteY2" fmla="*/ 551891 h 587549"/>
              <a:gd name="connsiteX3" fmla="*/ 99274 w 548807"/>
              <a:gd name="connsiteY3" fmla="*/ 528951 h 587549"/>
              <a:gd name="connsiteX4" fmla="*/ 136501 w 548807"/>
              <a:gd name="connsiteY4" fmla="*/ 512051 h 587549"/>
              <a:gd name="connsiteX5" fmla="*/ 150413 w 548807"/>
              <a:gd name="connsiteY5" fmla="*/ 503216 h 587549"/>
              <a:gd name="connsiteX6" fmla="*/ 167402 w 548807"/>
              <a:gd name="connsiteY6" fmla="*/ 494667 h 587549"/>
              <a:gd name="connsiteX7" fmla="*/ 213291 w 548807"/>
              <a:gd name="connsiteY7" fmla="*/ 463281 h 587549"/>
              <a:gd name="connsiteX8" fmla="*/ 247904 w 548807"/>
              <a:gd name="connsiteY8" fmla="*/ 441298 h 587549"/>
              <a:gd name="connsiteX9" fmla="*/ 256476 w 548807"/>
              <a:gd name="connsiteY9" fmla="*/ 433746 h 587549"/>
              <a:gd name="connsiteX10" fmla="*/ 267745 w 548807"/>
              <a:gd name="connsiteY10" fmla="*/ 426038 h 587549"/>
              <a:gd name="connsiteX11" fmla="*/ 312593 w 548807"/>
              <a:gd name="connsiteY11" fmla="*/ 384302 h 587549"/>
              <a:gd name="connsiteX12" fmla="*/ 341910 w 548807"/>
              <a:gd name="connsiteY12" fmla="*/ 358471 h 587549"/>
              <a:gd name="connsiteX13" fmla="*/ 346292 w 548807"/>
              <a:gd name="connsiteY13" fmla="*/ 352941 h 587549"/>
              <a:gd name="connsiteX14" fmla="*/ 352648 w 548807"/>
              <a:gd name="connsiteY14" fmla="*/ 347026 h 587549"/>
              <a:gd name="connsiteX15" fmla="*/ 395362 w 548807"/>
              <a:gd name="connsiteY15" fmla="*/ 291010 h 587549"/>
              <a:gd name="connsiteX16" fmla="*/ 416047 w 548807"/>
              <a:gd name="connsiteY16" fmla="*/ 264903 h 587549"/>
              <a:gd name="connsiteX17" fmla="*/ 417555 w 548807"/>
              <a:gd name="connsiteY17" fmla="*/ 261905 h 587549"/>
              <a:gd name="connsiteX18" fmla="*/ 420038 w 548807"/>
              <a:gd name="connsiteY18" fmla="*/ 258648 h 587549"/>
              <a:gd name="connsiteX19" fmla="*/ 467844 w 548807"/>
              <a:gd name="connsiteY19" fmla="*/ 161925 h 587549"/>
              <a:gd name="connsiteX20" fmla="*/ 548807 w 548807"/>
              <a:gd name="connsiteY20" fmla="*/ 161925 h 587549"/>
              <a:gd name="connsiteX21" fmla="*/ 416447 w 548807"/>
              <a:gd name="connsiteY21" fmla="*/ 0 h 587549"/>
              <a:gd name="connsiteX22" fmla="*/ 224957 w 548807"/>
              <a:gd name="connsiteY22" fmla="*/ 161925 h 587549"/>
              <a:gd name="connsiteX23" fmla="*/ 226514 w 548807"/>
              <a:gd name="connsiteY23" fmla="*/ 161925 h 587549"/>
              <a:gd name="connsiteX24" fmla="*/ 305918 w 548807"/>
              <a:gd name="connsiteY24" fmla="*/ 161925 h 587549"/>
              <a:gd name="connsiteX25" fmla="*/ 217924 w 548807"/>
              <a:gd name="connsiteY25" fmla="*/ 311313 h 587549"/>
              <a:gd name="connsiteX26" fmla="*/ 198929 w 548807"/>
              <a:gd name="connsiteY26" fmla="*/ 336284 h 587549"/>
              <a:gd name="connsiteX27" fmla="*/ 169998 w 548807"/>
              <a:gd name="connsiteY27" fmla="*/ 366170 h 587549"/>
              <a:gd name="connsiteX28" fmla="*/ 120665 w 548807"/>
              <a:gd name="connsiteY28" fmla="*/ 412223 h 587549"/>
              <a:gd name="connsiteX29" fmla="*/ 84948 w 548807"/>
              <a:gd name="connsiteY29" fmla="*/ 440206 h 587549"/>
              <a:gd name="connsiteX30" fmla="*/ 27616 w 548807"/>
              <a:gd name="connsiteY30" fmla="*/ 479528 h 587549"/>
              <a:gd name="connsiteX31" fmla="*/ 91440 w 548807"/>
              <a:gd name="connsiteY31" fmla="*/ 587549 h 587549"/>
              <a:gd name="connsiteX0" fmla="*/ 0 w 548807"/>
              <a:gd name="connsiteY0" fmla="*/ 496109 h 552338"/>
              <a:gd name="connsiteX1" fmla="*/ 52441 w 548807"/>
              <a:gd name="connsiteY1" fmla="*/ 552338 h 552338"/>
              <a:gd name="connsiteX2" fmla="*/ 53690 w 548807"/>
              <a:gd name="connsiteY2" fmla="*/ 551891 h 552338"/>
              <a:gd name="connsiteX3" fmla="*/ 99274 w 548807"/>
              <a:gd name="connsiteY3" fmla="*/ 528951 h 552338"/>
              <a:gd name="connsiteX4" fmla="*/ 136501 w 548807"/>
              <a:gd name="connsiteY4" fmla="*/ 512051 h 552338"/>
              <a:gd name="connsiteX5" fmla="*/ 150413 w 548807"/>
              <a:gd name="connsiteY5" fmla="*/ 503216 h 552338"/>
              <a:gd name="connsiteX6" fmla="*/ 167402 w 548807"/>
              <a:gd name="connsiteY6" fmla="*/ 494667 h 552338"/>
              <a:gd name="connsiteX7" fmla="*/ 213291 w 548807"/>
              <a:gd name="connsiteY7" fmla="*/ 463281 h 552338"/>
              <a:gd name="connsiteX8" fmla="*/ 247904 w 548807"/>
              <a:gd name="connsiteY8" fmla="*/ 441298 h 552338"/>
              <a:gd name="connsiteX9" fmla="*/ 256476 w 548807"/>
              <a:gd name="connsiteY9" fmla="*/ 433746 h 552338"/>
              <a:gd name="connsiteX10" fmla="*/ 267745 w 548807"/>
              <a:gd name="connsiteY10" fmla="*/ 426038 h 552338"/>
              <a:gd name="connsiteX11" fmla="*/ 312593 w 548807"/>
              <a:gd name="connsiteY11" fmla="*/ 384302 h 552338"/>
              <a:gd name="connsiteX12" fmla="*/ 341910 w 548807"/>
              <a:gd name="connsiteY12" fmla="*/ 358471 h 552338"/>
              <a:gd name="connsiteX13" fmla="*/ 346292 w 548807"/>
              <a:gd name="connsiteY13" fmla="*/ 352941 h 552338"/>
              <a:gd name="connsiteX14" fmla="*/ 352648 w 548807"/>
              <a:gd name="connsiteY14" fmla="*/ 347026 h 552338"/>
              <a:gd name="connsiteX15" fmla="*/ 395362 w 548807"/>
              <a:gd name="connsiteY15" fmla="*/ 291010 h 552338"/>
              <a:gd name="connsiteX16" fmla="*/ 416047 w 548807"/>
              <a:gd name="connsiteY16" fmla="*/ 264903 h 552338"/>
              <a:gd name="connsiteX17" fmla="*/ 417555 w 548807"/>
              <a:gd name="connsiteY17" fmla="*/ 261905 h 552338"/>
              <a:gd name="connsiteX18" fmla="*/ 420038 w 548807"/>
              <a:gd name="connsiteY18" fmla="*/ 258648 h 552338"/>
              <a:gd name="connsiteX19" fmla="*/ 467844 w 548807"/>
              <a:gd name="connsiteY19" fmla="*/ 161925 h 552338"/>
              <a:gd name="connsiteX20" fmla="*/ 548807 w 548807"/>
              <a:gd name="connsiteY20" fmla="*/ 161925 h 552338"/>
              <a:gd name="connsiteX21" fmla="*/ 416447 w 548807"/>
              <a:gd name="connsiteY21" fmla="*/ 0 h 552338"/>
              <a:gd name="connsiteX22" fmla="*/ 224957 w 548807"/>
              <a:gd name="connsiteY22" fmla="*/ 161925 h 552338"/>
              <a:gd name="connsiteX23" fmla="*/ 226514 w 548807"/>
              <a:gd name="connsiteY23" fmla="*/ 161925 h 552338"/>
              <a:gd name="connsiteX24" fmla="*/ 305918 w 548807"/>
              <a:gd name="connsiteY24" fmla="*/ 161925 h 552338"/>
              <a:gd name="connsiteX25" fmla="*/ 217924 w 548807"/>
              <a:gd name="connsiteY25" fmla="*/ 311313 h 552338"/>
              <a:gd name="connsiteX26" fmla="*/ 198929 w 548807"/>
              <a:gd name="connsiteY26" fmla="*/ 336284 h 552338"/>
              <a:gd name="connsiteX27" fmla="*/ 169998 w 548807"/>
              <a:gd name="connsiteY27" fmla="*/ 366170 h 552338"/>
              <a:gd name="connsiteX28" fmla="*/ 120665 w 548807"/>
              <a:gd name="connsiteY28" fmla="*/ 412223 h 552338"/>
              <a:gd name="connsiteX29" fmla="*/ 84948 w 548807"/>
              <a:gd name="connsiteY29" fmla="*/ 440206 h 552338"/>
              <a:gd name="connsiteX30" fmla="*/ 27616 w 548807"/>
              <a:gd name="connsiteY30" fmla="*/ 479528 h 552338"/>
              <a:gd name="connsiteX0" fmla="*/ 24825 w 521191"/>
              <a:gd name="connsiteY0" fmla="*/ 552338 h 552338"/>
              <a:gd name="connsiteX1" fmla="*/ 26074 w 521191"/>
              <a:gd name="connsiteY1" fmla="*/ 551891 h 552338"/>
              <a:gd name="connsiteX2" fmla="*/ 71658 w 521191"/>
              <a:gd name="connsiteY2" fmla="*/ 528951 h 552338"/>
              <a:gd name="connsiteX3" fmla="*/ 108885 w 521191"/>
              <a:gd name="connsiteY3" fmla="*/ 512051 h 552338"/>
              <a:gd name="connsiteX4" fmla="*/ 122797 w 521191"/>
              <a:gd name="connsiteY4" fmla="*/ 503216 h 552338"/>
              <a:gd name="connsiteX5" fmla="*/ 139786 w 521191"/>
              <a:gd name="connsiteY5" fmla="*/ 494667 h 552338"/>
              <a:gd name="connsiteX6" fmla="*/ 185675 w 521191"/>
              <a:gd name="connsiteY6" fmla="*/ 463281 h 552338"/>
              <a:gd name="connsiteX7" fmla="*/ 220288 w 521191"/>
              <a:gd name="connsiteY7" fmla="*/ 441298 h 552338"/>
              <a:gd name="connsiteX8" fmla="*/ 228860 w 521191"/>
              <a:gd name="connsiteY8" fmla="*/ 433746 h 552338"/>
              <a:gd name="connsiteX9" fmla="*/ 240129 w 521191"/>
              <a:gd name="connsiteY9" fmla="*/ 426038 h 552338"/>
              <a:gd name="connsiteX10" fmla="*/ 284977 w 521191"/>
              <a:gd name="connsiteY10" fmla="*/ 384302 h 552338"/>
              <a:gd name="connsiteX11" fmla="*/ 314294 w 521191"/>
              <a:gd name="connsiteY11" fmla="*/ 358471 h 552338"/>
              <a:gd name="connsiteX12" fmla="*/ 318676 w 521191"/>
              <a:gd name="connsiteY12" fmla="*/ 352941 h 552338"/>
              <a:gd name="connsiteX13" fmla="*/ 325032 w 521191"/>
              <a:gd name="connsiteY13" fmla="*/ 347026 h 552338"/>
              <a:gd name="connsiteX14" fmla="*/ 367746 w 521191"/>
              <a:gd name="connsiteY14" fmla="*/ 291010 h 552338"/>
              <a:gd name="connsiteX15" fmla="*/ 388431 w 521191"/>
              <a:gd name="connsiteY15" fmla="*/ 264903 h 552338"/>
              <a:gd name="connsiteX16" fmla="*/ 389939 w 521191"/>
              <a:gd name="connsiteY16" fmla="*/ 261905 h 552338"/>
              <a:gd name="connsiteX17" fmla="*/ 392422 w 521191"/>
              <a:gd name="connsiteY17" fmla="*/ 258648 h 552338"/>
              <a:gd name="connsiteX18" fmla="*/ 440228 w 521191"/>
              <a:gd name="connsiteY18" fmla="*/ 161925 h 552338"/>
              <a:gd name="connsiteX19" fmla="*/ 521191 w 521191"/>
              <a:gd name="connsiteY19" fmla="*/ 161925 h 552338"/>
              <a:gd name="connsiteX20" fmla="*/ 388831 w 521191"/>
              <a:gd name="connsiteY20" fmla="*/ 0 h 552338"/>
              <a:gd name="connsiteX21" fmla="*/ 197341 w 521191"/>
              <a:gd name="connsiteY21" fmla="*/ 161925 h 552338"/>
              <a:gd name="connsiteX22" fmla="*/ 198898 w 521191"/>
              <a:gd name="connsiteY22" fmla="*/ 161925 h 552338"/>
              <a:gd name="connsiteX23" fmla="*/ 278302 w 521191"/>
              <a:gd name="connsiteY23" fmla="*/ 161925 h 552338"/>
              <a:gd name="connsiteX24" fmla="*/ 190308 w 521191"/>
              <a:gd name="connsiteY24" fmla="*/ 311313 h 552338"/>
              <a:gd name="connsiteX25" fmla="*/ 171313 w 521191"/>
              <a:gd name="connsiteY25" fmla="*/ 336284 h 552338"/>
              <a:gd name="connsiteX26" fmla="*/ 142382 w 521191"/>
              <a:gd name="connsiteY26" fmla="*/ 366170 h 552338"/>
              <a:gd name="connsiteX27" fmla="*/ 93049 w 521191"/>
              <a:gd name="connsiteY27" fmla="*/ 412223 h 552338"/>
              <a:gd name="connsiteX28" fmla="*/ 57332 w 521191"/>
              <a:gd name="connsiteY28" fmla="*/ 440206 h 552338"/>
              <a:gd name="connsiteX29" fmla="*/ 0 w 521191"/>
              <a:gd name="connsiteY29" fmla="*/ 479528 h 552338"/>
              <a:gd name="connsiteX0" fmla="*/ 48841 w 545207"/>
              <a:gd name="connsiteY0" fmla="*/ 552338 h 552338"/>
              <a:gd name="connsiteX1" fmla="*/ 50090 w 545207"/>
              <a:gd name="connsiteY1" fmla="*/ 551891 h 552338"/>
              <a:gd name="connsiteX2" fmla="*/ 95674 w 545207"/>
              <a:gd name="connsiteY2" fmla="*/ 528951 h 552338"/>
              <a:gd name="connsiteX3" fmla="*/ 132901 w 545207"/>
              <a:gd name="connsiteY3" fmla="*/ 512051 h 552338"/>
              <a:gd name="connsiteX4" fmla="*/ 146813 w 545207"/>
              <a:gd name="connsiteY4" fmla="*/ 503216 h 552338"/>
              <a:gd name="connsiteX5" fmla="*/ 163802 w 545207"/>
              <a:gd name="connsiteY5" fmla="*/ 494667 h 552338"/>
              <a:gd name="connsiteX6" fmla="*/ 209691 w 545207"/>
              <a:gd name="connsiteY6" fmla="*/ 463281 h 552338"/>
              <a:gd name="connsiteX7" fmla="*/ 244304 w 545207"/>
              <a:gd name="connsiteY7" fmla="*/ 441298 h 552338"/>
              <a:gd name="connsiteX8" fmla="*/ 252876 w 545207"/>
              <a:gd name="connsiteY8" fmla="*/ 433746 h 552338"/>
              <a:gd name="connsiteX9" fmla="*/ 264145 w 545207"/>
              <a:gd name="connsiteY9" fmla="*/ 426038 h 552338"/>
              <a:gd name="connsiteX10" fmla="*/ 308993 w 545207"/>
              <a:gd name="connsiteY10" fmla="*/ 384302 h 552338"/>
              <a:gd name="connsiteX11" fmla="*/ 338310 w 545207"/>
              <a:gd name="connsiteY11" fmla="*/ 358471 h 552338"/>
              <a:gd name="connsiteX12" fmla="*/ 342692 w 545207"/>
              <a:gd name="connsiteY12" fmla="*/ 352941 h 552338"/>
              <a:gd name="connsiteX13" fmla="*/ 349048 w 545207"/>
              <a:gd name="connsiteY13" fmla="*/ 347026 h 552338"/>
              <a:gd name="connsiteX14" fmla="*/ 391762 w 545207"/>
              <a:gd name="connsiteY14" fmla="*/ 291010 h 552338"/>
              <a:gd name="connsiteX15" fmla="*/ 412447 w 545207"/>
              <a:gd name="connsiteY15" fmla="*/ 264903 h 552338"/>
              <a:gd name="connsiteX16" fmla="*/ 413955 w 545207"/>
              <a:gd name="connsiteY16" fmla="*/ 261905 h 552338"/>
              <a:gd name="connsiteX17" fmla="*/ 416438 w 545207"/>
              <a:gd name="connsiteY17" fmla="*/ 258648 h 552338"/>
              <a:gd name="connsiteX18" fmla="*/ 464244 w 545207"/>
              <a:gd name="connsiteY18" fmla="*/ 161925 h 552338"/>
              <a:gd name="connsiteX19" fmla="*/ 545207 w 545207"/>
              <a:gd name="connsiteY19" fmla="*/ 161925 h 552338"/>
              <a:gd name="connsiteX20" fmla="*/ 412847 w 545207"/>
              <a:gd name="connsiteY20" fmla="*/ 0 h 552338"/>
              <a:gd name="connsiteX21" fmla="*/ 221357 w 545207"/>
              <a:gd name="connsiteY21" fmla="*/ 161925 h 552338"/>
              <a:gd name="connsiteX22" fmla="*/ 222914 w 545207"/>
              <a:gd name="connsiteY22" fmla="*/ 161925 h 552338"/>
              <a:gd name="connsiteX23" fmla="*/ 302318 w 545207"/>
              <a:gd name="connsiteY23" fmla="*/ 161925 h 552338"/>
              <a:gd name="connsiteX24" fmla="*/ 214324 w 545207"/>
              <a:gd name="connsiteY24" fmla="*/ 311313 h 552338"/>
              <a:gd name="connsiteX25" fmla="*/ 195329 w 545207"/>
              <a:gd name="connsiteY25" fmla="*/ 336284 h 552338"/>
              <a:gd name="connsiteX26" fmla="*/ 166398 w 545207"/>
              <a:gd name="connsiteY26" fmla="*/ 366170 h 552338"/>
              <a:gd name="connsiteX27" fmla="*/ 117065 w 545207"/>
              <a:gd name="connsiteY27" fmla="*/ 412223 h 552338"/>
              <a:gd name="connsiteX28" fmla="*/ 81348 w 545207"/>
              <a:gd name="connsiteY28" fmla="*/ 440206 h 552338"/>
              <a:gd name="connsiteX29" fmla="*/ 0 w 545207"/>
              <a:gd name="connsiteY29" fmla="*/ 488386 h 5523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</a:cxnLst>
            <a:rect l="l" t="t" r="r" b="b"/>
            <a:pathLst>
              <a:path w="545207" h="552338">
                <a:moveTo>
                  <a:pt x="48841" y="552338"/>
                </a:moveTo>
                <a:lnTo>
                  <a:pt x="50090" y="551891"/>
                </a:lnTo>
                <a:lnTo>
                  <a:pt x="95674" y="528951"/>
                </a:lnTo>
                <a:lnTo>
                  <a:pt x="132901" y="512051"/>
                </a:lnTo>
                <a:lnTo>
                  <a:pt x="146813" y="503216"/>
                </a:lnTo>
                <a:lnTo>
                  <a:pt x="163802" y="494667"/>
                </a:lnTo>
                <a:lnTo>
                  <a:pt x="209691" y="463281"/>
                </a:lnTo>
                <a:lnTo>
                  <a:pt x="244304" y="441298"/>
                </a:lnTo>
                <a:lnTo>
                  <a:pt x="252876" y="433746"/>
                </a:lnTo>
                <a:lnTo>
                  <a:pt x="264145" y="426038"/>
                </a:lnTo>
                <a:lnTo>
                  <a:pt x="308993" y="384302"/>
                </a:lnTo>
                <a:lnTo>
                  <a:pt x="338310" y="358471"/>
                </a:lnTo>
                <a:lnTo>
                  <a:pt x="342692" y="352941"/>
                </a:lnTo>
                <a:lnTo>
                  <a:pt x="349048" y="347026"/>
                </a:lnTo>
                <a:lnTo>
                  <a:pt x="391762" y="291010"/>
                </a:lnTo>
                <a:lnTo>
                  <a:pt x="412447" y="264903"/>
                </a:lnTo>
                <a:lnTo>
                  <a:pt x="413955" y="261905"/>
                </a:lnTo>
                <a:lnTo>
                  <a:pt x="416438" y="258648"/>
                </a:lnTo>
                <a:cubicBezTo>
                  <a:pt x="435753" y="227741"/>
                  <a:pt x="451803" y="195444"/>
                  <a:pt x="464244" y="161925"/>
                </a:cubicBezTo>
                <a:lnTo>
                  <a:pt x="545207" y="161925"/>
                </a:lnTo>
                <a:lnTo>
                  <a:pt x="412847" y="0"/>
                </a:lnTo>
                <a:lnTo>
                  <a:pt x="221357" y="161925"/>
                </a:lnTo>
                <a:lnTo>
                  <a:pt x="222914" y="161925"/>
                </a:lnTo>
                <a:lnTo>
                  <a:pt x="302318" y="161925"/>
                </a:lnTo>
                <a:lnTo>
                  <a:pt x="214324" y="311313"/>
                </a:lnTo>
                <a:lnTo>
                  <a:pt x="195329" y="336284"/>
                </a:lnTo>
                <a:lnTo>
                  <a:pt x="166398" y="366170"/>
                </a:lnTo>
                <a:lnTo>
                  <a:pt x="117065" y="412223"/>
                </a:lnTo>
                <a:lnTo>
                  <a:pt x="81348" y="440206"/>
                </a:lnTo>
                <a:lnTo>
                  <a:pt x="0" y="488386"/>
                </a:lnTo>
              </a:path>
            </a:pathLst>
          </a:custGeom>
          <a:solidFill>
            <a:schemeClr val="bg1"/>
          </a:solidFill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68475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duotone>
              <a:schemeClr val="accent4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049" y="-449129"/>
            <a:ext cx="4431687" cy="785141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049" y="-449129"/>
            <a:ext cx="4431687" cy="7851415"/>
          </a:xfrm>
          <a:prstGeom prst="rect">
            <a:avLst/>
          </a:prstGeom>
        </p:spPr>
      </p:pic>
      <p:grpSp>
        <p:nvGrpSpPr>
          <p:cNvPr id="17" name="Group 16"/>
          <p:cNvGrpSpPr/>
          <p:nvPr/>
        </p:nvGrpSpPr>
        <p:grpSpPr>
          <a:xfrm>
            <a:off x="7956540" y="4019550"/>
            <a:ext cx="4121161" cy="3000375"/>
            <a:chOff x="3746490" y="4019550"/>
            <a:chExt cx="4121161" cy="3000375"/>
          </a:xfrm>
        </p:grpSpPr>
        <p:sp>
          <p:nvSpPr>
            <p:cNvPr id="18" name="Freeform 17"/>
            <p:cNvSpPr/>
            <p:nvPr/>
          </p:nvSpPr>
          <p:spPr>
            <a:xfrm>
              <a:off x="3943351" y="4019550"/>
              <a:ext cx="3924300" cy="3000375"/>
            </a:xfrm>
            <a:custGeom>
              <a:avLst/>
              <a:gdLst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9525 w 4886325"/>
                <a:gd name="connsiteY6" fmla="*/ 1133475 h 3000375"/>
                <a:gd name="connsiteX7" fmla="*/ 0 w 4886325"/>
                <a:gd name="connsiteY7" fmla="*/ 962025 h 3000375"/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233363 w 4886325"/>
                <a:gd name="connsiteY6" fmla="*/ 1152525 h 3000375"/>
                <a:gd name="connsiteX7" fmla="*/ 0 w 4886325"/>
                <a:gd name="connsiteY7" fmla="*/ 962025 h 3000375"/>
                <a:gd name="connsiteX0" fmla="*/ 4762 w 4652962"/>
                <a:gd name="connsiteY0" fmla="*/ 928688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4762 w 4652962"/>
                <a:gd name="connsiteY7" fmla="*/ 928688 h 3000375"/>
                <a:gd name="connsiteX0" fmla="*/ 728662 w 4652962"/>
                <a:gd name="connsiteY0" fmla="*/ 919163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728662 w 4652962"/>
                <a:gd name="connsiteY7" fmla="*/ 919163 h 3000375"/>
                <a:gd name="connsiteX0" fmla="*/ 0 w 3924300"/>
                <a:gd name="connsiteY0" fmla="*/ 919163 h 3000375"/>
                <a:gd name="connsiteX1" fmla="*/ 609600 w 3924300"/>
                <a:gd name="connsiteY1" fmla="*/ 0 h 3000375"/>
                <a:gd name="connsiteX2" fmla="*/ 3924300 w 3924300"/>
                <a:gd name="connsiteY2" fmla="*/ 0 h 3000375"/>
                <a:gd name="connsiteX3" fmla="*/ 3924300 w 3924300"/>
                <a:gd name="connsiteY3" fmla="*/ 3000375 h 3000375"/>
                <a:gd name="connsiteX4" fmla="*/ 3924300 w 3924300"/>
                <a:gd name="connsiteY4" fmla="*/ 3000375 h 3000375"/>
                <a:gd name="connsiteX5" fmla="*/ 609600 w 3924300"/>
                <a:gd name="connsiteY5" fmla="*/ 3000375 h 3000375"/>
                <a:gd name="connsiteX6" fmla="*/ 4763 w 3924300"/>
                <a:gd name="connsiteY6" fmla="*/ 1119187 h 3000375"/>
                <a:gd name="connsiteX7" fmla="*/ 0 w 3924300"/>
                <a:gd name="connsiteY7" fmla="*/ 919163 h 30003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924300" h="3000375">
                  <a:moveTo>
                    <a:pt x="0" y="919163"/>
                  </a:moveTo>
                  <a:lnTo>
                    <a:pt x="609600" y="0"/>
                  </a:lnTo>
                  <a:lnTo>
                    <a:pt x="3924300" y="0"/>
                  </a:lnTo>
                  <a:lnTo>
                    <a:pt x="3924300" y="3000375"/>
                  </a:lnTo>
                  <a:lnTo>
                    <a:pt x="3924300" y="3000375"/>
                  </a:lnTo>
                  <a:lnTo>
                    <a:pt x="609600" y="3000375"/>
                  </a:lnTo>
                  <a:lnTo>
                    <a:pt x="4763" y="1119187"/>
                  </a:lnTo>
                  <a:lnTo>
                    <a:pt x="0" y="919163"/>
                  </a:lnTo>
                  <a:close/>
                </a:path>
              </a:pathLst>
            </a:custGeom>
            <a:gradFill flip="none" rotWithShape="1">
              <a:gsLst>
                <a:gs pos="100000">
                  <a:schemeClr val="accent2">
                    <a:lumMod val="60000"/>
                    <a:lumOff val="40000"/>
                    <a:alpha val="0"/>
                  </a:schemeClr>
                </a:gs>
                <a:gs pos="71000">
                  <a:schemeClr val="accent2">
                    <a:lumMod val="60000"/>
                    <a:lumOff val="40000"/>
                    <a:alpha val="40000"/>
                  </a:scheme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746490" y="4967287"/>
              <a:ext cx="201184" cy="163462"/>
            </a:xfrm>
            <a:prstGeom prst="rect">
              <a:avLst/>
            </a:prstGeom>
            <a:solidFill>
              <a:schemeClr val="accent2">
                <a:lumMod val="60000"/>
                <a:lumOff val="40000"/>
                <a:alpha val="40000"/>
              </a:schemeClr>
            </a:solidFill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</p:grpSp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rcRect l="4296" t="4052" r="4336" b="4309"/>
          <a:stretch>
            <a:fillRect/>
          </a:stretch>
        </p:blipFill>
        <p:spPr>
          <a:xfrm>
            <a:off x="8779176" y="4029434"/>
            <a:ext cx="3280912" cy="2966589"/>
          </a:xfrm>
          <a:custGeom>
            <a:avLst/>
            <a:gdLst>
              <a:gd name="connsiteX0" fmla="*/ 0 w 3280912"/>
              <a:gd name="connsiteY0" fmla="*/ 0 h 2966589"/>
              <a:gd name="connsiteX1" fmla="*/ 3280912 w 3280912"/>
              <a:gd name="connsiteY1" fmla="*/ 0 h 2966589"/>
              <a:gd name="connsiteX2" fmla="*/ 3280912 w 3280912"/>
              <a:gd name="connsiteY2" fmla="*/ 2966589 h 2966589"/>
              <a:gd name="connsiteX3" fmla="*/ 0 w 3280912"/>
              <a:gd name="connsiteY3" fmla="*/ 2966589 h 29665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80912" h="2966589">
                <a:moveTo>
                  <a:pt x="0" y="0"/>
                </a:moveTo>
                <a:lnTo>
                  <a:pt x="3280912" y="0"/>
                </a:lnTo>
                <a:lnTo>
                  <a:pt x="3280912" y="2966589"/>
                </a:lnTo>
                <a:lnTo>
                  <a:pt x="0" y="2966589"/>
                </a:lnTo>
                <a:close/>
              </a:path>
            </a:pathLst>
          </a:custGeom>
        </p:spPr>
      </p:pic>
      <p:sp>
        <p:nvSpPr>
          <p:cNvPr id="21" name="TextBox 20"/>
          <p:cNvSpPr txBox="1"/>
          <p:nvPr/>
        </p:nvSpPr>
        <p:spPr>
          <a:xfrm>
            <a:off x="8884324" y="6387525"/>
            <a:ext cx="15456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dirty="0"/>
              <a:t>Joensuu</a:t>
            </a:r>
            <a:endParaRPr lang="fi-FI" sz="3200" dirty="0"/>
          </a:p>
        </p:txBody>
      </p:sp>
      <p:sp>
        <p:nvSpPr>
          <p:cNvPr id="22" name="TextBox 21"/>
          <p:cNvSpPr txBox="1"/>
          <p:nvPr/>
        </p:nvSpPr>
        <p:spPr>
          <a:xfrm>
            <a:off x="9404237" y="-85725"/>
            <a:ext cx="20170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dirty="0"/>
              <a:t>Downtown</a:t>
            </a:r>
            <a:endParaRPr lang="fi-FI" sz="3200" dirty="0"/>
          </a:p>
        </p:txBody>
      </p:sp>
      <p:grpSp>
        <p:nvGrpSpPr>
          <p:cNvPr id="23" name="Group 22"/>
          <p:cNvGrpSpPr/>
          <p:nvPr/>
        </p:nvGrpSpPr>
        <p:grpSpPr>
          <a:xfrm>
            <a:off x="8931519" y="465992"/>
            <a:ext cx="2963008" cy="5560631"/>
            <a:chOff x="4721469" y="465992"/>
            <a:chExt cx="2963008" cy="5560631"/>
          </a:xfrm>
        </p:grpSpPr>
        <p:sp>
          <p:nvSpPr>
            <p:cNvPr id="24" name="Freeform 23"/>
            <p:cNvSpPr/>
            <p:nvPr/>
          </p:nvSpPr>
          <p:spPr>
            <a:xfrm>
              <a:off x="4721469" y="465992"/>
              <a:ext cx="2963008" cy="4564702"/>
            </a:xfrm>
            <a:custGeom>
              <a:avLst/>
              <a:gdLst>
                <a:gd name="connsiteX0" fmla="*/ 791308 w 2963008"/>
                <a:gd name="connsiteY0" fmla="*/ 5574323 h 5574323"/>
                <a:gd name="connsiteX1" fmla="*/ 0 w 2963008"/>
                <a:gd name="connsiteY1" fmla="*/ 2954216 h 5574323"/>
                <a:gd name="connsiteX2" fmla="*/ 0 w 2963008"/>
                <a:gd name="connsiteY2" fmla="*/ 0 h 5574323"/>
                <a:gd name="connsiteX3" fmla="*/ 2963008 w 2963008"/>
                <a:gd name="connsiteY3" fmla="*/ 0 h 5574323"/>
                <a:gd name="connsiteX4" fmla="*/ 2963008 w 2963008"/>
                <a:gd name="connsiteY4" fmla="*/ 2963008 h 5574323"/>
                <a:gd name="connsiteX5" fmla="*/ 1811216 w 2963008"/>
                <a:gd name="connsiteY5" fmla="*/ 5556739 h 5574323"/>
                <a:gd name="connsiteX6" fmla="*/ 791308 w 2963008"/>
                <a:gd name="connsiteY6" fmla="*/ 5574323 h 5574323"/>
                <a:gd name="connsiteX0" fmla="*/ 791308 w 2963008"/>
                <a:gd name="connsiteY0" fmla="*/ 5574323 h 5574323"/>
                <a:gd name="connsiteX1" fmla="*/ 474419 w 2963008"/>
                <a:gd name="connsiteY1" fmla="*/ 4548921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2250831 w 2963008"/>
                <a:gd name="connsiteY6" fmla="*/ 4544158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2681 w 2963008"/>
                <a:gd name="connsiteY6" fmla="*/ 4558446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1811216 w 2963008"/>
                <a:gd name="connsiteY0" fmla="*/ 5556739 h 5556739"/>
                <a:gd name="connsiteX1" fmla="*/ 788744 w 2963008"/>
                <a:gd name="connsiteY1" fmla="*/ 4563208 h 5556739"/>
                <a:gd name="connsiteX2" fmla="*/ 0 w 2963008"/>
                <a:gd name="connsiteY2" fmla="*/ 2954216 h 5556739"/>
                <a:gd name="connsiteX3" fmla="*/ 0 w 2963008"/>
                <a:gd name="connsiteY3" fmla="*/ 0 h 5556739"/>
                <a:gd name="connsiteX4" fmla="*/ 2963008 w 2963008"/>
                <a:gd name="connsiteY4" fmla="*/ 0 h 5556739"/>
                <a:gd name="connsiteX5" fmla="*/ 2963008 w 2963008"/>
                <a:gd name="connsiteY5" fmla="*/ 2963008 h 5556739"/>
                <a:gd name="connsiteX6" fmla="*/ 1812681 w 2963008"/>
                <a:gd name="connsiteY6" fmla="*/ 4558446 h 5556739"/>
                <a:gd name="connsiteX7" fmla="*/ 1811216 w 2963008"/>
                <a:gd name="connsiteY7" fmla="*/ 5556739 h 5556739"/>
                <a:gd name="connsiteX0" fmla="*/ 1812681 w 2963008"/>
                <a:gd name="connsiteY0" fmla="*/ 4558446 h 4761122"/>
                <a:gd name="connsiteX1" fmla="*/ 788744 w 2963008"/>
                <a:gd name="connsiteY1" fmla="*/ 4563208 h 4761122"/>
                <a:gd name="connsiteX2" fmla="*/ 0 w 2963008"/>
                <a:gd name="connsiteY2" fmla="*/ 2954216 h 4761122"/>
                <a:gd name="connsiteX3" fmla="*/ 0 w 2963008"/>
                <a:gd name="connsiteY3" fmla="*/ 0 h 4761122"/>
                <a:gd name="connsiteX4" fmla="*/ 2963008 w 2963008"/>
                <a:gd name="connsiteY4" fmla="*/ 0 h 4761122"/>
                <a:gd name="connsiteX5" fmla="*/ 2963008 w 2963008"/>
                <a:gd name="connsiteY5" fmla="*/ 2963008 h 4761122"/>
                <a:gd name="connsiteX6" fmla="*/ 1812681 w 2963008"/>
                <a:gd name="connsiteY6" fmla="*/ 4558446 h 4761122"/>
                <a:gd name="connsiteX0" fmla="*/ 1812681 w 2963008"/>
                <a:gd name="connsiteY0" fmla="*/ 4558446 h 4678462"/>
                <a:gd name="connsiteX1" fmla="*/ 788744 w 2963008"/>
                <a:gd name="connsiteY1" fmla="*/ 4563208 h 4678462"/>
                <a:gd name="connsiteX2" fmla="*/ 0 w 2963008"/>
                <a:gd name="connsiteY2" fmla="*/ 2954216 h 4678462"/>
                <a:gd name="connsiteX3" fmla="*/ 0 w 2963008"/>
                <a:gd name="connsiteY3" fmla="*/ 0 h 4678462"/>
                <a:gd name="connsiteX4" fmla="*/ 2963008 w 2963008"/>
                <a:gd name="connsiteY4" fmla="*/ 0 h 4678462"/>
                <a:gd name="connsiteX5" fmla="*/ 2963008 w 2963008"/>
                <a:gd name="connsiteY5" fmla="*/ 2963008 h 4678462"/>
                <a:gd name="connsiteX6" fmla="*/ 1812681 w 2963008"/>
                <a:gd name="connsiteY6" fmla="*/ 4558446 h 4678462"/>
                <a:gd name="connsiteX0" fmla="*/ 1812681 w 2963008"/>
                <a:gd name="connsiteY0" fmla="*/ 4558446 h 4564702"/>
                <a:gd name="connsiteX1" fmla="*/ 788744 w 2963008"/>
                <a:gd name="connsiteY1" fmla="*/ 4563208 h 4564702"/>
                <a:gd name="connsiteX2" fmla="*/ 0 w 2963008"/>
                <a:gd name="connsiteY2" fmla="*/ 2954216 h 4564702"/>
                <a:gd name="connsiteX3" fmla="*/ 0 w 2963008"/>
                <a:gd name="connsiteY3" fmla="*/ 0 h 4564702"/>
                <a:gd name="connsiteX4" fmla="*/ 2963008 w 2963008"/>
                <a:gd name="connsiteY4" fmla="*/ 0 h 4564702"/>
                <a:gd name="connsiteX5" fmla="*/ 2963008 w 2963008"/>
                <a:gd name="connsiteY5" fmla="*/ 2963008 h 4564702"/>
                <a:gd name="connsiteX6" fmla="*/ 1812681 w 2963008"/>
                <a:gd name="connsiteY6" fmla="*/ 4558446 h 45647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963008" h="4564702">
                  <a:moveTo>
                    <a:pt x="1812681" y="4558446"/>
                  </a:moveTo>
                  <a:cubicBezTo>
                    <a:pt x="1530203" y="4567694"/>
                    <a:pt x="1552496" y="4564250"/>
                    <a:pt x="788744" y="4563208"/>
                  </a:cubicBezTo>
                  <a:lnTo>
                    <a:pt x="0" y="2954216"/>
                  </a:lnTo>
                  <a:lnTo>
                    <a:pt x="0" y="0"/>
                  </a:lnTo>
                  <a:lnTo>
                    <a:pt x="2963008" y="0"/>
                  </a:lnTo>
                  <a:lnTo>
                    <a:pt x="2963008" y="2963008"/>
                  </a:lnTo>
                  <a:lnTo>
                    <a:pt x="1812681" y="4558446"/>
                  </a:lnTo>
                  <a:close/>
                </a:path>
              </a:pathLst>
            </a:custGeom>
            <a:gradFill>
              <a:gsLst>
                <a:gs pos="64000">
                  <a:schemeClr val="accent1">
                    <a:lumMod val="60000"/>
                    <a:lumOff val="40000"/>
                    <a:alpha val="60000"/>
                  </a:schemeClr>
                </a:gs>
                <a:gs pos="95000">
                  <a:schemeClr val="accent1">
                    <a:lumMod val="30000"/>
                    <a:lumOff val="70000"/>
                    <a:alpha val="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5504988" y="5033638"/>
              <a:ext cx="1037855" cy="992985"/>
            </a:xfrm>
            <a:prstGeom prst="rect">
              <a:avLst/>
            </a:prstGeom>
            <a:solidFill>
              <a:schemeClr val="accent1">
                <a:lumMod val="60000"/>
                <a:lumOff val="40000"/>
                <a:alpha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</p:grpSp>
      <p:pic>
        <p:nvPicPr>
          <p:cNvPr id="26" name="Picture 25"/>
          <p:cNvPicPr>
            <a:picLocks noChangeAspect="1"/>
          </p:cNvPicPr>
          <p:nvPr/>
        </p:nvPicPr>
        <p:blipFill>
          <a:blip r:embed="rId5"/>
          <a:srcRect l="3660" t="3924" r="4515" b="4571"/>
          <a:stretch>
            <a:fillRect/>
          </a:stretch>
        </p:blipFill>
        <p:spPr>
          <a:xfrm>
            <a:off x="8934450" y="466725"/>
            <a:ext cx="2967038" cy="2962275"/>
          </a:xfrm>
          <a:custGeom>
            <a:avLst/>
            <a:gdLst>
              <a:gd name="connsiteX0" fmla="*/ 0 w 2967038"/>
              <a:gd name="connsiteY0" fmla="*/ 0 h 2962275"/>
              <a:gd name="connsiteX1" fmla="*/ 2967038 w 2967038"/>
              <a:gd name="connsiteY1" fmla="*/ 0 h 2962275"/>
              <a:gd name="connsiteX2" fmla="*/ 2967038 w 2967038"/>
              <a:gd name="connsiteY2" fmla="*/ 2962275 h 2962275"/>
              <a:gd name="connsiteX3" fmla="*/ 0 w 2967038"/>
              <a:gd name="connsiteY3" fmla="*/ 2962275 h 2962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67038" h="2962275">
                <a:moveTo>
                  <a:pt x="0" y="0"/>
                </a:moveTo>
                <a:lnTo>
                  <a:pt x="2967038" y="0"/>
                </a:lnTo>
                <a:lnTo>
                  <a:pt x="2967038" y="2962275"/>
                </a:lnTo>
                <a:lnTo>
                  <a:pt x="0" y="2962275"/>
                </a:lnTo>
                <a:close/>
              </a:path>
            </a:pathLst>
          </a:cu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091181" y="-444500"/>
            <a:ext cx="4437267" cy="7861300"/>
          </a:xfrm>
          <a:prstGeom prst="rect">
            <a:avLst/>
          </a:prstGeom>
        </p:spPr>
      </p:pic>
      <p:grpSp>
        <p:nvGrpSpPr>
          <p:cNvPr id="39" name="Group 38"/>
          <p:cNvGrpSpPr/>
          <p:nvPr/>
        </p:nvGrpSpPr>
        <p:grpSpPr>
          <a:xfrm>
            <a:off x="330190" y="4019550"/>
            <a:ext cx="4121161" cy="3000375"/>
            <a:chOff x="3746490" y="4019550"/>
            <a:chExt cx="4121161" cy="3000375"/>
          </a:xfrm>
        </p:grpSpPr>
        <p:sp>
          <p:nvSpPr>
            <p:cNvPr id="40" name="Freeform 39"/>
            <p:cNvSpPr/>
            <p:nvPr/>
          </p:nvSpPr>
          <p:spPr>
            <a:xfrm>
              <a:off x="3943351" y="4019550"/>
              <a:ext cx="3924300" cy="3000375"/>
            </a:xfrm>
            <a:custGeom>
              <a:avLst/>
              <a:gdLst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9525 w 4886325"/>
                <a:gd name="connsiteY6" fmla="*/ 1133475 h 3000375"/>
                <a:gd name="connsiteX7" fmla="*/ 0 w 4886325"/>
                <a:gd name="connsiteY7" fmla="*/ 962025 h 3000375"/>
                <a:gd name="connsiteX0" fmla="*/ 0 w 4886325"/>
                <a:gd name="connsiteY0" fmla="*/ 962025 h 3000375"/>
                <a:gd name="connsiteX1" fmla="*/ 1571625 w 4886325"/>
                <a:gd name="connsiteY1" fmla="*/ 0 h 3000375"/>
                <a:gd name="connsiteX2" fmla="*/ 4886325 w 4886325"/>
                <a:gd name="connsiteY2" fmla="*/ 0 h 3000375"/>
                <a:gd name="connsiteX3" fmla="*/ 4886325 w 4886325"/>
                <a:gd name="connsiteY3" fmla="*/ 3000375 h 3000375"/>
                <a:gd name="connsiteX4" fmla="*/ 4886325 w 4886325"/>
                <a:gd name="connsiteY4" fmla="*/ 3000375 h 3000375"/>
                <a:gd name="connsiteX5" fmla="*/ 1571625 w 4886325"/>
                <a:gd name="connsiteY5" fmla="*/ 3000375 h 3000375"/>
                <a:gd name="connsiteX6" fmla="*/ 233363 w 4886325"/>
                <a:gd name="connsiteY6" fmla="*/ 1152525 h 3000375"/>
                <a:gd name="connsiteX7" fmla="*/ 0 w 4886325"/>
                <a:gd name="connsiteY7" fmla="*/ 962025 h 3000375"/>
                <a:gd name="connsiteX0" fmla="*/ 4762 w 4652962"/>
                <a:gd name="connsiteY0" fmla="*/ 928688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4762 w 4652962"/>
                <a:gd name="connsiteY7" fmla="*/ 928688 h 3000375"/>
                <a:gd name="connsiteX0" fmla="*/ 728662 w 4652962"/>
                <a:gd name="connsiteY0" fmla="*/ 919163 h 3000375"/>
                <a:gd name="connsiteX1" fmla="*/ 1338262 w 4652962"/>
                <a:gd name="connsiteY1" fmla="*/ 0 h 3000375"/>
                <a:gd name="connsiteX2" fmla="*/ 4652962 w 4652962"/>
                <a:gd name="connsiteY2" fmla="*/ 0 h 3000375"/>
                <a:gd name="connsiteX3" fmla="*/ 4652962 w 4652962"/>
                <a:gd name="connsiteY3" fmla="*/ 3000375 h 3000375"/>
                <a:gd name="connsiteX4" fmla="*/ 4652962 w 4652962"/>
                <a:gd name="connsiteY4" fmla="*/ 3000375 h 3000375"/>
                <a:gd name="connsiteX5" fmla="*/ 1338262 w 4652962"/>
                <a:gd name="connsiteY5" fmla="*/ 3000375 h 3000375"/>
                <a:gd name="connsiteX6" fmla="*/ 0 w 4652962"/>
                <a:gd name="connsiteY6" fmla="*/ 1152525 h 3000375"/>
                <a:gd name="connsiteX7" fmla="*/ 728662 w 4652962"/>
                <a:gd name="connsiteY7" fmla="*/ 919163 h 3000375"/>
                <a:gd name="connsiteX0" fmla="*/ 0 w 3924300"/>
                <a:gd name="connsiteY0" fmla="*/ 919163 h 3000375"/>
                <a:gd name="connsiteX1" fmla="*/ 609600 w 3924300"/>
                <a:gd name="connsiteY1" fmla="*/ 0 h 3000375"/>
                <a:gd name="connsiteX2" fmla="*/ 3924300 w 3924300"/>
                <a:gd name="connsiteY2" fmla="*/ 0 h 3000375"/>
                <a:gd name="connsiteX3" fmla="*/ 3924300 w 3924300"/>
                <a:gd name="connsiteY3" fmla="*/ 3000375 h 3000375"/>
                <a:gd name="connsiteX4" fmla="*/ 3924300 w 3924300"/>
                <a:gd name="connsiteY4" fmla="*/ 3000375 h 3000375"/>
                <a:gd name="connsiteX5" fmla="*/ 609600 w 3924300"/>
                <a:gd name="connsiteY5" fmla="*/ 3000375 h 3000375"/>
                <a:gd name="connsiteX6" fmla="*/ 4763 w 3924300"/>
                <a:gd name="connsiteY6" fmla="*/ 1119187 h 3000375"/>
                <a:gd name="connsiteX7" fmla="*/ 0 w 3924300"/>
                <a:gd name="connsiteY7" fmla="*/ 919163 h 30003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924300" h="3000375">
                  <a:moveTo>
                    <a:pt x="0" y="919163"/>
                  </a:moveTo>
                  <a:lnTo>
                    <a:pt x="609600" y="0"/>
                  </a:lnTo>
                  <a:lnTo>
                    <a:pt x="3924300" y="0"/>
                  </a:lnTo>
                  <a:lnTo>
                    <a:pt x="3924300" y="3000375"/>
                  </a:lnTo>
                  <a:lnTo>
                    <a:pt x="3924300" y="3000375"/>
                  </a:lnTo>
                  <a:lnTo>
                    <a:pt x="609600" y="3000375"/>
                  </a:lnTo>
                  <a:lnTo>
                    <a:pt x="4763" y="1119187"/>
                  </a:lnTo>
                  <a:lnTo>
                    <a:pt x="0" y="919163"/>
                  </a:lnTo>
                  <a:close/>
                </a:path>
              </a:pathLst>
            </a:custGeom>
            <a:gradFill flip="none" rotWithShape="1">
              <a:gsLst>
                <a:gs pos="100000">
                  <a:schemeClr val="accent2">
                    <a:lumMod val="60000"/>
                    <a:lumOff val="40000"/>
                    <a:alpha val="0"/>
                  </a:schemeClr>
                </a:gs>
                <a:gs pos="71000">
                  <a:schemeClr val="accent2">
                    <a:lumMod val="60000"/>
                    <a:lumOff val="40000"/>
                    <a:alpha val="40000"/>
                  </a:scheme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3746490" y="4967287"/>
              <a:ext cx="201184" cy="163462"/>
            </a:xfrm>
            <a:prstGeom prst="rect">
              <a:avLst/>
            </a:prstGeom>
            <a:solidFill>
              <a:schemeClr val="accent2">
                <a:lumMod val="60000"/>
                <a:lumOff val="40000"/>
                <a:alpha val="40000"/>
              </a:schemeClr>
            </a:solidFill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1257974" y="6387525"/>
            <a:ext cx="15456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dirty="0"/>
              <a:t>Joensuu</a:t>
            </a:r>
            <a:endParaRPr lang="fi-FI" sz="3200" dirty="0"/>
          </a:p>
        </p:txBody>
      </p:sp>
      <p:sp>
        <p:nvSpPr>
          <p:cNvPr id="43" name="TextBox 42"/>
          <p:cNvSpPr txBox="1"/>
          <p:nvPr/>
        </p:nvSpPr>
        <p:spPr>
          <a:xfrm>
            <a:off x="1777887" y="-85725"/>
            <a:ext cx="20170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dirty="0"/>
              <a:t>Downtown</a:t>
            </a:r>
            <a:endParaRPr lang="fi-FI" sz="3200" dirty="0"/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8" t="4137" r="4119" b="4158"/>
          <a:stretch>
            <a:fillRect/>
          </a:stretch>
        </p:blipFill>
        <p:spPr>
          <a:xfrm>
            <a:off x="1112789" y="4032373"/>
            <a:ext cx="3316921" cy="2959100"/>
          </a:xfrm>
          <a:custGeom>
            <a:avLst/>
            <a:gdLst>
              <a:gd name="connsiteX0" fmla="*/ 0 w 3316921"/>
              <a:gd name="connsiteY0" fmla="*/ 0 h 2959100"/>
              <a:gd name="connsiteX1" fmla="*/ 3316921 w 3316921"/>
              <a:gd name="connsiteY1" fmla="*/ 0 h 2959100"/>
              <a:gd name="connsiteX2" fmla="*/ 3316921 w 3316921"/>
              <a:gd name="connsiteY2" fmla="*/ 2959100 h 2959100"/>
              <a:gd name="connsiteX3" fmla="*/ 0 w 3316921"/>
              <a:gd name="connsiteY3" fmla="*/ 2959100 h 295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316921" h="2959100">
                <a:moveTo>
                  <a:pt x="0" y="0"/>
                </a:moveTo>
                <a:lnTo>
                  <a:pt x="3316921" y="0"/>
                </a:lnTo>
                <a:lnTo>
                  <a:pt x="3316921" y="2959100"/>
                </a:lnTo>
                <a:lnTo>
                  <a:pt x="0" y="2959100"/>
                </a:lnTo>
                <a:close/>
              </a:path>
            </a:pathLst>
          </a:custGeom>
        </p:spPr>
      </p:pic>
      <p:grpSp>
        <p:nvGrpSpPr>
          <p:cNvPr id="45" name="Group 44"/>
          <p:cNvGrpSpPr/>
          <p:nvPr/>
        </p:nvGrpSpPr>
        <p:grpSpPr>
          <a:xfrm>
            <a:off x="1305169" y="465992"/>
            <a:ext cx="2963008" cy="5560631"/>
            <a:chOff x="4721469" y="465992"/>
            <a:chExt cx="2963008" cy="5560631"/>
          </a:xfrm>
        </p:grpSpPr>
        <p:sp>
          <p:nvSpPr>
            <p:cNvPr id="46" name="Freeform 45"/>
            <p:cNvSpPr/>
            <p:nvPr/>
          </p:nvSpPr>
          <p:spPr>
            <a:xfrm>
              <a:off x="4721469" y="465992"/>
              <a:ext cx="2963008" cy="4564702"/>
            </a:xfrm>
            <a:custGeom>
              <a:avLst/>
              <a:gdLst>
                <a:gd name="connsiteX0" fmla="*/ 791308 w 2963008"/>
                <a:gd name="connsiteY0" fmla="*/ 5574323 h 5574323"/>
                <a:gd name="connsiteX1" fmla="*/ 0 w 2963008"/>
                <a:gd name="connsiteY1" fmla="*/ 2954216 h 5574323"/>
                <a:gd name="connsiteX2" fmla="*/ 0 w 2963008"/>
                <a:gd name="connsiteY2" fmla="*/ 0 h 5574323"/>
                <a:gd name="connsiteX3" fmla="*/ 2963008 w 2963008"/>
                <a:gd name="connsiteY3" fmla="*/ 0 h 5574323"/>
                <a:gd name="connsiteX4" fmla="*/ 2963008 w 2963008"/>
                <a:gd name="connsiteY4" fmla="*/ 2963008 h 5574323"/>
                <a:gd name="connsiteX5" fmla="*/ 1811216 w 2963008"/>
                <a:gd name="connsiteY5" fmla="*/ 5556739 h 5574323"/>
                <a:gd name="connsiteX6" fmla="*/ 791308 w 2963008"/>
                <a:gd name="connsiteY6" fmla="*/ 5574323 h 5574323"/>
                <a:gd name="connsiteX0" fmla="*/ 791308 w 2963008"/>
                <a:gd name="connsiteY0" fmla="*/ 5574323 h 5574323"/>
                <a:gd name="connsiteX1" fmla="*/ 474419 w 2963008"/>
                <a:gd name="connsiteY1" fmla="*/ 4548921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1216 w 2963008"/>
                <a:gd name="connsiteY6" fmla="*/ 5556739 h 5574323"/>
                <a:gd name="connsiteX7" fmla="*/ 791308 w 2963008"/>
                <a:gd name="connsiteY7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2250831 w 2963008"/>
                <a:gd name="connsiteY6" fmla="*/ 4544158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791308 w 2963008"/>
                <a:gd name="connsiteY0" fmla="*/ 5574323 h 5574323"/>
                <a:gd name="connsiteX1" fmla="*/ 788744 w 2963008"/>
                <a:gd name="connsiteY1" fmla="*/ 4563208 h 5574323"/>
                <a:gd name="connsiteX2" fmla="*/ 0 w 2963008"/>
                <a:gd name="connsiteY2" fmla="*/ 2954216 h 5574323"/>
                <a:gd name="connsiteX3" fmla="*/ 0 w 2963008"/>
                <a:gd name="connsiteY3" fmla="*/ 0 h 5574323"/>
                <a:gd name="connsiteX4" fmla="*/ 2963008 w 2963008"/>
                <a:gd name="connsiteY4" fmla="*/ 0 h 5574323"/>
                <a:gd name="connsiteX5" fmla="*/ 2963008 w 2963008"/>
                <a:gd name="connsiteY5" fmla="*/ 2963008 h 5574323"/>
                <a:gd name="connsiteX6" fmla="*/ 1812681 w 2963008"/>
                <a:gd name="connsiteY6" fmla="*/ 4558446 h 5574323"/>
                <a:gd name="connsiteX7" fmla="*/ 1811216 w 2963008"/>
                <a:gd name="connsiteY7" fmla="*/ 5556739 h 5574323"/>
                <a:gd name="connsiteX8" fmla="*/ 791308 w 2963008"/>
                <a:gd name="connsiteY8" fmla="*/ 5574323 h 5574323"/>
                <a:gd name="connsiteX0" fmla="*/ 1811216 w 2963008"/>
                <a:gd name="connsiteY0" fmla="*/ 5556739 h 5556739"/>
                <a:gd name="connsiteX1" fmla="*/ 788744 w 2963008"/>
                <a:gd name="connsiteY1" fmla="*/ 4563208 h 5556739"/>
                <a:gd name="connsiteX2" fmla="*/ 0 w 2963008"/>
                <a:gd name="connsiteY2" fmla="*/ 2954216 h 5556739"/>
                <a:gd name="connsiteX3" fmla="*/ 0 w 2963008"/>
                <a:gd name="connsiteY3" fmla="*/ 0 h 5556739"/>
                <a:gd name="connsiteX4" fmla="*/ 2963008 w 2963008"/>
                <a:gd name="connsiteY4" fmla="*/ 0 h 5556739"/>
                <a:gd name="connsiteX5" fmla="*/ 2963008 w 2963008"/>
                <a:gd name="connsiteY5" fmla="*/ 2963008 h 5556739"/>
                <a:gd name="connsiteX6" fmla="*/ 1812681 w 2963008"/>
                <a:gd name="connsiteY6" fmla="*/ 4558446 h 5556739"/>
                <a:gd name="connsiteX7" fmla="*/ 1811216 w 2963008"/>
                <a:gd name="connsiteY7" fmla="*/ 5556739 h 5556739"/>
                <a:gd name="connsiteX0" fmla="*/ 1812681 w 2963008"/>
                <a:gd name="connsiteY0" fmla="*/ 4558446 h 4761122"/>
                <a:gd name="connsiteX1" fmla="*/ 788744 w 2963008"/>
                <a:gd name="connsiteY1" fmla="*/ 4563208 h 4761122"/>
                <a:gd name="connsiteX2" fmla="*/ 0 w 2963008"/>
                <a:gd name="connsiteY2" fmla="*/ 2954216 h 4761122"/>
                <a:gd name="connsiteX3" fmla="*/ 0 w 2963008"/>
                <a:gd name="connsiteY3" fmla="*/ 0 h 4761122"/>
                <a:gd name="connsiteX4" fmla="*/ 2963008 w 2963008"/>
                <a:gd name="connsiteY4" fmla="*/ 0 h 4761122"/>
                <a:gd name="connsiteX5" fmla="*/ 2963008 w 2963008"/>
                <a:gd name="connsiteY5" fmla="*/ 2963008 h 4761122"/>
                <a:gd name="connsiteX6" fmla="*/ 1812681 w 2963008"/>
                <a:gd name="connsiteY6" fmla="*/ 4558446 h 4761122"/>
                <a:gd name="connsiteX0" fmla="*/ 1812681 w 2963008"/>
                <a:gd name="connsiteY0" fmla="*/ 4558446 h 4678462"/>
                <a:gd name="connsiteX1" fmla="*/ 788744 w 2963008"/>
                <a:gd name="connsiteY1" fmla="*/ 4563208 h 4678462"/>
                <a:gd name="connsiteX2" fmla="*/ 0 w 2963008"/>
                <a:gd name="connsiteY2" fmla="*/ 2954216 h 4678462"/>
                <a:gd name="connsiteX3" fmla="*/ 0 w 2963008"/>
                <a:gd name="connsiteY3" fmla="*/ 0 h 4678462"/>
                <a:gd name="connsiteX4" fmla="*/ 2963008 w 2963008"/>
                <a:gd name="connsiteY4" fmla="*/ 0 h 4678462"/>
                <a:gd name="connsiteX5" fmla="*/ 2963008 w 2963008"/>
                <a:gd name="connsiteY5" fmla="*/ 2963008 h 4678462"/>
                <a:gd name="connsiteX6" fmla="*/ 1812681 w 2963008"/>
                <a:gd name="connsiteY6" fmla="*/ 4558446 h 4678462"/>
                <a:gd name="connsiteX0" fmla="*/ 1812681 w 2963008"/>
                <a:gd name="connsiteY0" fmla="*/ 4558446 h 4564702"/>
                <a:gd name="connsiteX1" fmla="*/ 788744 w 2963008"/>
                <a:gd name="connsiteY1" fmla="*/ 4563208 h 4564702"/>
                <a:gd name="connsiteX2" fmla="*/ 0 w 2963008"/>
                <a:gd name="connsiteY2" fmla="*/ 2954216 h 4564702"/>
                <a:gd name="connsiteX3" fmla="*/ 0 w 2963008"/>
                <a:gd name="connsiteY3" fmla="*/ 0 h 4564702"/>
                <a:gd name="connsiteX4" fmla="*/ 2963008 w 2963008"/>
                <a:gd name="connsiteY4" fmla="*/ 0 h 4564702"/>
                <a:gd name="connsiteX5" fmla="*/ 2963008 w 2963008"/>
                <a:gd name="connsiteY5" fmla="*/ 2963008 h 4564702"/>
                <a:gd name="connsiteX6" fmla="*/ 1812681 w 2963008"/>
                <a:gd name="connsiteY6" fmla="*/ 4558446 h 45647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963008" h="4564702">
                  <a:moveTo>
                    <a:pt x="1812681" y="4558446"/>
                  </a:moveTo>
                  <a:cubicBezTo>
                    <a:pt x="1530203" y="4567694"/>
                    <a:pt x="1552496" y="4564250"/>
                    <a:pt x="788744" y="4563208"/>
                  </a:cubicBezTo>
                  <a:lnTo>
                    <a:pt x="0" y="2954216"/>
                  </a:lnTo>
                  <a:lnTo>
                    <a:pt x="0" y="0"/>
                  </a:lnTo>
                  <a:lnTo>
                    <a:pt x="2963008" y="0"/>
                  </a:lnTo>
                  <a:lnTo>
                    <a:pt x="2963008" y="2963008"/>
                  </a:lnTo>
                  <a:lnTo>
                    <a:pt x="1812681" y="4558446"/>
                  </a:lnTo>
                  <a:close/>
                </a:path>
              </a:pathLst>
            </a:custGeom>
            <a:gradFill>
              <a:gsLst>
                <a:gs pos="64000">
                  <a:schemeClr val="accent1">
                    <a:lumMod val="60000"/>
                    <a:lumOff val="40000"/>
                    <a:alpha val="60000"/>
                  </a:schemeClr>
                </a:gs>
                <a:gs pos="95000">
                  <a:schemeClr val="accent1">
                    <a:lumMod val="30000"/>
                    <a:lumOff val="70000"/>
                    <a:alpha val="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5504988" y="5033638"/>
              <a:ext cx="1037855" cy="992985"/>
            </a:xfrm>
            <a:prstGeom prst="rect">
              <a:avLst/>
            </a:prstGeom>
            <a:solidFill>
              <a:schemeClr val="accent1">
                <a:lumMod val="60000"/>
                <a:lumOff val="40000"/>
                <a:alpha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</p:grpSp>
      <p:pic>
        <p:nvPicPr>
          <p:cNvPr id="48" name="Picture 4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5" t="4012" r="4122" b="4282"/>
          <a:stretch>
            <a:fillRect/>
          </a:stretch>
        </p:blipFill>
        <p:spPr>
          <a:xfrm>
            <a:off x="1308100" y="463550"/>
            <a:ext cx="2965450" cy="2959100"/>
          </a:xfrm>
          <a:custGeom>
            <a:avLst/>
            <a:gdLst>
              <a:gd name="connsiteX0" fmla="*/ 0 w 2965450"/>
              <a:gd name="connsiteY0" fmla="*/ 0 h 2959100"/>
              <a:gd name="connsiteX1" fmla="*/ 2965450 w 2965450"/>
              <a:gd name="connsiteY1" fmla="*/ 0 h 2959100"/>
              <a:gd name="connsiteX2" fmla="*/ 2965450 w 2965450"/>
              <a:gd name="connsiteY2" fmla="*/ 2959100 h 2959100"/>
              <a:gd name="connsiteX3" fmla="*/ 0 w 2965450"/>
              <a:gd name="connsiteY3" fmla="*/ 2959100 h 2959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65450" h="2959100">
                <a:moveTo>
                  <a:pt x="0" y="0"/>
                </a:moveTo>
                <a:lnTo>
                  <a:pt x="2965450" y="0"/>
                </a:lnTo>
                <a:lnTo>
                  <a:pt x="2965450" y="2959100"/>
                </a:lnTo>
                <a:lnTo>
                  <a:pt x="0" y="2959100"/>
                </a:lnTo>
                <a:close/>
              </a:path>
            </a:pathLst>
          </a:custGeom>
        </p:spPr>
      </p:pic>
      <p:sp>
        <p:nvSpPr>
          <p:cNvPr id="49" name="TextBox 48"/>
          <p:cNvSpPr txBox="1"/>
          <p:nvPr/>
        </p:nvSpPr>
        <p:spPr>
          <a:xfrm>
            <a:off x="-590830" y="-965200"/>
            <a:ext cx="360412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4000" b="1" dirty="0"/>
              <a:t>Delaunay Graph</a:t>
            </a:r>
            <a:endParaRPr lang="fi-FI" sz="40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5801367" y="-965200"/>
            <a:ext cx="555825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4000" b="1" dirty="0"/>
              <a:t>5 Delaunay &amp; 4 Quadrant</a:t>
            </a:r>
            <a:endParaRPr lang="fi-FI" sz="4000" b="1" dirty="0"/>
          </a:p>
        </p:txBody>
      </p:sp>
    </p:spTree>
    <p:extLst>
      <p:ext uri="{BB962C8B-B14F-4D97-AF65-F5344CB8AC3E}">
        <p14:creationId xmlns:p14="http://schemas.microsoft.com/office/powerpoint/2010/main" val="2499613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7</TotalTime>
  <Words>412</Words>
  <Application>Microsoft Office PowerPoint</Application>
  <PresentationFormat>Widescreen</PresentationFormat>
  <Paragraphs>167</Paragraphs>
  <Slides>2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rial</vt:lpstr>
      <vt:lpstr>Calibri</vt:lpstr>
      <vt:lpstr>Calibri Light</vt:lpstr>
      <vt:lpstr>Courier New</vt:lpstr>
      <vt:lpstr>Office Theme</vt:lpstr>
      <vt:lpstr>Solving the large-scale TSP problem in 1 hour:  Santa Claus Challenge 202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astern Fin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u Mariescu-Istodor</dc:creator>
  <cp:lastModifiedBy>Pasi Fränti</cp:lastModifiedBy>
  <cp:revision>62</cp:revision>
  <dcterms:created xsi:type="dcterms:W3CDTF">2021-03-24T14:53:29Z</dcterms:created>
  <dcterms:modified xsi:type="dcterms:W3CDTF">2021-09-17T10:38:56Z</dcterms:modified>
</cp:coreProperties>
</file>